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314" r:id="rId2"/>
    <p:sldId id="322" r:id="rId3"/>
    <p:sldId id="312" r:id="rId4"/>
    <p:sldId id="318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20305"/>
    <a:srgbClr val="C81B69"/>
    <a:srgbClr val="E91F7A"/>
    <a:srgbClr val="C61C6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25"/>
    <p:restoredTop sz="87143"/>
  </p:normalViewPr>
  <p:slideViewPr>
    <p:cSldViewPr snapToGrid="0">
      <p:cViewPr varScale="1">
        <p:scale>
          <a:sx n="65" d="100"/>
          <a:sy n="65" d="100"/>
        </p:scale>
        <p:origin x="13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大樹 山重" userId="16ee12dc8e3c78ba" providerId="LiveId" clId="{670E84D4-1927-F542-9000-BED8BF3BABBF}"/>
    <pc:docChg chg="modSld sldOrd">
      <pc:chgData name="大樹 山重" userId="16ee12dc8e3c78ba" providerId="LiveId" clId="{670E84D4-1927-F542-9000-BED8BF3BABBF}" dt="2024-09-21T22:53:58.668" v="14" actId="20577"/>
      <pc:docMkLst>
        <pc:docMk/>
      </pc:docMkLst>
      <pc:sldChg chg="modSp mod ord">
        <pc:chgData name="大樹 山重" userId="16ee12dc8e3c78ba" providerId="LiveId" clId="{670E84D4-1927-F542-9000-BED8BF3BABBF}" dt="2024-09-21T22:53:58.668" v="14" actId="20577"/>
        <pc:sldMkLst>
          <pc:docMk/>
          <pc:sldMk cId="1533477922" sldId="318"/>
        </pc:sldMkLst>
        <pc:spChg chg="mod">
          <ac:chgData name="大樹 山重" userId="16ee12dc8e3c78ba" providerId="LiveId" clId="{670E84D4-1927-F542-9000-BED8BF3BABBF}" dt="2024-09-21T22:53:58.668" v="14" actId="20577"/>
          <ac:spMkLst>
            <pc:docMk/>
            <pc:sldMk cId="1533477922" sldId="318"/>
            <ac:spMk id="5" creationId="{609E9C6A-9829-C523-B5F4-9C944E21FE08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16ee12dc8e3c78ba/&#12383;&#12441;&#12356;&#12365;&#12288;&#12501;&#12457;&#12523;&#12479;&#12441;/&#22269;&#31435;&#12363;&#12441;&#12435;&#12475;&#12531;&#12479;&#12540;&#20013;&#22830;&#30149;&#38498;/EUS-HGS/PS%20vs%20MS%20in%20EUS-HGS_/Figure/Figure%20materials/PS%20vs%20MS%20&#34880;&#28165;&#12486;&#12441;&#12540;&#12479;&#25512;&#31227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16ee12dc8e3c78ba/&#12383;&#12441;&#12356;&#12365;&#12288;&#12501;&#12457;&#12523;&#12479;&#12441;/&#22269;&#31435;&#12363;&#12441;&#12435;&#12475;&#12531;&#12479;&#12540;&#20013;&#22830;&#30149;&#38498;/EUS-HGS/PS%20vs%20MS%20in%20EUS-HGS_/Figure/Figure%20materials/PS%20vs%20MS%20&#34880;&#28165;&#12486;&#12441;&#12540;&#12479;&#25512;&#31227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16ee12dc8e3c78ba/&#12383;&#12441;&#12356;&#12365;&#12288;&#12501;&#12457;&#12523;&#12479;&#12441;/&#22269;&#31435;&#12363;&#12441;&#12435;&#12475;&#12531;&#12479;&#12540;&#20013;&#22830;&#30149;&#38498;/EUS-HGS/PS%20vs%20MS%20in%20EUS-HGS_/Figure/Figure%20materials/PS%20vs%20MS%20&#34880;&#28165;&#12486;&#12441;&#12540;&#12479;&#25512;&#31227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16ee12dc8e3c78ba/&#12383;&#12441;&#12356;&#12365;&#12288;&#12501;&#12457;&#12523;&#12479;&#12441;/&#22269;&#31435;&#12363;&#12441;&#12435;&#12475;&#12531;&#12479;&#12540;&#20013;&#22830;&#30149;&#38498;/EUS-HGS/PS%20vs%20MS%20in%20EUS-HGS_/Figure/Figure%20materials/PS%20vs%20MS%20&#34880;&#28165;&#12486;&#12441;&#12540;&#12479;&#25512;&#3122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23029839759797"/>
          <c:y val="0.19173629337999418"/>
          <c:w val="0.81502632061930247"/>
          <c:h val="0.74807852143482068"/>
        </c:manualLayout>
      </c:layout>
      <c:lineChart>
        <c:grouping val="standard"/>
        <c:varyColors val="0"/>
        <c:ser>
          <c:idx val="4"/>
          <c:order val="0"/>
          <c:tx>
            <c:strRef>
              <c:f>AST!$A$2</c:f>
              <c:strCache>
                <c:ptCount val="1"/>
                <c:pt idx="0">
                  <c:v>PS</c:v>
                </c:pt>
              </c:strCache>
            </c:strRef>
          </c:tx>
          <c:spPr>
            <a:ln>
              <a:solidFill>
                <a:srgbClr val="C00000"/>
              </a:solidFill>
            </a:ln>
          </c:spPr>
          <c:marker>
            <c:symbol val="square"/>
            <c:size val="3"/>
            <c:spPr>
              <a:solidFill>
                <a:srgbClr val="C00000"/>
              </a:solidFill>
              <a:ln>
                <a:noFill/>
              </a:ln>
            </c:spPr>
          </c:marker>
          <c:dPt>
            <c:idx val="2"/>
            <c:bubble3D val="0"/>
            <c:spPr>
              <a:ln w="19050" cap="rnd">
                <a:solidFill>
                  <a:srgbClr val="C00000"/>
                </a:solidFill>
                <a:round/>
              </a:ln>
              <a:effectLst>
                <a:outerShdw blurRad="12700" sx="101000" sy="101000" algn="ctr" rotWithShape="0">
                  <a:prstClr val="black">
                    <a:alpha val="4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606-9246-834D-A43FC58C61FB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AST!$C$6:$E$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9.9971000000000032</c:v>
                  </c:pt>
                  <c:pt idx="2">
                    <c:v>21.238500000000002</c:v>
                  </c:pt>
                </c:numCache>
              </c:numRef>
            </c:plus>
            <c:minus>
              <c:numRef>
                <c:f>AST!$C$4:$E$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9.9970999999999961</c:v>
                  </c:pt>
                  <c:pt idx="2">
                    <c:v>21.238499999999995</c:v>
                  </c:pt>
                </c:numCache>
              </c:numRef>
            </c:minus>
          </c:errBars>
          <c:cat>
            <c:strRef>
              <c:f>AST!$C$1:$E$1</c:f>
              <c:strCache>
                <c:ptCount val="3"/>
                <c:pt idx="0">
                  <c:v>Baseline</c:v>
                </c:pt>
                <c:pt idx="1">
                  <c:v>week 1</c:v>
                </c:pt>
                <c:pt idx="2">
                  <c:v>week 2</c:v>
                </c:pt>
              </c:strCache>
            </c:strRef>
          </c:cat>
          <c:val>
            <c:numRef>
              <c:f>AST!$C$2:$E$2</c:f>
              <c:numCache>
                <c:formatCode>General</c:formatCode>
                <c:ptCount val="3"/>
                <c:pt idx="0">
                  <c:v>0</c:v>
                </c:pt>
                <c:pt idx="1">
                  <c:v>-37.970300000000002</c:v>
                </c:pt>
                <c:pt idx="2">
                  <c:v>-14.346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1606-9246-834D-A43FC58C61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657782928"/>
        <c:axId val="-1657778032"/>
      </c:lineChart>
      <c:catAx>
        <c:axId val="-1657782928"/>
        <c:scaling>
          <c:orientation val="minMax"/>
        </c:scaling>
        <c:delete val="0"/>
        <c:axPos val="b"/>
        <c:numFmt formatCode="General" sourceLinked="1"/>
        <c:majorTickMark val="in"/>
        <c:minorTickMark val="in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b="1"/>
            </a:pPr>
            <a:endParaRPr lang="en-US"/>
          </a:p>
        </c:txPr>
        <c:crossAx val="-1657778032"/>
        <c:crosses val="autoZero"/>
        <c:auto val="1"/>
        <c:lblAlgn val="ctr"/>
        <c:lblOffset val="100"/>
        <c:noMultiLvlLbl val="0"/>
      </c:catAx>
      <c:valAx>
        <c:axId val="-1657778032"/>
        <c:scaling>
          <c:orientation val="minMax"/>
          <c:max val="10"/>
          <c:min val="-6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800"/>
            </a:pPr>
            <a:endParaRPr lang="en-US"/>
          </a:p>
        </c:txPr>
        <c:crossAx val="-1657782928"/>
        <c:crosses val="autoZero"/>
        <c:crossBetween val="between"/>
      </c:valAx>
      <c:spPr>
        <a:noFill/>
      </c:spPr>
    </c:plotArea>
    <c:plotVisOnly val="1"/>
    <c:dispBlanksAs val="gap"/>
    <c:showDLblsOverMax val="0"/>
    <c:extLst xmlns:c16r2="http://schemas.microsoft.com/office/drawing/2015/06/chart"/>
  </c:chart>
  <c:spPr>
    <a:noFill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0344925634295714E-2"/>
          <c:y val="0.19173629337999418"/>
          <c:w val="0.89521062992125988"/>
          <c:h val="0.74807852143482068"/>
        </c:manualLayout>
      </c:layout>
      <c:lineChart>
        <c:grouping val="standard"/>
        <c:varyColors val="0"/>
        <c:ser>
          <c:idx val="5"/>
          <c:order val="0"/>
          <c:tx>
            <c:strRef>
              <c:f>'AST revised'!$G$2</c:f>
              <c:strCache>
                <c:ptCount val="1"/>
                <c:pt idx="0">
                  <c:v>MS</c:v>
                </c:pt>
              </c:strCache>
            </c:strRef>
          </c:tx>
          <c:spPr>
            <a:ln w="15875">
              <a:solidFill>
                <a:schemeClr val="accent5">
                  <a:lumMod val="50000"/>
                </a:schemeClr>
              </a:solidFill>
            </a:ln>
          </c:spPr>
          <c:marker>
            <c:symbol val="square"/>
            <c:size val="3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ST revised'!$I$6:$K$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6.442799999999998</c:v>
                  </c:pt>
                  <c:pt idx="2">
                    <c:v>13.654100000000003</c:v>
                  </c:pt>
                </c:numCache>
              </c:numRef>
            </c:plus>
            <c:minus>
              <c:numRef>
                <c:f>'AST revised'!$I$4:$K$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7.124700000000004</c:v>
                  </c:pt>
                  <c:pt idx="2">
                    <c:v>13.6541</c:v>
                  </c:pt>
                </c:numCache>
              </c:numRef>
            </c:minus>
          </c:errBars>
          <c:cat>
            <c:strRef>
              <c:f>'AST revised'!$C$1:$E$1</c:f>
              <c:strCache>
                <c:ptCount val="3"/>
                <c:pt idx="0">
                  <c:v>Baseline</c:v>
                </c:pt>
                <c:pt idx="1">
                  <c:v>week 1</c:v>
                </c:pt>
                <c:pt idx="2">
                  <c:v>week 2</c:v>
                </c:pt>
              </c:strCache>
            </c:strRef>
          </c:cat>
          <c:val>
            <c:numRef>
              <c:f>'AST revised'!$I$2:$K$2</c:f>
              <c:numCache>
                <c:formatCode>General</c:formatCode>
                <c:ptCount val="3"/>
                <c:pt idx="0">
                  <c:v>0</c:v>
                </c:pt>
                <c:pt idx="1">
                  <c:v>-27.309899999999999</c:v>
                </c:pt>
                <c:pt idx="2">
                  <c:v>-30.71880000000000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427-AE49-ADD6-C1F883FF10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657777488"/>
        <c:axId val="-1657782384"/>
      </c:lineChart>
      <c:catAx>
        <c:axId val="-165777748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1657782384"/>
        <c:crosses val="autoZero"/>
        <c:auto val="1"/>
        <c:lblAlgn val="ctr"/>
        <c:lblOffset val="100"/>
        <c:noMultiLvlLbl val="0"/>
      </c:catAx>
      <c:valAx>
        <c:axId val="-1657782384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-1657777488"/>
        <c:crosses val="autoZero"/>
        <c:crossBetween val="between"/>
      </c:valAx>
      <c:spPr>
        <a:noFill/>
      </c:spPr>
    </c:plotArea>
    <c:plotVisOnly val="1"/>
    <c:dispBlanksAs val="gap"/>
    <c:showDLblsOverMax val="0"/>
    <c:extLst xmlns:c16r2="http://schemas.microsoft.com/office/drawing/2015/06/chart"/>
  </c:chart>
  <c:spPr>
    <a:noFill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0344925634295714E-2"/>
          <c:y val="0.19173629337999418"/>
          <c:w val="0.89521062992125988"/>
          <c:h val="0.74807852143482068"/>
        </c:manualLayout>
      </c:layout>
      <c:lineChart>
        <c:grouping val="standard"/>
        <c:varyColors val="0"/>
        <c:ser>
          <c:idx val="4"/>
          <c:order val="0"/>
          <c:tx>
            <c:strRef>
              <c:f>ALT!$A$2</c:f>
              <c:strCache>
                <c:ptCount val="1"/>
                <c:pt idx="0">
                  <c:v>PS</c:v>
                </c:pt>
              </c:strCache>
            </c:strRef>
          </c:tx>
          <c:spPr>
            <a:ln>
              <a:solidFill>
                <a:srgbClr val="C00000"/>
              </a:solidFill>
            </a:ln>
          </c:spPr>
          <c:marker>
            <c:symbol val="square"/>
            <c:size val="3"/>
            <c:spPr>
              <a:solidFill>
                <a:srgbClr val="C00000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LT!$C$6:$E$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9.485399999999998</c:v>
                  </c:pt>
                  <c:pt idx="2">
                    <c:v>19.878999999999998</c:v>
                  </c:pt>
                </c:numCache>
              </c:numRef>
            </c:plus>
            <c:minus>
              <c:numRef>
                <c:f>ALT!$C$4:$E$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9.485500000000002</c:v>
                  </c:pt>
                  <c:pt idx="2">
                    <c:v>19.878999999999998</c:v>
                  </c:pt>
                </c:numCache>
              </c:numRef>
            </c:minus>
          </c:errBars>
          <c:cat>
            <c:strRef>
              <c:f>ALT!$C$1:$E$1</c:f>
              <c:strCache>
                <c:ptCount val="3"/>
                <c:pt idx="0">
                  <c:v>Baseline</c:v>
                </c:pt>
                <c:pt idx="1">
                  <c:v>week 1</c:v>
                </c:pt>
                <c:pt idx="2">
                  <c:v>week 2</c:v>
                </c:pt>
              </c:strCache>
            </c:strRef>
          </c:cat>
          <c:val>
            <c:numRef>
              <c:f>ALT!$C$2:$E$2</c:f>
              <c:numCache>
                <c:formatCode>General</c:formatCode>
                <c:ptCount val="3"/>
                <c:pt idx="0">
                  <c:v>0</c:v>
                </c:pt>
                <c:pt idx="1">
                  <c:v>-37.230899999999998</c:v>
                </c:pt>
                <c:pt idx="2">
                  <c:v>-30.10569999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55C-3A4B-A07A-443F1984DF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657781296"/>
        <c:axId val="-1872054256"/>
      </c:lineChart>
      <c:catAx>
        <c:axId val="-1657781296"/>
        <c:scaling>
          <c:orientation val="minMax"/>
        </c:scaling>
        <c:delete val="0"/>
        <c:axPos val="b"/>
        <c:numFmt formatCode="General" sourceLinked="1"/>
        <c:majorTickMark val="in"/>
        <c:minorTickMark val="in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b="1"/>
            </a:pPr>
            <a:endParaRPr lang="en-US"/>
          </a:p>
        </c:txPr>
        <c:crossAx val="-1872054256"/>
        <c:crosses val="autoZero"/>
        <c:auto val="1"/>
        <c:lblAlgn val="ctr"/>
        <c:lblOffset val="100"/>
        <c:noMultiLvlLbl val="0"/>
      </c:catAx>
      <c:valAx>
        <c:axId val="-1872054256"/>
        <c:scaling>
          <c:orientation val="minMax"/>
          <c:min val="-6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lang="ja-JP" sz="800"/>
            </a:pPr>
            <a:endParaRPr lang="en-US"/>
          </a:p>
        </c:txPr>
        <c:crossAx val="-1657781296"/>
        <c:crosses val="autoZero"/>
        <c:crossBetween val="between"/>
      </c:valAx>
      <c:spPr>
        <a:noFill/>
      </c:spPr>
    </c:plotArea>
    <c:plotVisOnly val="1"/>
    <c:dispBlanksAs val="gap"/>
    <c:showDLblsOverMax val="0"/>
    <c:extLst xmlns:c16r2="http://schemas.microsoft.com/office/drawing/2015/06/chart"/>
  </c:chart>
  <c:spPr>
    <a:noFill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0344925634295714E-2"/>
          <c:y val="0.19173629337999418"/>
          <c:w val="0.89521062992125988"/>
          <c:h val="0.74807852143482068"/>
        </c:manualLayout>
      </c:layout>
      <c:lineChart>
        <c:grouping val="standard"/>
        <c:varyColors val="0"/>
        <c:ser>
          <c:idx val="5"/>
          <c:order val="0"/>
          <c:tx>
            <c:strRef>
              <c:f>'ALT revised'!$G$2</c:f>
              <c:strCache>
                <c:ptCount val="1"/>
                <c:pt idx="0">
                  <c:v>MS</c:v>
                </c:pt>
              </c:strCache>
            </c:strRef>
          </c:tx>
          <c:marker>
            <c:symbol val="square"/>
            <c:size val="3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</c:spPr>
          </c:marker>
          <c:dPt>
            <c:idx val="1"/>
            <c:bubble3D val="0"/>
            <c:spPr>
              <a:ln w="15875">
                <a:solidFill>
                  <a:schemeClr val="accent5">
                    <a:lumMod val="50000"/>
                  </a:scheme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646A-2144-AC8E-B5AC2B8C0549}"/>
              </c:ext>
            </c:extLst>
          </c:dPt>
          <c:dPt>
            <c:idx val="2"/>
            <c:bubble3D val="0"/>
            <c:spPr>
              <a:ln w="15875">
                <a:solidFill>
                  <a:schemeClr val="accent5">
                    <a:lumMod val="50000"/>
                  </a:scheme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646A-2144-AC8E-B5AC2B8C0549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ALT revised'!$I$6:$K$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3266000000000027</c:v>
                  </c:pt>
                  <c:pt idx="2">
                    <c:v>10.917099999999998</c:v>
                  </c:pt>
                </c:numCache>
              </c:numRef>
            </c:plus>
            <c:minus>
              <c:numRef>
                <c:f>'ALT revised'!$I$4:$K$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3264999999999958</c:v>
                  </c:pt>
                  <c:pt idx="2">
                    <c:v>10.917200000000001</c:v>
                  </c:pt>
                </c:numCache>
              </c:numRef>
            </c:minus>
          </c:errBars>
          <c:cat>
            <c:strRef>
              <c:f>'ALT revised'!$C$1:$E$1</c:f>
              <c:strCache>
                <c:ptCount val="3"/>
                <c:pt idx="0">
                  <c:v>Baseline</c:v>
                </c:pt>
                <c:pt idx="1">
                  <c:v>week 1</c:v>
                </c:pt>
                <c:pt idx="2">
                  <c:v>week 2</c:v>
                </c:pt>
              </c:strCache>
            </c:strRef>
          </c:cat>
          <c:val>
            <c:numRef>
              <c:f>'ALT revised'!$I$2:$K$2</c:f>
              <c:numCache>
                <c:formatCode>General</c:formatCode>
                <c:ptCount val="3"/>
                <c:pt idx="0">
                  <c:v>0</c:v>
                </c:pt>
                <c:pt idx="1">
                  <c:v>-38.066600000000001</c:v>
                </c:pt>
                <c:pt idx="2">
                  <c:v>-45.02230000000000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46A-2144-AC8E-B5AC2B8C05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872050992"/>
        <c:axId val="-1658550032"/>
      </c:lineChart>
      <c:catAx>
        <c:axId val="-18720509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1658550032"/>
        <c:crosses val="autoZero"/>
        <c:auto val="1"/>
        <c:lblAlgn val="ctr"/>
        <c:lblOffset val="100"/>
        <c:noMultiLvlLbl val="0"/>
      </c:catAx>
      <c:valAx>
        <c:axId val="-165855003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-1872050992"/>
        <c:crosses val="autoZero"/>
        <c:crossBetween val="between"/>
      </c:valAx>
      <c:spPr>
        <a:noFill/>
      </c:spPr>
    </c:plotArea>
    <c:plotVisOnly val="1"/>
    <c:dispBlanksAs val="gap"/>
    <c:showDLblsOverMax val="0"/>
    <c:extLst xmlns:c16r2="http://schemas.microsoft.com/office/drawing/2015/06/chart"/>
  </c:chart>
  <c:spPr>
    <a:noFill/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E45530-DC1F-6241-8B89-7A798A8357F2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4D30E2-C839-7E46-9F38-C16793A837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73402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4D30E2-C839-7E46-9F38-C16793A8372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3823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739DC71-E094-2653-3A10-8F500468A5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D7E4B61D-46D5-0084-B46E-68DE2554AC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D407FA2-D455-F50C-7DC9-AEFDBC6B1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C433809-DA41-5549-49CA-46B3453C1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00448A5-AC6D-4482-2D8A-38492EDA9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914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E260683-F2E2-D9C2-FB3D-DC1C7BA110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3420A013-E4C4-E191-EE79-DAB0A0444E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C7A4B3C-2E55-F9D7-A785-23C682AE4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B4704DE-D4F6-1A07-D8E9-4E2AA44B6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2CED16C2-91DF-E8E8-20A8-5202508C4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947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00E2E9F3-D433-6297-59B5-51C4C8E612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8F082CF0-A620-A90E-FF5A-AF0C773390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0F70546-2240-53B6-BEAE-A1F6325FF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145FC571-C16E-5B91-42A4-AF77D6C24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DC5A7683-24B5-0520-124C-F22304611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2534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3147454-1D8D-EC7B-1741-2DBBF14888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4FD2D73-E978-DD68-0A5F-55647B653E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14602A0-21B1-420F-6C52-50D5EFB3E7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C9C958A-B3C9-A62E-01C4-396FA5DAD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52BCC34-6C59-DB30-551D-A2DA82249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1398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BEAE13F-62BB-D63C-C522-0003B1CDD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97D66C80-532E-6B3B-150D-E5B4F0A1E5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CBF1B760-5FBD-A346-512C-AD03C1EC7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E01EC63-F4DE-CEE0-C8F3-EB7C601D50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AF7AB95-E219-C7E3-7B42-A03B5D376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7373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2ED4F2D-F1EF-3D62-5259-BC1E34C17B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DE03746-8FD1-3297-4AB0-2F6D842440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F95E1FF6-298F-59E2-98A1-A3593E0063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0B05C524-B352-C940-A4B4-6A1F52C22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294D49F4-716F-BE88-A9BB-8820971B4F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35310D8D-C031-7B06-3004-F4D361F66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382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1A53733-8FA9-95B2-4299-F2BA248889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5EC1FD46-1E3D-DED2-32F9-2DD3462A53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40A96538-1643-438E-68A2-ADC2C50AD3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94EF1474-1AF1-F659-4A16-159526F036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5572F2A2-B028-BCFF-2CA9-D41A3D0B24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123E4381-4633-7C7C-FFD5-2ABDA7B38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E183DA6B-A8CB-7B7E-DC2F-E2745B01E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6E32EC35-66EF-0C8D-D909-EF969AA08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247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43EFB59-B3C9-EE25-6438-F2D832BE2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3C73813F-EB4A-1E5D-CC33-AD9234FF1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93D3AD91-D5D5-7FE2-E4DB-BC89460A0D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65BBB870-C18D-B25A-D5A5-8EFF9FBA4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916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2AEB607A-0A07-F32C-5064-AB2099E479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DC874CB5-B2EE-6B48-AE2D-75707CD0B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E713263F-F986-9AC9-0CE2-648AF4EA8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7934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B555AAC-0D11-7691-7AA5-B56961C349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0BCEF4B6-F8B0-9C4B-0C94-C680A29A2B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E017F278-56DE-D1EA-7B60-ECC6AF7D8F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028FB8F0-44C8-0333-AAE5-2B49D6E9ED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F4B210CC-140D-A79D-C704-F2BD053E5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9569E5DF-5EAF-6A43-BC98-39946E5C9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087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A058896-09BE-9522-068D-B7F5FBEE10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2B4A72CC-966F-8E28-ABE9-AA67D5E4A6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8AD3125B-AF04-4D32-BA29-709BCD7DCC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2E210861-2C4F-B541-99D9-464F687A6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FBE81E79-2DB8-3C9F-639D-B5605E067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F543461F-4BFF-C1E0-C6FA-74D7F6CA8E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571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ECC6985E-16CD-362D-0DD7-3DBA97D1B9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33168E8B-0BEB-FF58-E37D-BD1438B941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65EA965-0F06-FCC0-AC5D-EAC95855F1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4194F-3A6A-D940-B992-FD80A0278615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ACD44070-2022-FF74-209A-56102C89F9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79A0012-7896-4BB1-CF8A-BDF1AAE873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A59D8-37A0-AD46-A08A-A8AD669212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203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D5937693-8FCA-5211-78EC-68A5868BD014}"/>
              </a:ext>
            </a:extLst>
          </p:cNvPr>
          <p:cNvSpPr txBox="1"/>
          <p:nvPr/>
        </p:nvSpPr>
        <p:spPr>
          <a:xfrm>
            <a:off x="3324616" y="1206706"/>
            <a:ext cx="1781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xmlns="" id="{E0B7DCB3-4627-B26E-20C8-B5F29B709556}"/>
              </a:ext>
            </a:extLst>
          </p:cNvPr>
          <p:cNvCxnSpPr>
            <a:cxnSpLocks/>
          </p:cNvCxnSpPr>
          <p:nvPr/>
        </p:nvCxnSpPr>
        <p:spPr>
          <a:xfrm>
            <a:off x="3749652" y="2759971"/>
            <a:ext cx="3090683" cy="0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xmlns="" id="{2C0E37E8-9445-9AA7-5F8F-78AFB90041BE}"/>
              </a:ext>
            </a:extLst>
          </p:cNvPr>
          <p:cNvSpPr/>
          <p:nvPr/>
        </p:nvSpPr>
        <p:spPr>
          <a:xfrm>
            <a:off x="6959579" y="2200811"/>
            <a:ext cx="2586862" cy="1690069"/>
          </a:xfrm>
          <a:prstGeom prst="rect">
            <a:avLst/>
          </a:prstGeom>
          <a:noFill/>
          <a:ln w="6350"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E68FDCD9-5033-6E61-83FE-8218A8337655}"/>
              </a:ext>
            </a:extLst>
          </p:cNvPr>
          <p:cNvSpPr txBox="1"/>
          <p:nvPr/>
        </p:nvSpPr>
        <p:spPr>
          <a:xfrm>
            <a:off x="7130194" y="2504992"/>
            <a:ext cx="2167040" cy="230832"/>
          </a:xfrm>
          <a:prstGeom prst="rect">
            <a:avLst/>
          </a:prstGeom>
          <a:noFill/>
          <a:ln w="6350">
            <a:noFill/>
            <a:prstDash val="sysDash"/>
          </a:ln>
        </p:spPr>
        <p:txBody>
          <a:bodyPr wrap="square" rtlCol="0" anchor="ctr" anchorCtr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S-CDS,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8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302D5D63-E604-D336-2515-28C59756E44F}"/>
              </a:ext>
            </a:extLst>
          </p:cNvPr>
          <p:cNvSpPr txBox="1"/>
          <p:nvPr/>
        </p:nvSpPr>
        <p:spPr>
          <a:xfrm>
            <a:off x="7114308" y="3102906"/>
            <a:ext cx="1630708" cy="230832"/>
          </a:xfrm>
          <a:prstGeom prst="rect">
            <a:avLst/>
          </a:prstGeom>
          <a:noFill/>
          <a:ln w="6350">
            <a:noFill/>
            <a:prstDash val="sysDash"/>
          </a:ln>
        </p:spPr>
        <p:txBody>
          <a:bodyPr wrap="square" rtlCol="0" anchor="ctr" anchorCtr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VEUS-BD,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0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9090BA60-CA2F-FD50-14A4-C7A3E9598840}"/>
              </a:ext>
            </a:extLst>
          </p:cNvPr>
          <p:cNvSpPr txBox="1"/>
          <p:nvPr/>
        </p:nvSpPr>
        <p:spPr>
          <a:xfrm>
            <a:off x="7108379" y="3328100"/>
            <a:ext cx="2147928" cy="230832"/>
          </a:xfrm>
          <a:prstGeom prst="rect">
            <a:avLst/>
          </a:prstGeom>
          <a:noFill/>
          <a:ln w="6350">
            <a:noFill/>
            <a:prstDash val="sysDash"/>
          </a:ln>
        </p:spPr>
        <p:txBody>
          <a:bodyPr wrap="square" rtlCol="0" anchor="ctr" anchorCtr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S-HDS,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5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EC9DB6CB-A1C3-983B-714F-2CA89A943C2E}"/>
              </a:ext>
            </a:extLst>
          </p:cNvPr>
          <p:cNvSpPr txBox="1"/>
          <p:nvPr/>
        </p:nvSpPr>
        <p:spPr>
          <a:xfrm>
            <a:off x="7131584" y="2265046"/>
            <a:ext cx="13310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kumimoji="1"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criteria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</a:t>
            </a:r>
            <a:endParaRPr kumimoji="1" lang="ja-JP" altLang="en-US" sz="10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664A7F85-A16A-693B-2E3A-9DA6ECC993AA}"/>
              </a:ext>
            </a:extLst>
          </p:cNvPr>
          <p:cNvSpPr txBox="1"/>
          <p:nvPr/>
        </p:nvSpPr>
        <p:spPr>
          <a:xfrm>
            <a:off x="3315515" y="4284558"/>
            <a:ext cx="1437111" cy="438582"/>
          </a:xfrm>
          <a:prstGeom prst="rect">
            <a:avLst/>
          </a:prstGeom>
          <a:solidFill>
            <a:schemeClr val="accent1">
              <a:lumMod val="50000"/>
            </a:schemeClr>
          </a:solidFill>
          <a:ln w="3175">
            <a:solidFill>
              <a:schemeClr val="tx1"/>
            </a:solidFill>
          </a:ln>
          <a:effectLst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MS group</a:t>
            </a:r>
          </a:p>
          <a:p>
            <a:pPr algn="ctr"/>
            <a:r>
              <a:rPr lang="en-US" altLang="ja-JP" sz="1000" b="1" dirty="0">
                <a:solidFill>
                  <a:schemeClr val="bg1"/>
                </a:solidFill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n=151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6D994E3E-5A24-7CE3-540C-43FB71501058}"/>
              </a:ext>
            </a:extLst>
          </p:cNvPr>
          <p:cNvSpPr txBox="1"/>
          <p:nvPr/>
        </p:nvSpPr>
        <p:spPr>
          <a:xfrm>
            <a:off x="4896692" y="4281343"/>
            <a:ext cx="1437111" cy="430887"/>
          </a:xfrm>
          <a:prstGeom prst="rect">
            <a:avLst/>
          </a:prstGeom>
          <a:solidFill>
            <a:srgbClr val="A20305"/>
          </a:solidFill>
          <a:ln w="3175">
            <a:solidFill>
              <a:schemeClr val="tx1"/>
            </a:solidFill>
          </a:ln>
          <a:effectLst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PS group</a:t>
            </a:r>
          </a:p>
          <a:p>
            <a:pPr algn="ctr"/>
            <a:r>
              <a:rPr lang="en-US" altLang="ja-JP" sz="1000" b="1" dirty="0">
                <a:solidFill>
                  <a:schemeClr val="bg1"/>
                </a:solidFill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n=72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1635D3D1-8245-BAEE-AC6F-21E22D63C74A}"/>
              </a:ext>
            </a:extLst>
          </p:cNvPr>
          <p:cNvSpPr txBox="1"/>
          <p:nvPr/>
        </p:nvSpPr>
        <p:spPr>
          <a:xfrm>
            <a:off x="4127708" y="3447885"/>
            <a:ext cx="1338373" cy="230832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chnical failure, n=4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xmlns="" id="{A0C60989-2E82-5FAE-6F3D-8ED02E019D73}"/>
              </a:ext>
            </a:extLst>
          </p:cNvPr>
          <p:cNvCxnSpPr>
            <a:cxnSpLocks/>
          </p:cNvCxnSpPr>
          <p:nvPr/>
        </p:nvCxnSpPr>
        <p:spPr>
          <a:xfrm flipV="1">
            <a:off x="3749652" y="3567395"/>
            <a:ext cx="188190" cy="1260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矢印コネクタ 66">
            <a:extLst>
              <a:ext uri="{FF2B5EF4-FFF2-40B4-BE49-F238E27FC236}">
                <a16:creationId xmlns:a16="http://schemas.microsoft.com/office/drawing/2014/main" xmlns="" id="{252A432E-1749-94FA-6D03-A191397571D8}"/>
              </a:ext>
            </a:extLst>
          </p:cNvPr>
          <p:cNvCxnSpPr>
            <a:cxnSpLocks/>
          </p:cNvCxnSpPr>
          <p:nvPr/>
        </p:nvCxnSpPr>
        <p:spPr>
          <a:xfrm>
            <a:off x="3749652" y="2529717"/>
            <a:ext cx="0" cy="16900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矢印コネクタ 68">
            <a:extLst>
              <a:ext uri="{FF2B5EF4-FFF2-40B4-BE49-F238E27FC236}">
                <a16:creationId xmlns:a16="http://schemas.microsoft.com/office/drawing/2014/main" xmlns="" id="{08C7C2F2-9EF9-3B7B-6C1E-A85AE0DF1632}"/>
              </a:ext>
            </a:extLst>
          </p:cNvPr>
          <p:cNvCxnSpPr>
            <a:cxnSpLocks/>
          </p:cNvCxnSpPr>
          <p:nvPr/>
        </p:nvCxnSpPr>
        <p:spPr>
          <a:xfrm>
            <a:off x="5909453" y="4021238"/>
            <a:ext cx="0" cy="1985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63080F84-85EA-5F12-8EA2-6D448DC54A6F}"/>
              </a:ext>
            </a:extLst>
          </p:cNvPr>
          <p:cNvSpPr txBox="1"/>
          <p:nvPr/>
        </p:nvSpPr>
        <p:spPr>
          <a:xfrm>
            <a:off x="3324616" y="2894740"/>
            <a:ext cx="3011907" cy="461665"/>
          </a:xfrm>
          <a:prstGeom prst="rect">
            <a:avLst/>
          </a:prstGeom>
          <a:solidFill>
            <a:schemeClr val="bg2">
              <a:lumMod val="90000"/>
            </a:schemeClr>
          </a:solidFill>
          <a:ln w="6350">
            <a:solidFill>
              <a:schemeClr val="tx1"/>
            </a:solidFill>
            <a:prstDash val="sysDot"/>
          </a:ln>
          <a:effectLst/>
        </p:spPr>
        <p:txBody>
          <a:bodyPr wrap="square" rtlCol="0" anchor="ctr" anchorCtr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Initial EUS-HGS</a:t>
            </a:r>
            <a:r>
              <a:rPr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 intention </a:t>
            </a:r>
          </a:p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for MBO</a:t>
            </a:r>
            <a:r>
              <a:rPr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 (n=227)</a:t>
            </a:r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 </a:t>
            </a:r>
            <a:endParaRPr kumimoji="1" lang="ja-JP" altLang="en-US" sz="1200" b="1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70601878-9DC4-0F8C-F6BC-A89FE663DC4D}"/>
              </a:ext>
            </a:extLst>
          </p:cNvPr>
          <p:cNvSpPr txBox="1"/>
          <p:nvPr/>
        </p:nvSpPr>
        <p:spPr>
          <a:xfrm>
            <a:off x="3327931" y="3744239"/>
            <a:ext cx="3005872" cy="276999"/>
          </a:xfrm>
          <a:prstGeom prst="rect">
            <a:avLst/>
          </a:prstGeom>
          <a:solidFill>
            <a:schemeClr val="bg2">
              <a:lumMod val="90000"/>
            </a:schemeClr>
          </a:solidFill>
          <a:ln w="6350">
            <a:solidFill>
              <a:schemeClr val="tx1"/>
            </a:solidFill>
            <a:prstDash val="sysDot"/>
          </a:ln>
          <a:effectLst/>
        </p:spPr>
        <p:txBody>
          <a:bodyPr wrap="square" rtlCol="0" anchor="ctr" anchorCtr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EUS-HGS for MBO</a:t>
            </a:r>
            <a:r>
              <a:rPr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 (n=223)</a:t>
            </a:r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 </a:t>
            </a:r>
            <a:endParaRPr kumimoji="1" lang="ja-JP" altLang="en-US" sz="1200" b="1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ECA99A50-AB20-83E5-A5A2-152E13597567}"/>
              </a:ext>
            </a:extLst>
          </p:cNvPr>
          <p:cNvSpPr txBox="1"/>
          <p:nvPr/>
        </p:nvSpPr>
        <p:spPr>
          <a:xfrm>
            <a:off x="3324616" y="2007801"/>
            <a:ext cx="3001180" cy="646331"/>
          </a:xfrm>
          <a:prstGeom prst="rect">
            <a:avLst/>
          </a:prstGeom>
          <a:solidFill>
            <a:srgbClr val="FFC000"/>
          </a:solidFill>
          <a:ln w="6350">
            <a:solidFill>
              <a:schemeClr val="tx1"/>
            </a:solidFill>
            <a:prstDash val="sysDot"/>
          </a:ln>
          <a:effectLst/>
        </p:spPr>
        <p:txBody>
          <a:bodyPr wrap="square" rtlCol="0" anchor="ctr" anchorCtr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Initial EUS-BD intention </a:t>
            </a:r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for MBO </a:t>
            </a:r>
          </a:p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between March 2018 and </a:t>
            </a:r>
            <a:r>
              <a:rPr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January</a:t>
            </a:r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 2024</a:t>
            </a:r>
            <a:r>
              <a:rPr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 (n=359)</a:t>
            </a:r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 </a:t>
            </a:r>
            <a:endParaRPr kumimoji="1" lang="ja-JP" altLang="en-US" sz="1200" b="1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D560D1D4-8814-4207-D1EC-99E89636B7C0}"/>
              </a:ext>
            </a:extLst>
          </p:cNvPr>
          <p:cNvSpPr txBox="1"/>
          <p:nvPr/>
        </p:nvSpPr>
        <p:spPr>
          <a:xfrm>
            <a:off x="7108379" y="2719348"/>
            <a:ext cx="2438070" cy="369332"/>
          </a:xfrm>
          <a:prstGeom prst="rect">
            <a:avLst/>
          </a:prstGeom>
          <a:noFill/>
          <a:ln w="6350">
            <a:noFill/>
            <a:prstDash val="sysDash"/>
          </a:ln>
        </p:spPr>
        <p:txBody>
          <a:bodyPr wrap="square" rtlCol="0" anchor="ctr" anchorCtr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bination with stenting through PTBD route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ot EUS-HGS failure),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A98C18B4-C702-478A-3EA6-FE2BFD112E0A}"/>
              </a:ext>
            </a:extLst>
          </p:cNvPr>
          <p:cNvSpPr txBox="1"/>
          <p:nvPr/>
        </p:nvSpPr>
        <p:spPr>
          <a:xfrm>
            <a:off x="7108379" y="3567520"/>
            <a:ext cx="2147928" cy="230832"/>
          </a:xfrm>
          <a:prstGeom prst="rect">
            <a:avLst/>
          </a:prstGeom>
          <a:noFill/>
          <a:ln w="6350">
            <a:noFill/>
            <a:prstDash val="sysDash"/>
          </a:ln>
        </p:spPr>
        <p:txBody>
          <a:bodyPr wrap="square" rtlCol="0" anchor="ctr" anchorCtr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egrade stenting,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2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75521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ABD80DEF-198E-8CF3-12B8-FEC54009F3C6}"/>
              </a:ext>
            </a:extLst>
          </p:cNvPr>
          <p:cNvSpPr txBox="1"/>
          <p:nvPr/>
        </p:nvSpPr>
        <p:spPr>
          <a:xfrm>
            <a:off x="954101" y="1084696"/>
            <a:ext cx="1781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xmlns="" id="{D0156BE1-C1C2-C346-C826-EB2192288E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5615985"/>
              </p:ext>
            </p:extLst>
          </p:nvPr>
        </p:nvGraphicFramePr>
        <p:xfrm>
          <a:off x="1333718" y="4615406"/>
          <a:ext cx="3788957" cy="42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20">
                  <a:extLst>
                    <a:ext uri="{9D8B030D-6E8A-4147-A177-3AD203B41FA5}">
                      <a16:colId xmlns:a16="http://schemas.microsoft.com/office/drawing/2014/main" xmlns="" val="1699681160"/>
                    </a:ext>
                  </a:extLst>
                </a:gridCol>
                <a:gridCol w="1141079">
                  <a:extLst>
                    <a:ext uri="{9D8B030D-6E8A-4147-A177-3AD203B41FA5}">
                      <a16:colId xmlns:a16="http://schemas.microsoft.com/office/drawing/2014/main" xmlns="" val="3569871478"/>
                    </a:ext>
                  </a:extLst>
                </a:gridCol>
                <a:gridCol w="1141079">
                  <a:extLst>
                    <a:ext uri="{9D8B030D-6E8A-4147-A177-3AD203B41FA5}">
                      <a16:colId xmlns:a16="http://schemas.microsoft.com/office/drawing/2014/main" xmlns="" val="3604822172"/>
                    </a:ext>
                  </a:extLst>
                </a:gridCol>
                <a:gridCol w="1141079">
                  <a:extLst>
                    <a:ext uri="{9D8B030D-6E8A-4147-A177-3AD203B41FA5}">
                      <a16:colId xmlns:a16="http://schemas.microsoft.com/office/drawing/2014/main" xmlns="" val="290841631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1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782425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03465206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3E02CE56-80D8-CB62-D724-99D4172635CC}"/>
              </a:ext>
            </a:extLst>
          </p:cNvPr>
          <p:cNvSpPr txBox="1"/>
          <p:nvPr/>
        </p:nvSpPr>
        <p:spPr>
          <a:xfrm>
            <a:off x="667022" y="4653258"/>
            <a:ext cx="76229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bserved (n)</a:t>
            </a:r>
            <a:endParaRPr kumimoji="1" lang="ja-JP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xmlns="" id="{E16055ED-69CB-BF5C-7B0A-1FE67EB4FF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2812418"/>
              </p:ext>
            </p:extLst>
          </p:nvPr>
        </p:nvGraphicFramePr>
        <p:xfrm>
          <a:off x="6938616" y="4619049"/>
          <a:ext cx="3789372" cy="42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xmlns="" val="1699681160"/>
                    </a:ext>
                  </a:extLst>
                </a:gridCol>
                <a:gridCol w="1141204">
                  <a:extLst>
                    <a:ext uri="{9D8B030D-6E8A-4147-A177-3AD203B41FA5}">
                      <a16:colId xmlns:a16="http://schemas.microsoft.com/office/drawing/2014/main" xmlns="" val="3569871478"/>
                    </a:ext>
                  </a:extLst>
                </a:gridCol>
                <a:gridCol w="1141204">
                  <a:extLst>
                    <a:ext uri="{9D8B030D-6E8A-4147-A177-3AD203B41FA5}">
                      <a16:colId xmlns:a16="http://schemas.microsoft.com/office/drawing/2014/main" xmlns="" val="3604822172"/>
                    </a:ext>
                  </a:extLst>
                </a:gridCol>
                <a:gridCol w="1141204">
                  <a:extLst>
                    <a:ext uri="{9D8B030D-6E8A-4147-A177-3AD203B41FA5}">
                      <a16:colId xmlns:a16="http://schemas.microsoft.com/office/drawing/2014/main" xmlns="" val="290841631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1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782425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03465206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8A2AF663-78B5-2F7F-FB10-605BEFF4CA17}"/>
              </a:ext>
            </a:extLst>
          </p:cNvPr>
          <p:cNvSpPr txBox="1"/>
          <p:nvPr/>
        </p:nvSpPr>
        <p:spPr>
          <a:xfrm>
            <a:off x="6215331" y="4654800"/>
            <a:ext cx="76229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</a:t>
            </a:r>
          </a:p>
          <a:p>
            <a:pPr algn="ctr"/>
            <a:r>
              <a:rPr kumimoji="1" lang="en-US" altLang="ja-JP" sz="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bserved (n)</a:t>
            </a:r>
            <a:endParaRPr kumimoji="1" lang="ja-JP" altLang="en-US" sz="8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xmlns="" id="{CD33923D-108D-A0D2-3F5F-6EF558EC08A3}"/>
              </a:ext>
            </a:extLst>
          </p:cNvPr>
          <p:cNvGrpSpPr/>
          <p:nvPr/>
        </p:nvGrpSpPr>
        <p:grpSpPr>
          <a:xfrm>
            <a:off x="1167289" y="2202849"/>
            <a:ext cx="4301144" cy="2497731"/>
            <a:chOff x="1167289" y="2202849"/>
            <a:chExt cx="4301144" cy="2497731"/>
          </a:xfrm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xmlns="" id="{AED8998A-8094-B1E8-BC63-5F5CB4B5A0BF}"/>
                </a:ext>
              </a:extLst>
            </p:cNvPr>
            <p:cNvSpPr txBox="1"/>
            <p:nvPr/>
          </p:nvSpPr>
          <p:spPr>
            <a:xfrm rot="16200000">
              <a:off x="266917" y="3462990"/>
              <a:ext cx="205056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n % change of AST (95%CI) (%)</a:t>
              </a:r>
              <a:endParaRPr kumimoji="1" lang="ja-JP" alt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xmlns="" id="{1DACBC6F-BA95-369E-9980-B534B0522E20}"/>
                </a:ext>
              </a:extLst>
            </p:cNvPr>
            <p:cNvSpPr txBox="1"/>
            <p:nvPr/>
          </p:nvSpPr>
          <p:spPr>
            <a:xfrm>
              <a:off x="3408656" y="3314427"/>
              <a:ext cx="5806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366</a:t>
              </a:r>
              <a:endParaRPr kumimoji="1" lang="ja-JP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xmlns="" id="{5845E2F6-C860-CC21-087C-B8993135B741}"/>
                </a:ext>
              </a:extLst>
            </p:cNvPr>
            <p:cNvSpPr txBox="1"/>
            <p:nvPr/>
          </p:nvSpPr>
          <p:spPr>
            <a:xfrm>
              <a:off x="4578694" y="3846133"/>
              <a:ext cx="5806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164</a:t>
              </a:r>
              <a:endParaRPr kumimoji="1" lang="ja-JP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xmlns="" id="{571C870E-80CB-A4D2-CCD3-E6926A2675B0}"/>
                </a:ext>
              </a:extLst>
            </p:cNvPr>
            <p:cNvSpPr txBox="1"/>
            <p:nvPr/>
          </p:nvSpPr>
          <p:spPr>
            <a:xfrm>
              <a:off x="1167289" y="2202849"/>
              <a:ext cx="6431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</a:t>
              </a:r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T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xmlns="" id="{87E89D1C-16EE-DF89-AB13-A0F7A65C8B56}"/>
                </a:ext>
              </a:extLst>
            </p:cNvPr>
            <p:cNvSpPr/>
            <p:nvPr/>
          </p:nvSpPr>
          <p:spPr>
            <a:xfrm>
              <a:off x="1987085" y="3598831"/>
              <a:ext cx="738786" cy="45265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 b="1">
                <a:solidFill>
                  <a:schemeClr val="tx1"/>
                </a:solidFill>
              </a:endParaRPr>
            </a:p>
          </p:txBody>
        </p:sp>
        <p:grpSp>
          <p:nvGrpSpPr>
            <p:cNvPr id="29" name="グループ化 28">
              <a:extLst>
                <a:ext uri="{FF2B5EF4-FFF2-40B4-BE49-F238E27FC236}">
                  <a16:creationId xmlns:a16="http://schemas.microsoft.com/office/drawing/2014/main" xmlns="" id="{4F870CBB-5862-0607-6FBB-A0A37A4E8462}"/>
                </a:ext>
              </a:extLst>
            </p:cNvPr>
            <p:cNvGrpSpPr/>
            <p:nvPr/>
          </p:nvGrpSpPr>
          <p:grpSpPr>
            <a:xfrm>
              <a:off x="2102163" y="3598831"/>
              <a:ext cx="515979" cy="452650"/>
              <a:chOff x="4251784" y="1784106"/>
              <a:chExt cx="564033" cy="452650"/>
            </a:xfrm>
          </p:grpSpPr>
          <p:cxnSp>
            <p:nvCxnSpPr>
              <p:cNvPr id="31" name="直線コネクタ 30">
                <a:extLst>
                  <a:ext uri="{FF2B5EF4-FFF2-40B4-BE49-F238E27FC236}">
                    <a16:creationId xmlns:a16="http://schemas.microsoft.com/office/drawing/2014/main" xmlns="" id="{EDACE6CA-8F64-5C61-8D16-FA063A392E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51784" y="1903592"/>
                <a:ext cx="169277" cy="0"/>
              </a:xfrm>
              <a:prstGeom prst="line">
                <a:avLst/>
              </a:prstGeom>
              <a:ln w="19050">
                <a:solidFill>
                  <a:schemeClr val="accent1">
                    <a:lumMod val="50000"/>
                  </a:schemeClr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xmlns="" id="{9855A5D4-C857-5CE6-718A-21BD271A419F}"/>
                  </a:ext>
                </a:extLst>
              </p:cNvPr>
              <p:cNvSpPr txBox="1"/>
              <p:nvPr/>
            </p:nvSpPr>
            <p:spPr>
              <a:xfrm>
                <a:off x="4421061" y="1784106"/>
                <a:ext cx="39111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xmlns="" id="{51487E4C-5CFD-7F87-C341-729EBCAAA1A7}"/>
                  </a:ext>
                </a:extLst>
              </p:cNvPr>
              <p:cNvSpPr txBox="1"/>
              <p:nvPr/>
            </p:nvSpPr>
            <p:spPr>
              <a:xfrm>
                <a:off x="4435219" y="2005924"/>
                <a:ext cx="38059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 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xmlns="" id="{0802EB4C-7C87-BE24-DD6E-A6D9EFEF0C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51784" y="2132382"/>
                <a:ext cx="169277" cy="0"/>
              </a:xfrm>
              <a:prstGeom prst="line">
                <a:avLst/>
              </a:prstGeom>
              <a:ln w="1905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23" name="グラフ 22">
              <a:extLst>
                <a:ext uri="{FF2B5EF4-FFF2-40B4-BE49-F238E27FC236}">
                  <a16:creationId xmlns:a16="http://schemas.microsoft.com/office/drawing/2014/main" xmlns="" id="{F8102F34-520A-1A1F-2277-C6B9BC2BDDF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63769595"/>
                </p:ext>
              </p:extLst>
            </p:nvPr>
          </p:nvGraphicFramePr>
          <p:xfrm>
            <a:off x="1348880" y="2207746"/>
            <a:ext cx="4119553" cy="24928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グラフ 6">
              <a:extLst>
                <a:ext uri="{FF2B5EF4-FFF2-40B4-BE49-F238E27FC236}">
                  <a16:creationId xmlns:a16="http://schemas.microsoft.com/office/drawing/2014/main" xmlns="" id="{644A2679-0173-561B-8F03-81F99A46926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45042394"/>
                </p:ext>
              </p:extLst>
            </p:nvPr>
          </p:nvGraphicFramePr>
          <p:xfrm>
            <a:off x="1581208" y="2631092"/>
            <a:ext cx="3543590" cy="18283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xmlns="" id="{C004E712-176B-67F2-5497-59D7251FF52E}"/>
              </a:ext>
            </a:extLst>
          </p:cNvPr>
          <p:cNvGrpSpPr/>
          <p:nvPr/>
        </p:nvGrpSpPr>
        <p:grpSpPr>
          <a:xfrm>
            <a:off x="6627062" y="2225612"/>
            <a:ext cx="4244172" cy="2474968"/>
            <a:chOff x="6627062" y="2225612"/>
            <a:chExt cx="4244172" cy="2474968"/>
          </a:xfrm>
        </p:grpSpPr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xmlns="" id="{FDA0C1F7-9097-56C5-6530-00783A9C1E41}"/>
                </a:ext>
              </a:extLst>
            </p:cNvPr>
            <p:cNvSpPr txBox="1"/>
            <p:nvPr/>
          </p:nvSpPr>
          <p:spPr>
            <a:xfrm rot="16200000">
              <a:off x="5746043" y="3467549"/>
              <a:ext cx="20633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n % change of ALT (95%CI) (%)</a:t>
              </a:r>
              <a:endParaRPr kumimoji="1" lang="ja-JP" alt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xmlns="" id="{2E5A9300-1817-F9F2-0F2C-2DFE5B3F59CE}"/>
                </a:ext>
              </a:extLst>
            </p:cNvPr>
            <p:cNvSpPr txBox="1"/>
            <p:nvPr/>
          </p:nvSpPr>
          <p:spPr>
            <a:xfrm>
              <a:off x="9044322" y="3417488"/>
              <a:ext cx="5806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796</a:t>
              </a:r>
              <a:endParaRPr kumimoji="1" lang="ja-JP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xmlns="" id="{1FD1C72D-E78B-8C47-AB6A-5D0257B2D405}"/>
                </a:ext>
              </a:extLst>
            </p:cNvPr>
            <p:cNvSpPr txBox="1"/>
            <p:nvPr/>
          </p:nvSpPr>
          <p:spPr>
            <a:xfrm>
              <a:off x="10290626" y="4076965"/>
              <a:ext cx="5806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138</a:t>
              </a:r>
              <a:endParaRPr kumimoji="1" lang="ja-JP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xmlns="" id="{884B284E-1DCC-B52F-A19F-F8A0B690CF7A}"/>
                </a:ext>
              </a:extLst>
            </p:cNvPr>
            <p:cNvSpPr txBox="1"/>
            <p:nvPr/>
          </p:nvSpPr>
          <p:spPr>
            <a:xfrm>
              <a:off x="6627062" y="2225612"/>
              <a:ext cx="6591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 </a:t>
              </a:r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T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xmlns="" id="{854F352E-DE42-4109-45A5-7537D007E139}"/>
                </a:ext>
              </a:extLst>
            </p:cNvPr>
            <p:cNvSpPr/>
            <p:nvPr/>
          </p:nvSpPr>
          <p:spPr>
            <a:xfrm>
              <a:off x="7535166" y="3974318"/>
              <a:ext cx="738786" cy="45265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 b="1">
                <a:solidFill>
                  <a:schemeClr val="tx1"/>
                </a:solidFill>
              </a:endParaRPr>
            </a:p>
          </p:txBody>
        </p:sp>
        <p:grpSp>
          <p:nvGrpSpPr>
            <p:cNvPr id="61" name="グループ化 60">
              <a:extLst>
                <a:ext uri="{FF2B5EF4-FFF2-40B4-BE49-F238E27FC236}">
                  <a16:creationId xmlns:a16="http://schemas.microsoft.com/office/drawing/2014/main" xmlns="" id="{A8BE547D-3210-6F99-E611-ECE58AC92780}"/>
                </a:ext>
              </a:extLst>
            </p:cNvPr>
            <p:cNvGrpSpPr/>
            <p:nvPr/>
          </p:nvGrpSpPr>
          <p:grpSpPr>
            <a:xfrm>
              <a:off x="7650244" y="3974318"/>
              <a:ext cx="515979" cy="452650"/>
              <a:chOff x="4251784" y="1784106"/>
              <a:chExt cx="564033" cy="452650"/>
            </a:xfrm>
          </p:grpSpPr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xmlns="" id="{CB2E2FBC-F395-0322-886E-74CA33BDF7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51784" y="1903592"/>
                <a:ext cx="169277" cy="0"/>
              </a:xfrm>
              <a:prstGeom prst="line">
                <a:avLst/>
              </a:prstGeom>
              <a:ln w="19050">
                <a:solidFill>
                  <a:schemeClr val="accent1">
                    <a:lumMod val="50000"/>
                  </a:schemeClr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xmlns="" id="{6DFEE81E-799C-EF94-653B-F56B4368BA4D}"/>
                  </a:ext>
                </a:extLst>
              </p:cNvPr>
              <p:cNvSpPr txBox="1"/>
              <p:nvPr/>
            </p:nvSpPr>
            <p:spPr>
              <a:xfrm>
                <a:off x="4421061" y="1784106"/>
                <a:ext cx="39111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xmlns="" id="{87B68B39-768D-FCD5-BEDC-FF5F6E7DCE4C}"/>
                  </a:ext>
                </a:extLst>
              </p:cNvPr>
              <p:cNvSpPr txBox="1"/>
              <p:nvPr/>
            </p:nvSpPr>
            <p:spPr>
              <a:xfrm>
                <a:off x="4435219" y="2005924"/>
                <a:ext cx="38059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 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5" name="直線コネクタ 64">
                <a:extLst>
                  <a:ext uri="{FF2B5EF4-FFF2-40B4-BE49-F238E27FC236}">
                    <a16:creationId xmlns:a16="http://schemas.microsoft.com/office/drawing/2014/main" xmlns="" id="{931EC141-3F78-033A-A59C-39A821BC28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51784" y="2132382"/>
                <a:ext cx="169277" cy="0"/>
              </a:xfrm>
              <a:prstGeom prst="line">
                <a:avLst/>
              </a:prstGeom>
              <a:ln w="1905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54" name="グラフ 53">
              <a:extLst>
                <a:ext uri="{FF2B5EF4-FFF2-40B4-BE49-F238E27FC236}">
                  <a16:creationId xmlns:a16="http://schemas.microsoft.com/office/drawing/2014/main" xmlns="" id="{A6E71C3F-249B-6FF5-19A6-6D75FF35633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63144056"/>
                </p:ext>
              </p:extLst>
            </p:nvPr>
          </p:nvGraphicFramePr>
          <p:xfrm>
            <a:off x="7072105" y="2249175"/>
            <a:ext cx="3786177" cy="23366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1" name="グラフ 10">
              <a:extLst>
                <a:ext uri="{FF2B5EF4-FFF2-40B4-BE49-F238E27FC236}">
                  <a16:creationId xmlns:a16="http://schemas.microsoft.com/office/drawing/2014/main" xmlns="" id="{754E36FF-7ADB-FB17-1D72-580B6A68DCA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59149077"/>
                </p:ext>
              </p:extLst>
            </p:nvPr>
          </p:nvGraphicFramePr>
          <p:xfrm>
            <a:off x="7086145" y="2250171"/>
            <a:ext cx="3703129" cy="245040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3081853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1684">
            <a:extLst>
              <a:ext uri="{FF2B5EF4-FFF2-40B4-BE49-F238E27FC236}">
                <a16:creationId xmlns:a16="http://schemas.microsoft.com/office/drawing/2014/main" xmlns="" id="{F2EB679F-87A0-2DF9-F9DD-8A8E57194E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8431026"/>
              </p:ext>
            </p:extLst>
          </p:nvPr>
        </p:nvGraphicFramePr>
        <p:xfrm>
          <a:off x="3303642" y="5041561"/>
          <a:ext cx="4997724" cy="42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47070">
                  <a:extLst>
                    <a:ext uri="{9D8B030D-6E8A-4147-A177-3AD203B41FA5}">
                      <a16:colId xmlns:a16="http://schemas.microsoft.com/office/drawing/2014/main" xmlns="" val="4265473964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2481464370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2206847067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2918086267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895740400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1531656154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1435945549"/>
                    </a:ext>
                  </a:extLst>
                </a:gridCol>
              </a:tblGrid>
              <a:tr h="203427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1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 anchorCtr="1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 anchorCtr="1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20329953"/>
                  </a:ext>
                </a:extLst>
              </a:tr>
              <a:tr h="2034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</a:t>
                      </a:r>
                      <a:endParaRPr kumimoji="1" lang="ja-JP" altLang="en-US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</a:p>
                  </a:txBody>
                  <a:tcPr anchor="ctr" anchorCtr="1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35996952"/>
                  </a:ext>
                </a:extLst>
              </a:tr>
            </a:tbl>
          </a:graphicData>
        </a:graphic>
      </p:graphicFrame>
      <p:sp>
        <p:nvSpPr>
          <p:cNvPr id="7" name="フリーフォーム 6">
            <a:extLst>
              <a:ext uri="{FF2B5EF4-FFF2-40B4-BE49-F238E27FC236}">
                <a16:creationId xmlns:a16="http://schemas.microsoft.com/office/drawing/2014/main" xmlns="" id="{E3CEE678-0B70-9C83-D49F-F2350B6AD412}"/>
              </a:ext>
            </a:extLst>
          </p:cNvPr>
          <p:cNvSpPr/>
          <p:nvPr/>
        </p:nvSpPr>
        <p:spPr>
          <a:xfrm>
            <a:off x="4890733" y="4720759"/>
            <a:ext cx="7425" cy="24518"/>
          </a:xfrm>
          <a:custGeom>
            <a:avLst/>
            <a:gdLst>
              <a:gd name="connsiteX0" fmla="*/ 0 w 9517"/>
              <a:gd name="connsiteY0" fmla="*/ 0 h 33527"/>
              <a:gd name="connsiteX1" fmla="*/ 0 w 9517"/>
              <a:gd name="connsiteY1" fmla="*/ 33528 h 335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33527">
                <a:moveTo>
                  <a:pt x="0" y="0"/>
                </a:moveTo>
                <a:lnTo>
                  <a:pt x="0" y="33528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9" name="フリーフォーム 8">
            <a:extLst>
              <a:ext uri="{FF2B5EF4-FFF2-40B4-BE49-F238E27FC236}">
                <a16:creationId xmlns:a16="http://schemas.microsoft.com/office/drawing/2014/main" xmlns="" id="{B39DDDED-E087-8A20-6672-0BF70993FFF8}"/>
              </a:ext>
            </a:extLst>
          </p:cNvPr>
          <p:cNvSpPr/>
          <p:nvPr/>
        </p:nvSpPr>
        <p:spPr>
          <a:xfrm>
            <a:off x="5573421" y="4720759"/>
            <a:ext cx="7425" cy="24518"/>
          </a:xfrm>
          <a:custGeom>
            <a:avLst/>
            <a:gdLst>
              <a:gd name="connsiteX0" fmla="*/ 0 w 9517"/>
              <a:gd name="connsiteY0" fmla="*/ 0 h 33527"/>
              <a:gd name="connsiteX1" fmla="*/ 0 w 9517"/>
              <a:gd name="connsiteY1" fmla="*/ 33528 h 335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33527">
                <a:moveTo>
                  <a:pt x="0" y="0"/>
                </a:moveTo>
                <a:lnTo>
                  <a:pt x="0" y="33528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0" name="フリーフォーム 9">
            <a:extLst>
              <a:ext uri="{FF2B5EF4-FFF2-40B4-BE49-F238E27FC236}">
                <a16:creationId xmlns:a16="http://schemas.microsoft.com/office/drawing/2014/main" xmlns="" id="{396BC0A3-B4E9-7470-898A-95C04CD66B6E}"/>
              </a:ext>
            </a:extLst>
          </p:cNvPr>
          <p:cNvSpPr/>
          <p:nvPr/>
        </p:nvSpPr>
        <p:spPr>
          <a:xfrm>
            <a:off x="6256110" y="4720759"/>
            <a:ext cx="7425" cy="24518"/>
          </a:xfrm>
          <a:custGeom>
            <a:avLst/>
            <a:gdLst>
              <a:gd name="connsiteX0" fmla="*/ 0 w 9517"/>
              <a:gd name="connsiteY0" fmla="*/ 0 h 33527"/>
              <a:gd name="connsiteX1" fmla="*/ 0 w 9517"/>
              <a:gd name="connsiteY1" fmla="*/ 33528 h 335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33527">
                <a:moveTo>
                  <a:pt x="0" y="0"/>
                </a:moveTo>
                <a:lnTo>
                  <a:pt x="0" y="33528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1" name="フリーフォーム 10">
            <a:extLst>
              <a:ext uri="{FF2B5EF4-FFF2-40B4-BE49-F238E27FC236}">
                <a16:creationId xmlns:a16="http://schemas.microsoft.com/office/drawing/2014/main" xmlns="" id="{61317584-7B4B-B2CA-3146-4F647DBF02D4}"/>
              </a:ext>
            </a:extLst>
          </p:cNvPr>
          <p:cNvSpPr/>
          <p:nvPr/>
        </p:nvSpPr>
        <p:spPr>
          <a:xfrm>
            <a:off x="6938800" y="4720759"/>
            <a:ext cx="7425" cy="24518"/>
          </a:xfrm>
          <a:custGeom>
            <a:avLst/>
            <a:gdLst>
              <a:gd name="connsiteX0" fmla="*/ 0 w 9517"/>
              <a:gd name="connsiteY0" fmla="*/ 0 h 33527"/>
              <a:gd name="connsiteX1" fmla="*/ 0 w 9517"/>
              <a:gd name="connsiteY1" fmla="*/ 33528 h 335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33527">
                <a:moveTo>
                  <a:pt x="0" y="0"/>
                </a:moveTo>
                <a:lnTo>
                  <a:pt x="0" y="33528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2" name="フリーフォーム 11">
            <a:extLst>
              <a:ext uri="{FF2B5EF4-FFF2-40B4-BE49-F238E27FC236}">
                <a16:creationId xmlns:a16="http://schemas.microsoft.com/office/drawing/2014/main" xmlns="" id="{E2F96562-0A32-2E5D-0680-4F75AF924A4B}"/>
              </a:ext>
            </a:extLst>
          </p:cNvPr>
          <p:cNvSpPr/>
          <p:nvPr/>
        </p:nvSpPr>
        <p:spPr>
          <a:xfrm>
            <a:off x="7621488" y="4720759"/>
            <a:ext cx="7425" cy="24518"/>
          </a:xfrm>
          <a:custGeom>
            <a:avLst/>
            <a:gdLst>
              <a:gd name="connsiteX0" fmla="*/ 0 w 9517"/>
              <a:gd name="connsiteY0" fmla="*/ 0 h 33527"/>
              <a:gd name="connsiteX1" fmla="*/ 0 w 9517"/>
              <a:gd name="connsiteY1" fmla="*/ 33528 h 335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33527">
                <a:moveTo>
                  <a:pt x="0" y="0"/>
                </a:moveTo>
                <a:lnTo>
                  <a:pt x="0" y="33528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3" name="フリーフォーム 12">
            <a:extLst>
              <a:ext uri="{FF2B5EF4-FFF2-40B4-BE49-F238E27FC236}">
                <a16:creationId xmlns:a16="http://schemas.microsoft.com/office/drawing/2014/main" xmlns="" id="{D8ADC03D-C96D-D15A-EAC5-542FB14400B2}"/>
              </a:ext>
            </a:extLst>
          </p:cNvPr>
          <p:cNvSpPr/>
          <p:nvPr/>
        </p:nvSpPr>
        <p:spPr>
          <a:xfrm>
            <a:off x="8304252" y="4720759"/>
            <a:ext cx="7425" cy="24518"/>
          </a:xfrm>
          <a:custGeom>
            <a:avLst/>
            <a:gdLst>
              <a:gd name="connsiteX0" fmla="*/ 0 w 9517"/>
              <a:gd name="connsiteY0" fmla="*/ 0 h 33527"/>
              <a:gd name="connsiteX1" fmla="*/ 0 w 9517"/>
              <a:gd name="connsiteY1" fmla="*/ 33528 h 335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33527">
                <a:moveTo>
                  <a:pt x="0" y="0"/>
                </a:moveTo>
                <a:lnTo>
                  <a:pt x="0" y="33528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4" name="フリーフォーム 13">
            <a:extLst>
              <a:ext uri="{FF2B5EF4-FFF2-40B4-BE49-F238E27FC236}">
                <a16:creationId xmlns:a16="http://schemas.microsoft.com/office/drawing/2014/main" xmlns="" id="{7DB5F3F8-E19E-D15E-2939-D4DEA31C7BDB}"/>
              </a:ext>
            </a:extLst>
          </p:cNvPr>
          <p:cNvSpPr/>
          <p:nvPr/>
        </p:nvSpPr>
        <p:spPr>
          <a:xfrm>
            <a:off x="4549388" y="4720759"/>
            <a:ext cx="7425" cy="49036"/>
          </a:xfrm>
          <a:custGeom>
            <a:avLst/>
            <a:gdLst>
              <a:gd name="connsiteX0" fmla="*/ 0 w 9517"/>
              <a:gd name="connsiteY0" fmla="*/ 0 h 67055"/>
              <a:gd name="connsiteX1" fmla="*/ 0 w 9517"/>
              <a:gd name="connsiteY1" fmla="*/ 67056 h 670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67055">
                <a:moveTo>
                  <a:pt x="0" y="0"/>
                </a:moveTo>
                <a:lnTo>
                  <a:pt x="0" y="67056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5" name="フリーフォーム 14">
            <a:extLst>
              <a:ext uri="{FF2B5EF4-FFF2-40B4-BE49-F238E27FC236}">
                <a16:creationId xmlns:a16="http://schemas.microsoft.com/office/drawing/2014/main" xmlns="" id="{9DF6F9AE-786B-D26A-EBF6-D9BEB21C9DC4}"/>
              </a:ext>
            </a:extLst>
          </p:cNvPr>
          <p:cNvSpPr/>
          <p:nvPr/>
        </p:nvSpPr>
        <p:spPr>
          <a:xfrm>
            <a:off x="5232077" y="4720759"/>
            <a:ext cx="7425" cy="49036"/>
          </a:xfrm>
          <a:custGeom>
            <a:avLst/>
            <a:gdLst>
              <a:gd name="connsiteX0" fmla="*/ 0 w 9517"/>
              <a:gd name="connsiteY0" fmla="*/ 0 h 67055"/>
              <a:gd name="connsiteX1" fmla="*/ 0 w 9517"/>
              <a:gd name="connsiteY1" fmla="*/ 67056 h 670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67055">
                <a:moveTo>
                  <a:pt x="0" y="0"/>
                </a:moveTo>
                <a:lnTo>
                  <a:pt x="0" y="67056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6" name="フリーフォーム 15">
            <a:extLst>
              <a:ext uri="{FF2B5EF4-FFF2-40B4-BE49-F238E27FC236}">
                <a16:creationId xmlns:a16="http://schemas.microsoft.com/office/drawing/2014/main" xmlns="" id="{1C996DE6-8160-C09A-C538-64274E69A986}"/>
              </a:ext>
            </a:extLst>
          </p:cNvPr>
          <p:cNvSpPr/>
          <p:nvPr/>
        </p:nvSpPr>
        <p:spPr>
          <a:xfrm>
            <a:off x="5914766" y="4720759"/>
            <a:ext cx="7425" cy="49036"/>
          </a:xfrm>
          <a:custGeom>
            <a:avLst/>
            <a:gdLst>
              <a:gd name="connsiteX0" fmla="*/ 0 w 9517"/>
              <a:gd name="connsiteY0" fmla="*/ 0 h 67055"/>
              <a:gd name="connsiteX1" fmla="*/ 0 w 9517"/>
              <a:gd name="connsiteY1" fmla="*/ 67056 h 670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67055">
                <a:moveTo>
                  <a:pt x="0" y="0"/>
                </a:moveTo>
                <a:lnTo>
                  <a:pt x="0" y="67056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7" name="フリーフォーム 16">
            <a:extLst>
              <a:ext uri="{FF2B5EF4-FFF2-40B4-BE49-F238E27FC236}">
                <a16:creationId xmlns:a16="http://schemas.microsoft.com/office/drawing/2014/main" xmlns="" id="{0FDACBA7-F494-CD88-FC95-5747C0FA1F1F}"/>
              </a:ext>
            </a:extLst>
          </p:cNvPr>
          <p:cNvSpPr/>
          <p:nvPr/>
        </p:nvSpPr>
        <p:spPr>
          <a:xfrm>
            <a:off x="6597455" y="4720759"/>
            <a:ext cx="7425" cy="49036"/>
          </a:xfrm>
          <a:custGeom>
            <a:avLst/>
            <a:gdLst>
              <a:gd name="connsiteX0" fmla="*/ 0 w 9517"/>
              <a:gd name="connsiteY0" fmla="*/ 0 h 67055"/>
              <a:gd name="connsiteX1" fmla="*/ 0 w 9517"/>
              <a:gd name="connsiteY1" fmla="*/ 67056 h 670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67055">
                <a:moveTo>
                  <a:pt x="0" y="0"/>
                </a:moveTo>
                <a:lnTo>
                  <a:pt x="0" y="67056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8" name="フリーフォーム 17">
            <a:extLst>
              <a:ext uri="{FF2B5EF4-FFF2-40B4-BE49-F238E27FC236}">
                <a16:creationId xmlns:a16="http://schemas.microsoft.com/office/drawing/2014/main" xmlns="" id="{3C66FA98-05E0-C1D3-BDE9-25DF9EC4D408}"/>
              </a:ext>
            </a:extLst>
          </p:cNvPr>
          <p:cNvSpPr/>
          <p:nvPr/>
        </p:nvSpPr>
        <p:spPr>
          <a:xfrm>
            <a:off x="7280144" y="4720759"/>
            <a:ext cx="7425" cy="49036"/>
          </a:xfrm>
          <a:custGeom>
            <a:avLst/>
            <a:gdLst>
              <a:gd name="connsiteX0" fmla="*/ 0 w 9517"/>
              <a:gd name="connsiteY0" fmla="*/ 0 h 67055"/>
              <a:gd name="connsiteX1" fmla="*/ 0 w 9517"/>
              <a:gd name="connsiteY1" fmla="*/ 67056 h 670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67055">
                <a:moveTo>
                  <a:pt x="0" y="0"/>
                </a:moveTo>
                <a:lnTo>
                  <a:pt x="0" y="67056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19" name="フリーフォーム 18">
            <a:extLst>
              <a:ext uri="{FF2B5EF4-FFF2-40B4-BE49-F238E27FC236}">
                <a16:creationId xmlns:a16="http://schemas.microsoft.com/office/drawing/2014/main" xmlns="" id="{C0775F57-755B-DBA9-F792-BD53EA599E1F}"/>
              </a:ext>
            </a:extLst>
          </p:cNvPr>
          <p:cNvSpPr/>
          <p:nvPr/>
        </p:nvSpPr>
        <p:spPr>
          <a:xfrm>
            <a:off x="7962907" y="4720759"/>
            <a:ext cx="7425" cy="49036"/>
          </a:xfrm>
          <a:custGeom>
            <a:avLst/>
            <a:gdLst>
              <a:gd name="connsiteX0" fmla="*/ 0 w 9517"/>
              <a:gd name="connsiteY0" fmla="*/ 0 h 67055"/>
              <a:gd name="connsiteX1" fmla="*/ 0 w 9517"/>
              <a:gd name="connsiteY1" fmla="*/ 67056 h 670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67055">
                <a:moveTo>
                  <a:pt x="0" y="0"/>
                </a:moveTo>
                <a:lnTo>
                  <a:pt x="0" y="67056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0" name="フリーフォーム 19">
            <a:extLst>
              <a:ext uri="{FF2B5EF4-FFF2-40B4-BE49-F238E27FC236}">
                <a16:creationId xmlns:a16="http://schemas.microsoft.com/office/drawing/2014/main" xmlns="" id="{FF372557-04CE-4C39-B97E-54612AE72E50}"/>
              </a:ext>
            </a:extLst>
          </p:cNvPr>
          <p:cNvSpPr/>
          <p:nvPr/>
        </p:nvSpPr>
        <p:spPr>
          <a:xfrm>
            <a:off x="4340735" y="4720759"/>
            <a:ext cx="4172095" cy="6966"/>
          </a:xfrm>
          <a:custGeom>
            <a:avLst/>
            <a:gdLst>
              <a:gd name="connsiteX0" fmla="*/ 0 w 5347614"/>
              <a:gd name="connsiteY0" fmla="*/ 0 h 9525"/>
              <a:gd name="connsiteX1" fmla="*/ 5347615 w 5347614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347614" h="9525">
                <a:moveTo>
                  <a:pt x="0" y="0"/>
                </a:moveTo>
                <a:lnTo>
                  <a:pt x="5347615" y="0"/>
                </a:lnTo>
              </a:path>
            </a:pathLst>
          </a:custGeom>
          <a:noFill/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1" name="フリーフォーム 20">
            <a:extLst>
              <a:ext uri="{FF2B5EF4-FFF2-40B4-BE49-F238E27FC236}">
                <a16:creationId xmlns:a16="http://schemas.microsoft.com/office/drawing/2014/main" xmlns="" id="{C6285BA4-6049-96AD-4090-E43508A0DEBA}"/>
              </a:ext>
            </a:extLst>
          </p:cNvPr>
          <p:cNvSpPr/>
          <p:nvPr/>
        </p:nvSpPr>
        <p:spPr>
          <a:xfrm>
            <a:off x="4314598" y="4332223"/>
            <a:ext cx="26137" cy="6966"/>
          </a:xfrm>
          <a:custGeom>
            <a:avLst/>
            <a:gdLst>
              <a:gd name="connsiteX0" fmla="*/ 33502 w 33501"/>
              <a:gd name="connsiteY0" fmla="*/ 0 h 9525"/>
              <a:gd name="connsiteX1" fmla="*/ 0 w 33501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3501" h="9525">
                <a:moveTo>
                  <a:pt x="33502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2" name="フリーフォーム 21">
            <a:extLst>
              <a:ext uri="{FF2B5EF4-FFF2-40B4-BE49-F238E27FC236}">
                <a16:creationId xmlns:a16="http://schemas.microsoft.com/office/drawing/2014/main" xmlns="" id="{7DB83024-29EA-7380-46DB-108A17F2577D}"/>
              </a:ext>
            </a:extLst>
          </p:cNvPr>
          <p:cNvSpPr/>
          <p:nvPr/>
        </p:nvSpPr>
        <p:spPr>
          <a:xfrm>
            <a:off x="4314598" y="3832657"/>
            <a:ext cx="26137" cy="6966"/>
          </a:xfrm>
          <a:custGeom>
            <a:avLst/>
            <a:gdLst>
              <a:gd name="connsiteX0" fmla="*/ 33502 w 33501"/>
              <a:gd name="connsiteY0" fmla="*/ 0 h 9525"/>
              <a:gd name="connsiteX1" fmla="*/ 0 w 33501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3501" h="9525">
                <a:moveTo>
                  <a:pt x="33502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3" name="フリーフォーム 22">
            <a:extLst>
              <a:ext uri="{FF2B5EF4-FFF2-40B4-BE49-F238E27FC236}">
                <a16:creationId xmlns:a16="http://schemas.microsoft.com/office/drawing/2014/main" xmlns="" id="{6FC523CE-6885-CC3D-E29D-8B75E77440C9}"/>
              </a:ext>
            </a:extLst>
          </p:cNvPr>
          <p:cNvSpPr/>
          <p:nvPr/>
        </p:nvSpPr>
        <p:spPr>
          <a:xfrm>
            <a:off x="4314598" y="3333020"/>
            <a:ext cx="26137" cy="6966"/>
          </a:xfrm>
          <a:custGeom>
            <a:avLst/>
            <a:gdLst>
              <a:gd name="connsiteX0" fmla="*/ 33502 w 33501"/>
              <a:gd name="connsiteY0" fmla="*/ 0 h 9525"/>
              <a:gd name="connsiteX1" fmla="*/ 0 w 33501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3501" h="9525">
                <a:moveTo>
                  <a:pt x="33502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4" name="フリーフォーム 23">
            <a:extLst>
              <a:ext uri="{FF2B5EF4-FFF2-40B4-BE49-F238E27FC236}">
                <a16:creationId xmlns:a16="http://schemas.microsoft.com/office/drawing/2014/main" xmlns="" id="{9EAC9D0D-8D77-E192-BA7D-1C33BC1F1CFD}"/>
              </a:ext>
            </a:extLst>
          </p:cNvPr>
          <p:cNvSpPr/>
          <p:nvPr/>
        </p:nvSpPr>
        <p:spPr>
          <a:xfrm>
            <a:off x="4314598" y="2833454"/>
            <a:ext cx="26137" cy="6966"/>
          </a:xfrm>
          <a:custGeom>
            <a:avLst/>
            <a:gdLst>
              <a:gd name="connsiteX0" fmla="*/ 33502 w 33501"/>
              <a:gd name="connsiteY0" fmla="*/ 0 h 9525"/>
              <a:gd name="connsiteX1" fmla="*/ 0 w 33501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3501" h="9525">
                <a:moveTo>
                  <a:pt x="33502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5" name="フリーフォーム 24">
            <a:extLst>
              <a:ext uri="{FF2B5EF4-FFF2-40B4-BE49-F238E27FC236}">
                <a16:creationId xmlns:a16="http://schemas.microsoft.com/office/drawing/2014/main" xmlns="" id="{4B7E50FF-A6FD-8DC7-47EA-08E04637A453}"/>
              </a:ext>
            </a:extLst>
          </p:cNvPr>
          <p:cNvSpPr/>
          <p:nvPr/>
        </p:nvSpPr>
        <p:spPr>
          <a:xfrm>
            <a:off x="4314598" y="2333887"/>
            <a:ext cx="26137" cy="6966"/>
          </a:xfrm>
          <a:custGeom>
            <a:avLst/>
            <a:gdLst>
              <a:gd name="connsiteX0" fmla="*/ 33502 w 33501"/>
              <a:gd name="connsiteY0" fmla="*/ 0 h 9525"/>
              <a:gd name="connsiteX1" fmla="*/ 0 w 33501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3501" h="9525">
                <a:moveTo>
                  <a:pt x="33502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6" name="フリーフォーム 25">
            <a:extLst>
              <a:ext uri="{FF2B5EF4-FFF2-40B4-BE49-F238E27FC236}">
                <a16:creationId xmlns:a16="http://schemas.microsoft.com/office/drawing/2014/main" xmlns="" id="{E4F627F2-36F1-0B7E-474C-631B697A55B0}"/>
              </a:ext>
            </a:extLst>
          </p:cNvPr>
          <p:cNvSpPr/>
          <p:nvPr/>
        </p:nvSpPr>
        <p:spPr>
          <a:xfrm>
            <a:off x="4288460" y="4582006"/>
            <a:ext cx="52274" cy="6966"/>
          </a:xfrm>
          <a:custGeom>
            <a:avLst/>
            <a:gdLst>
              <a:gd name="connsiteX0" fmla="*/ 67003 w 67003"/>
              <a:gd name="connsiteY0" fmla="*/ 0 h 9525"/>
              <a:gd name="connsiteX1" fmla="*/ 0 w 67003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7003" h="9525">
                <a:moveTo>
                  <a:pt x="67003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7" name="フリーフォーム 26">
            <a:extLst>
              <a:ext uri="{FF2B5EF4-FFF2-40B4-BE49-F238E27FC236}">
                <a16:creationId xmlns:a16="http://schemas.microsoft.com/office/drawing/2014/main" xmlns="" id="{DF2A3B99-2155-583A-9FCA-9CEBB28FF54B}"/>
              </a:ext>
            </a:extLst>
          </p:cNvPr>
          <p:cNvSpPr/>
          <p:nvPr/>
        </p:nvSpPr>
        <p:spPr>
          <a:xfrm>
            <a:off x="4288460" y="4082439"/>
            <a:ext cx="52274" cy="6966"/>
          </a:xfrm>
          <a:custGeom>
            <a:avLst/>
            <a:gdLst>
              <a:gd name="connsiteX0" fmla="*/ 67003 w 67003"/>
              <a:gd name="connsiteY0" fmla="*/ 0 h 9525"/>
              <a:gd name="connsiteX1" fmla="*/ 0 w 67003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7003" h="9525">
                <a:moveTo>
                  <a:pt x="67003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8" name="フリーフォーム 27">
            <a:extLst>
              <a:ext uri="{FF2B5EF4-FFF2-40B4-BE49-F238E27FC236}">
                <a16:creationId xmlns:a16="http://schemas.microsoft.com/office/drawing/2014/main" xmlns="" id="{DFDAE5E1-2916-8E81-5224-14A08EEB8ED2}"/>
              </a:ext>
            </a:extLst>
          </p:cNvPr>
          <p:cNvSpPr/>
          <p:nvPr/>
        </p:nvSpPr>
        <p:spPr>
          <a:xfrm>
            <a:off x="4288460" y="3582873"/>
            <a:ext cx="52274" cy="6966"/>
          </a:xfrm>
          <a:custGeom>
            <a:avLst/>
            <a:gdLst>
              <a:gd name="connsiteX0" fmla="*/ 67003 w 67003"/>
              <a:gd name="connsiteY0" fmla="*/ 0 h 9525"/>
              <a:gd name="connsiteX1" fmla="*/ 0 w 67003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7003" h="9525">
                <a:moveTo>
                  <a:pt x="67003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29" name="フリーフォーム 28">
            <a:extLst>
              <a:ext uri="{FF2B5EF4-FFF2-40B4-BE49-F238E27FC236}">
                <a16:creationId xmlns:a16="http://schemas.microsoft.com/office/drawing/2014/main" xmlns="" id="{2E03B7B6-A3F8-9839-76AC-40D1B84C9063}"/>
              </a:ext>
            </a:extLst>
          </p:cNvPr>
          <p:cNvSpPr/>
          <p:nvPr/>
        </p:nvSpPr>
        <p:spPr>
          <a:xfrm>
            <a:off x="4288460" y="3083237"/>
            <a:ext cx="52274" cy="6966"/>
          </a:xfrm>
          <a:custGeom>
            <a:avLst/>
            <a:gdLst>
              <a:gd name="connsiteX0" fmla="*/ 67003 w 67003"/>
              <a:gd name="connsiteY0" fmla="*/ 0 h 9525"/>
              <a:gd name="connsiteX1" fmla="*/ 0 w 67003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7003" h="9525">
                <a:moveTo>
                  <a:pt x="67003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30" name="フリーフォーム 29">
            <a:extLst>
              <a:ext uri="{FF2B5EF4-FFF2-40B4-BE49-F238E27FC236}">
                <a16:creationId xmlns:a16="http://schemas.microsoft.com/office/drawing/2014/main" xmlns="" id="{F9C792B8-33EE-1FE1-D873-CE2BC7B7F47C}"/>
              </a:ext>
            </a:extLst>
          </p:cNvPr>
          <p:cNvSpPr/>
          <p:nvPr/>
        </p:nvSpPr>
        <p:spPr>
          <a:xfrm>
            <a:off x="4288460" y="2583671"/>
            <a:ext cx="52274" cy="6966"/>
          </a:xfrm>
          <a:custGeom>
            <a:avLst/>
            <a:gdLst>
              <a:gd name="connsiteX0" fmla="*/ 67003 w 67003"/>
              <a:gd name="connsiteY0" fmla="*/ 0 h 9525"/>
              <a:gd name="connsiteX1" fmla="*/ 0 w 67003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7003" h="9525">
                <a:moveTo>
                  <a:pt x="67003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31" name="フリーフォーム 30">
            <a:extLst>
              <a:ext uri="{FF2B5EF4-FFF2-40B4-BE49-F238E27FC236}">
                <a16:creationId xmlns:a16="http://schemas.microsoft.com/office/drawing/2014/main" xmlns="" id="{E03573CE-57BE-F200-F2B8-F261B1CA48A1}"/>
              </a:ext>
            </a:extLst>
          </p:cNvPr>
          <p:cNvSpPr/>
          <p:nvPr/>
        </p:nvSpPr>
        <p:spPr>
          <a:xfrm>
            <a:off x="4288460" y="2084105"/>
            <a:ext cx="52274" cy="6966"/>
          </a:xfrm>
          <a:custGeom>
            <a:avLst/>
            <a:gdLst>
              <a:gd name="connsiteX0" fmla="*/ 67003 w 67003"/>
              <a:gd name="connsiteY0" fmla="*/ 0 h 9525"/>
              <a:gd name="connsiteX1" fmla="*/ 0 w 67003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7003" h="9525">
                <a:moveTo>
                  <a:pt x="67003" y="0"/>
                </a:moveTo>
                <a:lnTo>
                  <a:pt x="0" y="0"/>
                </a:lnTo>
              </a:path>
            </a:pathLst>
          </a:custGeom>
          <a:ln w="9514" cap="flat">
            <a:solidFill>
              <a:srgbClr val="AEAEAE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32" name="フリーフォーム 31">
            <a:extLst>
              <a:ext uri="{FF2B5EF4-FFF2-40B4-BE49-F238E27FC236}">
                <a16:creationId xmlns:a16="http://schemas.microsoft.com/office/drawing/2014/main" xmlns="" id="{C7B58CBF-486B-5FA2-E268-A77BD460CF1E}"/>
              </a:ext>
            </a:extLst>
          </p:cNvPr>
          <p:cNvSpPr/>
          <p:nvPr/>
        </p:nvSpPr>
        <p:spPr>
          <a:xfrm>
            <a:off x="4340735" y="1945282"/>
            <a:ext cx="7425" cy="2775477"/>
          </a:xfrm>
          <a:custGeom>
            <a:avLst/>
            <a:gdLst>
              <a:gd name="connsiteX0" fmla="*/ 0 w 9517"/>
              <a:gd name="connsiteY0" fmla="*/ 0 h 3795331"/>
              <a:gd name="connsiteX1" fmla="*/ 0 w 9517"/>
              <a:gd name="connsiteY1" fmla="*/ 3795332 h 37953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17" h="3795331">
                <a:moveTo>
                  <a:pt x="0" y="0"/>
                </a:moveTo>
                <a:lnTo>
                  <a:pt x="0" y="3795332"/>
                </a:lnTo>
              </a:path>
            </a:pathLst>
          </a:custGeom>
          <a:noFill/>
          <a:ln w="9514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b="1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07700B9E-2A08-6FD0-C231-0100EF2872F4}"/>
              </a:ext>
            </a:extLst>
          </p:cNvPr>
          <p:cNvSpPr txBox="1"/>
          <p:nvPr/>
        </p:nvSpPr>
        <p:spPr>
          <a:xfrm>
            <a:off x="3675416" y="1981267"/>
            <a:ext cx="646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%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7908A74F-C8BE-F094-4DE0-D903D83FC521}"/>
              </a:ext>
            </a:extLst>
          </p:cNvPr>
          <p:cNvSpPr txBox="1"/>
          <p:nvPr/>
        </p:nvSpPr>
        <p:spPr>
          <a:xfrm>
            <a:off x="3730887" y="2477689"/>
            <a:ext cx="5907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%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2ED2CBF0-0568-C21D-6BDC-68A50F372AEE}"/>
              </a:ext>
            </a:extLst>
          </p:cNvPr>
          <p:cNvSpPr txBox="1"/>
          <p:nvPr/>
        </p:nvSpPr>
        <p:spPr>
          <a:xfrm>
            <a:off x="3719109" y="2974111"/>
            <a:ext cx="602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%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B63D2FBB-4C2A-8E95-2EFF-D3E0AA23E543}"/>
              </a:ext>
            </a:extLst>
          </p:cNvPr>
          <p:cNvSpPr txBox="1"/>
          <p:nvPr/>
        </p:nvSpPr>
        <p:spPr>
          <a:xfrm>
            <a:off x="3712819" y="3470533"/>
            <a:ext cx="6087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%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6AADAFED-1065-689F-3FC2-9B625BBB7C99}"/>
              </a:ext>
            </a:extLst>
          </p:cNvPr>
          <p:cNvSpPr txBox="1"/>
          <p:nvPr/>
        </p:nvSpPr>
        <p:spPr>
          <a:xfrm>
            <a:off x="3712257" y="3966955"/>
            <a:ext cx="6093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%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7F2C95AE-36F9-70DE-5AC7-37A7223E38CE}"/>
              </a:ext>
            </a:extLst>
          </p:cNvPr>
          <p:cNvSpPr txBox="1"/>
          <p:nvPr/>
        </p:nvSpPr>
        <p:spPr>
          <a:xfrm>
            <a:off x="3633772" y="4463379"/>
            <a:ext cx="687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 %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E83C1BE1-3EDA-EB70-3A46-B5EE3787ADDE}"/>
              </a:ext>
            </a:extLst>
          </p:cNvPr>
          <p:cNvSpPr txBox="1"/>
          <p:nvPr/>
        </p:nvSpPr>
        <p:spPr>
          <a:xfrm>
            <a:off x="4439781" y="476606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75DFD942-7659-1FF3-45E7-5B7FCAB12420}"/>
              </a:ext>
            </a:extLst>
          </p:cNvPr>
          <p:cNvSpPr txBox="1"/>
          <p:nvPr/>
        </p:nvSpPr>
        <p:spPr>
          <a:xfrm>
            <a:off x="5052541" y="477809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8C5306FA-35A5-0CF4-CC7C-C586D8416288}"/>
              </a:ext>
            </a:extLst>
          </p:cNvPr>
          <p:cNvSpPr txBox="1"/>
          <p:nvPr/>
        </p:nvSpPr>
        <p:spPr>
          <a:xfrm>
            <a:off x="5737813" y="477809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6CF0541C-7921-FF43-EA58-B0A88F80CF10}"/>
              </a:ext>
            </a:extLst>
          </p:cNvPr>
          <p:cNvSpPr txBox="1"/>
          <p:nvPr/>
        </p:nvSpPr>
        <p:spPr>
          <a:xfrm>
            <a:off x="6423085" y="477809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7536E46B-C748-C3AA-4F31-9A518D077852}"/>
              </a:ext>
            </a:extLst>
          </p:cNvPr>
          <p:cNvSpPr txBox="1"/>
          <p:nvPr/>
        </p:nvSpPr>
        <p:spPr>
          <a:xfrm>
            <a:off x="7108357" y="477809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AC4D08BA-9DCC-7336-904A-5A134718546A}"/>
              </a:ext>
            </a:extLst>
          </p:cNvPr>
          <p:cNvSpPr txBox="1"/>
          <p:nvPr/>
        </p:nvSpPr>
        <p:spPr>
          <a:xfrm>
            <a:off x="7783120" y="477809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kumimoji="1"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kumimoji="1" lang="ja-JP" altLang="en-US" sz="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B9ECE337-BB1E-E33C-6276-ECEDDD1FBC8D}"/>
              </a:ext>
            </a:extLst>
          </p:cNvPr>
          <p:cNvSpPr txBox="1"/>
          <p:nvPr/>
        </p:nvSpPr>
        <p:spPr>
          <a:xfrm>
            <a:off x="8353000" y="4400036"/>
            <a:ext cx="9614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A48E6626-3F9F-51A4-D66F-D02190C065E1}"/>
              </a:ext>
            </a:extLst>
          </p:cNvPr>
          <p:cNvSpPr txBox="1"/>
          <p:nvPr/>
        </p:nvSpPr>
        <p:spPr>
          <a:xfrm rot="16200000">
            <a:off x="3057643" y="3190322"/>
            <a:ext cx="12602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Survival rate (%)</a:t>
            </a:r>
            <a:endParaRPr kumimoji="1" lang="ja-JP" altLang="en-US" sz="10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23" name="テキスト ボックス 5622">
            <a:extLst>
              <a:ext uri="{FF2B5EF4-FFF2-40B4-BE49-F238E27FC236}">
                <a16:creationId xmlns:a16="http://schemas.microsoft.com/office/drawing/2014/main" xmlns="" id="{2BC7470C-0065-B8CE-699C-24C63D51BA80}"/>
              </a:ext>
            </a:extLst>
          </p:cNvPr>
          <p:cNvSpPr txBox="1"/>
          <p:nvPr/>
        </p:nvSpPr>
        <p:spPr>
          <a:xfrm>
            <a:off x="6601167" y="3149568"/>
            <a:ext cx="1911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 0.99 (95% CI: 0.74–1.25)</a:t>
            </a:r>
          </a:p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 by log-rank test</a:t>
            </a:r>
            <a:r>
              <a:rPr kumimoji="1"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517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09DCECD0-033A-F314-3980-BECA6AA16751}"/>
              </a:ext>
            </a:extLst>
          </p:cNvPr>
          <p:cNvSpPr/>
          <p:nvPr/>
        </p:nvSpPr>
        <p:spPr>
          <a:xfrm>
            <a:off x="7028760" y="2053332"/>
            <a:ext cx="1324240" cy="582031"/>
          </a:xfrm>
          <a:prstGeom prst="rect">
            <a:avLst/>
          </a:prstGeom>
          <a:noFill/>
          <a:ln w="6350">
            <a:solidFill>
              <a:schemeClr val="tx1"/>
            </a:solidFill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b="1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xmlns="" id="{217B747C-18D1-72D7-E8BC-653097219C66}"/>
              </a:ext>
            </a:extLst>
          </p:cNvPr>
          <p:cNvGrpSpPr/>
          <p:nvPr/>
        </p:nvGrpSpPr>
        <p:grpSpPr>
          <a:xfrm>
            <a:off x="7157874" y="2126040"/>
            <a:ext cx="1139430" cy="452259"/>
            <a:chOff x="4251784" y="1784497"/>
            <a:chExt cx="1139430" cy="452259"/>
          </a:xfrm>
        </p:grpSpPr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xmlns="" id="{01843A27-4A56-28FD-25E9-6B970A7694F9}"/>
                </a:ext>
              </a:extLst>
            </p:cNvPr>
            <p:cNvCxnSpPr>
              <a:cxnSpLocks/>
            </p:cNvCxnSpPr>
            <p:nvPr/>
          </p:nvCxnSpPr>
          <p:spPr>
            <a:xfrm>
              <a:off x="4251784" y="1903592"/>
              <a:ext cx="169277" cy="0"/>
            </a:xfrm>
            <a:prstGeom prst="line">
              <a:avLst/>
            </a:prstGeom>
            <a:ln w="19050">
              <a:solidFill>
                <a:schemeClr val="accent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xmlns="" id="{9688BB46-C121-E4C3-953F-F526B1F59D45}"/>
                </a:ext>
              </a:extLst>
            </p:cNvPr>
            <p:cNvSpPr txBox="1"/>
            <p:nvPr/>
          </p:nvSpPr>
          <p:spPr>
            <a:xfrm>
              <a:off x="4465961" y="1784497"/>
              <a:ext cx="92525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 (reference)</a:t>
              </a:r>
              <a:endParaRPr kumimoji="1" lang="ja-JP" alt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xmlns="" id="{8025C2E1-05A4-E32C-9AB0-BAD09DABC9F7}"/>
                </a:ext>
              </a:extLst>
            </p:cNvPr>
            <p:cNvSpPr txBox="1"/>
            <p:nvPr/>
          </p:nvSpPr>
          <p:spPr>
            <a:xfrm>
              <a:off x="4468319" y="2005924"/>
              <a:ext cx="34817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 </a:t>
              </a:r>
              <a:endParaRPr kumimoji="1" lang="ja-JP" alt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xmlns="" id="{9CFDB094-4096-6E2F-DC84-7A8B5AE8226F}"/>
                </a:ext>
              </a:extLst>
            </p:cNvPr>
            <p:cNvCxnSpPr>
              <a:cxnSpLocks/>
            </p:cNvCxnSpPr>
            <p:nvPr/>
          </p:nvCxnSpPr>
          <p:spPr>
            <a:xfrm>
              <a:off x="4251784" y="2132382"/>
              <a:ext cx="169277" cy="0"/>
            </a:xfrm>
            <a:prstGeom prst="line">
              <a:avLst/>
            </a:prstGeom>
            <a:ln w="190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369C8DDD-C25E-7B67-F3F9-FA69E71408B5}"/>
              </a:ext>
            </a:extLst>
          </p:cNvPr>
          <p:cNvSpPr txBox="1"/>
          <p:nvPr/>
        </p:nvSpPr>
        <p:spPr>
          <a:xfrm>
            <a:off x="2374110" y="1088385"/>
            <a:ext cx="1781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966" name="グループ化 5965">
            <a:extLst>
              <a:ext uri="{FF2B5EF4-FFF2-40B4-BE49-F238E27FC236}">
                <a16:creationId xmlns:a16="http://schemas.microsoft.com/office/drawing/2014/main" xmlns="" id="{F5EEFB40-3395-27E3-EE8C-31395F6590FD}"/>
              </a:ext>
            </a:extLst>
          </p:cNvPr>
          <p:cNvGrpSpPr/>
          <p:nvPr/>
        </p:nvGrpSpPr>
        <p:grpSpPr>
          <a:xfrm>
            <a:off x="4556813" y="2083266"/>
            <a:ext cx="3650812" cy="2446708"/>
            <a:chOff x="4163090" y="6202499"/>
            <a:chExt cx="3650812" cy="2446708"/>
          </a:xfrm>
        </p:grpSpPr>
        <p:sp>
          <p:nvSpPr>
            <p:cNvPr id="5662" name="フリーフォーム 5661">
              <a:extLst>
                <a:ext uri="{FF2B5EF4-FFF2-40B4-BE49-F238E27FC236}">
                  <a16:creationId xmlns:a16="http://schemas.microsoft.com/office/drawing/2014/main" xmlns="" id="{DBFD0FA3-1A7A-E69B-731F-A34F54A94C96}"/>
                </a:ext>
              </a:extLst>
            </p:cNvPr>
            <p:cNvSpPr/>
            <p:nvPr/>
          </p:nvSpPr>
          <p:spPr>
            <a:xfrm>
              <a:off x="4163090" y="6219502"/>
              <a:ext cx="3634592" cy="2416069"/>
            </a:xfrm>
            <a:custGeom>
              <a:avLst/>
              <a:gdLst>
                <a:gd name="connsiteX0" fmla="*/ 0 w 3634592"/>
                <a:gd name="connsiteY0" fmla="*/ 0 h 2416069"/>
                <a:gd name="connsiteX1" fmla="*/ 17170 w 3634592"/>
                <a:gd name="connsiteY1" fmla="*/ 0 h 2416069"/>
                <a:gd name="connsiteX2" fmla="*/ 17218 w 3634592"/>
                <a:gd name="connsiteY2" fmla="*/ 16462 h 2416069"/>
                <a:gd name="connsiteX3" fmla="*/ 20623 w 3634592"/>
                <a:gd name="connsiteY3" fmla="*/ 16462 h 2416069"/>
                <a:gd name="connsiteX4" fmla="*/ 20623 w 3634592"/>
                <a:gd name="connsiteY4" fmla="*/ 32864 h 2416069"/>
                <a:gd name="connsiteX5" fmla="*/ 27529 w 3634592"/>
                <a:gd name="connsiteY5" fmla="*/ 32864 h 2416069"/>
                <a:gd name="connsiteX6" fmla="*/ 27529 w 3634592"/>
                <a:gd name="connsiteY6" fmla="*/ 49326 h 2416069"/>
                <a:gd name="connsiteX7" fmla="*/ 37840 w 3634592"/>
                <a:gd name="connsiteY7" fmla="*/ 49326 h 2416069"/>
                <a:gd name="connsiteX8" fmla="*/ 37840 w 3634592"/>
                <a:gd name="connsiteY8" fmla="*/ 65968 h 2416069"/>
                <a:gd name="connsiteX9" fmla="*/ 48200 w 3634592"/>
                <a:gd name="connsiteY9" fmla="*/ 65968 h 2416069"/>
                <a:gd name="connsiteX10" fmla="*/ 48200 w 3634592"/>
                <a:gd name="connsiteY10" fmla="*/ 99313 h 2416069"/>
                <a:gd name="connsiteX11" fmla="*/ 55058 w 3634592"/>
                <a:gd name="connsiteY11" fmla="*/ 99313 h 2416069"/>
                <a:gd name="connsiteX12" fmla="*/ 55058 w 3634592"/>
                <a:gd name="connsiteY12" fmla="*/ 132657 h 2416069"/>
                <a:gd name="connsiteX13" fmla="*/ 65417 w 3634592"/>
                <a:gd name="connsiteY13" fmla="*/ 132657 h 2416069"/>
                <a:gd name="connsiteX14" fmla="*/ 65417 w 3634592"/>
                <a:gd name="connsiteY14" fmla="*/ 149300 h 2416069"/>
                <a:gd name="connsiteX15" fmla="*/ 68822 w 3634592"/>
                <a:gd name="connsiteY15" fmla="*/ 149300 h 2416069"/>
                <a:gd name="connsiteX16" fmla="*/ 68870 w 3634592"/>
                <a:gd name="connsiteY16" fmla="*/ 166002 h 2416069"/>
                <a:gd name="connsiteX17" fmla="*/ 72276 w 3634592"/>
                <a:gd name="connsiteY17" fmla="*/ 166002 h 2416069"/>
                <a:gd name="connsiteX18" fmla="*/ 72276 w 3634592"/>
                <a:gd name="connsiteY18" fmla="*/ 199346 h 2416069"/>
                <a:gd name="connsiteX19" fmla="*/ 75729 w 3634592"/>
                <a:gd name="connsiteY19" fmla="*/ 199346 h 2416069"/>
                <a:gd name="connsiteX20" fmla="*/ 75729 w 3634592"/>
                <a:gd name="connsiteY20" fmla="*/ 215989 h 2416069"/>
                <a:gd name="connsiteX21" fmla="*/ 79182 w 3634592"/>
                <a:gd name="connsiteY21" fmla="*/ 215989 h 2416069"/>
                <a:gd name="connsiteX22" fmla="*/ 79182 w 3634592"/>
                <a:gd name="connsiteY22" fmla="*/ 232691 h 2416069"/>
                <a:gd name="connsiteX23" fmla="*/ 82635 w 3634592"/>
                <a:gd name="connsiteY23" fmla="*/ 232691 h 2416069"/>
                <a:gd name="connsiteX24" fmla="*/ 82635 w 3634592"/>
                <a:gd name="connsiteY24" fmla="*/ 249333 h 2416069"/>
                <a:gd name="connsiteX25" fmla="*/ 86040 w 3634592"/>
                <a:gd name="connsiteY25" fmla="*/ 249333 h 2416069"/>
                <a:gd name="connsiteX26" fmla="*/ 86088 w 3634592"/>
                <a:gd name="connsiteY26" fmla="*/ 282678 h 2416069"/>
                <a:gd name="connsiteX27" fmla="*/ 92946 w 3634592"/>
                <a:gd name="connsiteY27" fmla="*/ 282678 h 2416069"/>
                <a:gd name="connsiteX28" fmla="*/ 92946 w 3634592"/>
                <a:gd name="connsiteY28" fmla="*/ 299440 h 2416069"/>
                <a:gd name="connsiteX29" fmla="*/ 96399 w 3634592"/>
                <a:gd name="connsiteY29" fmla="*/ 299440 h 2416069"/>
                <a:gd name="connsiteX30" fmla="*/ 96399 w 3634592"/>
                <a:gd name="connsiteY30" fmla="*/ 316263 h 2416069"/>
                <a:gd name="connsiteX31" fmla="*/ 106711 w 3634592"/>
                <a:gd name="connsiteY31" fmla="*/ 316263 h 2416069"/>
                <a:gd name="connsiteX32" fmla="*/ 106711 w 3634592"/>
                <a:gd name="connsiteY32" fmla="*/ 333025 h 2416069"/>
                <a:gd name="connsiteX33" fmla="*/ 110164 w 3634592"/>
                <a:gd name="connsiteY33" fmla="*/ 333025 h 2416069"/>
                <a:gd name="connsiteX34" fmla="*/ 110164 w 3634592"/>
                <a:gd name="connsiteY34" fmla="*/ 366670 h 2416069"/>
                <a:gd name="connsiteX35" fmla="*/ 117070 w 3634592"/>
                <a:gd name="connsiteY35" fmla="*/ 366670 h 2416069"/>
                <a:gd name="connsiteX36" fmla="*/ 117070 w 3634592"/>
                <a:gd name="connsiteY36" fmla="*/ 383553 h 2416069"/>
                <a:gd name="connsiteX37" fmla="*/ 123928 w 3634592"/>
                <a:gd name="connsiteY37" fmla="*/ 383553 h 2416069"/>
                <a:gd name="connsiteX38" fmla="*/ 123928 w 3634592"/>
                <a:gd name="connsiteY38" fmla="*/ 400495 h 2416069"/>
                <a:gd name="connsiteX39" fmla="*/ 137693 w 3634592"/>
                <a:gd name="connsiteY39" fmla="*/ 400495 h 2416069"/>
                <a:gd name="connsiteX40" fmla="*/ 137693 w 3634592"/>
                <a:gd name="connsiteY40" fmla="*/ 417558 h 2416069"/>
                <a:gd name="connsiteX41" fmla="*/ 141146 w 3634592"/>
                <a:gd name="connsiteY41" fmla="*/ 417558 h 2416069"/>
                <a:gd name="connsiteX42" fmla="*/ 141146 w 3634592"/>
                <a:gd name="connsiteY42" fmla="*/ 434621 h 2416069"/>
                <a:gd name="connsiteX43" fmla="*/ 144599 w 3634592"/>
                <a:gd name="connsiteY43" fmla="*/ 434621 h 2416069"/>
                <a:gd name="connsiteX44" fmla="*/ 144599 w 3634592"/>
                <a:gd name="connsiteY44" fmla="*/ 451684 h 2416069"/>
                <a:gd name="connsiteX45" fmla="*/ 151505 w 3634592"/>
                <a:gd name="connsiteY45" fmla="*/ 451684 h 2416069"/>
                <a:gd name="connsiteX46" fmla="*/ 151505 w 3634592"/>
                <a:gd name="connsiteY46" fmla="*/ 468747 h 2416069"/>
                <a:gd name="connsiteX47" fmla="*/ 154910 w 3634592"/>
                <a:gd name="connsiteY47" fmla="*/ 468747 h 2416069"/>
                <a:gd name="connsiteX48" fmla="*/ 154910 w 3634592"/>
                <a:gd name="connsiteY48" fmla="*/ 485990 h 2416069"/>
                <a:gd name="connsiteX49" fmla="*/ 158364 w 3634592"/>
                <a:gd name="connsiteY49" fmla="*/ 485990 h 2416069"/>
                <a:gd name="connsiteX50" fmla="*/ 158364 w 3634592"/>
                <a:gd name="connsiteY50" fmla="*/ 503173 h 2416069"/>
                <a:gd name="connsiteX51" fmla="*/ 165270 w 3634592"/>
                <a:gd name="connsiteY51" fmla="*/ 503173 h 2416069"/>
                <a:gd name="connsiteX52" fmla="*/ 165270 w 3634592"/>
                <a:gd name="connsiteY52" fmla="*/ 520596 h 2416069"/>
                <a:gd name="connsiteX53" fmla="*/ 179034 w 3634592"/>
                <a:gd name="connsiteY53" fmla="*/ 520596 h 2416069"/>
                <a:gd name="connsiteX54" fmla="*/ 179034 w 3634592"/>
                <a:gd name="connsiteY54" fmla="*/ 538079 h 2416069"/>
                <a:gd name="connsiteX55" fmla="*/ 189346 w 3634592"/>
                <a:gd name="connsiteY55" fmla="*/ 538079 h 2416069"/>
                <a:gd name="connsiteX56" fmla="*/ 189346 w 3634592"/>
                <a:gd name="connsiteY56" fmla="*/ 555623 h 2416069"/>
                <a:gd name="connsiteX57" fmla="*/ 196252 w 3634592"/>
                <a:gd name="connsiteY57" fmla="*/ 555623 h 2416069"/>
                <a:gd name="connsiteX58" fmla="*/ 196252 w 3634592"/>
                <a:gd name="connsiteY58" fmla="*/ 573286 h 2416069"/>
                <a:gd name="connsiteX59" fmla="*/ 199705 w 3634592"/>
                <a:gd name="connsiteY59" fmla="*/ 573286 h 2416069"/>
                <a:gd name="connsiteX60" fmla="*/ 199705 w 3634592"/>
                <a:gd name="connsiteY60" fmla="*/ 590950 h 2416069"/>
                <a:gd name="connsiteX61" fmla="*/ 210016 w 3634592"/>
                <a:gd name="connsiteY61" fmla="*/ 590950 h 2416069"/>
                <a:gd name="connsiteX62" fmla="*/ 210016 w 3634592"/>
                <a:gd name="connsiteY62" fmla="*/ 608674 h 2416069"/>
                <a:gd name="connsiteX63" fmla="*/ 213470 w 3634592"/>
                <a:gd name="connsiteY63" fmla="*/ 608674 h 2416069"/>
                <a:gd name="connsiteX64" fmla="*/ 213470 w 3634592"/>
                <a:gd name="connsiteY64" fmla="*/ 626337 h 2416069"/>
                <a:gd name="connsiteX65" fmla="*/ 220328 w 3634592"/>
                <a:gd name="connsiteY65" fmla="*/ 626337 h 2416069"/>
                <a:gd name="connsiteX66" fmla="*/ 220376 w 3634592"/>
                <a:gd name="connsiteY66" fmla="*/ 661664 h 2416069"/>
                <a:gd name="connsiteX67" fmla="*/ 230687 w 3634592"/>
                <a:gd name="connsiteY67" fmla="*/ 661664 h 2416069"/>
                <a:gd name="connsiteX68" fmla="*/ 230687 w 3634592"/>
                <a:gd name="connsiteY68" fmla="*/ 697052 h 2416069"/>
                <a:gd name="connsiteX69" fmla="*/ 234140 w 3634592"/>
                <a:gd name="connsiteY69" fmla="*/ 697052 h 2416069"/>
                <a:gd name="connsiteX70" fmla="*/ 234140 w 3634592"/>
                <a:gd name="connsiteY70" fmla="*/ 714715 h 2416069"/>
                <a:gd name="connsiteX71" fmla="*/ 247905 w 3634592"/>
                <a:gd name="connsiteY71" fmla="*/ 714715 h 2416069"/>
                <a:gd name="connsiteX72" fmla="*/ 247905 w 3634592"/>
                <a:gd name="connsiteY72" fmla="*/ 732619 h 2416069"/>
                <a:gd name="connsiteX73" fmla="*/ 265122 w 3634592"/>
                <a:gd name="connsiteY73" fmla="*/ 732619 h 2416069"/>
                <a:gd name="connsiteX74" fmla="*/ 265122 w 3634592"/>
                <a:gd name="connsiteY74" fmla="*/ 750463 h 2416069"/>
                <a:gd name="connsiteX75" fmla="*/ 271981 w 3634592"/>
                <a:gd name="connsiteY75" fmla="*/ 750463 h 2416069"/>
                <a:gd name="connsiteX76" fmla="*/ 272029 w 3634592"/>
                <a:gd name="connsiteY76" fmla="*/ 786151 h 2416069"/>
                <a:gd name="connsiteX77" fmla="*/ 275434 w 3634592"/>
                <a:gd name="connsiteY77" fmla="*/ 786151 h 2416069"/>
                <a:gd name="connsiteX78" fmla="*/ 275434 w 3634592"/>
                <a:gd name="connsiteY78" fmla="*/ 804055 h 2416069"/>
                <a:gd name="connsiteX79" fmla="*/ 278887 w 3634592"/>
                <a:gd name="connsiteY79" fmla="*/ 804055 h 2416069"/>
                <a:gd name="connsiteX80" fmla="*/ 278887 w 3634592"/>
                <a:gd name="connsiteY80" fmla="*/ 821899 h 2416069"/>
                <a:gd name="connsiteX81" fmla="*/ 285793 w 3634592"/>
                <a:gd name="connsiteY81" fmla="*/ 821899 h 2416069"/>
                <a:gd name="connsiteX82" fmla="*/ 285793 w 3634592"/>
                <a:gd name="connsiteY82" fmla="*/ 839742 h 2416069"/>
                <a:gd name="connsiteX83" fmla="*/ 289198 w 3634592"/>
                <a:gd name="connsiteY83" fmla="*/ 839742 h 2416069"/>
                <a:gd name="connsiteX84" fmla="*/ 289198 w 3634592"/>
                <a:gd name="connsiteY84" fmla="*/ 857586 h 2416069"/>
                <a:gd name="connsiteX85" fmla="*/ 296104 w 3634592"/>
                <a:gd name="connsiteY85" fmla="*/ 857586 h 2416069"/>
                <a:gd name="connsiteX86" fmla="*/ 296104 w 3634592"/>
                <a:gd name="connsiteY86" fmla="*/ 875490 h 2416069"/>
                <a:gd name="connsiteX87" fmla="*/ 303011 w 3634592"/>
                <a:gd name="connsiteY87" fmla="*/ 875490 h 2416069"/>
                <a:gd name="connsiteX88" fmla="*/ 303011 w 3634592"/>
                <a:gd name="connsiteY88" fmla="*/ 893334 h 2416069"/>
                <a:gd name="connsiteX89" fmla="*/ 313322 w 3634592"/>
                <a:gd name="connsiteY89" fmla="*/ 893334 h 2416069"/>
                <a:gd name="connsiteX90" fmla="*/ 313322 w 3634592"/>
                <a:gd name="connsiteY90" fmla="*/ 911178 h 2416069"/>
                <a:gd name="connsiteX91" fmla="*/ 320180 w 3634592"/>
                <a:gd name="connsiteY91" fmla="*/ 911178 h 2416069"/>
                <a:gd name="connsiteX92" fmla="*/ 320228 w 3634592"/>
                <a:gd name="connsiteY92" fmla="*/ 946926 h 2416069"/>
                <a:gd name="connsiteX93" fmla="*/ 330540 w 3634592"/>
                <a:gd name="connsiteY93" fmla="*/ 946926 h 2416069"/>
                <a:gd name="connsiteX94" fmla="*/ 330540 w 3634592"/>
                <a:gd name="connsiteY94" fmla="*/ 965190 h 2416069"/>
                <a:gd name="connsiteX95" fmla="*/ 340851 w 3634592"/>
                <a:gd name="connsiteY95" fmla="*/ 965190 h 2416069"/>
                <a:gd name="connsiteX96" fmla="*/ 340851 w 3634592"/>
                <a:gd name="connsiteY96" fmla="*/ 983454 h 2416069"/>
                <a:gd name="connsiteX97" fmla="*/ 351210 w 3634592"/>
                <a:gd name="connsiteY97" fmla="*/ 983454 h 2416069"/>
                <a:gd name="connsiteX98" fmla="*/ 351210 w 3634592"/>
                <a:gd name="connsiteY98" fmla="*/ 1001779 h 2416069"/>
                <a:gd name="connsiteX99" fmla="*/ 354615 w 3634592"/>
                <a:gd name="connsiteY99" fmla="*/ 1001779 h 2416069"/>
                <a:gd name="connsiteX100" fmla="*/ 354663 w 3634592"/>
                <a:gd name="connsiteY100" fmla="*/ 1038308 h 2416069"/>
                <a:gd name="connsiteX101" fmla="*/ 368428 w 3634592"/>
                <a:gd name="connsiteY101" fmla="*/ 1038308 h 2416069"/>
                <a:gd name="connsiteX102" fmla="*/ 368428 w 3634592"/>
                <a:gd name="connsiteY102" fmla="*/ 1057113 h 2416069"/>
                <a:gd name="connsiteX103" fmla="*/ 382192 w 3634592"/>
                <a:gd name="connsiteY103" fmla="*/ 1057113 h 2416069"/>
                <a:gd name="connsiteX104" fmla="*/ 382192 w 3634592"/>
                <a:gd name="connsiteY104" fmla="*/ 1094603 h 2416069"/>
                <a:gd name="connsiteX105" fmla="*/ 389051 w 3634592"/>
                <a:gd name="connsiteY105" fmla="*/ 1094603 h 2416069"/>
                <a:gd name="connsiteX106" fmla="*/ 389099 w 3634592"/>
                <a:gd name="connsiteY106" fmla="*/ 1113348 h 2416069"/>
                <a:gd name="connsiteX107" fmla="*/ 399410 w 3634592"/>
                <a:gd name="connsiteY107" fmla="*/ 1113348 h 2416069"/>
                <a:gd name="connsiteX108" fmla="*/ 399410 w 3634592"/>
                <a:gd name="connsiteY108" fmla="*/ 1132394 h 2416069"/>
                <a:gd name="connsiteX109" fmla="*/ 402863 w 3634592"/>
                <a:gd name="connsiteY109" fmla="*/ 1132394 h 2416069"/>
                <a:gd name="connsiteX110" fmla="*/ 402863 w 3634592"/>
                <a:gd name="connsiteY110" fmla="*/ 1151679 h 2416069"/>
                <a:gd name="connsiteX111" fmla="*/ 420081 w 3634592"/>
                <a:gd name="connsiteY111" fmla="*/ 1151679 h 2416069"/>
                <a:gd name="connsiteX112" fmla="*/ 420081 w 3634592"/>
                <a:gd name="connsiteY112" fmla="*/ 1170965 h 2416069"/>
                <a:gd name="connsiteX113" fmla="*/ 426939 w 3634592"/>
                <a:gd name="connsiteY113" fmla="*/ 1170965 h 2416069"/>
                <a:gd name="connsiteX114" fmla="*/ 426939 w 3634592"/>
                <a:gd name="connsiteY114" fmla="*/ 1190251 h 2416069"/>
                <a:gd name="connsiteX115" fmla="*/ 440703 w 3634592"/>
                <a:gd name="connsiteY115" fmla="*/ 1190251 h 2416069"/>
                <a:gd name="connsiteX116" fmla="*/ 440751 w 3634592"/>
                <a:gd name="connsiteY116" fmla="*/ 1209837 h 2416069"/>
                <a:gd name="connsiteX117" fmla="*/ 461374 w 3634592"/>
                <a:gd name="connsiteY117" fmla="*/ 1209837 h 2416069"/>
                <a:gd name="connsiteX118" fmla="*/ 461374 w 3634592"/>
                <a:gd name="connsiteY118" fmla="*/ 1229423 h 2416069"/>
                <a:gd name="connsiteX119" fmla="*/ 464827 w 3634592"/>
                <a:gd name="connsiteY119" fmla="*/ 1229423 h 2416069"/>
                <a:gd name="connsiteX120" fmla="*/ 464827 w 3634592"/>
                <a:gd name="connsiteY120" fmla="*/ 1249009 h 2416069"/>
                <a:gd name="connsiteX121" fmla="*/ 482045 w 3634592"/>
                <a:gd name="connsiteY121" fmla="*/ 1249009 h 2416069"/>
                <a:gd name="connsiteX122" fmla="*/ 482045 w 3634592"/>
                <a:gd name="connsiteY122" fmla="*/ 1268896 h 2416069"/>
                <a:gd name="connsiteX123" fmla="*/ 492356 w 3634592"/>
                <a:gd name="connsiteY123" fmla="*/ 1268896 h 2416069"/>
                <a:gd name="connsiteX124" fmla="*/ 492356 w 3634592"/>
                <a:gd name="connsiteY124" fmla="*/ 1288843 h 2416069"/>
                <a:gd name="connsiteX125" fmla="*/ 499263 w 3634592"/>
                <a:gd name="connsiteY125" fmla="*/ 1288843 h 2416069"/>
                <a:gd name="connsiteX126" fmla="*/ 499263 w 3634592"/>
                <a:gd name="connsiteY126" fmla="*/ 1309030 h 2416069"/>
                <a:gd name="connsiteX127" fmla="*/ 502716 w 3634592"/>
                <a:gd name="connsiteY127" fmla="*/ 1309030 h 2416069"/>
                <a:gd name="connsiteX128" fmla="*/ 502716 w 3634592"/>
                <a:gd name="connsiteY128" fmla="*/ 1329277 h 2416069"/>
                <a:gd name="connsiteX129" fmla="*/ 519933 w 3634592"/>
                <a:gd name="connsiteY129" fmla="*/ 1329277 h 2416069"/>
                <a:gd name="connsiteX130" fmla="*/ 519933 w 3634592"/>
                <a:gd name="connsiteY130" fmla="*/ 1349524 h 2416069"/>
                <a:gd name="connsiteX131" fmla="*/ 523338 w 3634592"/>
                <a:gd name="connsiteY131" fmla="*/ 1349524 h 2416069"/>
                <a:gd name="connsiteX132" fmla="*/ 523386 w 3634592"/>
                <a:gd name="connsiteY132" fmla="*/ 1369771 h 2416069"/>
                <a:gd name="connsiteX133" fmla="*/ 530245 w 3634592"/>
                <a:gd name="connsiteY133" fmla="*/ 1369771 h 2416069"/>
                <a:gd name="connsiteX134" fmla="*/ 530245 w 3634592"/>
                <a:gd name="connsiteY134" fmla="*/ 1390018 h 2416069"/>
                <a:gd name="connsiteX135" fmla="*/ 537151 w 3634592"/>
                <a:gd name="connsiteY135" fmla="*/ 1390018 h 2416069"/>
                <a:gd name="connsiteX136" fmla="*/ 537151 w 3634592"/>
                <a:gd name="connsiteY136" fmla="*/ 1410265 h 2416069"/>
                <a:gd name="connsiteX137" fmla="*/ 540556 w 3634592"/>
                <a:gd name="connsiteY137" fmla="*/ 1410265 h 2416069"/>
                <a:gd name="connsiteX138" fmla="*/ 540604 w 3634592"/>
                <a:gd name="connsiteY138" fmla="*/ 1450699 h 2416069"/>
                <a:gd name="connsiteX139" fmla="*/ 544009 w 3634592"/>
                <a:gd name="connsiteY139" fmla="*/ 1450699 h 2416069"/>
                <a:gd name="connsiteX140" fmla="*/ 544009 w 3634592"/>
                <a:gd name="connsiteY140" fmla="*/ 1470946 h 2416069"/>
                <a:gd name="connsiteX141" fmla="*/ 571586 w 3634592"/>
                <a:gd name="connsiteY141" fmla="*/ 1470946 h 2416069"/>
                <a:gd name="connsiteX142" fmla="*/ 571586 w 3634592"/>
                <a:gd name="connsiteY142" fmla="*/ 1492034 h 2416069"/>
                <a:gd name="connsiteX143" fmla="*/ 578444 w 3634592"/>
                <a:gd name="connsiteY143" fmla="*/ 1492034 h 2416069"/>
                <a:gd name="connsiteX144" fmla="*/ 578444 w 3634592"/>
                <a:gd name="connsiteY144" fmla="*/ 1513122 h 2416069"/>
                <a:gd name="connsiteX145" fmla="*/ 602568 w 3634592"/>
                <a:gd name="connsiteY145" fmla="*/ 1513122 h 2416069"/>
                <a:gd name="connsiteX146" fmla="*/ 602568 w 3634592"/>
                <a:gd name="connsiteY146" fmla="*/ 1534211 h 2416069"/>
                <a:gd name="connsiteX147" fmla="*/ 619786 w 3634592"/>
                <a:gd name="connsiteY147" fmla="*/ 1534211 h 2416069"/>
                <a:gd name="connsiteX148" fmla="*/ 619786 w 3634592"/>
                <a:gd name="connsiteY148" fmla="*/ 1555299 h 2416069"/>
                <a:gd name="connsiteX149" fmla="*/ 626644 w 3634592"/>
                <a:gd name="connsiteY149" fmla="*/ 1555299 h 2416069"/>
                <a:gd name="connsiteX150" fmla="*/ 626644 w 3634592"/>
                <a:gd name="connsiteY150" fmla="*/ 1576327 h 2416069"/>
                <a:gd name="connsiteX151" fmla="*/ 633550 w 3634592"/>
                <a:gd name="connsiteY151" fmla="*/ 1576327 h 2416069"/>
                <a:gd name="connsiteX152" fmla="*/ 633550 w 3634592"/>
                <a:gd name="connsiteY152" fmla="*/ 1597415 h 2416069"/>
                <a:gd name="connsiteX153" fmla="*/ 643862 w 3634592"/>
                <a:gd name="connsiteY153" fmla="*/ 1597415 h 2416069"/>
                <a:gd name="connsiteX154" fmla="*/ 643862 w 3634592"/>
                <a:gd name="connsiteY154" fmla="*/ 1618503 h 2416069"/>
                <a:gd name="connsiteX155" fmla="*/ 650768 w 3634592"/>
                <a:gd name="connsiteY155" fmla="*/ 1618503 h 2416069"/>
                <a:gd name="connsiteX156" fmla="*/ 650768 w 3634592"/>
                <a:gd name="connsiteY156" fmla="*/ 1639591 h 2416069"/>
                <a:gd name="connsiteX157" fmla="*/ 657626 w 3634592"/>
                <a:gd name="connsiteY157" fmla="*/ 1639591 h 2416069"/>
                <a:gd name="connsiteX158" fmla="*/ 657674 w 3634592"/>
                <a:gd name="connsiteY158" fmla="*/ 1660680 h 2416069"/>
                <a:gd name="connsiteX159" fmla="*/ 671439 w 3634592"/>
                <a:gd name="connsiteY159" fmla="*/ 1660680 h 2416069"/>
                <a:gd name="connsiteX160" fmla="*/ 671439 w 3634592"/>
                <a:gd name="connsiteY160" fmla="*/ 1681768 h 2416069"/>
                <a:gd name="connsiteX161" fmla="*/ 695514 w 3634592"/>
                <a:gd name="connsiteY161" fmla="*/ 1681768 h 2416069"/>
                <a:gd name="connsiteX162" fmla="*/ 695514 w 3634592"/>
                <a:gd name="connsiteY162" fmla="*/ 1702856 h 2416069"/>
                <a:gd name="connsiteX163" fmla="*/ 729950 w 3634592"/>
                <a:gd name="connsiteY163" fmla="*/ 1702856 h 2416069"/>
                <a:gd name="connsiteX164" fmla="*/ 729950 w 3634592"/>
                <a:gd name="connsiteY164" fmla="*/ 1744972 h 2416069"/>
                <a:gd name="connsiteX165" fmla="*/ 736856 w 3634592"/>
                <a:gd name="connsiteY165" fmla="*/ 1744972 h 2416069"/>
                <a:gd name="connsiteX166" fmla="*/ 736856 w 3634592"/>
                <a:gd name="connsiteY166" fmla="*/ 1766060 h 2416069"/>
                <a:gd name="connsiteX167" fmla="*/ 791962 w 3634592"/>
                <a:gd name="connsiteY167" fmla="*/ 1766060 h 2416069"/>
                <a:gd name="connsiteX168" fmla="*/ 791962 w 3634592"/>
                <a:gd name="connsiteY168" fmla="*/ 1787149 h 2416069"/>
                <a:gd name="connsiteX169" fmla="*/ 805726 w 3634592"/>
                <a:gd name="connsiteY169" fmla="*/ 1787149 h 2416069"/>
                <a:gd name="connsiteX170" fmla="*/ 805726 w 3634592"/>
                <a:gd name="connsiteY170" fmla="*/ 1808237 h 2416069"/>
                <a:gd name="connsiteX171" fmla="*/ 816038 w 3634592"/>
                <a:gd name="connsiteY171" fmla="*/ 1808237 h 2416069"/>
                <a:gd name="connsiteX172" fmla="*/ 816038 w 3634592"/>
                <a:gd name="connsiteY172" fmla="*/ 1829325 h 2416069"/>
                <a:gd name="connsiteX173" fmla="*/ 833255 w 3634592"/>
                <a:gd name="connsiteY173" fmla="*/ 1829325 h 2416069"/>
                <a:gd name="connsiteX174" fmla="*/ 833255 w 3634592"/>
                <a:gd name="connsiteY174" fmla="*/ 1850413 h 2416069"/>
                <a:gd name="connsiteX175" fmla="*/ 843567 w 3634592"/>
                <a:gd name="connsiteY175" fmla="*/ 1850413 h 2416069"/>
                <a:gd name="connsiteX176" fmla="*/ 843615 w 3634592"/>
                <a:gd name="connsiteY176" fmla="*/ 1871501 h 2416069"/>
                <a:gd name="connsiteX177" fmla="*/ 853926 w 3634592"/>
                <a:gd name="connsiteY177" fmla="*/ 1871501 h 2416069"/>
                <a:gd name="connsiteX178" fmla="*/ 853926 w 3634592"/>
                <a:gd name="connsiteY178" fmla="*/ 1892590 h 2416069"/>
                <a:gd name="connsiteX179" fmla="*/ 864237 w 3634592"/>
                <a:gd name="connsiteY179" fmla="*/ 1892590 h 2416069"/>
                <a:gd name="connsiteX180" fmla="*/ 864237 w 3634592"/>
                <a:gd name="connsiteY180" fmla="*/ 1913618 h 2416069"/>
                <a:gd name="connsiteX181" fmla="*/ 905579 w 3634592"/>
                <a:gd name="connsiteY181" fmla="*/ 1913618 h 2416069"/>
                <a:gd name="connsiteX182" fmla="*/ 905579 w 3634592"/>
                <a:gd name="connsiteY182" fmla="*/ 1935547 h 2416069"/>
                <a:gd name="connsiteX183" fmla="*/ 1063942 w 3634592"/>
                <a:gd name="connsiteY183" fmla="*/ 1935547 h 2416069"/>
                <a:gd name="connsiteX184" fmla="*/ 1063990 w 3634592"/>
                <a:gd name="connsiteY184" fmla="*/ 1959339 h 2416069"/>
                <a:gd name="connsiteX185" fmla="*/ 1122501 w 3634592"/>
                <a:gd name="connsiteY185" fmla="*/ 1959339 h 2416069"/>
                <a:gd name="connsiteX186" fmla="*/ 1122501 w 3634592"/>
                <a:gd name="connsiteY186" fmla="*/ 1983131 h 2416069"/>
                <a:gd name="connsiteX187" fmla="*/ 1191372 w 3634592"/>
                <a:gd name="connsiteY187" fmla="*/ 1983131 h 2416069"/>
                <a:gd name="connsiteX188" fmla="*/ 1191372 w 3634592"/>
                <a:gd name="connsiteY188" fmla="*/ 2006922 h 2416069"/>
                <a:gd name="connsiteX189" fmla="*/ 1322206 w 3634592"/>
                <a:gd name="connsiteY189" fmla="*/ 2006922 h 2416069"/>
                <a:gd name="connsiteX190" fmla="*/ 1322206 w 3634592"/>
                <a:gd name="connsiteY190" fmla="*/ 2030714 h 2416069"/>
                <a:gd name="connsiteX191" fmla="*/ 1401388 w 3634592"/>
                <a:gd name="connsiteY191" fmla="*/ 2030714 h 2416069"/>
                <a:gd name="connsiteX192" fmla="*/ 1401436 w 3634592"/>
                <a:gd name="connsiteY192" fmla="*/ 2055828 h 2416069"/>
                <a:gd name="connsiteX193" fmla="*/ 1504694 w 3634592"/>
                <a:gd name="connsiteY193" fmla="*/ 2055828 h 2416069"/>
                <a:gd name="connsiteX194" fmla="*/ 1504694 w 3634592"/>
                <a:gd name="connsiteY194" fmla="*/ 2082503 h 2416069"/>
                <a:gd name="connsiteX195" fmla="*/ 1546035 w 3634592"/>
                <a:gd name="connsiteY195" fmla="*/ 2082503 h 2416069"/>
                <a:gd name="connsiteX196" fmla="*/ 1546035 w 3634592"/>
                <a:gd name="connsiteY196" fmla="*/ 2109179 h 2416069"/>
                <a:gd name="connsiteX197" fmla="*/ 1583923 w 3634592"/>
                <a:gd name="connsiteY197" fmla="*/ 2109179 h 2416069"/>
                <a:gd name="connsiteX198" fmla="*/ 1583923 w 3634592"/>
                <a:gd name="connsiteY198" fmla="*/ 2135915 h 2416069"/>
                <a:gd name="connsiteX199" fmla="*/ 1666558 w 3634592"/>
                <a:gd name="connsiteY199" fmla="*/ 2135915 h 2416069"/>
                <a:gd name="connsiteX200" fmla="*/ 1666558 w 3634592"/>
                <a:gd name="connsiteY200" fmla="*/ 2162591 h 2416069"/>
                <a:gd name="connsiteX201" fmla="*/ 1680323 w 3634592"/>
                <a:gd name="connsiteY201" fmla="*/ 2162591 h 2416069"/>
                <a:gd name="connsiteX202" fmla="*/ 1680323 w 3634592"/>
                <a:gd name="connsiteY202" fmla="*/ 2189266 h 2416069"/>
                <a:gd name="connsiteX203" fmla="*/ 1855904 w 3634592"/>
                <a:gd name="connsiteY203" fmla="*/ 2189266 h 2416069"/>
                <a:gd name="connsiteX204" fmla="*/ 1855952 w 3634592"/>
                <a:gd name="connsiteY204" fmla="*/ 2215942 h 2416069"/>
                <a:gd name="connsiteX205" fmla="*/ 2004004 w 3634592"/>
                <a:gd name="connsiteY205" fmla="*/ 2215942 h 2416069"/>
                <a:gd name="connsiteX206" fmla="*/ 2004004 w 3634592"/>
                <a:gd name="connsiteY206" fmla="*/ 2296029 h 2416069"/>
                <a:gd name="connsiteX207" fmla="*/ 2152057 w 3634592"/>
                <a:gd name="connsiteY207" fmla="*/ 2296029 h 2416069"/>
                <a:gd name="connsiteX208" fmla="*/ 2152057 w 3634592"/>
                <a:gd name="connsiteY208" fmla="*/ 2322704 h 2416069"/>
                <a:gd name="connsiteX209" fmla="*/ 2382744 w 3634592"/>
                <a:gd name="connsiteY209" fmla="*/ 2322704 h 2416069"/>
                <a:gd name="connsiteX210" fmla="*/ 2382744 w 3634592"/>
                <a:gd name="connsiteY210" fmla="*/ 2349380 h 2416069"/>
                <a:gd name="connsiteX211" fmla="*/ 2857930 w 3634592"/>
                <a:gd name="connsiteY211" fmla="*/ 2349380 h 2416069"/>
                <a:gd name="connsiteX212" fmla="*/ 2857930 w 3634592"/>
                <a:gd name="connsiteY212" fmla="*/ 2382725 h 2416069"/>
                <a:gd name="connsiteX213" fmla="*/ 3105835 w 3634592"/>
                <a:gd name="connsiteY213" fmla="*/ 2382725 h 2416069"/>
                <a:gd name="connsiteX214" fmla="*/ 3105835 w 3634592"/>
                <a:gd name="connsiteY214" fmla="*/ 2416069 h 2416069"/>
                <a:gd name="connsiteX215" fmla="*/ 3634593 w 3634592"/>
                <a:gd name="connsiteY215" fmla="*/ 2416069 h 24160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</a:cxnLst>
              <a:rect l="l" t="t" r="r" b="b"/>
              <a:pathLst>
                <a:path w="3634592" h="2416069">
                  <a:moveTo>
                    <a:pt x="0" y="0"/>
                  </a:moveTo>
                  <a:lnTo>
                    <a:pt x="17170" y="0"/>
                  </a:lnTo>
                  <a:lnTo>
                    <a:pt x="17218" y="16462"/>
                  </a:lnTo>
                  <a:lnTo>
                    <a:pt x="20623" y="16462"/>
                  </a:lnTo>
                  <a:lnTo>
                    <a:pt x="20623" y="32864"/>
                  </a:lnTo>
                  <a:lnTo>
                    <a:pt x="27529" y="32864"/>
                  </a:lnTo>
                  <a:lnTo>
                    <a:pt x="27529" y="49326"/>
                  </a:lnTo>
                  <a:lnTo>
                    <a:pt x="37840" y="49326"/>
                  </a:lnTo>
                  <a:lnTo>
                    <a:pt x="37840" y="65968"/>
                  </a:lnTo>
                  <a:lnTo>
                    <a:pt x="48200" y="65968"/>
                  </a:lnTo>
                  <a:lnTo>
                    <a:pt x="48200" y="99313"/>
                  </a:lnTo>
                  <a:lnTo>
                    <a:pt x="55058" y="99313"/>
                  </a:lnTo>
                  <a:lnTo>
                    <a:pt x="55058" y="132657"/>
                  </a:lnTo>
                  <a:lnTo>
                    <a:pt x="65417" y="132657"/>
                  </a:lnTo>
                  <a:lnTo>
                    <a:pt x="65417" y="149300"/>
                  </a:lnTo>
                  <a:lnTo>
                    <a:pt x="68822" y="149300"/>
                  </a:lnTo>
                  <a:lnTo>
                    <a:pt x="68870" y="166002"/>
                  </a:lnTo>
                  <a:lnTo>
                    <a:pt x="72276" y="166002"/>
                  </a:lnTo>
                  <a:lnTo>
                    <a:pt x="72276" y="199346"/>
                  </a:lnTo>
                  <a:lnTo>
                    <a:pt x="75729" y="199346"/>
                  </a:lnTo>
                  <a:lnTo>
                    <a:pt x="75729" y="215989"/>
                  </a:lnTo>
                  <a:lnTo>
                    <a:pt x="79182" y="215989"/>
                  </a:lnTo>
                  <a:lnTo>
                    <a:pt x="79182" y="232691"/>
                  </a:lnTo>
                  <a:lnTo>
                    <a:pt x="82635" y="232691"/>
                  </a:lnTo>
                  <a:lnTo>
                    <a:pt x="82635" y="249333"/>
                  </a:lnTo>
                  <a:lnTo>
                    <a:pt x="86040" y="249333"/>
                  </a:lnTo>
                  <a:lnTo>
                    <a:pt x="86088" y="282678"/>
                  </a:lnTo>
                  <a:lnTo>
                    <a:pt x="92946" y="282678"/>
                  </a:lnTo>
                  <a:lnTo>
                    <a:pt x="92946" y="299440"/>
                  </a:lnTo>
                  <a:lnTo>
                    <a:pt x="96399" y="299440"/>
                  </a:lnTo>
                  <a:lnTo>
                    <a:pt x="96399" y="316263"/>
                  </a:lnTo>
                  <a:lnTo>
                    <a:pt x="106711" y="316263"/>
                  </a:lnTo>
                  <a:lnTo>
                    <a:pt x="106711" y="333025"/>
                  </a:lnTo>
                  <a:lnTo>
                    <a:pt x="110164" y="333025"/>
                  </a:lnTo>
                  <a:lnTo>
                    <a:pt x="110164" y="366670"/>
                  </a:lnTo>
                  <a:lnTo>
                    <a:pt x="117070" y="366670"/>
                  </a:lnTo>
                  <a:lnTo>
                    <a:pt x="117070" y="383553"/>
                  </a:lnTo>
                  <a:lnTo>
                    <a:pt x="123928" y="383553"/>
                  </a:lnTo>
                  <a:lnTo>
                    <a:pt x="123928" y="400495"/>
                  </a:lnTo>
                  <a:lnTo>
                    <a:pt x="137693" y="400495"/>
                  </a:lnTo>
                  <a:lnTo>
                    <a:pt x="137693" y="417558"/>
                  </a:lnTo>
                  <a:lnTo>
                    <a:pt x="141146" y="417558"/>
                  </a:lnTo>
                  <a:lnTo>
                    <a:pt x="141146" y="434621"/>
                  </a:lnTo>
                  <a:lnTo>
                    <a:pt x="144599" y="434621"/>
                  </a:lnTo>
                  <a:lnTo>
                    <a:pt x="144599" y="451684"/>
                  </a:lnTo>
                  <a:lnTo>
                    <a:pt x="151505" y="451684"/>
                  </a:lnTo>
                  <a:lnTo>
                    <a:pt x="151505" y="468747"/>
                  </a:lnTo>
                  <a:lnTo>
                    <a:pt x="154910" y="468747"/>
                  </a:lnTo>
                  <a:lnTo>
                    <a:pt x="154910" y="485990"/>
                  </a:lnTo>
                  <a:lnTo>
                    <a:pt x="158364" y="485990"/>
                  </a:lnTo>
                  <a:lnTo>
                    <a:pt x="158364" y="503173"/>
                  </a:lnTo>
                  <a:lnTo>
                    <a:pt x="165270" y="503173"/>
                  </a:lnTo>
                  <a:lnTo>
                    <a:pt x="165270" y="520596"/>
                  </a:lnTo>
                  <a:lnTo>
                    <a:pt x="179034" y="520596"/>
                  </a:lnTo>
                  <a:lnTo>
                    <a:pt x="179034" y="538079"/>
                  </a:lnTo>
                  <a:lnTo>
                    <a:pt x="189346" y="538079"/>
                  </a:lnTo>
                  <a:lnTo>
                    <a:pt x="189346" y="555623"/>
                  </a:lnTo>
                  <a:lnTo>
                    <a:pt x="196252" y="555623"/>
                  </a:lnTo>
                  <a:lnTo>
                    <a:pt x="196252" y="573286"/>
                  </a:lnTo>
                  <a:lnTo>
                    <a:pt x="199705" y="573286"/>
                  </a:lnTo>
                  <a:lnTo>
                    <a:pt x="199705" y="590950"/>
                  </a:lnTo>
                  <a:lnTo>
                    <a:pt x="210016" y="590950"/>
                  </a:lnTo>
                  <a:lnTo>
                    <a:pt x="210016" y="608674"/>
                  </a:lnTo>
                  <a:lnTo>
                    <a:pt x="213470" y="608674"/>
                  </a:lnTo>
                  <a:lnTo>
                    <a:pt x="213470" y="626337"/>
                  </a:lnTo>
                  <a:lnTo>
                    <a:pt x="220328" y="626337"/>
                  </a:lnTo>
                  <a:lnTo>
                    <a:pt x="220376" y="661664"/>
                  </a:lnTo>
                  <a:lnTo>
                    <a:pt x="230687" y="661664"/>
                  </a:lnTo>
                  <a:lnTo>
                    <a:pt x="230687" y="697052"/>
                  </a:lnTo>
                  <a:lnTo>
                    <a:pt x="234140" y="697052"/>
                  </a:lnTo>
                  <a:lnTo>
                    <a:pt x="234140" y="714715"/>
                  </a:lnTo>
                  <a:lnTo>
                    <a:pt x="247905" y="714715"/>
                  </a:lnTo>
                  <a:lnTo>
                    <a:pt x="247905" y="732619"/>
                  </a:lnTo>
                  <a:lnTo>
                    <a:pt x="265122" y="732619"/>
                  </a:lnTo>
                  <a:lnTo>
                    <a:pt x="265122" y="750463"/>
                  </a:lnTo>
                  <a:lnTo>
                    <a:pt x="271981" y="750463"/>
                  </a:lnTo>
                  <a:lnTo>
                    <a:pt x="272029" y="786151"/>
                  </a:lnTo>
                  <a:lnTo>
                    <a:pt x="275434" y="786151"/>
                  </a:lnTo>
                  <a:lnTo>
                    <a:pt x="275434" y="804055"/>
                  </a:lnTo>
                  <a:lnTo>
                    <a:pt x="278887" y="804055"/>
                  </a:lnTo>
                  <a:lnTo>
                    <a:pt x="278887" y="821899"/>
                  </a:lnTo>
                  <a:lnTo>
                    <a:pt x="285793" y="821899"/>
                  </a:lnTo>
                  <a:lnTo>
                    <a:pt x="285793" y="839742"/>
                  </a:lnTo>
                  <a:lnTo>
                    <a:pt x="289198" y="839742"/>
                  </a:lnTo>
                  <a:lnTo>
                    <a:pt x="289198" y="857586"/>
                  </a:lnTo>
                  <a:lnTo>
                    <a:pt x="296104" y="857586"/>
                  </a:lnTo>
                  <a:lnTo>
                    <a:pt x="296104" y="875490"/>
                  </a:lnTo>
                  <a:lnTo>
                    <a:pt x="303011" y="875490"/>
                  </a:lnTo>
                  <a:lnTo>
                    <a:pt x="303011" y="893334"/>
                  </a:lnTo>
                  <a:lnTo>
                    <a:pt x="313322" y="893334"/>
                  </a:lnTo>
                  <a:lnTo>
                    <a:pt x="313322" y="911178"/>
                  </a:lnTo>
                  <a:lnTo>
                    <a:pt x="320180" y="911178"/>
                  </a:lnTo>
                  <a:lnTo>
                    <a:pt x="320228" y="946926"/>
                  </a:lnTo>
                  <a:lnTo>
                    <a:pt x="330540" y="946926"/>
                  </a:lnTo>
                  <a:lnTo>
                    <a:pt x="330540" y="965190"/>
                  </a:lnTo>
                  <a:lnTo>
                    <a:pt x="340851" y="965190"/>
                  </a:lnTo>
                  <a:lnTo>
                    <a:pt x="340851" y="983454"/>
                  </a:lnTo>
                  <a:lnTo>
                    <a:pt x="351210" y="983454"/>
                  </a:lnTo>
                  <a:lnTo>
                    <a:pt x="351210" y="1001779"/>
                  </a:lnTo>
                  <a:lnTo>
                    <a:pt x="354615" y="1001779"/>
                  </a:lnTo>
                  <a:lnTo>
                    <a:pt x="354663" y="1038308"/>
                  </a:lnTo>
                  <a:lnTo>
                    <a:pt x="368428" y="1038308"/>
                  </a:lnTo>
                  <a:lnTo>
                    <a:pt x="368428" y="1057113"/>
                  </a:lnTo>
                  <a:lnTo>
                    <a:pt x="382192" y="1057113"/>
                  </a:lnTo>
                  <a:lnTo>
                    <a:pt x="382192" y="1094603"/>
                  </a:lnTo>
                  <a:lnTo>
                    <a:pt x="389051" y="1094603"/>
                  </a:lnTo>
                  <a:lnTo>
                    <a:pt x="389099" y="1113348"/>
                  </a:lnTo>
                  <a:lnTo>
                    <a:pt x="399410" y="1113348"/>
                  </a:lnTo>
                  <a:lnTo>
                    <a:pt x="399410" y="1132394"/>
                  </a:lnTo>
                  <a:lnTo>
                    <a:pt x="402863" y="1132394"/>
                  </a:lnTo>
                  <a:lnTo>
                    <a:pt x="402863" y="1151679"/>
                  </a:lnTo>
                  <a:lnTo>
                    <a:pt x="420081" y="1151679"/>
                  </a:lnTo>
                  <a:lnTo>
                    <a:pt x="420081" y="1170965"/>
                  </a:lnTo>
                  <a:lnTo>
                    <a:pt x="426939" y="1170965"/>
                  </a:lnTo>
                  <a:lnTo>
                    <a:pt x="426939" y="1190251"/>
                  </a:lnTo>
                  <a:lnTo>
                    <a:pt x="440703" y="1190251"/>
                  </a:lnTo>
                  <a:lnTo>
                    <a:pt x="440751" y="1209837"/>
                  </a:lnTo>
                  <a:lnTo>
                    <a:pt x="461374" y="1209837"/>
                  </a:lnTo>
                  <a:lnTo>
                    <a:pt x="461374" y="1229423"/>
                  </a:lnTo>
                  <a:lnTo>
                    <a:pt x="464827" y="1229423"/>
                  </a:lnTo>
                  <a:lnTo>
                    <a:pt x="464827" y="1249009"/>
                  </a:lnTo>
                  <a:lnTo>
                    <a:pt x="482045" y="1249009"/>
                  </a:lnTo>
                  <a:lnTo>
                    <a:pt x="482045" y="1268896"/>
                  </a:lnTo>
                  <a:lnTo>
                    <a:pt x="492356" y="1268896"/>
                  </a:lnTo>
                  <a:lnTo>
                    <a:pt x="492356" y="1288843"/>
                  </a:lnTo>
                  <a:lnTo>
                    <a:pt x="499263" y="1288843"/>
                  </a:lnTo>
                  <a:lnTo>
                    <a:pt x="499263" y="1309030"/>
                  </a:lnTo>
                  <a:lnTo>
                    <a:pt x="502716" y="1309030"/>
                  </a:lnTo>
                  <a:lnTo>
                    <a:pt x="502716" y="1329277"/>
                  </a:lnTo>
                  <a:lnTo>
                    <a:pt x="519933" y="1329277"/>
                  </a:lnTo>
                  <a:lnTo>
                    <a:pt x="519933" y="1349524"/>
                  </a:lnTo>
                  <a:lnTo>
                    <a:pt x="523338" y="1349524"/>
                  </a:lnTo>
                  <a:lnTo>
                    <a:pt x="523386" y="1369771"/>
                  </a:lnTo>
                  <a:lnTo>
                    <a:pt x="530245" y="1369771"/>
                  </a:lnTo>
                  <a:lnTo>
                    <a:pt x="530245" y="1390018"/>
                  </a:lnTo>
                  <a:lnTo>
                    <a:pt x="537151" y="1390018"/>
                  </a:lnTo>
                  <a:lnTo>
                    <a:pt x="537151" y="1410265"/>
                  </a:lnTo>
                  <a:lnTo>
                    <a:pt x="540556" y="1410265"/>
                  </a:lnTo>
                  <a:lnTo>
                    <a:pt x="540604" y="1450699"/>
                  </a:lnTo>
                  <a:lnTo>
                    <a:pt x="544009" y="1450699"/>
                  </a:lnTo>
                  <a:lnTo>
                    <a:pt x="544009" y="1470946"/>
                  </a:lnTo>
                  <a:lnTo>
                    <a:pt x="571586" y="1470946"/>
                  </a:lnTo>
                  <a:lnTo>
                    <a:pt x="571586" y="1492034"/>
                  </a:lnTo>
                  <a:lnTo>
                    <a:pt x="578444" y="1492034"/>
                  </a:lnTo>
                  <a:lnTo>
                    <a:pt x="578444" y="1513122"/>
                  </a:lnTo>
                  <a:lnTo>
                    <a:pt x="602568" y="1513122"/>
                  </a:lnTo>
                  <a:lnTo>
                    <a:pt x="602568" y="1534211"/>
                  </a:lnTo>
                  <a:lnTo>
                    <a:pt x="619786" y="1534211"/>
                  </a:lnTo>
                  <a:lnTo>
                    <a:pt x="619786" y="1555299"/>
                  </a:lnTo>
                  <a:lnTo>
                    <a:pt x="626644" y="1555299"/>
                  </a:lnTo>
                  <a:lnTo>
                    <a:pt x="626644" y="1576327"/>
                  </a:lnTo>
                  <a:lnTo>
                    <a:pt x="633550" y="1576327"/>
                  </a:lnTo>
                  <a:lnTo>
                    <a:pt x="633550" y="1597415"/>
                  </a:lnTo>
                  <a:lnTo>
                    <a:pt x="643862" y="1597415"/>
                  </a:lnTo>
                  <a:lnTo>
                    <a:pt x="643862" y="1618503"/>
                  </a:lnTo>
                  <a:lnTo>
                    <a:pt x="650768" y="1618503"/>
                  </a:lnTo>
                  <a:lnTo>
                    <a:pt x="650768" y="1639591"/>
                  </a:lnTo>
                  <a:lnTo>
                    <a:pt x="657626" y="1639591"/>
                  </a:lnTo>
                  <a:lnTo>
                    <a:pt x="657674" y="1660680"/>
                  </a:lnTo>
                  <a:lnTo>
                    <a:pt x="671439" y="1660680"/>
                  </a:lnTo>
                  <a:lnTo>
                    <a:pt x="671439" y="1681768"/>
                  </a:lnTo>
                  <a:lnTo>
                    <a:pt x="695514" y="1681768"/>
                  </a:lnTo>
                  <a:lnTo>
                    <a:pt x="695514" y="1702856"/>
                  </a:lnTo>
                  <a:lnTo>
                    <a:pt x="729950" y="1702856"/>
                  </a:lnTo>
                  <a:lnTo>
                    <a:pt x="729950" y="1744972"/>
                  </a:lnTo>
                  <a:lnTo>
                    <a:pt x="736856" y="1744972"/>
                  </a:lnTo>
                  <a:lnTo>
                    <a:pt x="736856" y="1766060"/>
                  </a:lnTo>
                  <a:lnTo>
                    <a:pt x="791962" y="1766060"/>
                  </a:lnTo>
                  <a:lnTo>
                    <a:pt x="791962" y="1787149"/>
                  </a:lnTo>
                  <a:lnTo>
                    <a:pt x="805726" y="1787149"/>
                  </a:lnTo>
                  <a:lnTo>
                    <a:pt x="805726" y="1808237"/>
                  </a:lnTo>
                  <a:lnTo>
                    <a:pt x="816038" y="1808237"/>
                  </a:lnTo>
                  <a:lnTo>
                    <a:pt x="816038" y="1829325"/>
                  </a:lnTo>
                  <a:lnTo>
                    <a:pt x="833255" y="1829325"/>
                  </a:lnTo>
                  <a:lnTo>
                    <a:pt x="833255" y="1850413"/>
                  </a:lnTo>
                  <a:lnTo>
                    <a:pt x="843567" y="1850413"/>
                  </a:lnTo>
                  <a:lnTo>
                    <a:pt x="843615" y="1871501"/>
                  </a:lnTo>
                  <a:lnTo>
                    <a:pt x="853926" y="1871501"/>
                  </a:lnTo>
                  <a:lnTo>
                    <a:pt x="853926" y="1892590"/>
                  </a:lnTo>
                  <a:lnTo>
                    <a:pt x="864237" y="1892590"/>
                  </a:lnTo>
                  <a:lnTo>
                    <a:pt x="864237" y="1913618"/>
                  </a:lnTo>
                  <a:lnTo>
                    <a:pt x="905579" y="1913618"/>
                  </a:lnTo>
                  <a:lnTo>
                    <a:pt x="905579" y="1935547"/>
                  </a:lnTo>
                  <a:lnTo>
                    <a:pt x="1063942" y="1935547"/>
                  </a:lnTo>
                  <a:lnTo>
                    <a:pt x="1063990" y="1959339"/>
                  </a:lnTo>
                  <a:lnTo>
                    <a:pt x="1122501" y="1959339"/>
                  </a:lnTo>
                  <a:lnTo>
                    <a:pt x="1122501" y="1983131"/>
                  </a:lnTo>
                  <a:lnTo>
                    <a:pt x="1191372" y="1983131"/>
                  </a:lnTo>
                  <a:lnTo>
                    <a:pt x="1191372" y="2006922"/>
                  </a:lnTo>
                  <a:lnTo>
                    <a:pt x="1322206" y="2006922"/>
                  </a:lnTo>
                  <a:lnTo>
                    <a:pt x="1322206" y="2030714"/>
                  </a:lnTo>
                  <a:lnTo>
                    <a:pt x="1401388" y="2030714"/>
                  </a:lnTo>
                  <a:lnTo>
                    <a:pt x="1401436" y="2055828"/>
                  </a:lnTo>
                  <a:lnTo>
                    <a:pt x="1504694" y="2055828"/>
                  </a:lnTo>
                  <a:lnTo>
                    <a:pt x="1504694" y="2082503"/>
                  </a:lnTo>
                  <a:lnTo>
                    <a:pt x="1546035" y="2082503"/>
                  </a:lnTo>
                  <a:lnTo>
                    <a:pt x="1546035" y="2109179"/>
                  </a:lnTo>
                  <a:lnTo>
                    <a:pt x="1583923" y="2109179"/>
                  </a:lnTo>
                  <a:lnTo>
                    <a:pt x="1583923" y="2135915"/>
                  </a:lnTo>
                  <a:lnTo>
                    <a:pt x="1666558" y="2135915"/>
                  </a:lnTo>
                  <a:lnTo>
                    <a:pt x="1666558" y="2162591"/>
                  </a:lnTo>
                  <a:lnTo>
                    <a:pt x="1680323" y="2162591"/>
                  </a:lnTo>
                  <a:lnTo>
                    <a:pt x="1680323" y="2189266"/>
                  </a:lnTo>
                  <a:lnTo>
                    <a:pt x="1855904" y="2189266"/>
                  </a:lnTo>
                  <a:lnTo>
                    <a:pt x="1855952" y="2215942"/>
                  </a:lnTo>
                  <a:lnTo>
                    <a:pt x="2004004" y="2215942"/>
                  </a:lnTo>
                  <a:lnTo>
                    <a:pt x="2004004" y="2296029"/>
                  </a:lnTo>
                  <a:lnTo>
                    <a:pt x="2152057" y="2296029"/>
                  </a:lnTo>
                  <a:lnTo>
                    <a:pt x="2152057" y="2322704"/>
                  </a:lnTo>
                  <a:lnTo>
                    <a:pt x="2382744" y="2322704"/>
                  </a:lnTo>
                  <a:lnTo>
                    <a:pt x="2382744" y="2349380"/>
                  </a:lnTo>
                  <a:lnTo>
                    <a:pt x="2857930" y="2349380"/>
                  </a:lnTo>
                  <a:lnTo>
                    <a:pt x="2857930" y="2382725"/>
                  </a:lnTo>
                  <a:lnTo>
                    <a:pt x="3105835" y="2382725"/>
                  </a:lnTo>
                  <a:lnTo>
                    <a:pt x="3105835" y="2416069"/>
                  </a:lnTo>
                  <a:lnTo>
                    <a:pt x="3634593" y="2416069"/>
                  </a:lnTo>
                </a:path>
              </a:pathLst>
            </a:custGeom>
            <a:noFill/>
            <a:ln w="15875" cap="flat">
              <a:solidFill>
                <a:schemeClr val="accent5">
                  <a:lumMod val="50000"/>
                </a:schemeClr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664" name="フリーフォーム 5663">
              <a:extLst>
                <a:ext uri="{FF2B5EF4-FFF2-40B4-BE49-F238E27FC236}">
                  <a16:creationId xmlns:a16="http://schemas.microsoft.com/office/drawing/2014/main" xmlns="" id="{4A481BE4-57F4-EEC6-835A-1AE45E7B371D}"/>
                </a:ext>
              </a:extLst>
            </p:cNvPr>
            <p:cNvSpPr/>
            <p:nvPr/>
          </p:nvSpPr>
          <p:spPr>
            <a:xfrm>
              <a:off x="4177046" y="6202499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665" name="フリーフォーム 5664">
              <a:extLst>
                <a:ext uri="{FF2B5EF4-FFF2-40B4-BE49-F238E27FC236}">
                  <a16:creationId xmlns:a16="http://schemas.microsoft.com/office/drawing/2014/main" xmlns="" id="{A0CBF1B6-CAE5-7285-CCB5-70C5B62685DC}"/>
                </a:ext>
              </a:extLst>
            </p:cNvPr>
            <p:cNvSpPr/>
            <p:nvPr/>
          </p:nvSpPr>
          <p:spPr>
            <a:xfrm>
              <a:off x="4177046" y="6202499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34" name="フリーフォーム 5733">
              <a:extLst>
                <a:ext uri="{FF2B5EF4-FFF2-40B4-BE49-F238E27FC236}">
                  <a16:creationId xmlns:a16="http://schemas.microsoft.com/office/drawing/2014/main" xmlns="" id="{34EE3CC7-9272-8706-469A-4D8E762658D5}"/>
                </a:ext>
              </a:extLst>
            </p:cNvPr>
            <p:cNvSpPr/>
            <p:nvPr/>
          </p:nvSpPr>
          <p:spPr>
            <a:xfrm>
              <a:off x="4177046" y="6251825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35" name="フリーフォーム 5734">
              <a:extLst>
                <a:ext uri="{FF2B5EF4-FFF2-40B4-BE49-F238E27FC236}">
                  <a16:creationId xmlns:a16="http://schemas.microsoft.com/office/drawing/2014/main" xmlns="" id="{56D33580-1427-0D9B-E7D8-4D0C4EBFF882}"/>
                </a:ext>
              </a:extLst>
            </p:cNvPr>
            <p:cNvSpPr/>
            <p:nvPr/>
          </p:nvSpPr>
          <p:spPr>
            <a:xfrm>
              <a:off x="4177046" y="6251825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36" name="フリーフォーム 5735">
              <a:extLst>
                <a:ext uri="{FF2B5EF4-FFF2-40B4-BE49-F238E27FC236}">
                  <a16:creationId xmlns:a16="http://schemas.microsoft.com/office/drawing/2014/main" xmlns="" id="{C9D96A8B-CB99-E283-C78F-CBCC0E9A3619}"/>
                </a:ext>
              </a:extLst>
            </p:cNvPr>
            <p:cNvSpPr/>
            <p:nvPr/>
          </p:nvSpPr>
          <p:spPr>
            <a:xfrm>
              <a:off x="4177046" y="6251825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37" name="フリーフォーム 5736">
              <a:extLst>
                <a:ext uri="{FF2B5EF4-FFF2-40B4-BE49-F238E27FC236}">
                  <a16:creationId xmlns:a16="http://schemas.microsoft.com/office/drawing/2014/main" xmlns="" id="{0671C6F2-54BD-E831-3B66-0E391FDCFB67}"/>
                </a:ext>
              </a:extLst>
            </p:cNvPr>
            <p:cNvSpPr/>
            <p:nvPr/>
          </p:nvSpPr>
          <p:spPr>
            <a:xfrm>
              <a:off x="4177046" y="6251825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38" name="フリーフォーム 5737">
              <a:extLst>
                <a:ext uri="{FF2B5EF4-FFF2-40B4-BE49-F238E27FC236}">
                  <a16:creationId xmlns:a16="http://schemas.microsoft.com/office/drawing/2014/main" xmlns="" id="{796BC451-3A79-404A-8A77-E395D14BFEA0}"/>
                </a:ext>
              </a:extLst>
            </p:cNvPr>
            <p:cNvSpPr/>
            <p:nvPr/>
          </p:nvSpPr>
          <p:spPr>
            <a:xfrm>
              <a:off x="4235605" y="6490556"/>
              <a:ext cx="25200" cy="25200"/>
            </a:xfrm>
            <a:custGeom>
              <a:avLst/>
              <a:gdLst>
                <a:gd name="connsiteX0" fmla="*/ 13573 w 27097"/>
                <a:gd name="connsiteY0" fmla="*/ 0 h 34005"/>
                <a:gd name="connsiteX1" fmla="*/ 27097 w 27097"/>
                <a:gd name="connsiteY1" fmla="*/ 17003 h 34005"/>
                <a:gd name="connsiteX2" fmla="*/ 13573 w 27097"/>
                <a:gd name="connsiteY2" fmla="*/ 34005 h 34005"/>
                <a:gd name="connsiteX3" fmla="*/ 0 w 27097"/>
                <a:gd name="connsiteY3" fmla="*/ 17003 h 34005"/>
                <a:gd name="connsiteX4" fmla="*/ 13573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73" y="0"/>
                  </a:moveTo>
                  <a:lnTo>
                    <a:pt x="27097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39" name="フリーフォーム 5738">
              <a:extLst>
                <a:ext uri="{FF2B5EF4-FFF2-40B4-BE49-F238E27FC236}">
                  <a16:creationId xmlns:a16="http://schemas.microsoft.com/office/drawing/2014/main" xmlns="" id="{51F98706-FDEF-CE21-8118-A465678E8C30}"/>
                </a:ext>
              </a:extLst>
            </p:cNvPr>
            <p:cNvSpPr/>
            <p:nvPr/>
          </p:nvSpPr>
          <p:spPr>
            <a:xfrm>
              <a:off x="4235605" y="6490556"/>
              <a:ext cx="25200" cy="25200"/>
            </a:xfrm>
            <a:custGeom>
              <a:avLst/>
              <a:gdLst>
                <a:gd name="connsiteX0" fmla="*/ 13573 w 27097"/>
                <a:gd name="connsiteY0" fmla="*/ 0 h 34005"/>
                <a:gd name="connsiteX1" fmla="*/ 27097 w 27097"/>
                <a:gd name="connsiteY1" fmla="*/ 17003 h 34005"/>
                <a:gd name="connsiteX2" fmla="*/ 13573 w 27097"/>
                <a:gd name="connsiteY2" fmla="*/ 34005 h 34005"/>
                <a:gd name="connsiteX3" fmla="*/ 0 w 27097"/>
                <a:gd name="connsiteY3" fmla="*/ 17003 h 34005"/>
                <a:gd name="connsiteX4" fmla="*/ 13573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73" y="0"/>
                  </a:moveTo>
                  <a:lnTo>
                    <a:pt x="27097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0" name="フリーフォーム 5739">
              <a:extLst>
                <a:ext uri="{FF2B5EF4-FFF2-40B4-BE49-F238E27FC236}">
                  <a16:creationId xmlns:a16="http://schemas.microsoft.com/office/drawing/2014/main" xmlns="" id="{90C438FF-775C-9A3E-87EB-F90FE7B7F8A9}"/>
                </a:ext>
              </a:extLst>
            </p:cNvPr>
            <p:cNvSpPr/>
            <p:nvPr/>
          </p:nvSpPr>
          <p:spPr>
            <a:xfrm>
              <a:off x="4259681" y="6574548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7003 h 33945"/>
                <a:gd name="connsiteX2" fmla="*/ 13573 w 27145"/>
                <a:gd name="connsiteY2" fmla="*/ 33945 h 33945"/>
                <a:gd name="connsiteX3" fmla="*/ 0 w 27145"/>
                <a:gd name="connsiteY3" fmla="*/ 1700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7003"/>
                  </a:lnTo>
                  <a:lnTo>
                    <a:pt x="13573" y="3394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1" name="フリーフォーム 5740">
              <a:extLst>
                <a:ext uri="{FF2B5EF4-FFF2-40B4-BE49-F238E27FC236}">
                  <a16:creationId xmlns:a16="http://schemas.microsoft.com/office/drawing/2014/main" xmlns="" id="{DFC26CAC-1073-71BC-FD17-B8EF3C04F3C3}"/>
                </a:ext>
              </a:extLst>
            </p:cNvPr>
            <p:cNvSpPr/>
            <p:nvPr/>
          </p:nvSpPr>
          <p:spPr>
            <a:xfrm>
              <a:off x="4259681" y="6574548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7003 h 33945"/>
                <a:gd name="connsiteX2" fmla="*/ 13573 w 27145"/>
                <a:gd name="connsiteY2" fmla="*/ 33945 h 33945"/>
                <a:gd name="connsiteX3" fmla="*/ 0 w 27145"/>
                <a:gd name="connsiteY3" fmla="*/ 1700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7003"/>
                  </a:lnTo>
                  <a:lnTo>
                    <a:pt x="13573" y="3394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2" name="フリーフォーム 5741">
              <a:extLst>
                <a:ext uri="{FF2B5EF4-FFF2-40B4-BE49-F238E27FC236}">
                  <a16:creationId xmlns:a16="http://schemas.microsoft.com/office/drawing/2014/main" xmlns="" id="{42B5E49D-623D-22C2-E94C-FC9C67DABFC6}"/>
                </a:ext>
              </a:extLst>
            </p:cNvPr>
            <p:cNvSpPr/>
            <p:nvPr/>
          </p:nvSpPr>
          <p:spPr>
            <a:xfrm>
              <a:off x="4273446" y="6608373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3" name="フリーフォーム 5742">
              <a:extLst>
                <a:ext uri="{FF2B5EF4-FFF2-40B4-BE49-F238E27FC236}">
                  <a16:creationId xmlns:a16="http://schemas.microsoft.com/office/drawing/2014/main" xmlns="" id="{9585107D-383C-9E50-E14C-07F36078BBEA}"/>
                </a:ext>
              </a:extLst>
            </p:cNvPr>
            <p:cNvSpPr/>
            <p:nvPr/>
          </p:nvSpPr>
          <p:spPr>
            <a:xfrm>
              <a:off x="4273446" y="6608373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4" name="フリーフォーム 5743">
              <a:extLst>
                <a:ext uri="{FF2B5EF4-FFF2-40B4-BE49-F238E27FC236}">
                  <a16:creationId xmlns:a16="http://schemas.microsoft.com/office/drawing/2014/main" xmlns="" id="{78585C23-A616-A6C9-65FD-B7376634ACCB}"/>
                </a:ext>
              </a:extLst>
            </p:cNvPr>
            <p:cNvSpPr/>
            <p:nvPr/>
          </p:nvSpPr>
          <p:spPr>
            <a:xfrm>
              <a:off x="4301023" y="6676685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6943 h 33945"/>
                <a:gd name="connsiteX2" fmla="*/ 13573 w 27145"/>
                <a:gd name="connsiteY2" fmla="*/ 33945 h 33945"/>
                <a:gd name="connsiteX3" fmla="*/ 0 w 27145"/>
                <a:gd name="connsiteY3" fmla="*/ 1694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5" name="フリーフォーム 5744">
              <a:extLst>
                <a:ext uri="{FF2B5EF4-FFF2-40B4-BE49-F238E27FC236}">
                  <a16:creationId xmlns:a16="http://schemas.microsoft.com/office/drawing/2014/main" xmlns="" id="{166D75D2-8452-C23A-FE46-267AEA3A36C4}"/>
                </a:ext>
              </a:extLst>
            </p:cNvPr>
            <p:cNvSpPr/>
            <p:nvPr/>
          </p:nvSpPr>
          <p:spPr>
            <a:xfrm>
              <a:off x="4301023" y="6676685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6943 h 33945"/>
                <a:gd name="connsiteX2" fmla="*/ 13573 w 27145"/>
                <a:gd name="connsiteY2" fmla="*/ 33945 h 33945"/>
                <a:gd name="connsiteX3" fmla="*/ 0 w 27145"/>
                <a:gd name="connsiteY3" fmla="*/ 1694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6" name="フリーフォーム 5745">
              <a:extLst>
                <a:ext uri="{FF2B5EF4-FFF2-40B4-BE49-F238E27FC236}">
                  <a16:creationId xmlns:a16="http://schemas.microsoft.com/office/drawing/2014/main" xmlns="" id="{64362441-4622-C157-8BAD-9EF45491A997}"/>
                </a:ext>
              </a:extLst>
            </p:cNvPr>
            <p:cNvSpPr/>
            <p:nvPr/>
          </p:nvSpPr>
          <p:spPr>
            <a:xfrm>
              <a:off x="4307881" y="6711111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6943 h 33945"/>
                <a:gd name="connsiteX2" fmla="*/ 13573 w 27145"/>
                <a:gd name="connsiteY2" fmla="*/ 33945 h 33945"/>
                <a:gd name="connsiteX3" fmla="*/ 0 w 27145"/>
                <a:gd name="connsiteY3" fmla="*/ 1694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7" name="フリーフォーム 5746">
              <a:extLst>
                <a:ext uri="{FF2B5EF4-FFF2-40B4-BE49-F238E27FC236}">
                  <a16:creationId xmlns:a16="http://schemas.microsoft.com/office/drawing/2014/main" xmlns="" id="{CC651BDD-8913-8C26-58C4-79BFA88F03FC}"/>
                </a:ext>
              </a:extLst>
            </p:cNvPr>
            <p:cNvSpPr/>
            <p:nvPr/>
          </p:nvSpPr>
          <p:spPr>
            <a:xfrm>
              <a:off x="4307881" y="6711111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6943 h 33945"/>
                <a:gd name="connsiteX2" fmla="*/ 13573 w 27145"/>
                <a:gd name="connsiteY2" fmla="*/ 33945 h 33945"/>
                <a:gd name="connsiteX3" fmla="*/ 0 w 27145"/>
                <a:gd name="connsiteY3" fmla="*/ 1694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8" name="フリーフォーム 5747">
              <a:extLst>
                <a:ext uri="{FF2B5EF4-FFF2-40B4-BE49-F238E27FC236}">
                  <a16:creationId xmlns:a16="http://schemas.microsoft.com/office/drawing/2014/main" xmlns="" id="{ECFF12E5-938D-667C-EDBC-C2FDE555B512}"/>
                </a:ext>
              </a:extLst>
            </p:cNvPr>
            <p:cNvSpPr/>
            <p:nvPr/>
          </p:nvSpPr>
          <p:spPr>
            <a:xfrm>
              <a:off x="4314787" y="6728474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7003 h 33945"/>
                <a:gd name="connsiteX2" fmla="*/ 13573 w 27145"/>
                <a:gd name="connsiteY2" fmla="*/ 33945 h 33945"/>
                <a:gd name="connsiteX3" fmla="*/ 0 w 27145"/>
                <a:gd name="connsiteY3" fmla="*/ 1700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7003"/>
                  </a:lnTo>
                  <a:lnTo>
                    <a:pt x="13573" y="3394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49" name="フリーフォーム 5748">
              <a:extLst>
                <a:ext uri="{FF2B5EF4-FFF2-40B4-BE49-F238E27FC236}">
                  <a16:creationId xmlns:a16="http://schemas.microsoft.com/office/drawing/2014/main" xmlns="" id="{3E46E05D-A452-A3F6-E68E-AA6563790638}"/>
                </a:ext>
              </a:extLst>
            </p:cNvPr>
            <p:cNvSpPr/>
            <p:nvPr/>
          </p:nvSpPr>
          <p:spPr>
            <a:xfrm>
              <a:off x="4314787" y="6728474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7003 h 33945"/>
                <a:gd name="connsiteX2" fmla="*/ 13573 w 27145"/>
                <a:gd name="connsiteY2" fmla="*/ 33945 h 33945"/>
                <a:gd name="connsiteX3" fmla="*/ 0 w 27145"/>
                <a:gd name="connsiteY3" fmla="*/ 1700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7003"/>
                  </a:lnTo>
                  <a:lnTo>
                    <a:pt x="13573" y="3394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0" name="フリーフォーム 5749">
              <a:extLst>
                <a:ext uri="{FF2B5EF4-FFF2-40B4-BE49-F238E27FC236}">
                  <a16:creationId xmlns:a16="http://schemas.microsoft.com/office/drawing/2014/main" xmlns="" id="{531B254E-E930-E1B0-84BC-BAB9D43C5DDE}"/>
                </a:ext>
              </a:extLst>
            </p:cNvPr>
            <p:cNvSpPr/>
            <p:nvPr/>
          </p:nvSpPr>
          <p:spPr>
            <a:xfrm>
              <a:off x="4342316" y="6763501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1" name="フリーフォーム 5750">
              <a:extLst>
                <a:ext uri="{FF2B5EF4-FFF2-40B4-BE49-F238E27FC236}">
                  <a16:creationId xmlns:a16="http://schemas.microsoft.com/office/drawing/2014/main" xmlns="" id="{56758B6B-75E0-4755-60EC-B4ABB7BB07B3}"/>
                </a:ext>
              </a:extLst>
            </p:cNvPr>
            <p:cNvSpPr/>
            <p:nvPr/>
          </p:nvSpPr>
          <p:spPr>
            <a:xfrm>
              <a:off x="4342316" y="6763501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2" name="フリーフォーム 5751">
              <a:extLst>
                <a:ext uri="{FF2B5EF4-FFF2-40B4-BE49-F238E27FC236}">
                  <a16:creationId xmlns:a16="http://schemas.microsoft.com/office/drawing/2014/main" xmlns="" id="{C36BC25E-45E6-A126-3B14-7D19E31413D5}"/>
                </a:ext>
              </a:extLst>
            </p:cNvPr>
            <p:cNvSpPr/>
            <p:nvPr/>
          </p:nvSpPr>
          <p:spPr>
            <a:xfrm>
              <a:off x="4393969" y="6922593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3" name="フリーフォーム 5752">
              <a:extLst>
                <a:ext uri="{FF2B5EF4-FFF2-40B4-BE49-F238E27FC236}">
                  <a16:creationId xmlns:a16="http://schemas.microsoft.com/office/drawing/2014/main" xmlns="" id="{A94A076A-8035-07FA-D538-D3D267619FB5}"/>
                </a:ext>
              </a:extLst>
            </p:cNvPr>
            <p:cNvSpPr/>
            <p:nvPr/>
          </p:nvSpPr>
          <p:spPr>
            <a:xfrm>
              <a:off x="4393969" y="6922593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4" name="フリーフォーム 5753">
              <a:extLst>
                <a:ext uri="{FF2B5EF4-FFF2-40B4-BE49-F238E27FC236}">
                  <a16:creationId xmlns:a16="http://schemas.microsoft.com/office/drawing/2014/main" xmlns="" id="{4A279627-E22D-A5CB-0EC9-B024E4E69E8F}"/>
                </a:ext>
              </a:extLst>
            </p:cNvPr>
            <p:cNvSpPr/>
            <p:nvPr/>
          </p:nvSpPr>
          <p:spPr>
            <a:xfrm>
              <a:off x="4473199" y="7154804"/>
              <a:ext cx="25200" cy="25200"/>
            </a:xfrm>
            <a:custGeom>
              <a:avLst/>
              <a:gdLst>
                <a:gd name="connsiteX0" fmla="*/ 13525 w 27097"/>
                <a:gd name="connsiteY0" fmla="*/ 0 h 34005"/>
                <a:gd name="connsiteX1" fmla="*/ 27097 w 27097"/>
                <a:gd name="connsiteY1" fmla="*/ 17003 h 34005"/>
                <a:gd name="connsiteX2" fmla="*/ 13525 w 27097"/>
                <a:gd name="connsiteY2" fmla="*/ 34005 h 34005"/>
                <a:gd name="connsiteX3" fmla="*/ 0 w 27097"/>
                <a:gd name="connsiteY3" fmla="*/ 17003 h 34005"/>
                <a:gd name="connsiteX4" fmla="*/ 13525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25" y="0"/>
                  </a:moveTo>
                  <a:lnTo>
                    <a:pt x="27097" y="17003"/>
                  </a:lnTo>
                  <a:lnTo>
                    <a:pt x="13525" y="34005"/>
                  </a:lnTo>
                  <a:lnTo>
                    <a:pt x="0" y="17003"/>
                  </a:lnTo>
                  <a:lnTo>
                    <a:pt x="13525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5" name="フリーフォーム 5754">
              <a:extLst>
                <a:ext uri="{FF2B5EF4-FFF2-40B4-BE49-F238E27FC236}">
                  <a16:creationId xmlns:a16="http://schemas.microsoft.com/office/drawing/2014/main" xmlns="" id="{E1E284CD-9B32-5891-8A39-B592B5F80AD3}"/>
                </a:ext>
              </a:extLst>
            </p:cNvPr>
            <p:cNvSpPr/>
            <p:nvPr/>
          </p:nvSpPr>
          <p:spPr>
            <a:xfrm>
              <a:off x="4473199" y="7154804"/>
              <a:ext cx="25200" cy="25200"/>
            </a:xfrm>
            <a:custGeom>
              <a:avLst/>
              <a:gdLst>
                <a:gd name="connsiteX0" fmla="*/ 13525 w 27097"/>
                <a:gd name="connsiteY0" fmla="*/ 0 h 34005"/>
                <a:gd name="connsiteX1" fmla="*/ 27097 w 27097"/>
                <a:gd name="connsiteY1" fmla="*/ 17003 h 34005"/>
                <a:gd name="connsiteX2" fmla="*/ 13525 w 27097"/>
                <a:gd name="connsiteY2" fmla="*/ 34005 h 34005"/>
                <a:gd name="connsiteX3" fmla="*/ 0 w 27097"/>
                <a:gd name="connsiteY3" fmla="*/ 17003 h 34005"/>
                <a:gd name="connsiteX4" fmla="*/ 13525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25" y="0"/>
                  </a:moveTo>
                  <a:lnTo>
                    <a:pt x="27097" y="17003"/>
                  </a:lnTo>
                  <a:lnTo>
                    <a:pt x="13525" y="34005"/>
                  </a:lnTo>
                  <a:lnTo>
                    <a:pt x="0" y="17003"/>
                  </a:lnTo>
                  <a:lnTo>
                    <a:pt x="13525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6" name="フリーフォーム 5755">
              <a:extLst>
                <a:ext uri="{FF2B5EF4-FFF2-40B4-BE49-F238E27FC236}">
                  <a16:creationId xmlns:a16="http://schemas.microsoft.com/office/drawing/2014/main" xmlns="" id="{1BE2C47F-C2A9-1A3E-BE17-BF4F5ADB6CC3}"/>
                </a:ext>
              </a:extLst>
            </p:cNvPr>
            <p:cNvSpPr/>
            <p:nvPr/>
          </p:nvSpPr>
          <p:spPr>
            <a:xfrm>
              <a:off x="4473199" y="7154804"/>
              <a:ext cx="25200" cy="25200"/>
            </a:xfrm>
            <a:custGeom>
              <a:avLst/>
              <a:gdLst>
                <a:gd name="connsiteX0" fmla="*/ 13525 w 27097"/>
                <a:gd name="connsiteY0" fmla="*/ 0 h 34005"/>
                <a:gd name="connsiteX1" fmla="*/ 27097 w 27097"/>
                <a:gd name="connsiteY1" fmla="*/ 17003 h 34005"/>
                <a:gd name="connsiteX2" fmla="*/ 13525 w 27097"/>
                <a:gd name="connsiteY2" fmla="*/ 34005 h 34005"/>
                <a:gd name="connsiteX3" fmla="*/ 0 w 27097"/>
                <a:gd name="connsiteY3" fmla="*/ 17003 h 34005"/>
                <a:gd name="connsiteX4" fmla="*/ 13525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25" y="0"/>
                  </a:moveTo>
                  <a:lnTo>
                    <a:pt x="27097" y="17003"/>
                  </a:lnTo>
                  <a:lnTo>
                    <a:pt x="13525" y="34005"/>
                  </a:lnTo>
                  <a:lnTo>
                    <a:pt x="0" y="17003"/>
                  </a:lnTo>
                  <a:lnTo>
                    <a:pt x="13525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7" name="フリーフォーム 5756">
              <a:extLst>
                <a:ext uri="{FF2B5EF4-FFF2-40B4-BE49-F238E27FC236}">
                  <a16:creationId xmlns:a16="http://schemas.microsoft.com/office/drawing/2014/main" xmlns="" id="{49890ED3-4A12-4486-770F-2062E8C37123}"/>
                </a:ext>
              </a:extLst>
            </p:cNvPr>
            <p:cNvSpPr/>
            <p:nvPr/>
          </p:nvSpPr>
          <p:spPr>
            <a:xfrm>
              <a:off x="4473199" y="7154804"/>
              <a:ext cx="25200" cy="25200"/>
            </a:xfrm>
            <a:custGeom>
              <a:avLst/>
              <a:gdLst>
                <a:gd name="connsiteX0" fmla="*/ 13525 w 27097"/>
                <a:gd name="connsiteY0" fmla="*/ 0 h 34005"/>
                <a:gd name="connsiteX1" fmla="*/ 27097 w 27097"/>
                <a:gd name="connsiteY1" fmla="*/ 17003 h 34005"/>
                <a:gd name="connsiteX2" fmla="*/ 13525 w 27097"/>
                <a:gd name="connsiteY2" fmla="*/ 34005 h 34005"/>
                <a:gd name="connsiteX3" fmla="*/ 0 w 27097"/>
                <a:gd name="connsiteY3" fmla="*/ 17003 h 34005"/>
                <a:gd name="connsiteX4" fmla="*/ 13525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25" y="0"/>
                  </a:moveTo>
                  <a:lnTo>
                    <a:pt x="27097" y="17003"/>
                  </a:lnTo>
                  <a:lnTo>
                    <a:pt x="13525" y="34005"/>
                  </a:lnTo>
                  <a:lnTo>
                    <a:pt x="0" y="17003"/>
                  </a:lnTo>
                  <a:lnTo>
                    <a:pt x="13525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8" name="フリーフォーム 5757">
              <a:extLst>
                <a:ext uri="{FF2B5EF4-FFF2-40B4-BE49-F238E27FC236}">
                  <a16:creationId xmlns:a16="http://schemas.microsoft.com/office/drawing/2014/main" xmlns="" id="{F7152F2F-545E-B7F6-E3E7-0658FA245231}"/>
                </a:ext>
              </a:extLst>
            </p:cNvPr>
            <p:cNvSpPr/>
            <p:nvPr/>
          </p:nvSpPr>
          <p:spPr>
            <a:xfrm>
              <a:off x="4504181" y="7246246"/>
              <a:ext cx="25200" cy="25200"/>
            </a:xfrm>
            <a:custGeom>
              <a:avLst/>
              <a:gdLst>
                <a:gd name="connsiteX0" fmla="*/ 13573 w 27097"/>
                <a:gd name="connsiteY0" fmla="*/ 0 h 33945"/>
                <a:gd name="connsiteX1" fmla="*/ 27097 w 27097"/>
                <a:gd name="connsiteY1" fmla="*/ 16943 h 33945"/>
                <a:gd name="connsiteX2" fmla="*/ 13573 w 27097"/>
                <a:gd name="connsiteY2" fmla="*/ 33945 h 33945"/>
                <a:gd name="connsiteX3" fmla="*/ 0 w 27097"/>
                <a:gd name="connsiteY3" fmla="*/ 16943 h 33945"/>
                <a:gd name="connsiteX4" fmla="*/ 13573 w 27097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3945">
                  <a:moveTo>
                    <a:pt x="13573" y="0"/>
                  </a:moveTo>
                  <a:lnTo>
                    <a:pt x="27097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59" name="フリーフォーム 5758">
              <a:extLst>
                <a:ext uri="{FF2B5EF4-FFF2-40B4-BE49-F238E27FC236}">
                  <a16:creationId xmlns:a16="http://schemas.microsoft.com/office/drawing/2014/main" xmlns="" id="{E40562C2-28BB-A3F2-8D86-7A8677471894}"/>
                </a:ext>
              </a:extLst>
            </p:cNvPr>
            <p:cNvSpPr/>
            <p:nvPr/>
          </p:nvSpPr>
          <p:spPr>
            <a:xfrm>
              <a:off x="4504181" y="7246246"/>
              <a:ext cx="25200" cy="25200"/>
            </a:xfrm>
            <a:custGeom>
              <a:avLst/>
              <a:gdLst>
                <a:gd name="connsiteX0" fmla="*/ 13573 w 27097"/>
                <a:gd name="connsiteY0" fmla="*/ 0 h 33945"/>
                <a:gd name="connsiteX1" fmla="*/ 27097 w 27097"/>
                <a:gd name="connsiteY1" fmla="*/ 16943 h 33945"/>
                <a:gd name="connsiteX2" fmla="*/ 13573 w 27097"/>
                <a:gd name="connsiteY2" fmla="*/ 33945 h 33945"/>
                <a:gd name="connsiteX3" fmla="*/ 0 w 27097"/>
                <a:gd name="connsiteY3" fmla="*/ 16943 h 33945"/>
                <a:gd name="connsiteX4" fmla="*/ 13573 w 27097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3945">
                  <a:moveTo>
                    <a:pt x="13573" y="0"/>
                  </a:moveTo>
                  <a:lnTo>
                    <a:pt x="27097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0" name="フリーフォーム 5759">
              <a:extLst>
                <a:ext uri="{FF2B5EF4-FFF2-40B4-BE49-F238E27FC236}">
                  <a16:creationId xmlns:a16="http://schemas.microsoft.com/office/drawing/2014/main" xmlns="" id="{BFEC05C8-9B8A-B13A-8C72-F861E68A5441}"/>
                </a:ext>
              </a:extLst>
            </p:cNvPr>
            <p:cNvSpPr/>
            <p:nvPr/>
          </p:nvSpPr>
          <p:spPr>
            <a:xfrm>
              <a:off x="4504181" y="7246246"/>
              <a:ext cx="25200" cy="25200"/>
            </a:xfrm>
            <a:custGeom>
              <a:avLst/>
              <a:gdLst>
                <a:gd name="connsiteX0" fmla="*/ 13573 w 27097"/>
                <a:gd name="connsiteY0" fmla="*/ 0 h 33945"/>
                <a:gd name="connsiteX1" fmla="*/ 27097 w 27097"/>
                <a:gd name="connsiteY1" fmla="*/ 16943 h 33945"/>
                <a:gd name="connsiteX2" fmla="*/ 13573 w 27097"/>
                <a:gd name="connsiteY2" fmla="*/ 33945 h 33945"/>
                <a:gd name="connsiteX3" fmla="*/ 0 w 27097"/>
                <a:gd name="connsiteY3" fmla="*/ 16943 h 33945"/>
                <a:gd name="connsiteX4" fmla="*/ 13573 w 27097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3945">
                  <a:moveTo>
                    <a:pt x="13573" y="0"/>
                  </a:moveTo>
                  <a:lnTo>
                    <a:pt x="27097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1" name="フリーフォーム 5760">
              <a:extLst>
                <a:ext uri="{FF2B5EF4-FFF2-40B4-BE49-F238E27FC236}">
                  <a16:creationId xmlns:a16="http://schemas.microsoft.com/office/drawing/2014/main" xmlns="" id="{140EA555-3249-5E45-C492-E9BE9DA52015}"/>
                </a:ext>
              </a:extLst>
            </p:cNvPr>
            <p:cNvSpPr/>
            <p:nvPr/>
          </p:nvSpPr>
          <p:spPr>
            <a:xfrm>
              <a:off x="4504181" y="7246246"/>
              <a:ext cx="25200" cy="25200"/>
            </a:xfrm>
            <a:custGeom>
              <a:avLst/>
              <a:gdLst>
                <a:gd name="connsiteX0" fmla="*/ 13573 w 27097"/>
                <a:gd name="connsiteY0" fmla="*/ 0 h 33945"/>
                <a:gd name="connsiteX1" fmla="*/ 27097 w 27097"/>
                <a:gd name="connsiteY1" fmla="*/ 16943 h 33945"/>
                <a:gd name="connsiteX2" fmla="*/ 13573 w 27097"/>
                <a:gd name="connsiteY2" fmla="*/ 33945 h 33945"/>
                <a:gd name="connsiteX3" fmla="*/ 0 w 27097"/>
                <a:gd name="connsiteY3" fmla="*/ 16943 h 33945"/>
                <a:gd name="connsiteX4" fmla="*/ 13573 w 27097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3945">
                  <a:moveTo>
                    <a:pt x="13573" y="0"/>
                  </a:moveTo>
                  <a:lnTo>
                    <a:pt x="27097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2" name="フリーフォーム 5761">
              <a:extLst>
                <a:ext uri="{FF2B5EF4-FFF2-40B4-BE49-F238E27FC236}">
                  <a16:creationId xmlns:a16="http://schemas.microsoft.com/office/drawing/2014/main" xmlns="" id="{646D8B7B-FCFF-9BC7-A2FE-1668891DA79E}"/>
                </a:ext>
              </a:extLst>
            </p:cNvPr>
            <p:cNvSpPr/>
            <p:nvPr/>
          </p:nvSpPr>
          <p:spPr>
            <a:xfrm>
              <a:off x="4538616" y="7321226"/>
              <a:ext cx="25200" cy="25200"/>
            </a:xfrm>
            <a:custGeom>
              <a:avLst/>
              <a:gdLst>
                <a:gd name="connsiteX0" fmla="*/ 13573 w 27097"/>
                <a:gd name="connsiteY0" fmla="*/ 0 h 34005"/>
                <a:gd name="connsiteX1" fmla="*/ 27097 w 27097"/>
                <a:gd name="connsiteY1" fmla="*/ 17003 h 34005"/>
                <a:gd name="connsiteX2" fmla="*/ 13573 w 27097"/>
                <a:gd name="connsiteY2" fmla="*/ 34005 h 34005"/>
                <a:gd name="connsiteX3" fmla="*/ 0 w 27097"/>
                <a:gd name="connsiteY3" fmla="*/ 17003 h 34005"/>
                <a:gd name="connsiteX4" fmla="*/ 13573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73" y="0"/>
                  </a:moveTo>
                  <a:lnTo>
                    <a:pt x="27097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3" name="フリーフォーム 5762">
              <a:extLst>
                <a:ext uri="{FF2B5EF4-FFF2-40B4-BE49-F238E27FC236}">
                  <a16:creationId xmlns:a16="http://schemas.microsoft.com/office/drawing/2014/main" xmlns="" id="{A5CABA9D-AE9D-AB42-C8E6-722E2CC7074D}"/>
                </a:ext>
              </a:extLst>
            </p:cNvPr>
            <p:cNvSpPr/>
            <p:nvPr/>
          </p:nvSpPr>
          <p:spPr>
            <a:xfrm>
              <a:off x="4538616" y="7321226"/>
              <a:ext cx="25200" cy="25200"/>
            </a:xfrm>
            <a:custGeom>
              <a:avLst/>
              <a:gdLst>
                <a:gd name="connsiteX0" fmla="*/ 13573 w 27097"/>
                <a:gd name="connsiteY0" fmla="*/ 0 h 34005"/>
                <a:gd name="connsiteX1" fmla="*/ 27097 w 27097"/>
                <a:gd name="connsiteY1" fmla="*/ 17003 h 34005"/>
                <a:gd name="connsiteX2" fmla="*/ 13573 w 27097"/>
                <a:gd name="connsiteY2" fmla="*/ 34005 h 34005"/>
                <a:gd name="connsiteX3" fmla="*/ 0 w 27097"/>
                <a:gd name="connsiteY3" fmla="*/ 17003 h 34005"/>
                <a:gd name="connsiteX4" fmla="*/ 13573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73" y="0"/>
                  </a:moveTo>
                  <a:lnTo>
                    <a:pt x="27097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4" name="フリーフォーム 5763">
              <a:extLst>
                <a:ext uri="{FF2B5EF4-FFF2-40B4-BE49-F238E27FC236}">
                  <a16:creationId xmlns:a16="http://schemas.microsoft.com/office/drawing/2014/main" xmlns="" id="{DF571746-4666-0752-3A89-82764894BF9C}"/>
                </a:ext>
              </a:extLst>
            </p:cNvPr>
            <p:cNvSpPr/>
            <p:nvPr/>
          </p:nvSpPr>
          <p:spPr>
            <a:xfrm>
              <a:off x="4548927" y="7340272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5" name="フリーフォーム 5764">
              <a:extLst>
                <a:ext uri="{FF2B5EF4-FFF2-40B4-BE49-F238E27FC236}">
                  <a16:creationId xmlns:a16="http://schemas.microsoft.com/office/drawing/2014/main" xmlns="" id="{0839B6C6-E580-8103-FEF8-50D586D15755}"/>
                </a:ext>
              </a:extLst>
            </p:cNvPr>
            <p:cNvSpPr/>
            <p:nvPr/>
          </p:nvSpPr>
          <p:spPr>
            <a:xfrm>
              <a:off x="4548927" y="7340272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6" name="フリーフォーム 5765">
              <a:extLst>
                <a:ext uri="{FF2B5EF4-FFF2-40B4-BE49-F238E27FC236}">
                  <a16:creationId xmlns:a16="http://schemas.microsoft.com/office/drawing/2014/main" xmlns="" id="{7E3B9CCE-4A95-5F37-1544-CEEACA80CA1F}"/>
                </a:ext>
              </a:extLst>
            </p:cNvPr>
            <p:cNvSpPr/>
            <p:nvPr/>
          </p:nvSpPr>
          <p:spPr>
            <a:xfrm>
              <a:off x="4576456" y="7398129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7" name="フリーフォーム 5766">
              <a:extLst>
                <a:ext uri="{FF2B5EF4-FFF2-40B4-BE49-F238E27FC236}">
                  <a16:creationId xmlns:a16="http://schemas.microsoft.com/office/drawing/2014/main" xmlns="" id="{002822E5-0660-27EE-2559-C0AC524C321B}"/>
                </a:ext>
              </a:extLst>
            </p:cNvPr>
            <p:cNvSpPr/>
            <p:nvPr/>
          </p:nvSpPr>
          <p:spPr>
            <a:xfrm>
              <a:off x="4576456" y="7398129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8" name="フリーフォーム 5767">
              <a:extLst>
                <a:ext uri="{FF2B5EF4-FFF2-40B4-BE49-F238E27FC236}">
                  <a16:creationId xmlns:a16="http://schemas.microsoft.com/office/drawing/2014/main" xmlns="" id="{657EC145-B5A7-514D-5680-463864B679B2}"/>
                </a:ext>
              </a:extLst>
            </p:cNvPr>
            <p:cNvSpPr/>
            <p:nvPr/>
          </p:nvSpPr>
          <p:spPr>
            <a:xfrm>
              <a:off x="4628109" y="7456888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69" name="フリーフォーム 5768">
              <a:extLst>
                <a:ext uri="{FF2B5EF4-FFF2-40B4-BE49-F238E27FC236}">
                  <a16:creationId xmlns:a16="http://schemas.microsoft.com/office/drawing/2014/main" xmlns="" id="{358FEFC8-A12C-BFFA-C9E8-FFFA40C008C8}"/>
                </a:ext>
              </a:extLst>
            </p:cNvPr>
            <p:cNvSpPr/>
            <p:nvPr/>
          </p:nvSpPr>
          <p:spPr>
            <a:xfrm>
              <a:off x="4628109" y="7456888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0" name="フリーフォーム 5769">
              <a:extLst>
                <a:ext uri="{FF2B5EF4-FFF2-40B4-BE49-F238E27FC236}">
                  <a16:creationId xmlns:a16="http://schemas.microsoft.com/office/drawing/2014/main" xmlns="" id="{A150B210-8721-F960-B127-E96D2460D9B6}"/>
                </a:ext>
              </a:extLst>
            </p:cNvPr>
            <p:cNvSpPr/>
            <p:nvPr/>
          </p:nvSpPr>
          <p:spPr>
            <a:xfrm>
              <a:off x="4645327" y="7496721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7003 h 33945"/>
                <a:gd name="connsiteX2" fmla="*/ 13573 w 27145"/>
                <a:gd name="connsiteY2" fmla="*/ 33945 h 33945"/>
                <a:gd name="connsiteX3" fmla="*/ 0 w 27145"/>
                <a:gd name="connsiteY3" fmla="*/ 1700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7003"/>
                  </a:lnTo>
                  <a:lnTo>
                    <a:pt x="13573" y="3394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1" name="フリーフォーム 5770">
              <a:extLst>
                <a:ext uri="{FF2B5EF4-FFF2-40B4-BE49-F238E27FC236}">
                  <a16:creationId xmlns:a16="http://schemas.microsoft.com/office/drawing/2014/main" xmlns="" id="{7EE7A303-FBE7-1312-21B6-D6A665DDE746}"/>
                </a:ext>
              </a:extLst>
            </p:cNvPr>
            <p:cNvSpPr/>
            <p:nvPr/>
          </p:nvSpPr>
          <p:spPr>
            <a:xfrm>
              <a:off x="4645327" y="7496721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7003 h 33945"/>
                <a:gd name="connsiteX2" fmla="*/ 13573 w 27145"/>
                <a:gd name="connsiteY2" fmla="*/ 33945 h 33945"/>
                <a:gd name="connsiteX3" fmla="*/ 0 w 27145"/>
                <a:gd name="connsiteY3" fmla="*/ 1700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7003"/>
                  </a:lnTo>
                  <a:lnTo>
                    <a:pt x="13573" y="3394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2" name="フリーフォーム 5771">
              <a:extLst>
                <a:ext uri="{FF2B5EF4-FFF2-40B4-BE49-F238E27FC236}">
                  <a16:creationId xmlns:a16="http://schemas.microsoft.com/office/drawing/2014/main" xmlns="" id="{CA8531D9-6872-D2BB-1486-E961CC56EB95}"/>
                </a:ext>
              </a:extLst>
            </p:cNvPr>
            <p:cNvSpPr/>
            <p:nvPr/>
          </p:nvSpPr>
          <p:spPr>
            <a:xfrm>
              <a:off x="4707339" y="7678824"/>
              <a:ext cx="25200" cy="25200"/>
            </a:xfrm>
            <a:custGeom>
              <a:avLst/>
              <a:gdLst>
                <a:gd name="connsiteX0" fmla="*/ 13573 w 27097"/>
                <a:gd name="connsiteY0" fmla="*/ 0 h 34005"/>
                <a:gd name="connsiteX1" fmla="*/ 27097 w 27097"/>
                <a:gd name="connsiteY1" fmla="*/ 17003 h 34005"/>
                <a:gd name="connsiteX2" fmla="*/ 13573 w 27097"/>
                <a:gd name="connsiteY2" fmla="*/ 34005 h 34005"/>
                <a:gd name="connsiteX3" fmla="*/ 0 w 27097"/>
                <a:gd name="connsiteY3" fmla="*/ 17003 h 34005"/>
                <a:gd name="connsiteX4" fmla="*/ 13573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73" y="0"/>
                  </a:moveTo>
                  <a:lnTo>
                    <a:pt x="27097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3" name="フリーフォーム 5772">
              <a:extLst>
                <a:ext uri="{FF2B5EF4-FFF2-40B4-BE49-F238E27FC236}">
                  <a16:creationId xmlns:a16="http://schemas.microsoft.com/office/drawing/2014/main" xmlns="" id="{A9A5A585-04E3-653D-4337-D39C73D5A1A0}"/>
                </a:ext>
              </a:extLst>
            </p:cNvPr>
            <p:cNvSpPr/>
            <p:nvPr/>
          </p:nvSpPr>
          <p:spPr>
            <a:xfrm>
              <a:off x="4707339" y="7678824"/>
              <a:ext cx="25200" cy="25200"/>
            </a:xfrm>
            <a:custGeom>
              <a:avLst/>
              <a:gdLst>
                <a:gd name="connsiteX0" fmla="*/ 13573 w 27097"/>
                <a:gd name="connsiteY0" fmla="*/ 0 h 34005"/>
                <a:gd name="connsiteX1" fmla="*/ 27097 w 27097"/>
                <a:gd name="connsiteY1" fmla="*/ 17003 h 34005"/>
                <a:gd name="connsiteX2" fmla="*/ 13573 w 27097"/>
                <a:gd name="connsiteY2" fmla="*/ 34005 h 34005"/>
                <a:gd name="connsiteX3" fmla="*/ 0 w 27097"/>
                <a:gd name="connsiteY3" fmla="*/ 17003 h 34005"/>
                <a:gd name="connsiteX4" fmla="*/ 13573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73" y="0"/>
                  </a:moveTo>
                  <a:lnTo>
                    <a:pt x="27097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4" name="フリーフォーム 5773">
              <a:extLst>
                <a:ext uri="{FF2B5EF4-FFF2-40B4-BE49-F238E27FC236}">
                  <a16:creationId xmlns:a16="http://schemas.microsoft.com/office/drawing/2014/main" xmlns="" id="{9FE0A0E9-02F9-B828-7ED0-1458E5C38EF1}"/>
                </a:ext>
              </a:extLst>
            </p:cNvPr>
            <p:cNvSpPr/>
            <p:nvPr/>
          </p:nvSpPr>
          <p:spPr>
            <a:xfrm>
              <a:off x="4717650" y="7678824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5" name="フリーフォーム 5774">
              <a:extLst>
                <a:ext uri="{FF2B5EF4-FFF2-40B4-BE49-F238E27FC236}">
                  <a16:creationId xmlns:a16="http://schemas.microsoft.com/office/drawing/2014/main" xmlns="" id="{5F962B77-B946-4547-2D3C-B904FDD6D0C7}"/>
                </a:ext>
              </a:extLst>
            </p:cNvPr>
            <p:cNvSpPr/>
            <p:nvPr/>
          </p:nvSpPr>
          <p:spPr>
            <a:xfrm>
              <a:off x="4717650" y="7678824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6" name="フリーフォーム 5775">
              <a:extLst>
                <a:ext uri="{FF2B5EF4-FFF2-40B4-BE49-F238E27FC236}">
                  <a16:creationId xmlns:a16="http://schemas.microsoft.com/office/drawing/2014/main" xmlns="" id="{481E7EEC-B4AB-2A6E-9E69-796C5D30C641}"/>
                </a:ext>
              </a:extLst>
            </p:cNvPr>
            <p:cNvSpPr/>
            <p:nvPr/>
          </p:nvSpPr>
          <p:spPr>
            <a:xfrm>
              <a:off x="5027567" y="8121556"/>
              <a:ext cx="25200" cy="25200"/>
            </a:xfrm>
            <a:custGeom>
              <a:avLst/>
              <a:gdLst>
                <a:gd name="connsiteX0" fmla="*/ 13573 w 27097"/>
                <a:gd name="connsiteY0" fmla="*/ 0 h 33945"/>
                <a:gd name="connsiteX1" fmla="*/ 27097 w 27097"/>
                <a:gd name="connsiteY1" fmla="*/ 16943 h 33945"/>
                <a:gd name="connsiteX2" fmla="*/ 13573 w 27097"/>
                <a:gd name="connsiteY2" fmla="*/ 33945 h 33945"/>
                <a:gd name="connsiteX3" fmla="*/ 0 w 27097"/>
                <a:gd name="connsiteY3" fmla="*/ 16943 h 33945"/>
                <a:gd name="connsiteX4" fmla="*/ 13573 w 27097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3945">
                  <a:moveTo>
                    <a:pt x="13573" y="0"/>
                  </a:moveTo>
                  <a:lnTo>
                    <a:pt x="27097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7" name="フリーフォーム 5776">
              <a:extLst>
                <a:ext uri="{FF2B5EF4-FFF2-40B4-BE49-F238E27FC236}">
                  <a16:creationId xmlns:a16="http://schemas.microsoft.com/office/drawing/2014/main" xmlns="" id="{C8531AF7-5A5F-5946-8177-8FD0D17388AE}"/>
                </a:ext>
              </a:extLst>
            </p:cNvPr>
            <p:cNvSpPr/>
            <p:nvPr/>
          </p:nvSpPr>
          <p:spPr>
            <a:xfrm>
              <a:off x="5027567" y="8121556"/>
              <a:ext cx="25200" cy="25200"/>
            </a:xfrm>
            <a:custGeom>
              <a:avLst/>
              <a:gdLst>
                <a:gd name="connsiteX0" fmla="*/ 13573 w 27097"/>
                <a:gd name="connsiteY0" fmla="*/ 0 h 33945"/>
                <a:gd name="connsiteX1" fmla="*/ 27097 w 27097"/>
                <a:gd name="connsiteY1" fmla="*/ 16943 h 33945"/>
                <a:gd name="connsiteX2" fmla="*/ 13573 w 27097"/>
                <a:gd name="connsiteY2" fmla="*/ 33945 h 33945"/>
                <a:gd name="connsiteX3" fmla="*/ 0 w 27097"/>
                <a:gd name="connsiteY3" fmla="*/ 16943 h 33945"/>
                <a:gd name="connsiteX4" fmla="*/ 13573 w 27097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3945">
                  <a:moveTo>
                    <a:pt x="13573" y="0"/>
                  </a:moveTo>
                  <a:lnTo>
                    <a:pt x="27097" y="16943"/>
                  </a:lnTo>
                  <a:lnTo>
                    <a:pt x="13573" y="33945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8" name="フリーフォーム 5777">
              <a:extLst>
                <a:ext uri="{FF2B5EF4-FFF2-40B4-BE49-F238E27FC236}">
                  <a16:creationId xmlns:a16="http://schemas.microsoft.com/office/drawing/2014/main" xmlns="" id="{47690C68-CCBB-EED1-B44E-A10DA1BC3ADD}"/>
                </a:ext>
              </a:extLst>
            </p:cNvPr>
            <p:cNvSpPr/>
            <p:nvPr/>
          </p:nvSpPr>
          <p:spPr>
            <a:xfrm>
              <a:off x="5092984" y="8143425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79" name="フリーフォーム 5778">
              <a:extLst>
                <a:ext uri="{FF2B5EF4-FFF2-40B4-BE49-F238E27FC236}">
                  <a16:creationId xmlns:a16="http://schemas.microsoft.com/office/drawing/2014/main" xmlns="" id="{BD97B99C-1ECC-9E24-FD5D-A667B5257486}"/>
                </a:ext>
              </a:extLst>
            </p:cNvPr>
            <p:cNvSpPr/>
            <p:nvPr/>
          </p:nvSpPr>
          <p:spPr>
            <a:xfrm>
              <a:off x="5092984" y="8143425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0" name="フリーフォーム 5779">
              <a:extLst>
                <a:ext uri="{FF2B5EF4-FFF2-40B4-BE49-F238E27FC236}">
                  <a16:creationId xmlns:a16="http://schemas.microsoft.com/office/drawing/2014/main" xmlns="" id="{B5E2CA98-2356-D495-D92D-3FA11B6CD18B}"/>
                </a:ext>
              </a:extLst>
            </p:cNvPr>
            <p:cNvSpPr/>
            <p:nvPr/>
          </p:nvSpPr>
          <p:spPr>
            <a:xfrm>
              <a:off x="5161855" y="8143425"/>
              <a:ext cx="25200" cy="25200"/>
            </a:xfrm>
            <a:custGeom>
              <a:avLst/>
              <a:gdLst>
                <a:gd name="connsiteX0" fmla="*/ 13573 w 27097"/>
                <a:gd name="connsiteY0" fmla="*/ 0 h 34005"/>
                <a:gd name="connsiteX1" fmla="*/ 27097 w 27097"/>
                <a:gd name="connsiteY1" fmla="*/ 17003 h 34005"/>
                <a:gd name="connsiteX2" fmla="*/ 13573 w 27097"/>
                <a:gd name="connsiteY2" fmla="*/ 34005 h 34005"/>
                <a:gd name="connsiteX3" fmla="*/ 0 w 27097"/>
                <a:gd name="connsiteY3" fmla="*/ 17003 h 34005"/>
                <a:gd name="connsiteX4" fmla="*/ 13573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73" y="0"/>
                  </a:moveTo>
                  <a:lnTo>
                    <a:pt x="27097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1" name="フリーフォーム 5780">
              <a:extLst>
                <a:ext uri="{FF2B5EF4-FFF2-40B4-BE49-F238E27FC236}">
                  <a16:creationId xmlns:a16="http://schemas.microsoft.com/office/drawing/2014/main" xmlns="" id="{209072B3-E18E-F44D-475F-7818DE1D4ADF}"/>
                </a:ext>
              </a:extLst>
            </p:cNvPr>
            <p:cNvSpPr/>
            <p:nvPr/>
          </p:nvSpPr>
          <p:spPr>
            <a:xfrm>
              <a:off x="5161855" y="8143425"/>
              <a:ext cx="25200" cy="25200"/>
            </a:xfrm>
            <a:custGeom>
              <a:avLst/>
              <a:gdLst>
                <a:gd name="connsiteX0" fmla="*/ 13573 w 27097"/>
                <a:gd name="connsiteY0" fmla="*/ 0 h 34005"/>
                <a:gd name="connsiteX1" fmla="*/ 27097 w 27097"/>
                <a:gd name="connsiteY1" fmla="*/ 17003 h 34005"/>
                <a:gd name="connsiteX2" fmla="*/ 13573 w 27097"/>
                <a:gd name="connsiteY2" fmla="*/ 34005 h 34005"/>
                <a:gd name="connsiteX3" fmla="*/ 0 w 27097"/>
                <a:gd name="connsiteY3" fmla="*/ 17003 h 34005"/>
                <a:gd name="connsiteX4" fmla="*/ 13573 w 27097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097" h="34005">
                  <a:moveTo>
                    <a:pt x="13573" y="0"/>
                  </a:moveTo>
                  <a:lnTo>
                    <a:pt x="27097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2" name="フリーフォーム 5781">
              <a:extLst>
                <a:ext uri="{FF2B5EF4-FFF2-40B4-BE49-F238E27FC236}">
                  <a16:creationId xmlns:a16="http://schemas.microsoft.com/office/drawing/2014/main" xmlns="" id="{6E7A3533-FEC8-BC06-7A8D-FAF5D01CBDEE}"/>
                </a:ext>
              </a:extLst>
            </p:cNvPr>
            <p:cNvSpPr/>
            <p:nvPr/>
          </p:nvSpPr>
          <p:spPr>
            <a:xfrm>
              <a:off x="5475177" y="8238592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3" name="フリーフォーム 5782">
              <a:extLst>
                <a:ext uri="{FF2B5EF4-FFF2-40B4-BE49-F238E27FC236}">
                  <a16:creationId xmlns:a16="http://schemas.microsoft.com/office/drawing/2014/main" xmlns="" id="{7504E9FC-00C9-7364-B6F5-D0A49C2A9406}"/>
                </a:ext>
              </a:extLst>
            </p:cNvPr>
            <p:cNvSpPr/>
            <p:nvPr/>
          </p:nvSpPr>
          <p:spPr>
            <a:xfrm>
              <a:off x="5475177" y="8238592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4" name="フリーフォーム 5783">
              <a:extLst>
                <a:ext uri="{FF2B5EF4-FFF2-40B4-BE49-F238E27FC236}">
                  <a16:creationId xmlns:a16="http://schemas.microsoft.com/office/drawing/2014/main" xmlns="" id="{6790679C-D560-79A3-8317-67A5F35DF315}"/>
                </a:ext>
              </a:extLst>
            </p:cNvPr>
            <p:cNvSpPr/>
            <p:nvPr/>
          </p:nvSpPr>
          <p:spPr>
            <a:xfrm>
              <a:off x="5612918" y="8263706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5" name="フリーフォーム 5784">
              <a:extLst>
                <a:ext uri="{FF2B5EF4-FFF2-40B4-BE49-F238E27FC236}">
                  <a16:creationId xmlns:a16="http://schemas.microsoft.com/office/drawing/2014/main" xmlns="" id="{5CE239DA-4D43-94AB-FED7-546B087CA43F}"/>
                </a:ext>
              </a:extLst>
            </p:cNvPr>
            <p:cNvSpPr/>
            <p:nvPr/>
          </p:nvSpPr>
          <p:spPr>
            <a:xfrm>
              <a:off x="5612918" y="8263706"/>
              <a:ext cx="25200" cy="25200"/>
            </a:xfrm>
            <a:custGeom>
              <a:avLst/>
              <a:gdLst>
                <a:gd name="connsiteX0" fmla="*/ 13573 w 27145"/>
                <a:gd name="connsiteY0" fmla="*/ 0 h 34005"/>
                <a:gd name="connsiteX1" fmla="*/ 27145 w 27145"/>
                <a:gd name="connsiteY1" fmla="*/ 17003 h 34005"/>
                <a:gd name="connsiteX2" fmla="*/ 13573 w 27145"/>
                <a:gd name="connsiteY2" fmla="*/ 34005 h 34005"/>
                <a:gd name="connsiteX3" fmla="*/ 0 w 27145"/>
                <a:gd name="connsiteY3" fmla="*/ 17003 h 34005"/>
                <a:gd name="connsiteX4" fmla="*/ 13573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3" y="0"/>
                  </a:moveTo>
                  <a:lnTo>
                    <a:pt x="27145" y="17003"/>
                  </a:lnTo>
                  <a:lnTo>
                    <a:pt x="13573" y="34005"/>
                  </a:lnTo>
                  <a:lnTo>
                    <a:pt x="0" y="1700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6" name="フリーフォーム 5785">
              <a:extLst>
                <a:ext uri="{FF2B5EF4-FFF2-40B4-BE49-F238E27FC236}">
                  <a16:creationId xmlns:a16="http://schemas.microsoft.com/office/drawing/2014/main" xmlns="" id="{4B64A692-7FD0-6E01-5D1A-671BBD9929E5}"/>
                </a:ext>
              </a:extLst>
            </p:cNvPr>
            <p:cNvSpPr/>
            <p:nvPr/>
          </p:nvSpPr>
          <p:spPr>
            <a:xfrm>
              <a:off x="6869707" y="8557258"/>
              <a:ext cx="25200" cy="25200"/>
            </a:xfrm>
            <a:custGeom>
              <a:avLst/>
              <a:gdLst>
                <a:gd name="connsiteX0" fmla="*/ 13572 w 27145"/>
                <a:gd name="connsiteY0" fmla="*/ 0 h 34005"/>
                <a:gd name="connsiteX1" fmla="*/ 27145 w 27145"/>
                <a:gd name="connsiteY1" fmla="*/ 17003 h 34005"/>
                <a:gd name="connsiteX2" fmla="*/ 13572 w 27145"/>
                <a:gd name="connsiteY2" fmla="*/ 34005 h 34005"/>
                <a:gd name="connsiteX3" fmla="*/ 0 w 27145"/>
                <a:gd name="connsiteY3" fmla="*/ 17003 h 34005"/>
                <a:gd name="connsiteX4" fmla="*/ 13572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2" y="0"/>
                  </a:moveTo>
                  <a:lnTo>
                    <a:pt x="27145" y="17003"/>
                  </a:lnTo>
                  <a:lnTo>
                    <a:pt x="13572" y="34005"/>
                  </a:lnTo>
                  <a:lnTo>
                    <a:pt x="0" y="17003"/>
                  </a:lnTo>
                  <a:lnTo>
                    <a:pt x="13572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7" name="フリーフォーム 5786">
              <a:extLst>
                <a:ext uri="{FF2B5EF4-FFF2-40B4-BE49-F238E27FC236}">
                  <a16:creationId xmlns:a16="http://schemas.microsoft.com/office/drawing/2014/main" xmlns="" id="{C976EC13-0F89-E547-9863-F28DADED9E88}"/>
                </a:ext>
              </a:extLst>
            </p:cNvPr>
            <p:cNvSpPr/>
            <p:nvPr/>
          </p:nvSpPr>
          <p:spPr>
            <a:xfrm>
              <a:off x="6869707" y="8557258"/>
              <a:ext cx="25200" cy="25200"/>
            </a:xfrm>
            <a:custGeom>
              <a:avLst/>
              <a:gdLst>
                <a:gd name="connsiteX0" fmla="*/ 13572 w 27145"/>
                <a:gd name="connsiteY0" fmla="*/ 0 h 34005"/>
                <a:gd name="connsiteX1" fmla="*/ 27145 w 27145"/>
                <a:gd name="connsiteY1" fmla="*/ 17003 h 34005"/>
                <a:gd name="connsiteX2" fmla="*/ 13572 w 27145"/>
                <a:gd name="connsiteY2" fmla="*/ 34005 h 34005"/>
                <a:gd name="connsiteX3" fmla="*/ 0 w 27145"/>
                <a:gd name="connsiteY3" fmla="*/ 17003 h 34005"/>
                <a:gd name="connsiteX4" fmla="*/ 13572 w 27145"/>
                <a:gd name="connsiteY4" fmla="*/ 0 h 34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4005">
                  <a:moveTo>
                    <a:pt x="13572" y="0"/>
                  </a:moveTo>
                  <a:lnTo>
                    <a:pt x="27145" y="17003"/>
                  </a:lnTo>
                  <a:lnTo>
                    <a:pt x="13572" y="34005"/>
                  </a:lnTo>
                  <a:lnTo>
                    <a:pt x="0" y="17003"/>
                  </a:lnTo>
                  <a:lnTo>
                    <a:pt x="13572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8" name="フリーフォーム 5787">
              <a:extLst>
                <a:ext uri="{FF2B5EF4-FFF2-40B4-BE49-F238E27FC236}">
                  <a16:creationId xmlns:a16="http://schemas.microsoft.com/office/drawing/2014/main" xmlns="" id="{6E615D95-8251-C680-1CD6-5625087C7A90}"/>
                </a:ext>
              </a:extLst>
            </p:cNvPr>
            <p:cNvSpPr/>
            <p:nvPr/>
          </p:nvSpPr>
          <p:spPr>
            <a:xfrm>
              <a:off x="7761521" y="8624007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6943 h 33945"/>
                <a:gd name="connsiteX2" fmla="*/ 13573 w 27145"/>
                <a:gd name="connsiteY2" fmla="*/ 33946 h 33945"/>
                <a:gd name="connsiteX3" fmla="*/ 0 w 27145"/>
                <a:gd name="connsiteY3" fmla="*/ 1694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6943"/>
                  </a:lnTo>
                  <a:lnTo>
                    <a:pt x="13573" y="33946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solidFill>
              <a:srgbClr val="000000"/>
            </a:solidFill>
            <a:ln w="4791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89" name="フリーフォーム 5788">
              <a:extLst>
                <a:ext uri="{FF2B5EF4-FFF2-40B4-BE49-F238E27FC236}">
                  <a16:creationId xmlns:a16="http://schemas.microsoft.com/office/drawing/2014/main" xmlns="" id="{DC66EA77-B776-5D1B-E019-D5ED07E1F309}"/>
                </a:ext>
              </a:extLst>
            </p:cNvPr>
            <p:cNvSpPr/>
            <p:nvPr/>
          </p:nvSpPr>
          <p:spPr>
            <a:xfrm>
              <a:off x="7761521" y="8624007"/>
              <a:ext cx="25200" cy="25200"/>
            </a:xfrm>
            <a:custGeom>
              <a:avLst/>
              <a:gdLst>
                <a:gd name="connsiteX0" fmla="*/ 13573 w 27145"/>
                <a:gd name="connsiteY0" fmla="*/ 0 h 33945"/>
                <a:gd name="connsiteX1" fmla="*/ 27145 w 27145"/>
                <a:gd name="connsiteY1" fmla="*/ 16943 h 33945"/>
                <a:gd name="connsiteX2" fmla="*/ 13573 w 27145"/>
                <a:gd name="connsiteY2" fmla="*/ 33946 h 33945"/>
                <a:gd name="connsiteX3" fmla="*/ 0 w 27145"/>
                <a:gd name="connsiteY3" fmla="*/ 16943 h 33945"/>
                <a:gd name="connsiteX4" fmla="*/ 13573 w 27145"/>
                <a:gd name="connsiteY4" fmla="*/ 0 h 33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7145" h="33945">
                  <a:moveTo>
                    <a:pt x="13573" y="0"/>
                  </a:moveTo>
                  <a:lnTo>
                    <a:pt x="27145" y="16943"/>
                  </a:lnTo>
                  <a:lnTo>
                    <a:pt x="13573" y="33946"/>
                  </a:lnTo>
                  <a:lnTo>
                    <a:pt x="0" y="16943"/>
                  </a:lnTo>
                  <a:lnTo>
                    <a:pt x="13573" y="0"/>
                  </a:lnTo>
                  <a:close/>
                </a:path>
              </a:pathLst>
            </a:custGeom>
            <a:noFill/>
            <a:ln w="4791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grpSp>
          <p:nvGrpSpPr>
            <p:cNvPr id="5964" name="グループ化 5963">
              <a:extLst>
                <a:ext uri="{FF2B5EF4-FFF2-40B4-BE49-F238E27FC236}">
                  <a16:creationId xmlns:a16="http://schemas.microsoft.com/office/drawing/2014/main" xmlns="" id="{EC5AFA74-E699-C718-D46E-D5942509B129}"/>
                </a:ext>
              </a:extLst>
            </p:cNvPr>
            <p:cNvGrpSpPr/>
            <p:nvPr/>
          </p:nvGrpSpPr>
          <p:grpSpPr>
            <a:xfrm>
              <a:off x="4176459" y="6218802"/>
              <a:ext cx="3637443" cy="2363655"/>
              <a:chOff x="8384871" y="6202499"/>
              <a:chExt cx="3637443" cy="2047114"/>
            </a:xfrm>
          </p:grpSpPr>
          <p:sp>
            <p:nvSpPr>
              <p:cNvPr id="5836" name="フリーフォーム 5835">
                <a:extLst>
                  <a:ext uri="{FF2B5EF4-FFF2-40B4-BE49-F238E27FC236}">
                    <a16:creationId xmlns:a16="http://schemas.microsoft.com/office/drawing/2014/main" xmlns="" id="{B8AFADD3-21D3-0ED5-D3F6-07E94186CA96}"/>
                  </a:ext>
                </a:extLst>
              </p:cNvPr>
              <p:cNvSpPr/>
              <p:nvPr/>
            </p:nvSpPr>
            <p:spPr>
              <a:xfrm>
                <a:off x="8384871" y="6219502"/>
                <a:ext cx="3625815" cy="2016475"/>
              </a:xfrm>
              <a:custGeom>
                <a:avLst/>
                <a:gdLst>
                  <a:gd name="connsiteX0" fmla="*/ 0 w 3625815"/>
                  <a:gd name="connsiteY0" fmla="*/ 0 h 2016475"/>
                  <a:gd name="connsiteX1" fmla="*/ 17170 w 3625815"/>
                  <a:gd name="connsiteY1" fmla="*/ 0 h 2016475"/>
                  <a:gd name="connsiteX2" fmla="*/ 17218 w 3625815"/>
                  <a:gd name="connsiteY2" fmla="*/ 0 h 2016475"/>
                  <a:gd name="connsiteX3" fmla="*/ 41293 w 3625815"/>
                  <a:gd name="connsiteY3" fmla="*/ 0 h 2016475"/>
                  <a:gd name="connsiteX4" fmla="*/ 41293 w 3625815"/>
                  <a:gd name="connsiteY4" fmla="*/ 34967 h 2016475"/>
                  <a:gd name="connsiteX5" fmla="*/ 92946 w 3625815"/>
                  <a:gd name="connsiteY5" fmla="*/ 34967 h 2016475"/>
                  <a:gd name="connsiteX6" fmla="*/ 92946 w 3625815"/>
                  <a:gd name="connsiteY6" fmla="*/ 72036 h 2016475"/>
                  <a:gd name="connsiteX7" fmla="*/ 141146 w 3625815"/>
                  <a:gd name="connsiteY7" fmla="*/ 72036 h 2016475"/>
                  <a:gd name="connsiteX8" fmla="*/ 141146 w 3625815"/>
                  <a:gd name="connsiteY8" fmla="*/ 148579 h 2016475"/>
                  <a:gd name="connsiteX9" fmla="*/ 144599 w 3625815"/>
                  <a:gd name="connsiteY9" fmla="*/ 148579 h 2016475"/>
                  <a:gd name="connsiteX10" fmla="*/ 144599 w 3625815"/>
                  <a:gd name="connsiteY10" fmla="*/ 187511 h 2016475"/>
                  <a:gd name="connsiteX11" fmla="*/ 161817 w 3625815"/>
                  <a:gd name="connsiteY11" fmla="*/ 187511 h 2016475"/>
                  <a:gd name="connsiteX12" fmla="*/ 161817 w 3625815"/>
                  <a:gd name="connsiteY12" fmla="*/ 226383 h 2016475"/>
                  <a:gd name="connsiteX13" fmla="*/ 168675 w 3625815"/>
                  <a:gd name="connsiteY13" fmla="*/ 226383 h 2016475"/>
                  <a:gd name="connsiteX14" fmla="*/ 168723 w 3625815"/>
                  <a:gd name="connsiteY14" fmla="*/ 265315 h 2016475"/>
                  <a:gd name="connsiteX15" fmla="*/ 175581 w 3625815"/>
                  <a:gd name="connsiteY15" fmla="*/ 265315 h 2016475"/>
                  <a:gd name="connsiteX16" fmla="*/ 175581 w 3625815"/>
                  <a:gd name="connsiteY16" fmla="*/ 304187 h 2016475"/>
                  <a:gd name="connsiteX17" fmla="*/ 179034 w 3625815"/>
                  <a:gd name="connsiteY17" fmla="*/ 304187 h 2016475"/>
                  <a:gd name="connsiteX18" fmla="*/ 179034 w 3625815"/>
                  <a:gd name="connsiteY18" fmla="*/ 343119 h 2016475"/>
                  <a:gd name="connsiteX19" fmla="*/ 182487 w 3625815"/>
                  <a:gd name="connsiteY19" fmla="*/ 343119 h 2016475"/>
                  <a:gd name="connsiteX20" fmla="*/ 182487 w 3625815"/>
                  <a:gd name="connsiteY20" fmla="*/ 420923 h 2016475"/>
                  <a:gd name="connsiteX21" fmla="*/ 185893 w 3625815"/>
                  <a:gd name="connsiteY21" fmla="*/ 420923 h 2016475"/>
                  <a:gd name="connsiteX22" fmla="*/ 185941 w 3625815"/>
                  <a:gd name="connsiteY22" fmla="*/ 459795 h 2016475"/>
                  <a:gd name="connsiteX23" fmla="*/ 206563 w 3625815"/>
                  <a:gd name="connsiteY23" fmla="*/ 459795 h 2016475"/>
                  <a:gd name="connsiteX24" fmla="*/ 206563 w 3625815"/>
                  <a:gd name="connsiteY24" fmla="*/ 498727 h 2016475"/>
                  <a:gd name="connsiteX25" fmla="*/ 261669 w 3625815"/>
                  <a:gd name="connsiteY25" fmla="*/ 498727 h 2016475"/>
                  <a:gd name="connsiteX26" fmla="*/ 261669 w 3625815"/>
                  <a:gd name="connsiteY26" fmla="*/ 537599 h 2016475"/>
                  <a:gd name="connsiteX27" fmla="*/ 292651 w 3625815"/>
                  <a:gd name="connsiteY27" fmla="*/ 537599 h 2016475"/>
                  <a:gd name="connsiteX28" fmla="*/ 292651 w 3625815"/>
                  <a:gd name="connsiteY28" fmla="*/ 578153 h 2016475"/>
                  <a:gd name="connsiteX29" fmla="*/ 337398 w 3625815"/>
                  <a:gd name="connsiteY29" fmla="*/ 578153 h 2016475"/>
                  <a:gd name="connsiteX30" fmla="*/ 337446 w 3625815"/>
                  <a:gd name="connsiteY30" fmla="*/ 620449 h 2016475"/>
                  <a:gd name="connsiteX31" fmla="*/ 351210 w 3625815"/>
                  <a:gd name="connsiteY31" fmla="*/ 620449 h 2016475"/>
                  <a:gd name="connsiteX32" fmla="*/ 351210 w 3625815"/>
                  <a:gd name="connsiteY32" fmla="*/ 663767 h 2016475"/>
                  <a:gd name="connsiteX33" fmla="*/ 358069 w 3625815"/>
                  <a:gd name="connsiteY33" fmla="*/ 663767 h 2016475"/>
                  <a:gd name="connsiteX34" fmla="*/ 358069 w 3625815"/>
                  <a:gd name="connsiteY34" fmla="*/ 710450 h 2016475"/>
                  <a:gd name="connsiteX35" fmla="*/ 364975 w 3625815"/>
                  <a:gd name="connsiteY35" fmla="*/ 710450 h 2016475"/>
                  <a:gd name="connsiteX36" fmla="*/ 364975 w 3625815"/>
                  <a:gd name="connsiteY36" fmla="*/ 757072 h 2016475"/>
                  <a:gd name="connsiteX37" fmla="*/ 368428 w 3625815"/>
                  <a:gd name="connsiteY37" fmla="*/ 757072 h 2016475"/>
                  <a:gd name="connsiteX38" fmla="*/ 368428 w 3625815"/>
                  <a:gd name="connsiteY38" fmla="*/ 805016 h 2016475"/>
                  <a:gd name="connsiteX39" fmla="*/ 375286 w 3625815"/>
                  <a:gd name="connsiteY39" fmla="*/ 805016 h 2016475"/>
                  <a:gd name="connsiteX40" fmla="*/ 375286 w 3625815"/>
                  <a:gd name="connsiteY40" fmla="*/ 948788 h 2016475"/>
                  <a:gd name="connsiteX41" fmla="*/ 395957 w 3625815"/>
                  <a:gd name="connsiteY41" fmla="*/ 948788 h 2016475"/>
                  <a:gd name="connsiteX42" fmla="*/ 395957 w 3625815"/>
                  <a:gd name="connsiteY42" fmla="*/ 996732 h 2016475"/>
                  <a:gd name="connsiteX43" fmla="*/ 413175 w 3625815"/>
                  <a:gd name="connsiteY43" fmla="*/ 996732 h 2016475"/>
                  <a:gd name="connsiteX44" fmla="*/ 413175 w 3625815"/>
                  <a:gd name="connsiteY44" fmla="*/ 1044676 h 2016475"/>
                  <a:gd name="connsiteX45" fmla="*/ 420081 w 3625815"/>
                  <a:gd name="connsiteY45" fmla="*/ 1044676 h 2016475"/>
                  <a:gd name="connsiteX46" fmla="*/ 420081 w 3625815"/>
                  <a:gd name="connsiteY46" fmla="*/ 1092620 h 2016475"/>
                  <a:gd name="connsiteX47" fmla="*/ 437298 w 3625815"/>
                  <a:gd name="connsiteY47" fmla="*/ 1092620 h 2016475"/>
                  <a:gd name="connsiteX48" fmla="*/ 437298 w 3625815"/>
                  <a:gd name="connsiteY48" fmla="*/ 1144109 h 2016475"/>
                  <a:gd name="connsiteX49" fmla="*/ 457921 w 3625815"/>
                  <a:gd name="connsiteY49" fmla="*/ 1144109 h 2016475"/>
                  <a:gd name="connsiteX50" fmla="*/ 457921 w 3625815"/>
                  <a:gd name="connsiteY50" fmla="*/ 1195598 h 2016475"/>
                  <a:gd name="connsiteX51" fmla="*/ 461374 w 3625815"/>
                  <a:gd name="connsiteY51" fmla="*/ 1195598 h 2016475"/>
                  <a:gd name="connsiteX52" fmla="*/ 461374 w 3625815"/>
                  <a:gd name="connsiteY52" fmla="*/ 1247087 h 2016475"/>
                  <a:gd name="connsiteX53" fmla="*/ 468280 w 3625815"/>
                  <a:gd name="connsiteY53" fmla="*/ 1247087 h 2016475"/>
                  <a:gd name="connsiteX54" fmla="*/ 468280 w 3625815"/>
                  <a:gd name="connsiteY54" fmla="*/ 1298576 h 2016475"/>
                  <a:gd name="connsiteX55" fmla="*/ 547462 w 3625815"/>
                  <a:gd name="connsiteY55" fmla="*/ 1298576 h 2016475"/>
                  <a:gd name="connsiteX56" fmla="*/ 547462 w 3625815"/>
                  <a:gd name="connsiteY56" fmla="*/ 1350065 h 2016475"/>
                  <a:gd name="connsiteX57" fmla="*/ 554368 w 3625815"/>
                  <a:gd name="connsiteY57" fmla="*/ 1350065 h 2016475"/>
                  <a:gd name="connsiteX58" fmla="*/ 554368 w 3625815"/>
                  <a:gd name="connsiteY58" fmla="*/ 1406720 h 2016475"/>
                  <a:gd name="connsiteX59" fmla="*/ 595662 w 3625815"/>
                  <a:gd name="connsiteY59" fmla="*/ 1406720 h 2016475"/>
                  <a:gd name="connsiteX60" fmla="*/ 595662 w 3625815"/>
                  <a:gd name="connsiteY60" fmla="*/ 1478456 h 2016475"/>
                  <a:gd name="connsiteX61" fmla="*/ 667985 w 3625815"/>
                  <a:gd name="connsiteY61" fmla="*/ 1478456 h 2016475"/>
                  <a:gd name="connsiteX62" fmla="*/ 667985 w 3625815"/>
                  <a:gd name="connsiteY62" fmla="*/ 1550192 h 2016475"/>
                  <a:gd name="connsiteX63" fmla="*/ 922796 w 3625815"/>
                  <a:gd name="connsiteY63" fmla="*/ 1550192 h 2016475"/>
                  <a:gd name="connsiteX64" fmla="*/ 922796 w 3625815"/>
                  <a:gd name="connsiteY64" fmla="*/ 1666748 h 2016475"/>
                  <a:gd name="connsiteX65" fmla="*/ 1112190 w 3625815"/>
                  <a:gd name="connsiteY65" fmla="*/ 1666748 h 2016475"/>
                  <a:gd name="connsiteX66" fmla="*/ 1112190 w 3625815"/>
                  <a:gd name="connsiteY66" fmla="*/ 1783364 h 2016475"/>
                  <a:gd name="connsiteX67" fmla="*/ 1969569 w 3625815"/>
                  <a:gd name="connsiteY67" fmla="*/ 1783364 h 2016475"/>
                  <a:gd name="connsiteX68" fmla="*/ 1969569 w 3625815"/>
                  <a:gd name="connsiteY68" fmla="*/ 2016475 h 2016475"/>
                  <a:gd name="connsiteX69" fmla="*/ 3625768 w 3625815"/>
                  <a:gd name="connsiteY69" fmla="*/ 2016475 h 2016475"/>
                  <a:gd name="connsiteX70" fmla="*/ 3625816 w 3625815"/>
                  <a:gd name="connsiteY70" fmla="*/ 2016475 h 2016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</a:cxnLst>
                <a:rect l="l" t="t" r="r" b="b"/>
                <a:pathLst>
                  <a:path w="3625815" h="2016475">
                    <a:moveTo>
                      <a:pt x="0" y="0"/>
                    </a:moveTo>
                    <a:lnTo>
                      <a:pt x="17170" y="0"/>
                    </a:lnTo>
                    <a:lnTo>
                      <a:pt x="17218" y="0"/>
                    </a:lnTo>
                    <a:lnTo>
                      <a:pt x="41293" y="0"/>
                    </a:lnTo>
                    <a:lnTo>
                      <a:pt x="41293" y="34967"/>
                    </a:lnTo>
                    <a:lnTo>
                      <a:pt x="92946" y="34967"/>
                    </a:lnTo>
                    <a:lnTo>
                      <a:pt x="92946" y="72036"/>
                    </a:lnTo>
                    <a:lnTo>
                      <a:pt x="141146" y="72036"/>
                    </a:lnTo>
                    <a:lnTo>
                      <a:pt x="141146" y="148579"/>
                    </a:lnTo>
                    <a:lnTo>
                      <a:pt x="144599" y="148579"/>
                    </a:lnTo>
                    <a:lnTo>
                      <a:pt x="144599" y="187511"/>
                    </a:lnTo>
                    <a:lnTo>
                      <a:pt x="161817" y="187511"/>
                    </a:lnTo>
                    <a:lnTo>
                      <a:pt x="161817" y="226383"/>
                    </a:lnTo>
                    <a:lnTo>
                      <a:pt x="168675" y="226383"/>
                    </a:lnTo>
                    <a:lnTo>
                      <a:pt x="168723" y="265315"/>
                    </a:lnTo>
                    <a:lnTo>
                      <a:pt x="175581" y="265315"/>
                    </a:lnTo>
                    <a:lnTo>
                      <a:pt x="175581" y="304187"/>
                    </a:lnTo>
                    <a:lnTo>
                      <a:pt x="179034" y="304187"/>
                    </a:lnTo>
                    <a:lnTo>
                      <a:pt x="179034" y="343119"/>
                    </a:lnTo>
                    <a:lnTo>
                      <a:pt x="182487" y="343119"/>
                    </a:lnTo>
                    <a:lnTo>
                      <a:pt x="182487" y="420923"/>
                    </a:lnTo>
                    <a:lnTo>
                      <a:pt x="185893" y="420923"/>
                    </a:lnTo>
                    <a:lnTo>
                      <a:pt x="185941" y="459795"/>
                    </a:lnTo>
                    <a:lnTo>
                      <a:pt x="206563" y="459795"/>
                    </a:lnTo>
                    <a:lnTo>
                      <a:pt x="206563" y="498727"/>
                    </a:lnTo>
                    <a:lnTo>
                      <a:pt x="261669" y="498727"/>
                    </a:lnTo>
                    <a:lnTo>
                      <a:pt x="261669" y="537599"/>
                    </a:lnTo>
                    <a:lnTo>
                      <a:pt x="292651" y="537599"/>
                    </a:lnTo>
                    <a:lnTo>
                      <a:pt x="292651" y="578153"/>
                    </a:lnTo>
                    <a:lnTo>
                      <a:pt x="337398" y="578153"/>
                    </a:lnTo>
                    <a:lnTo>
                      <a:pt x="337446" y="620449"/>
                    </a:lnTo>
                    <a:lnTo>
                      <a:pt x="351210" y="620449"/>
                    </a:lnTo>
                    <a:lnTo>
                      <a:pt x="351210" y="663767"/>
                    </a:lnTo>
                    <a:lnTo>
                      <a:pt x="358069" y="663767"/>
                    </a:lnTo>
                    <a:lnTo>
                      <a:pt x="358069" y="710450"/>
                    </a:lnTo>
                    <a:lnTo>
                      <a:pt x="364975" y="710450"/>
                    </a:lnTo>
                    <a:lnTo>
                      <a:pt x="364975" y="757072"/>
                    </a:lnTo>
                    <a:lnTo>
                      <a:pt x="368428" y="757072"/>
                    </a:lnTo>
                    <a:lnTo>
                      <a:pt x="368428" y="805016"/>
                    </a:lnTo>
                    <a:lnTo>
                      <a:pt x="375286" y="805016"/>
                    </a:lnTo>
                    <a:lnTo>
                      <a:pt x="375286" y="948788"/>
                    </a:lnTo>
                    <a:lnTo>
                      <a:pt x="395957" y="948788"/>
                    </a:lnTo>
                    <a:lnTo>
                      <a:pt x="395957" y="996732"/>
                    </a:lnTo>
                    <a:lnTo>
                      <a:pt x="413175" y="996732"/>
                    </a:lnTo>
                    <a:lnTo>
                      <a:pt x="413175" y="1044676"/>
                    </a:lnTo>
                    <a:lnTo>
                      <a:pt x="420081" y="1044676"/>
                    </a:lnTo>
                    <a:lnTo>
                      <a:pt x="420081" y="1092620"/>
                    </a:lnTo>
                    <a:lnTo>
                      <a:pt x="437298" y="1092620"/>
                    </a:lnTo>
                    <a:lnTo>
                      <a:pt x="437298" y="1144109"/>
                    </a:lnTo>
                    <a:lnTo>
                      <a:pt x="457921" y="1144109"/>
                    </a:lnTo>
                    <a:lnTo>
                      <a:pt x="457921" y="1195598"/>
                    </a:lnTo>
                    <a:lnTo>
                      <a:pt x="461374" y="1195598"/>
                    </a:lnTo>
                    <a:lnTo>
                      <a:pt x="461374" y="1247087"/>
                    </a:lnTo>
                    <a:lnTo>
                      <a:pt x="468280" y="1247087"/>
                    </a:lnTo>
                    <a:lnTo>
                      <a:pt x="468280" y="1298576"/>
                    </a:lnTo>
                    <a:lnTo>
                      <a:pt x="547462" y="1298576"/>
                    </a:lnTo>
                    <a:lnTo>
                      <a:pt x="547462" y="1350065"/>
                    </a:lnTo>
                    <a:lnTo>
                      <a:pt x="554368" y="1350065"/>
                    </a:lnTo>
                    <a:lnTo>
                      <a:pt x="554368" y="1406720"/>
                    </a:lnTo>
                    <a:lnTo>
                      <a:pt x="595662" y="1406720"/>
                    </a:lnTo>
                    <a:lnTo>
                      <a:pt x="595662" y="1478456"/>
                    </a:lnTo>
                    <a:lnTo>
                      <a:pt x="667985" y="1478456"/>
                    </a:lnTo>
                    <a:lnTo>
                      <a:pt x="667985" y="1550192"/>
                    </a:lnTo>
                    <a:lnTo>
                      <a:pt x="922796" y="1550192"/>
                    </a:lnTo>
                    <a:lnTo>
                      <a:pt x="922796" y="1666748"/>
                    </a:lnTo>
                    <a:lnTo>
                      <a:pt x="1112190" y="1666748"/>
                    </a:lnTo>
                    <a:lnTo>
                      <a:pt x="1112190" y="1783364"/>
                    </a:lnTo>
                    <a:lnTo>
                      <a:pt x="1969569" y="1783364"/>
                    </a:lnTo>
                    <a:lnTo>
                      <a:pt x="1969569" y="2016475"/>
                    </a:lnTo>
                    <a:lnTo>
                      <a:pt x="3625768" y="2016475"/>
                    </a:lnTo>
                    <a:lnTo>
                      <a:pt x="3625816" y="2016475"/>
                    </a:lnTo>
                  </a:path>
                </a:pathLst>
              </a:custGeom>
              <a:noFill/>
              <a:ln w="15875" cap="flat">
                <a:solidFill>
                  <a:srgbClr val="C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38" name="フリーフォーム 5837">
                <a:extLst>
                  <a:ext uri="{FF2B5EF4-FFF2-40B4-BE49-F238E27FC236}">
                    <a16:creationId xmlns:a16="http://schemas.microsoft.com/office/drawing/2014/main" xmlns="" id="{C6B5667C-1FE1-85C7-034A-69C997BDC4C6}"/>
                  </a:ext>
                </a:extLst>
              </p:cNvPr>
              <p:cNvSpPr/>
              <p:nvPr/>
            </p:nvSpPr>
            <p:spPr>
              <a:xfrm>
                <a:off x="8398827" y="6202499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39" name="フリーフォーム 5838">
                <a:extLst>
                  <a:ext uri="{FF2B5EF4-FFF2-40B4-BE49-F238E27FC236}">
                    <a16:creationId xmlns:a16="http://schemas.microsoft.com/office/drawing/2014/main" xmlns="" id="{B2A5778C-E640-A4EC-1FA3-5C2C9959D1C2}"/>
                  </a:ext>
                </a:extLst>
              </p:cNvPr>
              <p:cNvSpPr/>
              <p:nvPr/>
            </p:nvSpPr>
            <p:spPr>
              <a:xfrm>
                <a:off x="8398827" y="6202499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46" name="フリーフォーム 5845">
                <a:extLst>
                  <a:ext uri="{FF2B5EF4-FFF2-40B4-BE49-F238E27FC236}">
                    <a16:creationId xmlns:a16="http://schemas.microsoft.com/office/drawing/2014/main" xmlns="" id="{8BB2A30E-61A5-5446-99FA-020665C848ED}"/>
                  </a:ext>
                </a:extLst>
              </p:cNvPr>
              <p:cNvSpPr/>
              <p:nvPr/>
            </p:nvSpPr>
            <p:spPr>
              <a:xfrm>
                <a:off x="8447027" y="6242845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47" name="フリーフォーム 5846">
                <a:extLst>
                  <a:ext uri="{FF2B5EF4-FFF2-40B4-BE49-F238E27FC236}">
                    <a16:creationId xmlns:a16="http://schemas.microsoft.com/office/drawing/2014/main" xmlns="" id="{A7F9C8A6-33E3-0C45-97BA-18FB91E68166}"/>
                  </a:ext>
                </a:extLst>
              </p:cNvPr>
              <p:cNvSpPr/>
              <p:nvPr/>
            </p:nvSpPr>
            <p:spPr>
              <a:xfrm>
                <a:off x="8447027" y="6242845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48" name="フリーフォーム 5847">
                <a:extLst>
                  <a:ext uri="{FF2B5EF4-FFF2-40B4-BE49-F238E27FC236}">
                    <a16:creationId xmlns:a16="http://schemas.microsoft.com/office/drawing/2014/main" xmlns="" id="{D732CD7F-B5B5-9319-6EFF-6E6391D9C535}"/>
                  </a:ext>
                </a:extLst>
              </p:cNvPr>
              <p:cNvSpPr/>
              <p:nvPr/>
            </p:nvSpPr>
            <p:spPr>
              <a:xfrm>
                <a:off x="8471151" y="6279914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49" name="フリーフォーム 5848">
                <a:extLst>
                  <a:ext uri="{FF2B5EF4-FFF2-40B4-BE49-F238E27FC236}">
                    <a16:creationId xmlns:a16="http://schemas.microsoft.com/office/drawing/2014/main" xmlns="" id="{A3F040A5-E21B-1C80-48BD-D8F65CE75BBA}"/>
                  </a:ext>
                </a:extLst>
              </p:cNvPr>
              <p:cNvSpPr/>
              <p:nvPr/>
            </p:nvSpPr>
            <p:spPr>
              <a:xfrm>
                <a:off x="8471151" y="6279914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0" name="フリーフォーム 5849">
                <a:extLst>
                  <a:ext uri="{FF2B5EF4-FFF2-40B4-BE49-F238E27FC236}">
                    <a16:creationId xmlns:a16="http://schemas.microsoft.com/office/drawing/2014/main" xmlns="" id="{510F9B59-CEE9-B366-3F4F-B60CA4AAA55B}"/>
                  </a:ext>
                </a:extLst>
              </p:cNvPr>
              <p:cNvSpPr/>
              <p:nvPr/>
            </p:nvSpPr>
            <p:spPr>
              <a:xfrm>
                <a:off x="8498680" y="6279914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1" name="フリーフォーム 5850">
                <a:extLst>
                  <a:ext uri="{FF2B5EF4-FFF2-40B4-BE49-F238E27FC236}">
                    <a16:creationId xmlns:a16="http://schemas.microsoft.com/office/drawing/2014/main" xmlns="" id="{11D5EA76-0AE5-CD0F-6573-85D6676831CE}"/>
                  </a:ext>
                </a:extLst>
              </p:cNvPr>
              <p:cNvSpPr/>
              <p:nvPr/>
            </p:nvSpPr>
            <p:spPr>
              <a:xfrm>
                <a:off x="8498680" y="6279914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2" name="フリーフォーム 5851">
                <a:extLst>
                  <a:ext uri="{FF2B5EF4-FFF2-40B4-BE49-F238E27FC236}">
                    <a16:creationId xmlns:a16="http://schemas.microsoft.com/office/drawing/2014/main" xmlns="" id="{A1E586DF-79E4-1FA6-2247-359DDEAEEC36}"/>
                  </a:ext>
                </a:extLst>
              </p:cNvPr>
              <p:cNvSpPr/>
              <p:nvPr/>
            </p:nvSpPr>
            <p:spPr>
              <a:xfrm>
                <a:off x="8512444" y="6356457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3" name="フリーフォーム 5852">
                <a:extLst>
                  <a:ext uri="{FF2B5EF4-FFF2-40B4-BE49-F238E27FC236}">
                    <a16:creationId xmlns:a16="http://schemas.microsoft.com/office/drawing/2014/main" xmlns="" id="{F0007B18-63E2-C334-7F13-5D9EDC14461A}"/>
                  </a:ext>
                </a:extLst>
              </p:cNvPr>
              <p:cNvSpPr/>
              <p:nvPr/>
            </p:nvSpPr>
            <p:spPr>
              <a:xfrm>
                <a:off x="8512444" y="6356457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4" name="フリーフォーム 5853">
                <a:extLst>
                  <a:ext uri="{FF2B5EF4-FFF2-40B4-BE49-F238E27FC236}">
                    <a16:creationId xmlns:a16="http://schemas.microsoft.com/office/drawing/2014/main" xmlns="" id="{1329DBC3-E4A3-26B8-69AE-A204EB954E68}"/>
                  </a:ext>
                </a:extLst>
              </p:cNvPr>
              <p:cNvSpPr/>
              <p:nvPr/>
            </p:nvSpPr>
            <p:spPr>
              <a:xfrm>
                <a:off x="8646732" y="6745537"/>
                <a:ext cx="25200" cy="25200"/>
              </a:xfrm>
              <a:custGeom>
                <a:avLst/>
                <a:gdLst>
                  <a:gd name="connsiteX0" fmla="*/ 13573 w 27145"/>
                  <a:gd name="connsiteY0" fmla="*/ 0 h 33945"/>
                  <a:gd name="connsiteX1" fmla="*/ 27145 w 27145"/>
                  <a:gd name="connsiteY1" fmla="*/ 16943 h 33945"/>
                  <a:gd name="connsiteX2" fmla="*/ 13573 w 27145"/>
                  <a:gd name="connsiteY2" fmla="*/ 33945 h 33945"/>
                  <a:gd name="connsiteX3" fmla="*/ 0 w 27145"/>
                  <a:gd name="connsiteY3" fmla="*/ 16943 h 33945"/>
                  <a:gd name="connsiteX4" fmla="*/ 13573 w 27145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3945">
                    <a:moveTo>
                      <a:pt x="13573" y="0"/>
                    </a:moveTo>
                    <a:lnTo>
                      <a:pt x="27145" y="16943"/>
                    </a:lnTo>
                    <a:lnTo>
                      <a:pt x="13573" y="33945"/>
                    </a:lnTo>
                    <a:lnTo>
                      <a:pt x="0" y="1694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5" name="フリーフォーム 5854">
                <a:extLst>
                  <a:ext uri="{FF2B5EF4-FFF2-40B4-BE49-F238E27FC236}">
                    <a16:creationId xmlns:a16="http://schemas.microsoft.com/office/drawing/2014/main" xmlns="" id="{56E36C37-AB1F-C69A-9DEE-36F165DB5A1A}"/>
                  </a:ext>
                </a:extLst>
              </p:cNvPr>
              <p:cNvSpPr/>
              <p:nvPr/>
            </p:nvSpPr>
            <p:spPr>
              <a:xfrm>
                <a:off x="8646732" y="6745537"/>
                <a:ext cx="25200" cy="25200"/>
              </a:xfrm>
              <a:custGeom>
                <a:avLst/>
                <a:gdLst>
                  <a:gd name="connsiteX0" fmla="*/ 13573 w 27145"/>
                  <a:gd name="connsiteY0" fmla="*/ 0 h 33945"/>
                  <a:gd name="connsiteX1" fmla="*/ 27145 w 27145"/>
                  <a:gd name="connsiteY1" fmla="*/ 16943 h 33945"/>
                  <a:gd name="connsiteX2" fmla="*/ 13573 w 27145"/>
                  <a:gd name="connsiteY2" fmla="*/ 33945 h 33945"/>
                  <a:gd name="connsiteX3" fmla="*/ 0 w 27145"/>
                  <a:gd name="connsiteY3" fmla="*/ 16943 h 33945"/>
                  <a:gd name="connsiteX4" fmla="*/ 13573 w 27145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3945">
                    <a:moveTo>
                      <a:pt x="13573" y="0"/>
                    </a:moveTo>
                    <a:lnTo>
                      <a:pt x="27145" y="16943"/>
                    </a:lnTo>
                    <a:lnTo>
                      <a:pt x="13573" y="33945"/>
                    </a:lnTo>
                    <a:lnTo>
                      <a:pt x="0" y="1694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6" name="フリーフォーム 5855">
                <a:extLst>
                  <a:ext uri="{FF2B5EF4-FFF2-40B4-BE49-F238E27FC236}">
                    <a16:creationId xmlns:a16="http://schemas.microsoft.com/office/drawing/2014/main" xmlns="" id="{C922C2D0-FDA0-BCFE-C23B-15E001C4A00E}"/>
                  </a:ext>
                </a:extLst>
              </p:cNvPr>
              <p:cNvSpPr/>
              <p:nvPr/>
            </p:nvSpPr>
            <p:spPr>
              <a:xfrm>
                <a:off x="8650185" y="6745537"/>
                <a:ext cx="25200" cy="25200"/>
              </a:xfrm>
              <a:custGeom>
                <a:avLst/>
                <a:gdLst>
                  <a:gd name="connsiteX0" fmla="*/ 13573 w 27145"/>
                  <a:gd name="connsiteY0" fmla="*/ 0 h 33945"/>
                  <a:gd name="connsiteX1" fmla="*/ 27145 w 27145"/>
                  <a:gd name="connsiteY1" fmla="*/ 16943 h 33945"/>
                  <a:gd name="connsiteX2" fmla="*/ 13573 w 27145"/>
                  <a:gd name="connsiteY2" fmla="*/ 33945 h 33945"/>
                  <a:gd name="connsiteX3" fmla="*/ 0 w 27145"/>
                  <a:gd name="connsiteY3" fmla="*/ 16943 h 33945"/>
                  <a:gd name="connsiteX4" fmla="*/ 13573 w 27145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3945">
                    <a:moveTo>
                      <a:pt x="13573" y="0"/>
                    </a:moveTo>
                    <a:lnTo>
                      <a:pt x="27145" y="16943"/>
                    </a:lnTo>
                    <a:lnTo>
                      <a:pt x="13573" y="33945"/>
                    </a:lnTo>
                    <a:lnTo>
                      <a:pt x="0" y="1694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7" name="フリーフォーム 5856">
                <a:extLst>
                  <a:ext uri="{FF2B5EF4-FFF2-40B4-BE49-F238E27FC236}">
                    <a16:creationId xmlns:a16="http://schemas.microsoft.com/office/drawing/2014/main" xmlns="" id="{049BD799-6572-7248-6D00-8D94F3A9B93E}"/>
                  </a:ext>
                </a:extLst>
              </p:cNvPr>
              <p:cNvSpPr/>
              <p:nvPr/>
            </p:nvSpPr>
            <p:spPr>
              <a:xfrm>
                <a:off x="8650185" y="6745537"/>
                <a:ext cx="25200" cy="25200"/>
              </a:xfrm>
              <a:custGeom>
                <a:avLst/>
                <a:gdLst>
                  <a:gd name="connsiteX0" fmla="*/ 13573 w 27145"/>
                  <a:gd name="connsiteY0" fmla="*/ 0 h 33945"/>
                  <a:gd name="connsiteX1" fmla="*/ 27145 w 27145"/>
                  <a:gd name="connsiteY1" fmla="*/ 16943 h 33945"/>
                  <a:gd name="connsiteX2" fmla="*/ 13573 w 27145"/>
                  <a:gd name="connsiteY2" fmla="*/ 33945 h 33945"/>
                  <a:gd name="connsiteX3" fmla="*/ 0 w 27145"/>
                  <a:gd name="connsiteY3" fmla="*/ 16943 h 33945"/>
                  <a:gd name="connsiteX4" fmla="*/ 13573 w 27145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3945">
                    <a:moveTo>
                      <a:pt x="13573" y="0"/>
                    </a:moveTo>
                    <a:lnTo>
                      <a:pt x="27145" y="16943"/>
                    </a:lnTo>
                    <a:lnTo>
                      <a:pt x="13573" y="33945"/>
                    </a:lnTo>
                    <a:lnTo>
                      <a:pt x="0" y="1694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8" name="フリーフォーム 5857">
                <a:extLst>
                  <a:ext uri="{FF2B5EF4-FFF2-40B4-BE49-F238E27FC236}">
                    <a16:creationId xmlns:a16="http://schemas.microsoft.com/office/drawing/2014/main" xmlns="" id="{3EBD7BF8-EA09-879B-8167-F7858AEA3E6D}"/>
                  </a:ext>
                </a:extLst>
              </p:cNvPr>
              <p:cNvSpPr/>
              <p:nvPr/>
            </p:nvSpPr>
            <p:spPr>
              <a:xfrm>
                <a:off x="8663950" y="6786031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59" name="フリーフォーム 5858">
                <a:extLst>
                  <a:ext uri="{FF2B5EF4-FFF2-40B4-BE49-F238E27FC236}">
                    <a16:creationId xmlns:a16="http://schemas.microsoft.com/office/drawing/2014/main" xmlns="" id="{631E831B-2E47-4FCE-EC31-CAA9E43BBFA0}"/>
                  </a:ext>
                </a:extLst>
              </p:cNvPr>
              <p:cNvSpPr/>
              <p:nvPr/>
            </p:nvSpPr>
            <p:spPr>
              <a:xfrm>
                <a:off x="8663950" y="6786031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0" name="フリーフォーム 5859">
                <a:extLst>
                  <a:ext uri="{FF2B5EF4-FFF2-40B4-BE49-F238E27FC236}">
                    <a16:creationId xmlns:a16="http://schemas.microsoft.com/office/drawing/2014/main" xmlns="" id="{5851F4F0-EBEF-FE23-A0C0-1386A2231520}"/>
                  </a:ext>
                </a:extLst>
              </p:cNvPr>
              <p:cNvSpPr/>
              <p:nvPr/>
            </p:nvSpPr>
            <p:spPr>
              <a:xfrm>
                <a:off x="8701838" y="6786031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1" name="フリーフォーム 5860">
                <a:extLst>
                  <a:ext uri="{FF2B5EF4-FFF2-40B4-BE49-F238E27FC236}">
                    <a16:creationId xmlns:a16="http://schemas.microsoft.com/office/drawing/2014/main" xmlns="" id="{CBF50D12-9B11-3E76-4F18-3EC84176DC6A}"/>
                  </a:ext>
                </a:extLst>
              </p:cNvPr>
              <p:cNvSpPr/>
              <p:nvPr/>
            </p:nvSpPr>
            <p:spPr>
              <a:xfrm>
                <a:off x="8701838" y="6786031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2" name="フリーフォーム 5861">
                <a:extLst>
                  <a:ext uri="{FF2B5EF4-FFF2-40B4-BE49-F238E27FC236}">
                    <a16:creationId xmlns:a16="http://schemas.microsoft.com/office/drawing/2014/main" xmlns="" id="{A55D97D4-39A4-F410-8F78-8BD5619C26B2}"/>
                  </a:ext>
                </a:extLst>
              </p:cNvPr>
              <p:cNvSpPr/>
              <p:nvPr/>
            </p:nvSpPr>
            <p:spPr>
              <a:xfrm>
                <a:off x="8712197" y="6828388"/>
                <a:ext cx="25200" cy="25200"/>
              </a:xfrm>
              <a:custGeom>
                <a:avLst/>
                <a:gdLst>
                  <a:gd name="connsiteX0" fmla="*/ 13525 w 27097"/>
                  <a:gd name="connsiteY0" fmla="*/ 0 h 33945"/>
                  <a:gd name="connsiteX1" fmla="*/ 27097 w 27097"/>
                  <a:gd name="connsiteY1" fmla="*/ 16943 h 33945"/>
                  <a:gd name="connsiteX2" fmla="*/ 13525 w 27097"/>
                  <a:gd name="connsiteY2" fmla="*/ 33945 h 33945"/>
                  <a:gd name="connsiteX3" fmla="*/ 0 w 27097"/>
                  <a:gd name="connsiteY3" fmla="*/ 16943 h 33945"/>
                  <a:gd name="connsiteX4" fmla="*/ 13525 w 27097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3945">
                    <a:moveTo>
                      <a:pt x="13525" y="0"/>
                    </a:moveTo>
                    <a:lnTo>
                      <a:pt x="27097" y="16943"/>
                    </a:lnTo>
                    <a:lnTo>
                      <a:pt x="13525" y="33945"/>
                    </a:lnTo>
                    <a:lnTo>
                      <a:pt x="0" y="16943"/>
                    </a:lnTo>
                    <a:lnTo>
                      <a:pt x="13525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3" name="フリーフォーム 5862">
                <a:extLst>
                  <a:ext uri="{FF2B5EF4-FFF2-40B4-BE49-F238E27FC236}">
                    <a16:creationId xmlns:a16="http://schemas.microsoft.com/office/drawing/2014/main" xmlns="" id="{83C87C59-E931-46D4-8B7E-A2DC7F5A49F1}"/>
                  </a:ext>
                </a:extLst>
              </p:cNvPr>
              <p:cNvSpPr/>
              <p:nvPr/>
            </p:nvSpPr>
            <p:spPr>
              <a:xfrm>
                <a:off x="8712197" y="6828388"/>
                <a:ext cx="25200" cy="25200"/>
              </a:xfrm>
              <a:custGeom>
                <a:avLst/>
                <a:gdLst>
                  <a:gd name="connsiteX0" fmla="*/ 13525 w 27097"/>
                  <a:gd name="connsiteY0" fmla="*/ 0 h 33945"/>
                  <a:gd name="connsiteX1" fmla="*/ 27097 w 27097"/>
                  <a:gd name="connsiteY1" fmla="*/ 16943 h 33945"/>
                  <a:gd name="connsiteX2" fmla="*/ 13525 w 27097"/>
                  <a:gd name="connsiteY2" fmla="*/ 33945 h 33945"/>
                  <a:gd name="connsiteX3" fmla="*/ 0 w 27097"/>
                  <a:gd name="connsiteY3" fmla="*/ 16943 h 33945"/>
                  <a:gd name="connsiteX4" fmla="*/ 13525 w 27097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3945">
                    <a:moveTo>
                      <a:pt x="13525" y="0"/>
                    </a:moveTo>
                    <a:lnTo>
                      <a:pt x="27097" y="16943"/>
                    </a:lnTo>
                    <a:lnTo>
                      <a:pt x="13525" y="33945"/>
                    </a:lnTo>
                    <a:lnTo>
                      <a:pt x="0" y="16943"/>
                    </a:lnTo>
                    <a:lnTo>
                      <a:pt x="13525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4" name="フリーフォーム 5863">
                <a:extLst>
                  <a:ext uri="{FF2B5EF4-FFF2-40B4-BE49-F238E27FC236}">
                    <a16:creationId xmlns:a16="http://schemas.microsoft.com/office/drawing/2014/main" xmlns="" id="{E78EF08B-A929-72F3-E751-F564D7324849}"/>
                  </a:ext>
                </a:extLst>
              </p:cNvPr>
              <p:cNvSpPr/>
              <p:nvPr/>
            </p:nvSpPr>
            <p:spPr>
              <a:xfrm>
                <a:off x="8722509" y="6871645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5" name="フリーフォーム 5864">
                <a:extLst>
                  <a:ext uri="{FF2B5EF4-FFF2-40B4-BE49-F238E27FC236}">
                    <a16:creationId xmlns:a16="http://schemas.microsoft.com/office/drawing/2014/main" xmlns="" id="{266CB9BF-FED4-6F3B-5316-2F6719430C4E}"/>
                  </a:ext>
                </a:extLst>
              </p:cNvPr>
              <p:cNvSpPr/>
              <p:nvPr/>
            </p:nvSpPr>
            <p:spPr>
              <a:xfrm>
                <a:off x="8722509" y="6871645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6" name="フリーフォーム 5865">
                <a:extLst>
                  <a:ext uri="{FF2B5EF4-FFF2-40B4-BE49-F238E27FC236}">
                    <a16:creationId xmlns:a16="http://schemas.microsoft.com/office/drawing/2014/main" xmlns="" id="{72BD31E3-C2EF-EFA2-649E-60BD63D78316}"/>
                  </a:ext>
                </a:extLst>
              </p:cNvPr>
              <p:cNvSpPr/>
              <p:nvPr/>
            </p:nvSpPr>
            <p:spPr>
              <a:xfrm>
                <a:off x="8725962" y="6871645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7" name="フリーフォーム 5866">
                <a:extLst>
                  <a:ext uri="{FF2B5EF4-FFF2-40B4-BE49-F238E27FC236}">
                    <a16:creationId xmlns:a16="http://schemas.microsoft.com/office/drawing/2014/main" xmlns="" id="{25F3C85B-FF08-30A1-A762-823E79655AEE}"/>
                  </a:ext>
                </a:extLst>
              </p:cNvPr>
              <p:cNvSpPr/>
              <p:nvPr/>
            </p:nvSpPr>
            <p:spPr>
              <a:xfrm>
                <a:off x="8725962" y="6871645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8" name="フリーフォーム 5867">
                <a:extLst>
                  <a:ext uri="{FF2B5EF4-FFF2-40B4-BE49-F238E27FC236}">
                    <a16:creationId xmlns:a16="http://schemas.microsoft.com/office/drawing/2014/main" xmlns="" id="{D2BD7508-52A8-45BB-1609-4F97E87DCBA7}"/>
                  </a:ext>
                </a:extLst>
              </p:cNvPr>
              <p:cNvSpPr/>
              <p:nvPr/>
            </p:nvSpPr>
            <p:spPr>
              <a:xfrm>
                <a:off x="8725962" y="6871645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69" name="フリーフォーム 5868">
                <a:extLst>
                  <a:ext uri="{FF2B5EF4-FFF2-40B4-BE49-F238E27FC236}">
                    <a16:creationId xmlns:a16="http://schemas.microsoft.com/office/drawing/2014/main" xmlns="" id="{1896172B-C839-1E26-0490-DAB8E6F4C733}"/>
                  </a:ext>
                </a:extLst>
              </p:cNvPr>
              <p:cNvSpPr/>
              <p:nvPr/>
            </p:nvSpPr>
            <p:spPr>
              <a:xfrm>
                <a:off x="8725962" y="6871645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0" name="フリーフォーム 5869">
                <a:extLst>
                  <a:ext uri="{FF2B5EF4-FFF2-40B4-BE49-F238E27FC236}">
                    <a16:creationId xmlns:a16="http://schemas.microsoft.com/office/drawing/2014/main" xmlns="" id="{3CAE5131-DD09-6D6A-7D74-B59C06204584}"/>
                  </a:ext>
                </a:extLst>
              </p:cNvPr>
              <p:cNvSpPr/>
              <p:nvPr/>
            </p:nvSpPr>
            <p:spPr>
              <a:xfrm>
                <a:off x="8736273" y="6964950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1" name="フリーフォーム 5870">
                <a:extLst>
                  <a:ext uri="{FF2B5EF4-FFF2-40B4-BE49-F238E27FC236}">
                    <a16:creationId xmlns:a16="http://schemas.microsoft.com/office/drawing/2014/main" xmlns="" id="{8FAF429B-FE90-3B35-7F42-2AFE88FC944E}"/>
                  </a:ext>
                </a:extLst>
              </p:cNvPr>
              <p:cNvSpPr/>
              <p:nvPr/>
            </p:nvSpPr>
            <p:spPr>
              <a:xfrm>
                <a:off x="8736273" y="6964950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2" name="フリーフォーム 5871">
                <a:extLst>
                  <a:ext uri="{FF2B5EF4-FFF2-40B4-BE49-F238E27FC236}">
                    <a16:creationId xmlns:a16="http://schemas.microsoft.com/office/drawing/2014/main" xmlns="" id="{0FFAD924-317E-E01D-75CD-83FB688DD4EC}"/>
                  </a:ext>
                </a:extLst>
              </p:cNvPr>
              <p:cNvSpPr/>
              <p:nvPr/>
            </p:nvSpPr>
            <p:spPr>
              <a:xfrm>
                <a:off x="8801690" y="7300499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3" name="フリーフォーム 5872">
                <a:extLst>
                  <a:ext uri="{FF2B5EF4-FFF2-40B4-BE49-F238E27FC236}">
                    <a16:creationId xmlns:a16="http://schemas.microsoft.com/office/drawing/2014/main" xmlns="" id="{893EEE35-9FDC-D9E2-D4F2-3A1BE4D24A50}"/>
                  </a:ext>
                </a:extLst>
              </p:cNvPr>
              <p:cNvSpPr/>
              <p:nvPr/>
            </p:nvSpPr>
            <p:spPr>
              <a:xfrm>
                <a:off x="8801690" y="7300499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4" name="フリーフォーム 5873">
                <a:extLst>
                  <a:ext uri="{FF2B5EF4-FFF2-40B4-BE49-F238E27FC236}">
                    <a16:creationId xmlns:a16="http://schemas.microsoft.com/office/drawing/2014/main" xmlns="" id="{A28807CA-5B21-6E75-CD64-8388AE53405C}"/>
                  </a:ext>
                </a:extLst>
              </p:cNvPr>
              <p:cNvSpPr/>
              <p:nvPr/>
            </p:nvSpPr>
            <p:spPr>
              <a:xfrm>
                <a:off x="8805144" y="7300499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5" name="フリーフォーム 5874">
                <a:extLst>
                  <a:ext uri="{FF2B5EF4-FFF2-40B4-BE49-F238E27FC236}">
                    <a16:creationId xmlns:a16="http://schemas.microsoft.com/office/drawing/2014/main" xmlns="" id="{63ABBE15-9C11-9FFE-4CF0-C2437A72DD68}"/>
                  </a:ext>
                </a:extLst>
              </p:cNvPr>
              <p:cNvSpPr/>
              <p:nvPr/>
            </p:nvSpPr>
            <p:spPr>
              <a:xfrm>
                <a:off x="8805144" y="7300499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6" name="フリーフォーム 5875">
                <a:extLst>
                  <a:ext uri="{FF2B5EF4-FFF2-40B4-BE49-F238E27FC236}">
                    <a16:creationId xmlns:a16="http://schemas.microsoft.com/office/drawing/2014/main" xmlns="" id="{338B019E-78C2-180A-6F4B-404A96E709AA}"/>
                  </a:ext>
                </a:extLst>
              </p:cNvPr>
              <p:cNvSpPr/>
              <p:nvPr/>
            </p:nvSpPr>
            <p:spPr>
              <a:xfrm>
                <a:off x="8918761" y="7557943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7" name="フリーフォーム 5876">
                <a:extLst>
                  <a:ext uri="{FF2B5EF4-FFF2-40B4-BE49-F238E27FC236}">
                    <a16:creationId xmlns:a16="http://schemas.microsoft.com/office/drawing/2014/main" xmlns="" id="{96C71AEC-17CB-2389-FF0B-01BB0C852EAD}"/>
                  </a:ext>
                </a:extLst>
              </p:cNvPr>
              <p:cNvSpPr/>
              <p:nvPr/>
            </p:nvSpPr>
            <p:spPr>
              <a:xfrm>
                <a:off x="8918761" y="7557943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8" name="フリーフォーム 5877">
                <a:extLst>
                  <a:ext uri="{FF2B5EF4-FFF2-40B4-BE49-F238E27FC236}">
                    <a16:creationId xmlns:a16="http://schemas.microsoft.com/office/drawing/2014/main" xmlns="" id="{73645B9B-034F-DCF8-F83B-3DC0E8DDE0B8}"/>
                  </a:ext>
                </a:extLst>
              </p:cNvPr>
              <p:cNvSpPr/>
              <p:nvPr/>
            </p:nvSpPr>
            <p:spPr>
              <a:xfrm>
                <a:off x="8922214" y="7557943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79" name="フリーフォーム 5878">
                <a:extLst>
                  <a:ext uri="{FF2B5EF4-FFF2-40B4-BE49-F238E27FC236}">
                    <a16:creationId xmlns:a16="http://schemas.microsoft.com/office/drawing/2014/main" xmlns="" id="{9E50DD23-1971-86AB-6919-CC20A9D16382}"/>
                  </a:ext>
                </a:extLst>
              </p:cNvPr>
              <p:cNvSpPr/>
              <p:nvPr/>
            </p:nvSpPr>
            <p:spPr>
              <a:xfrm>
                <a:off x="8922214" y="7557943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0" name="フリーフォーム 5879">
                <a:extLst>
                  <a:ext uri="{FF2B5EF4-FFF2-40B4-BE49-F238E27FC236}">
                    <a16:creationId xmlns:a16="http://schemas.microsoft.com/office/drawing/2014/main" xmlns="" id="{98387499-2E78-E3C8-A687-DAB9798C42D2}"/>
                  </a:ext>
                </a:extLst>
              </p:cNvPr>
              <p:cNvSpPr/>
              <p:nvPr/>
            </p:nvSpPr>
            <p:spPr>
              <a:xfrm>
                <a:off x="8942884" y="7614598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1" name="フリーフォーム 5880">
                <a:extLst>
                  <a:ext uri="{FF2B5EF4-FFF2-40B4-BE49-F238E27FC236}">
                    <a16:creationId xmlns:a16="http://schemas.microsoft.com/office/drawing/2014/main" xmlns="" id="{FED0DE99-F443-B2DD-9AC3-658934A25E00}"/>
                  </a:ext>
                </a:extLst>
              </p:cNvPr>
              <p:cNvSpPr/>
              <p:nvPr/>
            </p:nvSpPr>
            <p:spPr>
              <a:xfrm>
                <a:off x="8942884" y="7614598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2" name="フリーフォーム 5881">
                <a:extLst>
                  <a:ext uri="{FF2B5EF4-FFF2-40B4-BE49-F238E27FC236}">
                    <a16:creationId xmlns:a16="http://schemas.microsoft.com/office/drawing/2014/main" xmlns="" id="{84C64274-88FE-8E29-3B78-A1E8E4188214}"/>
                  </a:ext>
                </a:extLst>
              </p:cNvPr>
              <p:cNvSpPr/>
              <p:nvPr/>
            </p:nvSpPr>
            <p:spPr>
              <a:xfrm>
                <a:off x="8946337" y="7614598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3" name="フリーフォーム 5882">
                <a:extLst>
                  <a:ext uri="{FF2B5EF4-FFF2-40B4-BE49-F238E27FC236}">
                    <a16:creationId xmlns:a16="http://schemas.microsoft.com/office/drawing/2014/main" xmlns="" id="{9F11D766-482E-C026-E3A4-7378FB8AD107}"/>
                  </a:ext>
                </a:extLst>
              </p:cNvPr>
              <p:cNvSpPr/>
              <p:nvPr/>
            </p:nvSpPr>
            <p:spPr>
              <a:xfrm>
                <a:off x="8946337" y="7614598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4" name="フリーフォーム 5883">
                <a:extLst>
                  <a:ext uri="{FF2B5EF4-FFF2-40B4-BE49-F238E27FC236}">
                    <a16:creationId xmlns:a16="http://schemas.microsoft.com/office/drawing/2014/main" xmlns="" id="{2ED8AFC1-10FE-F5D6-7F11-64CCF32F6176}"/>
                  </a:ext>
                </a:extLst>
              </p:cNvPr>
              <p:cNvSpPr/>
              <p:nvPr/>
            </p:nvSpPr>
            <p:spPr>
              <a:xfrm>
                <a:off x="8953196" y="7614598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5" name="フリーフォーム 5884">
                <a:extLst>
                  <a:ext uri="{FF2B5EF4-FFF2-40B4-BE49-F238E27FC236}">
                    <a16:creationId xmlns:a16="http://schemas.microsoft.com/office/drawing/2014/main" xmlns="" id="{0E167E80-EB34-9122-5AAD-1AF3F74F7F1E}"/>
                  </a:ext>
                </a:extLst>
              </p:cNvPr>
              <p:cNvSpPr/>
              <p:nvPr/>
            </p:nvSpPr>
            <p:spPr>
              <a:xfrm>
                <a:off x="8953196" y="7614598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6" name="フリーフォーム 5885">
                <a:extLst>
                  <a:ext uri="{FF2B5EF4-FFF2-40B4-BE49-F238E27FC236}">
                    <a16:creationId xmlns:a16="http://schemas.microsoft.com/office/drawing/2014/main" xmlns="" id="{569F05FD-2CD7-7A9D-03BF-8174C1D0FF81}"/>
                  </a:ext>
                </a:extLst>
              </p:cNvPr>
              <p:cNvSpPr/>
              <p:nvPr/>
            </p:nvSpPr>
            <p:spPr>
              <a:xfrm>
                <a:off x="8960102" y="7614598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7" name="フリーフォーム 5886">
                <a:extLst>
                  <a:ext uri="{FF2B5EF4-FFF2-40B4-BE49-F238E27FC236}">
                    <a16:creationId xmlns:a16="http://schemas.microsoft.com/office/drawing/2014/main" xmlns="" id="{EF87C8BE-BD15-4E2F-286B-6B9C42F2F716}"/>
                  </a:ext>
                </a:extLst>
              </p:cNvPr>
              <p:cNvSpPr/>
              <p:nvPr/>
            </p:nvSpPr>
            <p:spPr>
              <a:xfrm>
                <a:off x="8960102" y="7614598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8" name="フリーフォーム 5887">
                <a:extLst>
                  <a:ext uri="{FF2B5EF4-FFF2-40B4-BE49-F238E27FC236}">
                    <a16:creationId xmlns:a16="http://schemas.microsoft.com/office/drawing/2014/main" xmlns="" id="{B51475CB-C9A2-E432-FD47-E1C5A84C44F5}"/>
                  </a:ext>
                </a:extLst>
              </p:cNvPr>
              <p:cNvSpPr/>
              <p:nvPr/>
            </p:nvSpPr>
            <p:spPr>
              <a:xfrm>
                <a:off x="9063407" y="7758070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89" name="フリーフォーム 5888">
                <a:extLst>
                  <a:ext uri="{FF2B5EF4-FFF2-40B4-BE49-F238E27FC236}">
                    <a16:creationId xmlns:a16="http://schemas.microsoft.com/office/drawing/2014/main" xmlns="" id="{7C651D51-8EDB-6F60-0C93-8155E054A09E}"/>
                  </a:ext>
                </a:extLst>
              </p:cNvPr>
              <p:cNvSpPr/>
              <p:nvPr/>
            </p:nvSpPr>
            <p:spPr>
              <a:xfrm>
                <a:off x="9063407" y="7758070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0" name="フリーフォーム 5889">
                <a:extLst>
                  <a:ext uri="{FF2B5EF4-FFF2-40B4-BE49-F238E27FC236}">
                    <a16:creationId xmlns:a16="http://schemas.microsoft.com/office/drawing/2014/main" xmlns="" id="{1320BD63-7A13-AE7D-217B-86D928F98019}"/>
                  </a:ext>
                </a:extLst>
              </p:cNvPr>
              <p:cNvSpPr/>
              <p:nvPr/>
            </p:nvSpPr>
            <p:spPr>
              <a:xfrm>
                <a:off x="9097843" y="7758070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1" name="フリーフォーム 5890">
                <a:extLst>
                  <a:ext uri="{FF2B5EF4-FFF2-40B4-BE49-F238E27FC236}">
                    <a16:creationId xmlns:a16="http://schemas.microsoft.com/office/drawing/2014/main" xmlns="" id="{0876C5A4-6B9A-F0FD-A6B1-A1F00317D8D7}"/>
                  </a:ext>
                </a:extLst>
              </p:cNvPr>
              <p:cNvSpPr/>
              <p:nvPr/>
            </p:nvSpPr>
            <p:spPr>
              <a:xfrm>
                <a:off x="9097843" y="7758070"/>
                <a:ext cx="25200" cy="25200"/>
              </a:xfrm>
              <a:custGeom>
                <a:avLst/>
                <a:gdLst>
                  <a:gd name="connsiteX0" fmla="*/ 13573 w 27097"/>
                  <a:gd name="connsiteY0" fmla="*/ 0 h 34005"/>
                  <a:gd name="connsiteX1" fmla="*/ 27097 w 27097"/>
                  <a:gd name="connsiteY1" fmla="*/ 17003 h 34005"/>
                  <a:gd name="connsiteX2" fmla="*/ 13573 w 27097"/>
                  <a:gd name="connsiteY2" fmla="*/ 34005 h 34005"/>
                  <a:gd name="connsiteX3" fmla="*/ 0 w 27097"/>
                  <a:gd name="connsiteY3" fmla="*/ 17003 h 34005"/>
                  <a:gd name="connsiteX4" fmla="*/ 13573 w 27097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4005">
                    <a:moveTo>
                      <a:pt x="13573" y="0"/>
                    </a:moveTo>
                    <a:lnTo>
                      <a:pt x="27097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2" name="フリーフォーム 5891">
                <a:extLst>
                  <a:ext uri="{FF2B5EF4-FFF2-40B4-BE49-F238E27FC236}">
                    <a16:creationId xmlns:a16="http://schemas.microsoft.com/office/drawing/2014/main" xmlns="" id="{847787D0-6B72-740E-07F2-FFA0C760D2D8}"/>
                  </a:ext>
                </a:extLst>
              </p:cNvPr>
              <p:cNvSpPr/>
              <p:nvPr/>
            </p:nvSpPr>
            <p:spPr>
              <a:xfrm>
                <a:off x="9108154" y="7758070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3" name="フリーフォーム 5892">
                <a:extLst>
                  <a:ext uri="{FF2B5EF4-FFF2-40B4-BE49-F238E27FC236}">
                    <a16:creationId xmlns:a16="http://schemas.microsoft.com/office/drawing/2014/main" xmlns="" id="{D1A4D4C2-800C-FC5D-A298-D9BCFCE97314}"/>
                  </a:ext>
                </a:extLst>
              </p:cNvPr>
              <p:cNvSpPr/>
              <p:nvPr/>
            </p:nvSpPr>
            <p:spPr>
              <a:xfrm>
                <a:off x="9108154" y="7758070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4" name="フリーフォーム 5893">
                <a:extLst>
                  <a:ext uri="{FF2B5EF4-FFF2-40B4-BE49-F238E27FC236}">
                    <a16:creationId xmlns:a16="http://schemas.microsoft.com/office/drawing/2014/main" xmlns="" id="{615B69C3-5FAF-3F11-B250-189E553A9F48}"/>
                  </a:ext>
                </a:extLst>
              </p:cNvPr>
              <p:cNvSpPr/>
              <p:nvPr/>
            </p:nvSpPr>
            <p:spPr>
              <a:xfrm>
                <a:off x="9228677" y="7758070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5" name="フリーフォーム 5894">
                <a:extLst>
                  <a:ext uri="{FF2B5EF4-FFF2-40B4-BE49-F238E27FC236}">
                    <a16:creationId xmlns:a16="http://schemas.microsoft.com/office/drawing/2014/main" xmlns="" id="{71F695E8-30D1-B0BD-B996-DAF16074B6E3}"/>
                  </a:ext>
                </a:extLst>
              </p:cNvPr>
              <p:cNvSpPr/>
              <p:nvPr/>
            </p:nvSpPr>
            <p:spPr>
              <a:xfrm>
                <a:off x="9228677" y="7758070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6" name="フリーフォーム 5895">
                <a:extLst>
                  <a:ext uri="{FF2B5EF4-FFF2-40B4-BE49-F238E27FC236}">
                    <a16:creationId xmlns:a16="http://schemas.microsoft.com/office/drawing/2014/main" xmlns="" id="{9510939B-E5A6-C516-75CD-6A7019C9B88E}"/>
                  </a:ext>
                </a:extLst>
              </p:cNvPr>
              <p:cNvSpPr/>
              <p:nvPr/>
            </p:nvSpPr>
            <p:spPr>
              <a:xfrm>
                <a:off x="9276877" y="7758070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7" name="フリーフォーム 5896">
                <a:extLst>
                  <a:ext uri="{FF2B5EF4-FFF2-40B4-BE49-F238E27FC236}">
                    <a16:creationId xmlns:a16="http://schemas.microsoft.com/office/drawing/2014/main" xmlns="" id="{2A410294-7E31-28F2-A7B4-A74C972A6F21}"/>
                  </a:ext>
                </a:extLst>
              </p:cNvPr>
              <p:cNvSpPr/>
              <p:nvPr/>
            </p:nvSpPr>
            <p:spPr>
              <a:xfrm>
                <a:off x="9276877" y="7758070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8" name="フリーフォーム 5897">
                <a:extLst>
                  <a:ext uri="{FF2B5EF4-FFF2-40B4-BE49-F238E27FC236}">
                    <a16:creationId xmlns:a16="http://schemas.microsoft.com/office/drawing/2014/main" xmlns="" id="{E01690C0-DABB-D4E6-DAA8-A0CAAF8A0B8B}"/>
                  </a:ext>
                </a:extLst>
              </p:cNvPr>
              <p:cNvSpPr/>
              <p:nvPr/>
            </p:nvSpPr>
            <p:spPr>
              <a:xfrm>
                <a:off x="9528235" y="7991242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899" name="フリーフォーム 5898">
                <a:extLst>
                  <a:ext uri="{FF2B5EF4-FFF2-40B4-BE49-F238E27FC236}">
                    <a16:creationId xmlns:a16="http://schemas.microsoft.com/office/drawing/2014/main" xmlns="" id="{2C8C8A49-EB5C-E525-7041-3E4CCA31D0AD}"/>
                  </a:ext>
                </a:extLst>
              </p:cNvPr>
              <p:cNvSpPr/>
              <p:nvPr/>
            </p:nvSpPr>
            <p:spPr>
              <a:xfrm>
                <a:off x="9528235" y="7991242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00" name="フリーフォーム 5899">
                <a:extLst>
                  <a:ext uri="{FF2B5EF4-FFF2-40B4-BE49-F238E27FC236}">
                    <a16:creationId xmlns:a16="http://schemas.microsoft.com/office/drawing/2014/main" xmlns="" id="{621AB703-A9A8-4B17-EB43-11F45D31F995}"/>
                  </a:ext>
                </a:extLst>
              </p:cNvPr>
              <p:cNvSpPr/>
              <p:nvPr/>
            </p:nvSpPr>
            <p:spPr>
              <a:xfrm>
                <a:off x="9748610" y="7991242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01" name="フリーフォーム 5900">
                <a:extLst>
                  <a:ext uri="{FF2B5EF4-FFF2-40B4-BE49-F238E27FC236}">
                    <a16:creationId xmlns:a16="http://schemas.microsoft.com/office/drawing/2014/main" xmlns="" id="{DA467D7C-6C6C-08BE-7173-6936F6FD3FD0}"/>
                  </a:ext>
                </a:extLst>
              </p:cNvPr>
              <p:cNvSpPr/>
              <p:nvPr/>
            </p:nvSpPr>
            <p:spPr>
              <a:xfrm>
                <a:off x="9748610" y="7991242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02" name="フリーフォーム 5901">
                <a:extLst>
                  <a:ext uri="{FF2B5EF4-FFF2-40B4-BE49-F238E27FC236}">
                    <a16:creationId xmlns:a16="http://schemas.microsoft.com/office/drawing/2014/main" xmlns="" id="{2E359F6B-624C-8217-2CF0-785FE9713599}"/>
                  </a:ext>
                </a:extLst>
              </p:cNvPr>
              <p:cNvSpPr/>
              <p:nvPr/>
            </p:nvSpPr>
            <p:spPr>
              <a:xfrm>
                <a:off x="10068839" y="7991242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03" name="フリーフォーム 5902">
                <a:extLst>
                  <a:ext uri="{FF2B5EF4-FFF2-40B4-BE49-F238E27FC236}">
                    <a16:creationId xmlns:a16="http://schemas.microsoft.com/office/drawing/2014/main" xmlns="" id="{85A14FD7-8E81-8564-883E-CE9DF6693ECA}"/>
                  </a:ext>
                </a:extLst>
              </p:cNvPr>
              <p:cNvSpPr/>
              <p:nvPr/>
            </p:nvSpPr>
            <p:spPr>
              <a:xfrm>
                <a:off x="10068839" y="7991242"/>
                <a:ext cx="25200" cy="25200"/>
              </a:xfrm>
              <a:custGeom>
                <a:avLst/>
                <a:gdLst>
                  <a:gd name="connsiteX0" fmla="*/ 13573 w 27145"/>
                  <a:gd name="connsiteY0" fmla="*/ 0 h 34005"/>
                  <a:gd name="connsiteX1" fmla="*/ 27145 w 27145"/>
                  <a:gd name="connsiteY1" fmla="*/ 17003 h 34005"/>
                  <a:gd name="connsiteX2" fmla="*/ 13573 w 27145"/>
                  <a:gd name="connsiteY2" fmla="*/ 34005 h 34005"/>
                  <a:gd name="connsiteX3" fmla="*/ 0 w 27145"/>
                  <a:gd name="connsiteY3" fmla="*/ 17003 h 34005"/>
                  <a:gd name="connsiteX4" fmla="*/ 13573 w 27145"/>
                  <a:gd name="connsiteY4" fmla="*/ 0 h 340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400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400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04" name="フリーフォーム 5903">
                <a:extLst>
                  <a:ext uri="{FF2B5EF4-FFF2-40B4-BE49-F238E27FC236}">
                    <a16:creationId xmlns:a16="http://schemas.microsoft.com/office/drawing/2014/main" xmlns="" id="{36360C26-2248-1987-DFA3-20D16E7AE546}"/>
                  </a:ext>
                </a:extLst>
              </p:cNvPr>
              <p:cNvSpPr/>
              <p:nvPr/>
            </p:nvSpPr>
            <p:spPr>
              <a:xfrm>
                <a:off x="11194793" y="8224413"/>
                <a:ext cx="25200" cy="25200"/>
              </a:xfrm>
              <a:custGeom>
                <a:avLst/>
                <a:gdLst>
                  <a:gd name="connsiteX0" fmla="*/ 13573 w 27145"/>
                  <a:gd name="connsiteY0" fmla="*/ 0 h 33945"/>
                  <a:gd name="connsiteX1" fmla="*/ 27145 w 27145"/>
                  <a:gd name="connsiteY1" fmla="*/ 16943 h 33945"/>
                  <a:gd name="connsiteX2" fmla="*/ 13573 w 27145"/>
                  <a:gd name="connsiteY2" fmla="*/ 33945 h 33945"/>
                  <a:gd name="connsiteX3" fmla="*/ 0 w 27145"/>
                  <a:gd name="connsiteY3" fmla="*/ 16943 h 33945"/>
                  <a:gd name="connsiteX4" fmla="*/ 13573 w 27145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3945">
                    <a:moveTo>
                      <a:pt x="13573" y="0"/>
                    </a:moveTo>
                    <a:lnTo>
                      <a:pt x="27145" y="16943"/>
                    </a:lnTo>
                    <a:lnTo>
                      <a:pt x="13573" y="33945"/>
                    </a:lnTo>
                    <a:lnTo>
                      <a:pt x="0" y="1694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05" name="フリーフォーム 5904">
                <a:extLst>
                  <a:ext uri="{FF2B5EF4-FFF2-40B4-BE49-F238E27FC236}">
                    <a16:creationId xmlns:a16="http://schemas.microsoft.com/office/drawing/2014/main" xmlns="" id="{7BC28568-1E93-1239-5F14-102CBEC9D7FC}"/>
                  </a:ext>
                </a:extLst>
              </p:cNvPr>
              <p:cNvSpPr/>
              <p:nvPr/>
            </p:nvSpPr>
            <p:spPr>
              <a:xfrm>
                <a:off x="11194793" y="8224413"/>
                <a:ext cx="25200" cy="25200"/>
              </a:xfrm>
              <a:custGeom>
                <a:avLst/>
                <a:gdLst>
                  <a:gd name="connsiteX0" fmla="*/ 13573 w 27145"/>
                  <a:gd name="connsiteY0" fmla="*/ 0 h 33945"/>
                  <a:gd name="connsiteX1" fmla="*/ 27145 w 27145"/>
                  <a:gd name="connsiteY1" fmla="*/ 16943 h 33945"/>
                  <a:gd name="connsiteX2" fmla="*/ 13573 w 27145"/>
                  <a:gd name="connsiteY2" fmla="*/ 33945 h 33945"/>
                  <a:gd name="connsiteX3" fmla="*/ 0 w 27145"/>
                  <a:gd name="connsiteY3" fmla="*/ 16943 h 33945"/>
                  <a:gd name="connsiteX4" fmla="*/ 13573 w 27145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3945">
                    <a:moveTo>
                      <a:pt x="13573" y="0"/>
                    </a:moveTo>
                    <a:lnTo>
                      <a:pt x="27145" y="16943"/>
                    </a:lnTo>
                    <a:lnTo>
                      <a:pt x="13573" y="33945"/>
                    </a:lnTo>
                    <a:lnTo>
                      <a:pt x="0" y="1694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06" name="フリーフォーム 5905">
                <a:extLst>
                  <a:ext uri="{FF2B5EF4-FFF2-40B4-BE49-F238E27FC236}">
                    <a16:creationId xmlns:a16="http://schemas.microsoft.com/office/drawing/2014/main" xmlns="" id="{D986C5A7-FFF7-1D27-1DBB-672CA5A1D2E8}"/>
                  </a:ext>
                </a:extLst>
              </p:cNvPr>
              <p:cNvSpPr/>
              <p:nvPr/>
            </p:nvSpPr>
            <p:spPr>
              <a:xfrm>
                <a:off x="11997114" y="8224413"/>
                <a:ext cx="25200" cy="25200"/>
              </a:xfrm>
              <a:custGeom>
                <a:avLst/>
                <a:gdLst>
                  <a:gd name="connsiteX0" fmla="*/ 13573 w 27097"/>
                  <a:gd name="connsiteY0" fmla="*/ 0 h 33945"/>
                  <a:gd name="connsiteX1" fmla="*/ 27097 w 27097"/>
                  <a:gd name="connsiteY1" fmla="*/ 16943 h 33945"/>
                  <a:gd name="connsiteX2" fmla="*/ 13573 w 27097"/>
                  <a:gd name="connsiteY2" fmla="*/ 33945 h 33945"/>
                  <a:gd name="connsiteX3" fmla="*/ 0 w 27097"/>
                  <a:gd name="connsiteY3" fmla="*/ 16943 h 33945"/>
                  <a:gd name="connsiteX4" fmla="*/ 13573 w 27097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3945">
                    <a:moveTo>
                      <a:pt x="13573" y="0"/>
                    </a:moveTo>
                    <a:lnTo>
                      <a:pt x="27097" y="16943"/>
                    </a:lnTo>
                    <a:lnTo>
                      <a:pt x="13573" y="33945"/>
                    </a:lnTo>
                    <a:lnTo>
                      <a:pt x="0" y="1694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07" name="フリーフォーム 5906">
                <a:extLst>
                  <a:ext uri="{FF2B5EF4-FFF2-40B4-BE49-F238E27FC236}">
                    <a16:creationId xmlns:a16="http://schemas.microsoft.com/office/drawing/2014/main" xmlns="" id="{512614D5-0CA5-6FC0-0C80-29F29F925E54}"/>
                  </a:ext>
                </a:extLst>
              </p:cNvPr>
              <p:cNvSpPr/>
              <p:nvPr/>
            </p:nvSpPr>
            <p:spPr>
              <a:xfrm>
                <a:off x="11997114" y="8224413"/>
                <a:ext cx="25200" cy="25200"/>
              </a:xfrm>
              <a:custGeom>
                <a:avLst/>
                <a:gdLst>
                  <a:gd name="connsiteX0" fmla="*/ 13573 w 27097"/>
                  <a:gd name="connsiteY0" fmla="*/ 0 h 33945"/>
                  <a:gd name="connsiteX1" fmla="*/ 27097 w 27097"/>
                  <a:gd name="connsiteY1" fmla="*/ 16943 h 33945"/>
                  <a:gd name="connsiteX2" fmla="*/ 13573 w 27097"/>
                  <a:gd name="connsiteY2" fmla="*/ 33945 h 33945"/>
                  <a:gd name="connsiteX3" fmla="*/ 0 w 27097"/>
                  <a:gd name="connsiteY3" fmla="*/ 16943 h 33945"/>
                  <a:gd name="connsiteX4" fmla="*/ 13573 w 27097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097" h="33945">
                    <a:moveTo>
                      <a:pt x="13573" y="0"/>
                    </a:moveTo>
                    <a:lnTo>
                      <a:pt x="27097" y="16943"/>
                    </a:lnTo>
                    <a:lnTo>
                      <a:pt x="13573" y="33945"/>
                    </a:lnTo>
                    <a:lnTo>
                      <a:pt x="0" y="1694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44" name="フリーフォーム 5943">
                <a:extLst>
                  <a:ext uri="{FF2B5EF4-FFF2-40B4-BE49-F238E27FC236}">
                    <a16:creationId xmlns:a16="http://schemas.microsoft.com/office/drawing/2014/main" xmlns="" id="{CBEF6E61-152C-6E29-12DE-4D98397A555A}"/>
                  </a:ext>
                </a:extLst>
              </p:cNvPr>
              <p:cNvSpPr/>
              <p:nvPr/>
            </p:nvSpPr>
            <p:spPr>
              <a:xfrm>
                <a:off x="8867108" y="7496721"/>
                <a:ext cx="25200" cy="25200"/>
              </a:xfrm>
              <a:custGeom>
                <a:avLst/>
                <a:gdLst>
                  <a:gd name="connsiteX0" fmla="*/ 13573 w 27145"/>
                  <a:gd name="connsiteY0" fmla="*/ 0 h 33945"/>
                  <a:gd name="connsiteX1" fmla="*/ 27145 w 27145"/>
                  <a:gd name="connsiteY1" fmla="*/ 17003 h 33945"/>
                  <a:gd name="connsiteX2" fmla="*/ 13573 w 27145"/>
                  <a:gd name="connsiteY2" fmla="*/ 33945 h 33945"/>
                  <a:gd name="connsiteX3" fmla="*/ 0 w 27145"/>
                  <a:gd name="connsiteY3" fmla="*/ 17003 h 33945"/>
                  <a:gd name="connsiteX4" fmla="*/ 13573 w 27145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394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394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91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5945" name="フリーフォーム 5944">
                <a:extLst>
                  <a:ext uri="{FF2B5EF4-FFF2-40B4-BE49-F238E27FC236}">
                    <a16:creationId xmlns:a16="http://schemas.microsoft.com/office/drawing/2014/main" xmlns="" id="{EDD8B39F-0330-8DC9-208F-851B40EFCFBE}"/>
                  </a:ext>
                </a:extLst>
              </p:cNvPr>
              <p:cNvSpPr/>
              <p:nvPr/>
            </p:nvSpPr>
            <p:spPr>
              <a:xfrm>
                <a:off x="8867108" y="7496721"/>
                <a:ext cx="25200" cy="25200"/>
              </a:xfrm>
              <a:custGeom>
                <a:avLst/>
                <a:gdLst>
                  <a:gd name="connsiteX0" fmla="*/ 13573 w 27145"/>
                  <a:gd name="connsiteY0" fmla="*/ 0 h 33945"/>
                  <a:gd name="connsiteX1" fmla="*/ 27145 w 27145"/>
                  <a:gd name="connsiteY1" fmla="*/ 17003 h 33945"/>
                  <a:gd name="connsiteX2" fmla="*/ 13573 w 27145"/>
                  <a:gd name="connsiteY2" fmla="*/ 33945 h 33945"/>
                  <a:gd name="connsiteX3" fmla="*/ 0 w 27145"/>
                  <a:gd name="connsiteY3" fmla="*/ 17003 h 33945"/>
                  <a:gd name="connsiteX4" fmla="*/ 13573 w 27145"/>
                  <a:gd name="connsiteY4" fmla="*/ 0 h 339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7145" h="33945">
                    <a:moveTo>
                      <a:pt x="13573" y="0"/>
                    </a:moveTo>
                    <a:lnTo>
                      <a:pt x="27145" y="17003"/>
                    </a:lnTo>
                    <a:lnTo>
                      <a:pt x="13573" y="33945"/>
                    </a:lnTo>
                    <a:lnTo>
                      <a:pt x="0" y="17003"/>
                    </a:lnTo>
                    <a:lnTo>
                      <a:pt x="13573" y="0"/>
                    </a:lnTo>
                    <a:close/>
                  </a:path>
                </a:pathLst>
              </a:custGeom>
              <a:noFill/>
              <a:ln w="4791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090184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609E9C6A-9829-C523-B5F4-9C944E21FE08}"/>
              </a:ext>
            </a:extLst>
          </p:cNvPr>
          <p:cNvSpPr txBox="1"/>
          <p:nvPr/>
        </p:nvSpPr>
        <p:spPr>
          <a:xfrm>
            <a:off x="1312832" y="577768"/>
            <a:ext cx="16482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1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表 1684">
            <a:extLst>
              <a:ext uri="{FF2B5EF4-FFF2-40B4-BE49-F238E27FC236}">
                <a16:creationId xmlns:a16="http://schemas.microsoft.com/office/drawing/2014/main" xmlns="" id="{CC63173D-AC3C-3EDF-00B6-42C7BB8E1D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143794"/>
              </p:ext>
            </p:extLst>
          </p:nvPr>
        </p:nvGraphicFramePr>
        <p:xfrm>
          <a:off x="1070554" y="5042992"/>
          <a:ext cx="4458932" cy="42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8278">
                  <a:extLst>
                    <a:ext uri="{9D8B030D-6E8A-4147-A177-3AD203B41FA5}">
                      <a16:colId xmlns:a16="http://schemas.microsoft.com/office/drawing/2014/main" xmlns="" val="4265473964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2481464370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2206847067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2918086267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895740400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1531656154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1435945549"/>
                    </a:ext>
                  </a:extLst>
                </a:gridCol>
              </a:tblGrid>
              <a:tr h="203427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 anchorCtr="1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20329953"/>
                  </a:ext>
                </a:extLst>
              </a:tr>
              <a:tr h="2034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</a:p>
                  </a:txBody>
                  <a:tcPr anchor="ctr" anchorCtr="1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35996952"/>
                  </a:ext>
                </a:extLst>
              </a:tr>
            </a:tbl>
          </a:graphicData>
        </a:graphic>
      </p:graphicFrame>
      <p:graphicFrame>
        <p:nvGraphicFramePr>
          <p:cNvPr id="303" name="表 1684">
            <a:extLst>
              <a:ext uri="{FF2B5EF4-FFF2-40B4-BE49-F238E27FC236}">
                <a16:creationId xmlns:a16="http://schemas.microsoft.com/office/drawing/2014/main" xmlns="" id="{69BFDB57-F70F-F2FF-C72C-2EDEAF2483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0622825"/>
              </p:ext>
            </p:extLst>
          </p:nvPr>
        </p:nvGraphicFramePr>
        <p:xfrm>
          <a:off x="6110177" y="5039920"/>
          <a:ext cx="4659212" cy="853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08558">
                  <a:extLst>
                    <a:ext uri="{9D8B030D-6E8A-4147-A177-3AD203B41FA5}">
                      <a16:colId xmlns:a16="http://schemas.microsoft.com/office/drawing/2014/main" xmlns="" val="4265473964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2481464370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2206847067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2918086267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895740400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1531656154"/>
                    </a:ext>
                  </a:extLst>
                </a:gridCol>
                <a:gridCol w="675109">
                  <a:extLst>
                    <a:ext uri="{9D8B030D-6E8A-4147-A177-3AD203B41FA5}">
                      <a16:colId xmlns:a16="http://schemas.microsoft.com/office/drawing/2014/main" xmlns="" val="1435945549"/>
                    </a:ext>
                  </a:extLst>
                </a:gridCol>
              </a:tblGrid>
              <a:tr h="203427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-M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 anchorCtr="1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20329953"/>
                  </a:ext>
                </a:extLst>
              </a:tr>
              <a:tr h="2034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-PS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 anchor="ctr" anchorCtr="1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35996952"/>
                  </a:ext>
                </a:extLst>
              </a:tr>
              <a:tr h="2034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-MS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 anchorCtr="1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93207418"/>
                  </a:ext>
                </a:extLst>
              </a:tr>
              <a:tr h="2034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-PS</a:t>
                      </a:r>
                      <a:endParaRPr kumimoji="1" lang="ja-JP" altLang="en-US" sz="8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anchor="ctr" anchorCtr="1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466813"/>
                  </a:ext>
                </a:extLst>
              </a:tr>
            </a:tbl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C5B5DF2D-70D3-5719-5D6F-C51EC3CA18E3}"/>
              </a:ext>
            </a:extLst>
          </p:cNvPr>
          <p:cNvSpPr txBox="1"/>
          <p:nvPr/>
        </p:nvSpPr>
        <p:spPr>
          <a:xfrm>
            <a:off x="1507006" y="1257953"/>
            <a:ext cx="1273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R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ision stent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xmlns="" id="{3B9C5D0F-ACF2-FD80-5FD9-06F62C574943}"/>
              </a:ext>
            </a:extLst>
          </p:cNvPr>
          <p:cNvGrpSpPr/>
          <p:nvPr/>
        </p:nvGrpSpPr>
        <p:grpSpPr>
          <a:xfrm>
            <a:off x="731828" y="1898526"/>
            <a:ext cx="5130882" cy="3048260"/>
            <a:chOff x="731828" y="1898526"/>
            <a:chExt cx="5130882" cy="3048260"/>
          </a:xfrm>
        </p:grpSpPr>
        <p:sp>
          <p:nvSpPr>
            <p:cNvPr id="264" name="フリーフォーム 263">
              <a:extLst>
                <a:ext uri="{FF2B5EF4-FFF2-40B4-BE49-F238E27FC236}">
                  <a16:creationId xmlns:a16="http://schemas.microsoft.com/office/drawing/2014/main" xmlns="" id="{85C80CB7-3626-1597-7895-0799D1E5E1CD}"/>
                </a:ext>
              </a:extLst>
            </p:cNvPr>
            <p:cNvSpPr/>
            <p:nvPr/>
          </p:nvSpPr>
          <p:spPr>
            <a:xfrm>
              <a:off x="2138846" y="4674003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65" name="フリーフォーム 264">
              <a:extLst>
                <a:ext uri="{FF2B5EF4-FFF2-40B4-BE49-F238E27FC236}">
                  <a16:creationId xmlns:a16="http://schemas.microsoft.com/office/drawing/2014/main" xmlns="" id="{BC5F60A1-02E9-868B-AEB7-6145171CE332}"/>
                </a:ext>
              </a:extLst>
            </p:cNvPr>
            <p:cNvSpPr/>
            <p:nvPr/>
          </p:nvSpPr>
          <p:spPr>
            <a:xfrm>
              <a:off x="2821534" y="4674003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66" name="フリーフォーム 265">
              <a:extLst>
                <a:ext uri="{FF2B5EF4-FFF2-40B4-BE49-F238E27FC236}">
                  <a16:creationId xmlns:a16="http://schemas.microsoft.com/office/drawing/2014/main" xmlns="" id="{B67E51D4-80E4-8381-3F7A-371B457F6956}"/>
                </a:ext>
              </a:extLst>
            </p:cNvPr>
            <p:cNvSpPr/>
            <p:nvPr/>
          </p:nvSpPr>
          <p:spPr>
            <a:xfrm>
              <a:off x="3504223" y="4674003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67" name="フリーフォーム 266">
              <a:extLst>
                <a:ext uri="{FF2B5EF4-FFF2-40B4-BE49-F238E27FC236}">
                  <a16:creationId xmlns:a16="http://schemas.microsoft.com/office/drawing/2014/main" xmlns="" id="{D2859083-D54F-3855-D252-1BCCB4969B29}"/>
                </a:ext>
              </a:extLst>
            </p:cNvPr>
            <p:cNvSpPr/>
            <p:nvPr/>
          </p:nvSpPr>
          <p:spPr>
            <a:xfrm>
              <a:off x="4186913" y="4674003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68" name="フリーフォーム 267">
              <a:extLst>
                <a:ext uri="{FF2B5EF4-FFF2-40B4-BE49-F238E27FC236}">
                  <a16:creationId xmlns:a16="http://schemas.microsoft.com/office/drawing/2014/main" xmlns="" id="{FF90C9B1-6382-43C7-A816-26D55B94CF51}"/>
                </a:ext>
              </a:extLst>
            </p:cNvPr>
            <p:cNvSpPr/>
            <p:nvPr/>
          </p:nvSpPr>
          <p:spPr>
            <a:xfrm>
              <a:off x="4869601" y="4674003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69" name="フリーフォーム 268">
              <a:extLst>
                <a:ext uri="{FF2B5EF4-FFF2-40B4-BE49-F238E27FC236}">
                  <a16:creationId xmlns:a16="http://schemas.microsoft.com/office/drawing/2014/main" xmlns="" id="{4765A0A8-4BD7-6F3E-CA4A-03F561A8926E}"/>
                </a:ext>
              </a:extLst>
            </p:cNvPr>
            <p:cNvSpPr/>
            <p:nvPr/>
          </p:nvSpPr>
          <p:spPr>
            <a:xfrm>
              <a:off x="5552365" y="4674003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0" name="フリーフォーム 269">
              <a:extLst>
                <a:ext uri="{FF2B5EF4-FFF2-40B4-BE49-F238E27FC236}">
                  <a16:creationId xmlns:a16="http://schemas.microsoft.com/office/drawing/2014/main" xmlns="" id="{FB3E0B17-DBE8-5C94-A06E-23D34BFE914B}"/>
                </a:ext>
              </a:extLst>
            </p:cNvPr>
            <p:cNvSpPr/>
            <p:nvPr/>
          </p:nvSpPr>
          <p:spPr>
            <a:xfrm>
              <a:off x="1797501" y="4674003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1" name="フリーフォーム 270">
              <a:extLst>
                <a:ext uri="{FF2B5EF4-FFF2-40B4-BE49-F238E27FC236}">
                  <a16:creationId xmlns:a16="http://schemas.microsoft.com/office/drawing/2014/main" xmlns="" id="{E80F9F9A-0007-4084-12A0-B29CB3AF0594}"/>
                </a:ext>
              </a:extLst>
            </p:cNvPr>
            <p:cNvSpPr/>
            <p:nvPr/>
          </p:nvSpPr>
          <p:spPr>
            <a:xfrm>
              <a:off x="2480190" y="4674003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2" name="フリーフォーム 271">
              <a:extLst>
                <a:ext uri="{FF2B5EF4-FFF2-40B4-BE49-F238E27FC236}">
                  <a16:creationId xmlns:a16="http://schemas.microsoft.com/office/drawing/2014/main" xmlns="" id="{038DE2C5-309F-0449-E98B-6EED45C96412}"/>
                </a:ext>
              </a:extLst>
            </p:cNvPr>
            <p:cNvSpPr/>
            <p:nvPr/>
          </p:nvSpPr>
          <p:spPr>
            <a:xfrm>
              <a:off x="3162879" y="4674003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3" name="フリーフォーム 272">
              <a:extLst>
                <a:ext uri="{FF2B5EF4-FFF2-40B4-BE49-F238E27FC236}">
                  <a16:creationId xmlns:a16="http://schemas.microsoft.com/office/drawing/2014/main" xmlns="" id="{C958784F-D14A-5C4D-3720-2CC0D6DBA081}"/>
                </a:ext>
              </a:extLst>
            </p:cNvPr>
            <p:cNvSpPr/>
            <p:nvPr/>
          </p:nvSpPr>
          <p:spPr>
            <a:xfrm>
              <a:off x="3845568" y="4674003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4" name="フリーフォーム 273">
              <a:extLst>
                <a:ext uri="{FF2B5EF4-FFF2-40B4-BE49-F238E27FC236}">
                  <a16:creationId xmlns:a16="http://schemas.microsoft.com/office/drawing/2014/main" xmlns="" id="{DEDA2DB9-6AE5-0333-262F-A65C4443E7DC}"/>
                </a:ext>
              </a:extLst>
            </p:cNvPr>
            <p:cNvSpPr/>
            <p:nvPr/>
          </p:nvSpPr>
          <p:spPr>
            <a:xfrm>
              <a:off x="4528257" y="4674003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5" name="フリーフォーム 274">
              <a:extLst>
                <a:ext uri="{FF2B5EF4-FFF2-40B4-BE49-F238E27FC236}">
                  <a16:creationId xmlns:a16="http://schemas.microsoft.com/office/drawing/2014/main" xmlns="" id="{2DE18C0F-AA48-FDBA-9F18-BF0B8EE52C70}"/>
                </a:ext>
              </a:extLst>
            </p:cNvPr>
            <p:cNvSpPr/>
            <p:nvPr/>
          </p:nvSpPr>
          <p:spPr>
            <a:xfrm>
              <a:off x="5211020" y="4674003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6" name="フリーフォーム 275">
              <a:extLst>
                <a:ext uri="{FF2B5EF4-FFF2-40B4-BE49-F238E27FC236}">
                  <a16:creationId xmlns:a16="http://schemas.microsoft.com/office/drawing/2014/main" xmlns="" id="{BD6DAED3-AF89-5491-E0F3-08CA2791B35A}"/>
                </a:ext>
              </a:extLst>
            </p:cNvPr>
            <p:cNvSpPr/>
            <p:nvPr/>
          </p:nvSpPr>
          <p:spPr>
            <a:xfrm>
              <a:off x="1588848" y="4674003"/>
              <a:ext cx="4172095" cy="6966"/>
            </a:xfrm>
            <a:custGeom>
              <a:avLst/>
              <a:gdLst>
                <a:gd name="connsiteX0" fmla="*/ 0 w 5347614"/>
                <a:gd name="connsiteY0" fmla="*/ 0 h 9525"/>
                <a:gd name="connsiteX1" fmla="*/ 5347615 w 5347614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347614" h="9525">
                  <a:moveTo>
                    <a:pt x="0" y="0"/>
                  </a:moveTo>
                  <a:lnTo>
                    <a:pt x="5347615" y="0"/>
                  </a:lnTo>
                </a:path>
              </a:pathLst>
            </a:custGeom>
            <a:noFill/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7" name="フリーフォーム 276">
              <a:extLst>
                <a:ext uri="{FF2B5EF4-FFF2-40B4-BE49-F238E27FC236}">
                  <a16:creationId xmlns:a16="http://schemas.microsoft.com/office/drawing/2014/main" xmlns="" id="{69E50847-F82A-B785-3900-5D844D03B80F}"/>
                </a:ext>
              </a:extLst>
            </p:cNvPr>
            <p:cNvSpPr/>
            <p:nvPr/>
          </p:nvSpPr>
          <p:spPr>
            <a:xfrm>
              <a:off x="1562711" y="4285467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8" name="フリーフォーム 277">
              <a:extLst>
                <a:ext uri="{FF2B5EF4-FFF2-40B4-BE49-F238E27FC236}">
                  <a16:creationId xmlns:a16="http://schemas.microsoft.com/office/drawing/2014/main" xmlns="" id="{68473626-A393-7343-A126-011FFE508DFD}"/>
                </a:ext>
              </a:extLst>
            </p:cNvPr>
            <p:cNvSpPr/>
            <p:nvPr/>
          </p:nvSpPr>
          <p:spPr>
            <a:xfrm>
              <a:off x="1562711" y="3785901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79" name="フリーフォーム 278">
              <a:extLst>
                <a:ext uri="{FF2B5EF4-FFF2-40B4-BE49-F238E27FC236}">
                  <a16:creationId xmlns:a16="http://schemas.microsoft.com/office/drawing/2014/main" xmlns="" id="{5CFA6677-A133-DA00-45E2-7742FCB9E754}"/>
                </a:ext>
              </a:extLst>
            </p:cNvPr>
            <p:cNvSpPr/>
            <p:nvPr/>
          </p:nvSpPr>
          <p:spPr>
            <a:xfrm>
              <a:off x="1562711" y="3286264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0" name="フリーフォーム 279">
              <a:extLst>
                <a:ext uri="{FF2B5EF4-FFF2-40B4-BE49-F238E27FC236}">
                  <a16:creationId xmlns:a16="http://schemas.microsoft.com/office/drawing/2014/main" xmlns="" id="{D5CD24F2-B754-0AFE-A892-821BA4F5C2FA}"/>
                </a:ext>
              </a:extLst>
            </p:cNvPr>
            <p:cNvSpPr/>
            <p:nvPr/>
          </p:nvSpPr>
          <p:spPr>
            <a:xfrm>
              <a:off x="1562711" y="2786698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1" name="フリーフォーム 280">
              <a:extLst>
                <a:ext uri="{FF2B5EF4-FFF2-40B4-BE49-F238E27FC236}">
                  <a16:creationId xmlns:a16="http://schemas.microsoft.com/office/drawing/2014/main" xmlns="" id="{D705E119-CD52-6C4C-13B1-BF11526252EB}"/>
                </a:ext>
              </a:extLst>
            </p:cNvPr>
            <p:cNvSpPr/>
            <p:nvPr/>
          </p:nvSpPr>
          <p:spPr>
            <a:xfrm>
              <a:off x="1562711" y="2287131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2" name="フリーフォーム 281">
              <a:extLst>
                <a:ext uri="{FF2B5EF4-FFF2-40B4-BE49-F238E27FC236}">
                  <a16:creationId xmlns:a16="http://schemas.microsoft.com/office/drawing/2014/main" xmlns="" id="{6C317553-501E-E1DC-6518-D8240CA7FF74}"/>
                </a:ext>
              </a:extLst>
            </p:cNvPr>
            <p:cNvSpPr/>
            <p:nvPr/>
          </p:nvSpPr>
          <p:spPr>
            <a:xfrm>
              <a:off x="1536573" y="4535250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3" name="フリーフォーム 282">
              <a:extLst>
                <a:ext uri="{FF2B5EF4-FFF2-40B4-BE49-F238E27FC236}">
                  <a16:creationId xmlns:a16="http://schemas.microsoft.com/office/drawing/2014/main" xmlns="" id="{65707862-7BE5-4533-49EF-AC7F61384D1B}"/>
                </a:ext>
              </a:extLst>
            </p:cNvPr>
            <p:cNvSpPr/>
            <p:nvPr/>
          </p:nvSpPr>
          <p:spPr>
            <a:xfrm>
              <a:off x="1536573" y="4035683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4" name="フリーフォーム 283">
              <a:extLst>
                <a:ext uri="{FF2B5EF4-FFF2-40B4-BE49-F238E27FC236}">
                  <a16:creationId xmlns:a16="http://schemas.microsoft.com/office/drawing/2014/main" xmlns="" id="{44637F96-CA0D-9CB0-9008-BAFCC3371742}"/>
                </a:ext>
              </a:extLst>
            </p:cNvPr>
            <p:cNvSpPr/>
            <p:nvPr/>
          </p:nvSpPr>
          <p:spPr>
            <a:xfrm>
              <a:off x="1536573" y="3536117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5" name="フリーフォーム 284">
              <a:extLst>
                <a:ext uri="{FF2B5EF4-FFF2-40B4-BE49-F238E27FC236}">
                  <a16:creationId xmlns:a16="http://schemas.microsoft.com/office/drawing/2014/main" xmlns="" id="{E21DED79-5759-0BCB-EAD2-EAA0F148C261}"/>
                </a:ext>
              </a:extLst>
            </p:cNvPr>
            <p:cNvSpPr/>
            <p:nvPr/>
          </p:nvSpPr>
          <p:spPr>
            <a:xfrm>
              <a:off x="1536573" y="3036481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6" name="フリーフォーム 285">
              <a:extLst>
                <a:ext uri="{FF2B5EF4-FFF2-40B4-BE49-F238E27FC236}">
                  <a16:creationId xmlns:a16="http://schemas.microsoft.com/office/drawing/2014/main" xmlns="" id="{63E87062-3725-CF1E-A6FF-129FFFA8AF93}"/>
                </a:ext>
              </a:extLst>
            </p:cNvPr>
            <p:cNvSpPr/>
            <p:nvPr/>
          </p:nvSpPr>
          <p:spPr>
            <a:xfrm>
              <a:off x="1536573" y="2536915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7" name="フリーフォーム 286">
              <a:extLst>
                <a:ext uri="{FF2B5EF4-FFF2-40B4-BE49-F238E27FC236}">
                  <a16:creationId xmlns:a16="http://schemas.microsoft.com/office/drawing/2014/main" xmlns="" id="{9B573473-64D1-FF5F-43B6-17E79E1695C2}"/>
                </a:ext>
              </a:extLst>
            </p:cNvPr>
            <p:cNvSpPr/>
            <p:nvPr/>
          </p:nvSpPr>
          <p:spPr>
            <a:xfrm>
              <a:off x="1536573" y="2037349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8" name="フリーフォーム 287">
              <a:extLst>
                <a:ext uri="{FF2B5EF4-FFF2-40B4-BE49-F238E27FC236}">
                  <a16:creationId xmlns:a16="http://schemas.microsoft.com/office/drawing/2014/main" xmlns="" id="{FF6399FB-5C2A-6AEC-18C6-3E1A3B83363B}"/>
                </a:ext>
              </a:extLst>
            </p:cNvPr>
            <p:cNvSpPr/>
            <p:nvPr/>
          </p:nvSpPr>
          <p:spPr>
            <a:xfrm>
              <a:off x="1588848" y="1898526"/>
              <a:ext cx="7425" cy="2775477"/>
            </a:xfrm>
            <a:custGeom>
              <a:avLst/>
              <a:gdLst>
                <a:gd name="connsiteX0" fmla="*/ 0 w 9517"/>
                <a:gd name="connsiteY0" fmla="*/ 0 h 3795331"/>
                <a:gd name="connsiteX1" fmla="*/ 0 w 9517"/>
                <a:gd name="connsiteY1" fmla="*/ 3795332 h 37953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795331">
                  <a:moveTo>
                    <a:pt x="0" y="0"/>
                  </a:moveTo>
                  <a:lnTo>
                    <a:pt x="0" y="3795332"/>
                  </a:lnTo>
                </a:path>
              </a:pathLst>
            </a:custGeom>
            <a:noFill/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289" name="テキスト ボックス 288">
              <a:extLst>
                <a:ext uri="{FF2B5EF4-FFF2-40B4-BE49-F238E27FC236}">
                  <a16:creationId xmlns:a16="http://schemas.microsoft.com/office/drawing/2014/main" xmlns="" id="{1916C408-3D51-6548-956A-2684E710F493}"/>
                </a:ext>
              </a:extLst>
            </p:cNvPr>
            <p:cNvSpPr txBox="1"/>
            <p:nvPr/>
          </p:nvSpPr>
          <p:spPr>
            <a:xfrm>
              <a:off x="949765" y="1934511"/>
              <a:ext cx="6199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テキスト ボックス 289">
              <a:extLst>
                <a:ext uri="{FF2B5EF4-FFF2-40B4-BE49-F238E27FC236}">
                  <a16:creationId xmlns:a16="http://schemas.microsoft.com/office/drawing/2014/main" xmlns="" id="{780B806A-A31E-CBD8-ADBD-97B35C4AB797}"/>
                </a:ext>
              </a:extLst>
            </p:cNvPr>
            <p:cNvSpPr txBox="1"/>
            <p:nvPr/>
          </p:nvSpPr>
          <p:spPr>
            <a:xfrm>
              <a:off x="1002984" y="2430933"/>
              <a:ext cx="5667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テキスト ボックス 290">
              <a:extLst>
                <a:ext uri="{FF2B5EF4-FFF2-40B4-BE49-F238E27FC236}">
                  <a16:creationId xmlns:a16="http://schemas.microsoft.com/office/drawing/2014/main" xmlns="" id="{C8DD663F-861A-7E98-570F-C88689E6DD0E}"/>
                </a:ext>
              </a:extLst>
            </p:cNvPr>
            <p:cNvSpPr txBox="1"/>
            <p:nvPr/>
          </p:nvSpPr>
          <p:spPr>
            <a:xfrm>
              <a:off x="991684" y="2927355"/>
              <a:ext cx="5780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テキスト ボックス 291">
              <a:extLst>
                <a:ext uri="{FF2B5EF4-FFF2-40B4-BE49-F238E27FC236}">
                  <a16:creationId xmlns:a16="http://schemas.microsoft.com/office/drawing/2014/main" xmlns="" id="{9755E878-F358-6F2E-F506-6693EE223070}"/>
                </a:ext>
              </a:extLst>
            </p:cNvPr>
            <p:cNvSpPr txBox="1"/>
            <p:nvPr/>
          </p:nvSpPr>
          <p:spPr>
            <a:xfrm>
              <a:off x="1001764" y="3423777"/>
              <a:ext cx="5679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テキスト ボックス 292">
              <a:extLst>
                <a:ext uri="{FF2B5EF4-FFF2-40B4-BE49-F238E27FC236}">
                  <a16:creationId xmlns:a16="http://schemas.microsoft.com/office/drawing/2014/main" xmlns="" id="{3AE8FEF6-3BE4-7E1F-1F58-9C2BB0081E08}"/>
                </a:ext>
              </a:extLst>
            </p:cNvPr>
            <p:cNvSpPr txBox="1"/>
            <p:nvPr/>
          </p:nvSpPr>
          <p:spPr>
            <a:xfrm>
              <a:off x="1012259" y="3920199"/>
              <a:ext cx="5574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テキスト ボックス 293">
              <a:extLst>
                <a:ext uri="{FF2B5EF4-FFF2-40B4-BE49-F238E27FC236}">
                  <a16:creationId xmlns:a16="http://schemas.microsoft.com/office/drawing/2014/main" xmlns="" id="{0F86E65A-C7A8-926F-0EAE-1D21C1AED4B5}"/>
                </a:ext>
              </a:extLst>
            </p:cNvPr>
            <p:cNvSpPr txBox="1"/>
            <p:nvPr/>
          </p:nvSpPr>
          <p:spPr>
            <a:xfrm>
              <a:off x="909812" y="4416623"/>
              <a:ext cx="6599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xmlns="" id="{7A7752CF-EB2B-D228-711C-E0C41409B4A2}"/>
                </a:ext>
              </a:extLst>
            </p:cNvPr>
            <p:cNvSpPr txBox="1"/>
            <p:nvPr/>
          </p:nvSpPr>
          <p:spPr>
            <a:xfrm>
              <a:off x="1687894" y="471931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テキスト ボックス 295">
              <a:extLst>
                <a:ext uri="{FF2B5EF4-FFF2-40B4-BE49-F238E27FC236}">
                  <a16:creationId xmlns:a16="http://schemas.microsoft.com/office/drawing/2014/main" xmlns="" id="{0DCBEAE5-D7D3-5AA2-7B92-3BE16EC9C664}"/>
                </a:ext>
              </a:extLst>
            </p:cNvPr>
            <p:cNvSpPr txBox="1"/>
            <p:nvPr/>
          </p:nvSpPr>
          <p:spPr>
            <a:xfrm>
              <a:off x="2300654" y="473134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xmlns="" id="{B65E0E88-E155-6265-FECA-21902BA4D54A}"/>
                </a:ext>
              </a:extLst>
            </p:cNvPr>
            <p:cNvSpPr txBox="1"/>
            <p:nvPr/>
          </p:nvSpPr>
          <p:spPr>
            <a:xfrm>
              <a:off x="2985926" y="473134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テキスト ボックス 297">
              <a:extLst>
                <a:ext uri="{FF2B5EF4-FFF2-40B4-BE49-F238E27FC236}">
                  <a16:creationId xmlns:a16="http://schemas.microsoft.com/office/drawing/2014/main" xmlns="" id="{1868E8BD-4ACD-0AC4-EDE8-AEC25FE6E353}"/>
                </a:ext>
              </a:extLst>
            </p:cNvPr>
            <p:cNvSpPr txBox="1"/>
            <p:nvPr/>
          </p:nvSpPr>
          <p:spPr>
            <a:xfrm>
              <a:off x="3671198" y="473134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テキスト ボックス 298">
              <a:extLst>
                <a:ext uri="{FF2B5EF4-FFF2-40B4-BE49-F238E27FC236}">
                  <a16:creationId xmlns:a16="http://schemas.microsoft.com/office/drawing/2014/main" xmlns="" id="{0BAC1523-70B2-51D2-BEDD-31B1F94D3777}"/>
                </a:ext>
              </a:extLst>
            </p:cNvPr>
            <p:cNvSpPr txBox="1"/>
            <p:nvPr/>
          </p:nvSpPr>
          <p:spPr>
            <a:xfrm>
              <a:off x="4356470" y="473134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テキスト ボックス 299">
              <a:extLst>
                <a:ext uri="{FF2B5EF4-FFF2-40B4-BE49-F238E27FC236}">
                  <a16:creationId xmlns:a16="http://schemas.microsoft.com/office/drawing/2014/main" xmlns="" id="{EDBF7A3A-6427-BD80-88C2-7D51B64055E3}"/>
                </a:ext>
              </a:extLst>
            </p:cNvPr>
            <p:cNvSpPr txBox="1"/>
            <p:nvPr/>
          </p:nvSpPr>
          <p:spPr>
            <a:xfrm>
              <a:off x="5041743" y="473134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テキスト ボックス 300">
              <a:extLst>
                <a:ext uri="{FF2B5EF4-FFF2-40B4-BE49-F238E27FC236}">
                  <a16:creationId xmlns:a16="http://schemas.microsoft.com/office/drawing/2014/main" xmlns="" id="{8EA92EAC-E6B4-3AFC-02F0-B679F3D125A6}"/>
                </a:ext>
              </a:extLst>
            </p:cNvPr>
            <p:cNvSpPr txBox="1"/>
            <p:nvPr/>
          </p:nvSpPr>
          <p:spPr>
            <a:xfrm>
              <a:off x="5017607" y="4406585"/>
              <a:ext cx="8451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</a:t>
              </a:r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</a:t>
              </a:r>
              <a:r>
                <a:rPr kumimoji="1"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 sz="11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テキスト ボックス 301">
              <a:extLst>
                <a:ext uri="{FF2B5EF4-FFF2-40B4-BE49-F238E27FC236}">
                  <a16:creationId xmlns:a16="http://schemas.microsoft.com/office/drawing/2014/main" xmlns="" id="{1DB3F83F-838D-4FAB-9ECC-CDF53324B6CE}"/>
                </a:ext>
              </a:extLst>
            </p:cNvPr>
            <p:cNvSpPr txBox="1"/>
            <p:nvPr/>
          </p:nvSpPr>
          <p:spPr>
            <a:xfrm rot="16200000">
              <a:off x="209249" y="3146335"/>
              <a:ext cx="13067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BO-free rate</a:t>
              </a:r>
              <a:r>
                <a:rPr kumimoji="1"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%)</a:t>
              </a:r>
              <a:endParaRPr kumimoji="1" lang="ja-JP" altLang="en-US" sz="11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正方形/長方形 257">
              <a:extLst>
                <a:ext uri="{FF2B5EF4-FFF2-40B4-BE49-F238E27FC236}">
                  <a16:creationId xmlns:a16="http://schemas.microsoft.com/office/drawing/2014/main" xmlns="" id="{00CE521F-0F74-793B-FD28-A46D5343E4F4}"/>
                </a:ext>
              </a:extLst>
            </p:cNvPr>
            <p:cNvSpPr/>
            <p:nvPr/>
          </p:nvSpPr>
          <p:spPr>
            <a:xfrm>
              <a:off x="3829418" y="2103246"/>
              <a:ext cx="1324240" cy="582031"/>
            </a:xfrm>
            <a:prstGeom prst="rect">
              <a:avLst/>
            </a:prstGeom>
            <a:noFill/>
            <a:ln w="9525">
              <a:solidFill>
                <a:schemeClr val="accent1">
                  <a:lumMod val="50000"/>
                </a:schemeClr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 b="1">
                <a:solidFill>
                  <a:schemeClr val="tx1"/>
                </a:solidFill>
              </a:endParaRPr>
            </a:p>
          </p:txBody>
        </p:sp>
        <p:grpSp>
          <p:nvGrpSpPr>
            <p:cNvPr id="259" name="グループ化 258">
              <a:extLst>
                <a:ext uri="{FF2B5EF4-FFF2-40B4-BE49-F238E27FC236}">
                  <a16:creationId xmlns:a16="http://schemas.microsoft.com/office/drawing/2014/main" xmlns="" id="{246F4DB2-4E3A-B634-0E0F-C78AB0E9C717}"/>
                </a:ext>
              </a:extLst>
            </p:cNvPr>
            <p:cNvGrpSpPr/>
            <p:nvPr/>
          </p:nvGrpSpPr>
          <p:grpSpPr>
            <a:xfrm>
              <a:off x="3958532" y="2175954"/>
              <a:ext cx="1139430" cy="452259"/>
              <a:chOff x="4251784" y="1784497"/>
              <a:chExt cx="1139430" cy="452259"/>
            </a:xfrm>
          </p:grpSpPr>
          <p:cxnSp>
            <p:nvCxnSpPr>
              <p:cNvPr id="260" name="直線コネクタ 259">
                <a:extLst>
                  <a:ext uri="{FF2B5EF4-FFF2-40B4-BE49-F238E27FC236}">
                    <a16:creationId xmlns:a16="http://schemas.microsoft.com/office/drawing/2014/main" xmlns="" id="{41B60ECF-52ED-E865-F661-E4EB2072AC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51784" y="1903592"/>
                <a:ext cx="169277" cy="0"/>
              </a:xfrm>
              <a:prstGeom prst="line">
                <a:avLst/>
              </a:prstGeom>
              <a:ln w="19050">
                <a:solidFill>
                  <a:schemeClr val="accent1">
                    <a:lumMod val="50000"/>
                  </a:schemeClr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1" name="テキスト ボックス 260">
                <a:extLst>
                  <a:ext uri="{FF2B5EF4-FFF2-40B4-BE49-F238E27FC236}">
                    <a16:creationId xmlns:a16="http://schemas.microsoft.com/office/drawing/2014/main" xmlns="" id="{E09CC714-49AB-4B72-B9DD-30AF0EB6C93C}"/>
                  </a:ext>
                </a:extLst>
              </p:cNvPr>
              <p:cNvSpPr txBox="1"/>
              <p:nvPr/>
            </p:nvSpPr>
            <p:spPr>
              <a:xfrm>
                <a:off x="4465961" y="1784497"/>
                <a:ext cx="92525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 (reference)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2" name="テキスト ボックス 261">
                <a:extLst>
                  <a:ext uri="{FF2B5EF4-FFF2-40B4-BE49-F238E27FC236}">
                    <a16:creationId xmlns:a16="http://schemas.microsoft.com/office/drawing/2014/main" xmlns="" id="{D84B1A65-0770-55B8-223B-517FC163424B}"/>
                  </a:ext>
                </a:extLst>
              </p:cNvPr>
              <p:cNvSpPr txBox="1"/>
              <p:nvPr/>
            </p:nvSpPr>
            <p:spPr>
              <a:xfrm>
                <a:off x="4468319" y="2005924"/>
                <a:ext cx="34817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 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63" name="直線コネクタ 262">
                <a:extLst>
                  <a:ext uri="{FF2B5EF4-FFF2-40B4-BE49-F238E27FC236}">
                    <a16:creationId xmlns:a16="http://schemas.microsoft.com/office/drawing/2014/main" xmlns="" id="{F8CA69FB-5798-3B20-6E61-354EF2CD50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51784" y="2132382"/>
                <a:ext cx="169277" cy="0"/>
              </a:xfrm>
              <a:prstGeom prst="line">
                <a:avLst/>
              </a:prstGeom>
              <a:ln w="1905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xmlns="" id="{6A217BC7-B4D3-2F98-A2BB-B64B60FBECE2}"/>
                </a:ext>
              </a:extLst>
            </p:cNvPr>
            <p:cNvSpPr txBox="1"/>
            <p:nvPr/>
          </p:nvSpPr>
          <p:spPr>
            <a:xfrm>
              <a:off x="3485419" y="2903440"/>
              <a:ext cx="19111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 0.40 </a:t>
              </a:r>
              <a:r>
                <a:rPr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95% CI</a:t>
              </a:r>
              <a:r>
                <a:rPr lang="en-US" altLang="ja-JP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: 0.14–1.64</a:t>
              </a:r>
              <a:r>
                <a:rPr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  <a:p>
              <a:r>
                <a:rPr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atified by log-rank test</a:t>
              </a:r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kumimoji="1" lang="en-US" altLang="ja-JP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470</a:t>
              </a:r>
              <a:endParaRPr kumimoji="1" lang="ja-JP" alt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フリーフォーム 17">
              <a:extLst>
                <a:ext uri="{FF2B5EF4-FFF2-40B4-BE49-F238E27FC236}">
                  <a16:creationId xmlns:a16="http://schemas.microsoft.com/office/drawing/2014/main" xmlns="" id="{E7C45FA9-233E-4A0D-AD76-E28F533C2D6B}"/>
                </a:ext>
              </a:extLst>
            </p:cNvPr>
            <p:cNvSpPr/>
            <p:nvPr/>
          </p:nvSpPr>
          <p:spPr>
            <a:xfrm>
              <a:off x="1791447" y="2059200"/>
              <a:ext cx="2533636" cy="2477502"/>
            </a:xfrm>
            <a:custGeom>
              <a:avLst/>
              <a:gdLst>
                <a:gd name="connsiteX0" fmla="*/ 0 w 2533636"/>
                <a:gd name="connsiteY0" fmla="*/ 0 h 2477502"/>
                <a:gd name="connsiteX1" fmla="*/ 6747 w 2533636"/>
                <a:gd name="connsiteY1" fmla="*/ 0 h 2477502"/>
                <a:gd name="connsiteX2" fmla="*/ 6747 w 2533636"/>
                <a:gd name="connsiteY2" fmla="*/ 35911 h 2477502"/>
                <a:gd name="connsiteX3" fmla="*/ 13540 w 2533636"/>
                <a:gd name="connsiteY3" fmla="*/ 35911 h 2477502"/>
                <a:gd name="connsiteX4" fmla="*/ 13540 w 2533636"/>
                <a:gd name="connsiteY4" fmla="*/ 71822 h 2477502"/>
                <a:gd name="connsiteX5" fmla="*/ 27081 w 2533636"/>
                <a:gd name="connsiteY5" fmla="*/ 71822 h 2477502"/>
                <a:gd name="connsiteX6" fmla="*/ 27081 w 2533636"/>
                <a:gd name="connsiteY6" fmla="*/ 107733 h 2477502"/>
                <a:gd name="connsiteX7" fmla="*/ 54161 w 2533636"/>
                <a:gd name="connsiteY7" fmla="*/ 107733 h 2477502"/>
                <a:gd name="connsiteX8" fmla="*/ 54161 w 2533636"/>
                <a:gd name="connsiteY8" fmla="*/ 144723 h 2477502"/>
                <a:gd name="connsiteX9" fmla="*/ 88035 w 2533636"/>
                <a:gd name="connsiteY9" fmla="*/ 144723 h 2477502"/>
                <a:gd name="connsiteX10" fmla="*/ 88035 w 2533636"/>
                <a:gd name="connsiteY10" fmla="*/ 182373 h 2477502"/>
                <a:gd name="connsiteX11" fmla="*/ 101576 w 2533636"/>
                <a:gd name="connsiteY11" fmla="*/ 182373 h 2477502"/>
                <a:gd name="connsiteX12" fmla="*/ 101623 w 2533636"/>
                <a:gd name="connsiteY12" fmla="*/ 219963 h 2477502"/>
                <a:gd name="connsiteX13" fmla="*/ 115163 w 2533636"/>
                <a:gd name="connsiteY13" fmla="*/ 219963 h 2477502"/>
                <a:gd name="connsiteX14" fmla="*/ 115163 w 2533636"/>
                <a:gd name="connsiteY14" fmla="*/ 258931 h 2477502"/>
                <a:gd name="connsiteX15" fmla="*/ 121910 w 2533636"/>
                <a:gd name="connsiteY15" fmla="*/ 258931 h 2477502"/>
                <a:gd name="connsiteX16" fmla="*/ 121910 w 2533636"/>
                <a:gd name="connsiteY16" fmla="*/ 336749 h 2477502"/>
                <a:gd name="connsiteX17" fmla="*/ 149037 w 2533636"/>
                <a:gd name="connsiteY17" fmla="*/ 336749 h 2477502"/>
                <a:gd name="connsiteX18" fmla="*/ 149037 w 2533636"/>
                <a:gd name="connsiteY18" fmla="*/ 377935 h 2477502"/>
                <a:gd name="connsiteX19" fmla="*/ 155784 w 2533636"/>
                <a:gd name="connsiteY19" fmla="*/ 377935 h 2477502"/>
                <a:gd name="connsiteX20" fmla="*/ 155784 w 2533636"/>
                <a:gd name="connsiteY20" fmla="*/ 419062 h 2477502"/>
                <a:gd name="connsiteX21" fmla="*/ 182912 w 2533636"/>
                <a:gd name="connsiteY21" fmla="*/ 419062 h 2477502"/>
                <a:gd name="connsiteX22" fmla="*/ 182912 w 2533636"/>
                <a:gd name="connsiteY22" fmla="*/ 461988 h 2477502"/>
                <a:gd name="connsiteX23" fmla="*/ 189658 w 2533636"/>
                <a:gd name="connsiteY23" fmla="*/ 461988 h 2477502"/>
                <a:gd name="connsiteX24" fmla="*/ 189658 w 2533636"/>
                <a:gd name="connsiteY24" fmla="*/ 549577 h 2477502"/>
                <a:gd name="connsiteX25" fmla="*/ 237073 w 2533636"/>
                <a:gd name="connsiteY25" fmla="*/ 549577 h 2477502"/>
                <a:gd name="connsiteX26" fmla="*/ 237073 w 2533636"/>
                <a:gd name="connsiteY26" fmla="*/ 597778 h 2477502"/>
                <a:gd name="connsiteX27" fmla="*/ 284487 w 2533636"/>
                <a:gd name="connsiteY27" fmla="*/ 597778 h 2477502"/>
                <a:gd name="connsiteX28" fmla="*/ 284487 w 2533636"/>
                <a:gd name="connsiteY28" fmla="*/ 696758 h 2477502"/>
                <a:gd name="connsiteX29" fmla="*/ 304821 w 2533636"/>
                <a:gd name="connsiteY29" fmla="*/ 696758 h 2477502"/>
                <a:gd name="connsiteX30" fmla="*/ 304821 w 2533636"/>
                <a:gd name="connsiteY30" fmla="*/ 747597 h 2477502"/>
                <a:gd name="connsiteX31" fmla="*/ 318362 w 2533636"/>
                <a:gd name="connsiteY31" fmla="*/ 747597 h 2477502"/>
                <a:gd name="connsiteX32" fmla="*/ 318362 w 2533636"/>
                <a:gd name="connsiteY32" fmla="*/ 798496 h 2477502"/>
                <a:gd name="connsiteX33" fmla="*/ 325155 w 2533636"/>
                <a:gd name="connsiteY33" fmla="*/ 798496 h 2477502"/>
                <a:gd name="connsiteX34" fmla="*/ 325155 w 2533636"/>
                <a:gd name="connsiteY34" fmla="*/ 849395 h 2477502"/>
                <a:gd name="connsiteX35" fmla="*/ 331949 w 2533636"/>
                <a:gd name="connsiteY35" fmla="*/ 849395 h 2477502"/>
                <a:gd name="connsiteX36" fmla="*/ 331949 w 2533636"/>
                <a:gd name="connsiteY36" fmla="*/ 900234 h 2477502"/>
                <a:gd name="connsiteX37" fmla="*/ 338696 w 2533636"/>
                <a:gd name="connsiteY37" fmla="*/ 900234 h 2477502"/>
                <a:gd name="connsiteX38" fmla="*/ 338696 w 2533636"/>
                <a:gd name="connsiteY38" fmla="*/ 951133 h 2477502"/>
                <a:gd name="connsiteX39" fmla="*/ 386110 w 2533636"/>
                <a:gd name="connsiteY39" fmla="*/ 951133 h 2477502"/>
                <a:gd name="connsiteX40" fmla="*/ 386110 w 2533636"/>
                <a:gd name="connsiteY40" fmla="*/ 1005629 h 2477502"/>
                <a:gd name="connsiteX41" fmla="*/ 413238 w 2533636"/>
                <a:gd name="connsiteY41" fmla="*/ 1005629 h 2477502"/>
                <a:gd name="connsiteX42" fmla="*/ 413238 w 2533636"/>
                <a:gd name="connsiteY42" fmla="*/ 1064502 h 2477502"/>
                <a:gd name="connsiteX43" fmla="*/ 426778 w 2533636"/>
                <a:gd name="connsiteY43" fmla="*/ 1064502 h 2477502"/>
                <a:gd name="connsiteX44" fmla="*/ 426778 w 2533636"/>
                <a:gd name="connsiteY44" fmla="*/ 1123374 h 2477502"/>
                <a:gd name="connsiteX45" fmla="*/ 467399 w 2533636"/>
                <a:gd name="connsiteY45" fmla="*/ 1123374 h 2477502"/>
                <a:gd name="connsiteX46" fmla="*/ 467399 w 2533636"/>
                <a:gd name="connsiteY46" fmla="*/ 1187882 h 2477502"/>
                <a:gd name="connsiteX47" fmla="*/ 528401 w 2533636"/>
                <a:gd name="connsiteY47" fmla="*/ 1187882 h 2477502"/>
                <a:gd name="connsiteX48" fmla="*/ 528401 w 2533636"/>
                <a:gd name="connsiteY48" fmla="*/ 1259525 h 2477502"/>
                <a:gd name="connsiteX49" fmla="*/ 569022 w 2533636"/>
                <a:gd name="connsiteY49" fmla="*/ 1259525 h 2477502"/>
                <a:gd name="connsiteX50" fmla="*/ 569022 w 2533636"/>
                <a:gd name="connsiteY50" fmla="*/ 1335663 h 2477502"/>
                <a:gd name="connsiteX51" fmla="*/ 596150 w 2533636"/>
                <a:gd name="connsiteY51" fmla="*/ 1335663 h 2477502"/>
                <a:gd name="connsiteX52" fmla="*/ 596150 w 2533636"/>
                <a:gd name="connsiteY52" fmla="*/ 1411742 h 2477502"/>
                <a:gd name="connsiteX53" fmla="*/ 663851 w 2533636"/>
                <a:gd name="connsiteY53" fmla="*/ 1411742 h 2477502"/>
                <a:gd name="connsiteX54" fmla="*/ 663898 w 2533636"/>
                <a:gd name="connsiteY54" fmla="*/ 1493756 h 2477502"/>
                <a:gd name="connsiteX55" fmla="*/ 738394 w 2533636"/>
                <a:gd name="connsiteY55" fmla="*/ 1493756 h 2477502"/>
                <a:gd name="connsiteX56" fmla="*/ 738394 w 2533636"/>
                <a:gd name="connsiteY56" fmla="*/ 1592136 h 2477502"/>
                <a:gd name="connsiteX57" fmla="*/ 772268 w 2533636"/>
                <a:gd name="connsiteY57" fmla="*/ 1592136 h 2477502"/>
                <a:gd name="connsiteX58" fmla="*/ 772268 w 2533636"/>
                <a:gd name="connsiteY58" fmla="*/ 1690517 h 2477502"/>
                <a:gd name="connsiteX59" fmla="*/ 1131298 w 2533636"/>
                <a:gd name="connsiteY59" fmla="*/ 1690517 h 2477502"/>
                <a:gd name="connsiteX60" fmla="*/ 1131298 w 2533636"/>
                <a:gd name="connsiteY60" fmla="*/ 1847890 h 2477502"/>
                <a:gd name="connsiteX61" fmla="*/ 2533637 w 2533636"/>
                <a:gd name="connsiteY61" fmla="*/ 1847890 h 2477502"/>
                <a:gd name="connsiteX62" fmla="*/ 2533637 w 2533636"/>
                <a:gd name="connsiteY62" fmla="*/ 2477503 h 24775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</a:cxnLst>
              <a:rect l="l" t="t" r="r" b="b"/>
              <a:pathLst>
                <a:path w="2533636" h="2477502">
                  <a:moveTo>
                    <a:pt x="0" y="0"/>
                  </a:moveTo>
                  <a:lnTo>
                    <a:pt x="6747" y="0"/>
                  </a:lnTo>
                  <a:lnTo>
                    <a:pt x="6747" y="35911"/>
                  </a:lnTo>
                  <a:lnTo>
                    <a:pt x="13540" y="35911"/>
                  </a:lnTo>
                  <a:lnTo>
                    <a:pt x="13540" y="71822"/>
                  </a:lnTo>
                  <a:lnTo>
                    <a:pt x="27081" y="71822"/>
                  </a:lnTo>
                  <a:lnTo>
                    <a:pt x="27081" y="107733"/>
                  </a:lnTo>
                  <a:lnTo>
                    <a:pt x="54161" y="107733"/>
                  </a:lnTo>
                  <a:lnTo>
                    <a:pt x="54161" y="144723"/>
                  </a:lnTo>
                  <a:lnTo>
                    <a:pt x="88035" y="144723"/>
                  </a:lnTo>
                  <a:lnTo>
                    <a:pt x="88035" y="182373"/>
                  </a:lnTo>
                  <a:lnTo>
                    <a:pt x="101576" y="182373"/>
                  </a:lnTo>
                  <a:lnTo>
                    <a:pt x="101623" y="219963"/>
                  </a:lnTo>
                  <a:lnTo>
                    <a:pt x="115163" y="219963"/>
                  </a:lnTo>
                  <a:lnTo>
                    <a:pt x="115163" y="258931"/>
                  </a:lnTo>
                  <a:lnTo>
                    <a:pt x="121910" y="258931"/>
                  </a:lnTo>
                  <a:lnTo>
                    <a:pt x="121910" y="336749"/>
                  </a:lnTo>
                  <a:lnTo>
                    <a:pt x="149037" y="336749"/>
                  </a:lnTo>
                  <a:lnTo>
                    <a:pt x="149037" y="377935"/>
                  </a:lnTo>
                  <a:lnTo>
                    <a:pt x="155784" y="377935"/>
                  </a:lnTo>
                  <a:lnTo>
                    <a:pt x="155784" y="419062"/>
                  </a:lnTo>
                  <a:lnTo>
                    <a:pt x="182912" y="419062"/>
                  </a:lnTo>
                  <a:lnTo>
                    <a:pt x="182912" y="461988"/>
                  </a:lnTo>
                  <a:lnTo>
                    <a:pt x="189658" y="461988"/>
                  </a:lnTo>
                  <a:lnTo>
                    <a:pt x="189658" y="549577"/>
                  </a:lnTo>
                  <a:lnTo>
                    <a:pt x="237073" y="549577"/>
                  </a:lnTo>
                  <a:lnTo>
                    <a:pt x="237073" y="597778"/>
                  </a:lnTo>
                  <a:lnTo>
                    <a:pt x="284487" y="597778"/>
                  </a:lnTo>
                  <a:lnTo>
                    <a:pt x="284487" y="696758"/>
                  </a:lnTo>
                  <a:lnTo>
                    <a:pt x="304821" y="696758"/>
                  </a:lnTo>
                  <a:lnTo>
                    <a:pt x="304821" y="747597"/>
                  </a:lnTo>
                  <a:lnTo>
                    <a:pt x="318362" y="747597"/>
                  </a:lnTo>
                  <a:lnTo>
                    <a:pt x="318362" y="798496"/>
                  </a:lnTo>
                  <a:lnTo>
                    <a:pt x="325155" y="798496"/>
                  </a:lnTo>
                  <a:lnTo>
                    <a:pt x="325155" y="849395"/>
                  </a:lnTo>
                  <a:lnTo>
                    <a:pt x="331949" y="849395"/>
                  </a:lnTo>
                  <a:lnTo>
                    <a:pt x="331949" y="900234"/>
                  </a:lnTo>
                  <a:lnTo>
                    <a:pt x="338696" y="900234"/>
                  </a:lnTo>
                  <a:lnTo>
                    <a:pt x="338696" y="951133"/>
                  </a:lnTo>
                  <a:lnTo>
                    <a:pt x="386110" y="951133"/>
                  </a:lnTo>
                  <a:lnTo>
                    <a:pt x="386110" y="1005629"/>
                  </a:lnTo>
                  <a:lnTo>
                    <a:pt x="413238" y="1005629"/>
                  </a:lnTo>
                  <a:lnTo>
                    <a:pt x="413238" y="1064502"/>
                  </a:lnTo>
                  <a:lnTo>
                    <a:pt x="426778" y="1064502"/>
                  </a:lnTo>
                  <a:lnTo>
                    <a:pt x="426778" y="1123374"/>
                  </a:lnTo>
                  <a:lnTo>
                    <a:pt x="467399" y="1123374"/>
                  </a:lnTo>
                  <a:lnTo>
                    <a:pt x="467399" y="1187882"/>
                  </a:lnTo>
                  <a:lnTo>
                    <a:pt x="528401" y="1187882"/>
                  </a:lnTo>
                  <a:lnTo>
                    <a:pt x="528401" y="1259525"/>
                  </a:lnTo>
                  <a:lnTo>
                    <a:pt x="569022" y="1259525"/>
                  </a:lnTo>
                  <a:lnTo>
                    <a:pt x="569022" y="1335663"/>
                  </a:lnTo>
                  <a:lnTo>
                    <a:pt x="596150" y="1335663"/>
                  </a:lnTo>
                  <a:lnTo>
                    <a:pt x="596150" y="1411742"/>
                  </a:lnTo>
                  <a:lnTo>
                    <a:pt x="663851" y="1411742"/>
                  </a:lnTo>
                  <a:lnTo>
                    <a:pt x="663898" y="1493756"/>
                  </a:lnTo>
                  <a:lnTo>
                    <a:pt x="738394" y="1493756"/>
                  </a:lnTo>
                  <a:lnTo>
                    <a:pt x="738394" y="1592136"/>
                  </a:lnTo>
                  <a:lnTo>
                    <a:pt x="772268" y="1592136"/>
                  </a:lnTo>
                  <a:lnTo>
                    <a:pt x="772268" y="1690517"/>
                  </a:lnTo>
                  <a:lnTo>
                    <a:pt x="1131298" y="1690517"/>
                  </a:lnTo>
                  <a:lnTo>
                    <a:pt x="1131298" y="1847890"/>
                  </a:lnTo>
                  <a:lnTo>
                    <a:pt x="2533637" y="1847890"/>
                  </a:lnTo>
                  <a:lnTo>
                    <a:pt x="2533637" y="2477503"/>
                  </a:lnTo>
                </a:path>
              </a:pathLst>
            </a:custGeom>
            <a:noFill/>
            <a:ln w="19050" cap="flat">
              <a:solidFill>
                <a:srgbClr val="C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9" name="フリーフォーム 18">
              <a:extLst>
                <a:ext uri="{FF2B5EF4-FFF2-40B4-BE49-F238E27FC236}">
                  <a16:creationId xmlns:a16="http://schemas.microsoft.com/office/drawing/2014/main" xmlns="" id="{1B8425E9-FB70-2170-2256-3F221AB84F7F}"/>
                </a:ext>
              </a:extLst>
            </p:cNvPr>
            <p:cNvSpPr/>
            <p:nvPr/>
          </p:nvSpPr>
          <p:spPr>
            <a:xfrm>
              <a:off x="1791447" y="2059200"/>
              <a:ext cx="690978" cy="1638790"/>
            </a:xfrm>
            <a:custGeom>
              <a:avLst/>
              <a:gdLst>
                <a:gd name="connsiteX0" fmla="*/ 0 w 690978"/>
                <a:gd name="connsiteY0" fmla="*/ 0 h 1566596"/>
                <a:gd name="connsiteX1" fmla="*/ 6747 w 690978"/>
                <a:gd name="connsiteY1" fmla="*/ 0 h 1566596"/>
                <a:gd name="connsiteX2" fmla="*/ 6747 w 690978"/>
                <a:gd name="connsiteY2" fmla="*/ 0 h 1566596"/>
                <a:gd name="connsiteX3" fmla="*/ 40621 w 690978"/>
                <a:gd name="connsiteY3" fmla="*/ 0 h 1566596"/>
                <a:gd name="connsiteX4" fmla="*/ 40621 w 690978"/>
                <a:gd name="connsiteY4" fmla="*/ 330334 h 1566596"/>
                <a:gd name="connsiteX5" fmla="*/ 149037 w 690978"/>
                <a:gd name="connsiteY5" fmla="*/ 330334 h 1566596"/>
                <a:gd name="connsiteX6" fmla="*/ 149037 w 690978"/>
                <a:gd name="connsiteY6" fmla="*/ 525536 h 1566596"/>
                <a:gd name="connsiteX7" fmla="*/ 176118 w 690978"/>
                <a:gd name="connsiteY7" fmla="*/ 525536 h 1566596"/>
                <a:gd name="connsiteX8" fmla="*/ 176118 w 690978"/>
                <a:gd name="connsiteY8" fmla="*/ 915942 h 1566596"/>
                <a:gd name="connsiteX9" fmla="*/ 203199 w 690978"/>
                <a:gd name="connsiteY9" fmla="*/ 915942 h 1566596"/>
                <a:gd name="connsiteX10" fmla="*/ 203199 w 690978"/>
                <a:gd name="connsiteY10" fmla="*/ 1111144 h 1566596"/>
                <a:gd name="connsiteX11" fmla="*/ 230326 w 690978"/>
                <a:gd name="connsiteY11" fmla="*/ 1111144 h 1566596"/>
                <a:gd name="connsiteX12" fmla="*/ 230326 w 690978"/>
                <a:gd name="connsiteY12" fmla="*/ 1338841 h 1566596"/>
                <a:gd name="connsiteX13" fmla="*/ 264201 w 690978"/>
                <a:gd name="connsiteY13" fmla="*/ 1338841 h 1566596"/>
                <a:gd name="connsiteX14" fmla="*/ 264201 w 690978"/>
                <a:gd name="connsiteY14" fmla="*/ 1566597 h 1566596"/>
                <a:gd name="connsiteX15" fmla="*/ 690979 w 690978"/>
                <a:gd name="connsiteY15" fmla="*/ 1566597 h 1566596"/>
                <a:gd name="connsiteX16" fmla="*/ 690979 w 690978"/>
                <a:gd name="connsiteY16" fmla="*/ 1566597 h 15665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690978" h="1566596">
                  <a:moveTo>
                    <a:pt x="0" y="0"/>
                  </a:moveTo>
                  <a:lnTo>
                    <a:pt x="6747" y="0"/>
                  </a:lnTo>
                  <a:lnTo>
                    <a:pt x="6747" y="0"/>
                  </a:lnTo>
                  <a:lnTo>
                    <a:pt x="40621" y="0"/>
                  </a:lnTo>
                  <a:lnTo>
                    <a:pt x="40621" y="330334"/>
                  </a:lnTo>
                  <a:lnTo>
                    <a:pt x="149037" y="330334"/>
                  </a:lnTo>
                  <a:lnTo>
                    <a:pt x="149037" y="525536"/>
                  </a:lnTo>
                  <a:lnTo>
                    <a:pt x="176118" y="525536"/>
                  </a:lnTo>
                  <a:lnTo>
                    <a:pt x="176118" y="915942"/>
                  </a:lnTo>
                  <a:lnTo>
                    <a:pt x="203199" y="915942"/>
                  </a:lnTo>
                  <a:lnTo>
                    <a:pt x="203199" y="1111144"/>
                  </a:lnTo>
                  <a:lnTo>
                    <a:pt x="230326" y="1111144"/>
                  </a:lnTo>
                  <a:lnTo>
                    <a:pt x="230326" y="1338841"/>
                  </a:lnTo>
                  <a:lnTo>
                    <a:pt x="264201" y="1338841"/>
                  </a:lnTo>
                  <a:lnTo>
                    <a:pt x="264201" y="1566597"/>
                  </a:lnTo>
                  <a:lnTo>
                    <a:pt x="690979" y="1566597"/>
                  </a:lnTo>
                  <a:lnTo>
                    <a:pt x="690979" y="1566597"/>
                  </a:lnTo>
                </a:path>
              </a:pathLst>
            </a:custGeom>
            <a:noFill/>
            <a:ln w="19050" cap="flat">
              <a:solidFill>
                <a:schemeClr val="accent5">
                  <a:lumMod val="50000"/>
                </a:schemeClr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3" name="フリーフォーム 22">
              <a:extLst>
                <a:ext uri="{FF2B5EF4-FFF2-40B4-BE49-F238E27FC236}">
                  <a16:creationId xmlns:a16="http://schemas.microsoft.com/office/drawing/2014/main" xmlns="" id="{4820AD49-A73D-A16A-6056-5D7E5E9EDC9A}"/>
                </a:ext>
              </a:extLst>
            </p:cNvPr>
            <p:cNvSpPr/>
            <p:nvPr/>
          </p:nvSpPr>
          <p:spPr>
            <a:xfrm>
              <a:off x="1818715" y="2149967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4" name="フリーフォーム 23">
              <a:extLst>
                <a:ext uri="{FF2B5EF4-FFF2-40B4-BE49-F238E27FC236}">
                  <a16:creationId xmlns:a16="http://schemas.microsoft.com/office/drawing/2014/main" xmlns="" id="{7C078B6B-5555-7467-440B-527A28E6D9C0}"/>
                </a:ext>
              </a:extLst>
            </p:cNvPr>
            <p:cNvSpPr/>
            <p:nvPr/>
          </p:nvSpPr>
          <p:spPr>
            <a:xfrm>
              <a:off x="1818715" y="2149967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5" name="フリーフォーム 24">
              <a:extLst>
                <a:ext uri="{FF2B5EF4-FFF2-40B4-BE49-F238E27FC236}">
                  <a16:creationId xmlns:a16="http://schemas.microsoft.com/office/drawing/2014/main" xmlns="" id="{00AE7E1D-42AB-2DE5-41FD-4C6E4BF1FE0B}"/>
                </a:ext>
              </a:extLst>
            </p:cNvPr>
            <p:cNvSpPr/>
            <p:nvPr/>
          </p:nvSpPr>
          <p:spPr>
            <a:xfrm>
              <a:off x="1825509" y="2149967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6" name="フリーフォーム 25">
              <a:extLst>
                <a:ext uri="{FF2B5EF4-FFF2-40B4-BE49-F238E27FC236}">
                  <a16:creationId xmlns:a16="http://schemas.microsoft.com/office/drawing/2014/main" xmlns="" id="{A21BBD4F-07E4-AE5D-5FB6-4EC555656DEA}"/>
                </a:ext>
              </a:extLst>
            </p:cNvPr>
            <p:cNvSpPr/>
            <p:nvPr/>
          </p:nvSpPr>
          <p:spPr>
            <a:xfrm>
              <a:off x="1825509" y="2149967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7" name="フリーフォーム 26">
              <a:extLst>
                <a:ext uri="{FF2B5EF4-FFF2-40B4-BE49-F238E27FC236}">
                  <a16:creationId xmlns:a16="http://schemas.microsoft.com/office/drawing/2014/main" xmlns="" id="{BA291196-589E-A4FD-C67D-4F20FE2C3703}"/>
                </a:ext>
              </a:extLst>
            </p:cNvPr>
            <p:cNvSpPr/>
            <p:nvPr/>
          </p:nvSpPr>
          <p:spPr>
            <a:xfrm>
              <a:off x="1859383" y="2186957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8" name="フリーフォーム 27">
              <a:extLst>
                <a:ext uri="{FF2B5EF4-FFF2-40B4-BE49-F238E27FC236}">
                  <a16:creationId xmlns:a16="http://schemas.microsoft.com/office/drawing/2014/main" xmlns="" id="{B00C9E7C-BAEA-A3B5-E096-7269A5EC2B58}"/>
                </a:ext>
              </a:extLst>
            </p:cNvPr>
            <p:cNvSpPr/>
            <p:nvPr/>
          </p:nvSpPr>
          <p:spPr>
            <a:xfrm>
              <a:off x="1859383" y="2186957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9" name="フリーフォーム 28">
              <a:extLst>
                <a:ext uri="{FF2B5EF4-FFF2-40B4-BE49-F238E27FC236}">
                  <a16:creationId xmlns:a16="http://schemas.microsoft.com/office/drawing/2014/main" xmlns="" id="{6BC43F58-B3D4-9B11-8362-4FDB4E4D2F54}"/>
                </a:ext>
              </a:extLst>
            </p:cNvPr>
            <p:cNvSpPr/>
            <p:nvPr/>
          </p:nvSpPr>
          <p:spPr>
            <a:xfrm>
              <a:off x="1886464" y="2262257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0" name="フリーフォーム 29">
              <a:extLst>
                <a:ext uri="{FF2B5EF4-FFF2-40B4-BE49-F238E27FC236}">
                  <a16:creationId xmlns:a16="http://schemas.microsoft.com/office/drawing/2014/main" xmlns="" id="{B907AF57-FF14-9DA7-EEC6-FD27BAA66001}"/>
                </a:ext>
              </a:extLst>
            </p:cNvPr>
            <p:cNvSpPr/>
            <p:nvPr/>
          </p:nvSpPr>
          <p:spPr>
            <a:xfrm>
              <a:off x="1886464" y="2262257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1" name="フリーフォーム 30">
              <a:extLst>
                <a:ext uri="{FF2B5EF4-FFF2-40B4-BE49-F238E27FC236}">
                  <a16:creationId xmlns:a16="http://schemas.microsoft.com/office/drawing/2014/main" xmlns="" id="{484032CC-E3DC-F89E-479C-7E00AB96A95E}"/>
                </a:ext>
              </a:extLst>
            </p:cNvPr>
            <p:cNvSpPr/>
            <p:nvPr/>
          </p:nvSpPr>
          <p:spPr>
            <a:xfrm>
              <a:off x="1886464" y="2262257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2" name="フリーフォーム 31">
              <a:extLst>
                <a:ext uri="{FF2B5EF4-FFF2-40B4-BE49-F238E27FC236}">
                  <a16:creationId xmlns:a16="http://schemas.microsoft.com/office/drawing/2014/main" xmlns="" id="{46ED3764-F84D-A66A-C040-9E262FD8E03D}"/>
                </a:ext>
              </a:extLst>
            </p:cNvPr>
            <p:cNvSpPr/>
            <p:nvPr/>
          </p:nvSpPr>
          <p:spPr>
            <a:xfrm>
              <a:off x="1886464" y="2262257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3" name="フリーフォーム 32">
              <a:extLst>
                <a:ext uri="{FF2B5EF4-FFF2-40B4-BE49-F238E27FC236}">
                  <a16:creationId xmlns:a16="http://schemas.microsoft.com/office/drawing/2014/main" xmlns="" id="{BBCA6B52-A3CD-8A5B-E050-06D2462FF154}"/>
                </a:ext>
              </a:extLst>
            </p:cNvPr>
            <p:cNvSpPr/>
            <p:nvPr/>
          </p:nvSpPr>
          <p:spPr>
            <a:xfrm>
              <a:off x="1900004" y="2400499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4" name="フリーフォーム 33">
              <a:extLst>
                <a:ext uri="{FF2B5EF4-FFF2-40B4-BE49-F238E27FC236}">
                  <a16:creationId xmlns:a16="http://schemas.microsoft.com/office/drawing/2014/main" xmlns="" id="{C6F807D5-76B0-DEB8-AEA8-776AEA6ED54A}"/>
                </a:ext>
              </a:extLst>
            </p:cNvPr>
            <p:cNvSpPr/>
            <p:nvPr/>
          </p:nvSpPr>
          <p:spPr>
            <a:xfrm>
              <a:off x="1900004" y="2400499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5" name="フリーフォーム 34">
              <a:extLst>
                <a:ext uri="{FF2B5EF4-FFF2-40B4-BE49-F238E27FC236}">
                  <a16:creationId xmlns:a16="http://schemas.microsoft.com/office/drawing/2014/main" xmlns="" id="{9DBCAAB9-CB8D-4CCD-62EE-27CA494EAFEA}"/>
                </a:ext>
              </a:extLst>
            </p:cNvPr>
            <p:cNvSpPr/>
            <p:nvPr/>
          </p:nvSpPr>
          <p:spPr>
            <a:xfrm>
              <a:off x="1920338" y="2378983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6" name="フリーフォーム 35">
              <a:extLst>
                <a:ext uri="{FF2B5EF4-FFF2-40B4-BE49-F238E27FC236}">
                  <a16:creationId xmlns:a16="http://schemas.microsoft.com/office/drawing/2014/main" xmlns="" id="{941D7ADC-C45F-D10B-C6CA-10E0B9A7D515}"/>
                </a:ext>
              </a:extLst>
            </p:cNvPr>
            <p:cNvSpPr/>
            <p:nvPr/>
          </p:nvSpPr>
          <p:spPr>
            <a:xfrm>
              <a:off x="1920338" y="2378983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7" name="フリーフォーム 36">
              <a:extLst>
                <a:ext uri="{FF2B5EF4-FFF2-40B4-BE49-F238E27FC236}">
                  <a16:creationId xmlns:a16="http://schemas.microsoft.com/office/drawing/2014/main" xmlns="" id="{E1B4F07D-C087-2E62-7C74-E7563C58912C}"/>
                </a:ext>
              </a:extLst>
            </p:cNvPr>
            <p:cNvSpPr/>
            <p:nvPr/>
          </p:nvSpPr>
          <p:spPr>
            <a:xfrm>
              <a:off x="1920338" y="2378983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8" name="フリーフォーム 37">
              <a:extLst>
                <a:ext uri="{FF2B5EF4-FFF2-40B4-BE49-F238E27FC236}">
                  <a16:creationId xmlns:a16="http://schemas.microsoft.com/office/drawing/2014/main" xmlns="" id="{E9EA545F-C161-7FB8-007A-E7F0C94CD5B8}"/>
                </a:ext>
              </a:extLst>
            </p:cNvPr>
            <p:cNvSpPr/>
            <p:nvPr/>
          </p:nvSpPr>
          <p:spPr>
            <a:xfrm>
              <a:off x="1920338" y="2378983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9" name="フリーフォーム 38">
              <a:extLst>
                <a:ext uri="{FF2B5EF4-FFF2-40B4-BE49-F238E27FC236}">
                  <a16:creationId xmlns:a16="http://schemas.microsoft.com/office/drawing/2014/main" xmlns="" id="{EC59A5DB-46E0-C024-7480-9F28862705B8}"/>
                </a:ext>
              </a:extLst>
            </p:cNvPr>
            <p:cNvSpPr/>
            <p:nvPr/>
          </p:nvSpPr>
          <p:spPr>
            <a:xfrm>
              <a:off x="1933878" y="2461356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0" name="フリーフォーム 39">
              <a:extLst>
                <a:ext uri="{FF2B5EF4-FFF2-40B4-BE49-F238E27FC236}">
                  <a16:creationId xmlns:a16="http://schemas.microsoft.com/office/drawing/2014/main" xmlns="" id="{E46DFDD5-ABA5-A880-D9C8-B4310FED9326}"/>
                </a:ext>
              </a:extLst>
            </p:cNvPr>
            <p:cNvSpPr/>
            <p:nvPr/>
          </p:nvSpPr>
          <p:spPr>
            <a:xfrm>
              <a:off x="1933878" y="2461356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1" name="フリーフォーム 40">
              <a:extLst>
                <a:ext uri="{FF2B5EF4-FFF2-40B4-BE49-F238E27FC236}">
                  <a16:creationId xmlns:a16="http://schemas.microsoft.com/office/drawing/2014/main" xmlns="" id="{4C96FDC7-C21B-9FCB-0B02-4928EC64D7DE}"/>
                </a:ext>
              </a:extLst>
            </p:cNvPr>
            <p:cNvSpPr/>
            <p:nvPr/>
          </p:nvSpPr>
          <p:spPr>
            <a:xfrm>
              <a:off x="1940672" y="2461356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2" name="フリーフォーム 41">
              <a:extLst>
                <a:ext uri="{FF2B5EF4-FFF2-40B4-BE49-F238E27FC236}">
                  <a16:creationId xmlns:a16="http://schemas.microsoft.com/office/drawing/2014/main" xmlns="" id="{CD071146-4EFA-45E1-F499-177947E40A5A}"/>
                </a:ext>
              </a:extLst>
            </p:cNvPr>
            <p:cNvSpPr/>
            <p:nvPr/>
          </p:nvSpPr>
          <p:spPr>
            <a:xfrm>
              <a:off x="1940672" y="2461356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3" name="フリーフォーム 42">
              <a:extLst>
                <a:ext uri="{FF2B5EF4-FFF2-40B4-BE49-F238E27FC236}">
                  <a16:creationId xmlns:a16="http://schemas.microsoft.com/office/drawing/2014/main" xmlns="" id="{7917BD9E-3EAE-88B3-7349-FD2F0B8AB569}"/>
                </a:ext>
              </a:extLst>
            </p:cNvPr>
            <p:cNvSpPr/>
            <p:nvPr/>
          </p:nvSpPr>
          <p:spPr>
            <a:xfrm>
              <a:off x="1961006" y="2504222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4" name="フリーフォーム 43">
              <a:extLst>
                <a:ext uri="{FF2B5EF4-FFF2-40B4-BE49-F238E27FC236}">
                  <a16:creationId xmlns:a16="http://schemas.microsoft.com/office/drawing/2014/main" xmlns="" id="{60F9FDD9-EE0A-F5A8-0A3F-EF2FF2B053DC}"/>
                </a:ext>
              </a:extLst>
            </p:cNvPr>
            <p:cNvSpPr/>
            <p:nvPr/>
          </p:nvSpPr>
          <p:spPr>
            <a:xfrm>
              <a:off x="1961006" y="2504222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5" name="フリーフォーム 44">
              <a:extLst>
                <a:ext uri="{FF2B5EF4-FFF2-40B4-BE49-F238E27FC236}">
                  <a16:creationId xmlns:a16="http://schemas.microsoft.com/office/drawing/2014/main" xmlns="" id="{8DDD3F35-1215-51A4-FA3E-85B2CF8A1CF6}"/>
                </a:ext>
              </a:extLst>
            </p:cNvPr>
            <p:cNvSpPr/>
            <p:nvPr/>
          </p:nvSpPr>
          <p:spPr>
            <a:xfrm>
              <a:off x="1974546" y="259187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6" name="フリーフォーム 45">
              <a:extLst>
                <a:ext uri="{FF2B5EF4-FFF2-40B4-BE49-F238E27FC236}">
                  <a16:creationId xmlns:a16="http://schemas.microsoft.com/office/drawing/2014/main" xmlns="" id="{0EEDAA4C-11EB-21D3-A11D-906AF9559607}"/>
                </a:ext>
              </a:extLst>
            </p:cNvPr>
            <p:cNvSpPr/>
            <p:nvPr/>
          </p:nvSpPr>
          <p:spPr>
            <a:xfrm>
              <a:off x="1974546" y="259187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7" name="フリーフォーム 46">
              <a:extLst>
                <a:ext uri="{FF2B5EF4-FFF2-40B4-BE49-F238E27FC236}">
                  <a16:creationId xmlns:a16="http://schemas.microsoft.com/office/drawing/2014/main" xmlns="" id="{76B12743-FC78-596E-A99D-6648B896A8E9}"/>
                </a:ext>
              </a:extLst>
            </p:cNvPr>
            <p:cNvSpPr/>
            <p:nvPr/>
          </p:nvSpPr>
          <p:spPr>
            <a:xfrm>
              <a:off x="1974546" y="259187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8" name="フリーフォーム 47">
              <a:extLst>
                <a:ext uri="{FF2B5EF4-FFF2-40B4-BE49-F238E27FC236}">
                  <a16:creationId xmlns:a16="http://schemas.microsoft.com/office/drawing/2014/main" xmlns="" id="{CEC4580C-7A2B-3F17-1857-1AB1A9679DEA}"/>
                </a:ext>
              </a:extLst>
            </p:cNvPr>
            <p:cNvSpPr/>
            <p:nvPr/>
          </p:nvSpPr>
          <p:spPr>
            <a:xfrm>
              <a:off x="1974546" y="259187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49" name="フリーフォーム 48">
              <a:extLst>
                <a:ext uri="{FF2B5EF4-FFF2-40B4-BE49-F238E27FC236}">
                  <a16:creationId xmlns:a16="http://schemas.microsoft.com/office/drawing/2014/main" xmlns="" id="{EF40C0B3-1DD2-2785-FD73-A8AD78AE9457}"/>
                </a:ext>
              </a:extLst>
            </p:cNvPr>
            <p:cNvSpPr/>
            <p:nvPr/>
          </p:nvSpPr>
          <p:spPr>
            <a:xfrm>
              <a:off x="1974546" y="259187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0" name="フリーフォーム 49">
              <a:extLst>
                <a:ext uri="{FF2B5EF4-FFF2-40B4-BE49-F238E27FC236}">
                  <a16:creationId xmlns:a16="http://schemas.microsoft.com/office/drawing/2014/main" xmlns="" id="{6E33A7A1-32EC-CE28-408B-556ED33DD7CE}"/>
                </a:ext>
              </a:extLst>
            </p:cNvPr>
            <p:cNvSpPr/>
            <p:nvPr/>
          </p:nvSpPr>
          <p:spPr>
            <a:xfrm>
              <a:off x="1974546" y="259187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1" name="フリーフォーム 50">
              <a:extLst>
                <a:ext uri="{FF2B5EF4-FFF2-40B4-BE49-F238E27FC236}">
                  <a16:creationId xmlns:a16="http://schemas.microsoft.com/office/drawing/2014/main" xmlns="" id="{14CB13C7-3B8D-28C5-FBDA-AF84C8086732}"/>
                </a:ext>
              </a:extLst>
            </p:cNvPr>
            <p:cNvSpPr/>
            <p:nvPr/>
          </p:nvSpPr>
          <p:spPr>
            <a:xfrm>
              <a:off x="1988086" y="259187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2" name="フリーフォーム 51">
              <a:extLst>
                <a:ext uri="{FF2B5EF4-FFF2-40B4-BE49-F238E27FC236}">
                  <a16:creationId xmlns:a16="http://schemas.microsoft.com/office/drawing/2014/main" xmlns="" id="{8FEA9262-49D4-FA5B-FD80-95AD650DE8B5}"/>
                </a:ext>
              </a:extLst>
            </p:cNvPr>
            <p:cNvSpPr/>
            <p:nvPr/>
          </p:nvSpPr>
          <p:spPr>
            <a:xfrm>
              <a:off x="1988086" y="259187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3" name="フリーフォーム 52">
              <a:extLst>
                <a:ext uri="{FF2B5EF4-FFF2-40B4-BE49-F238E27FC236}">
                  <a16:creationId xmlns:a16="http://schemas.microsoft.com/office/drawing/2014/main" xmlns="" id="{F9A91101-C369-33D8-B12C-B70CE7DBB36F}"/>
                </a:ext>
              </a:extLst>
            </p:cNvPr>
            <p:cNvSpPr/>
            <p:nvPr/>
          </p:nvSpPr>
          <p:spPr>
            <a:xfrm>
              <a:off x="2021961" y="2640072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4" name="フリーフォーム 53">
              <a:extLst>
                <a:ext uri="{FF2B5EF4-FFF2-40B4-BE49-F238E27FC236}">
                  <a16:creationId xmlns:a16="http://schemas.microsoft.com/office/drawing/2014/main" xmlns="" id="{4438CC32-2A16-A283-EDE2-1551E48C6136}"/>
                </a:ext>
              </a:extLst>
            </p:cNvPr>
            <p:cNvSpPr/>
            <p:nvPr/>
          </p:nvSpPr>
          <p:spPr>
            <a:xfrm>
              <a:off x="2021961" y="2640072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5" name="フリーフォーム 54">
              <a:extLst>
                <a:ext uri="{FF2B5EF4-FFF2-40B4-BE49-F238E27FC236}">
                  <a16:creationId xmlns:a16="http://schemas.microsoft.com/office/drawing/2014/main" xmlns="" id="{1E7412EB-F7DB-4868-91A2-038D21D4778D}"/>
                </a:ext>
              </a:extLst>
            </p:cNvPr>
            <p:cNvSpPr/>
            <p:nvPr/>
          </p:nvSpPr>
          <p:spPr>
            <a:xfrm>
              <a:off x="2069375" y="2738992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6" name="フリーフォーム 55">
              <a:extLst>
                <a:ext uri="{FF2B5EF4-FFF2-40B4-BE49-F238E27FC236}">
                  <a16:creationId xmlns:a16="http://schemas.microsoft.com/office/drawing/2014/main" xmlns="" id="{99AD685D-0C8C-9AD8-1639-9E66EA1CB8E2}"/>
                </a:ext>
              </a:extLst>
            </p:cNvPr>
            <p:cNvSpPr/>
            <p:nvPr/>
          </p:nvSpPr>
          <p:spPr>
            <a:xfrm>
              <a:off x="2069375" y="2738992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7" name="フリーフォーム 56">
              <a:extLst>
                <a:ext uri="{FF2B5EF4-FFF2-40B4-BE49-F238E27FC236}">
                  <a16:creationId xmlns:a16="http://schemas.microsoft.com/office/drawing/2014/main" xmlns="" id="{E77145C8-9B95-BCE7-552D-E31988722B1B}"/>
                </a:ext>
              </a:extLst>
            </p:cNvPr>
            <p:cNvSpPr/>
            <p:nvPr/>
          </p:nvSpPr>
          <p:spPr>
            <a:xfrm>
              <a:off x="2137124" y="2998447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8" name="フリーフォーム 57">
              <a:extLst>
                <a:ext uri="{FF2B5EF4-FFF2-40B4-BE49-F238E27FC236}">
                  <a16:creationId xmlns:a16="http://schemas.microsoft.com/office/drawing/2014/main" xmlns="" id="{441C5D47-3439-AAD8-C1AD-ECD6C8C047E4}"/>
                </a:ext>
              </a:extLst>
            </p:cNvPr>
            <p:cNvSpPr/>
            <p:nvPr/>
          </p:nvSpPr>
          <p:spPr>
            <a:xfrm>
              <a:off x="2137124" y="2998447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59" name="フリーフォーム 58">
              <a:extLst>
                <a:ext uri="{FF2B5EF4-FFF2-40B4-BE49-F238E27FC236}">
                  <a16:creationId xmlns:a16="http://schemas.microsoft.com/office/drawing/2014/main" xmlns="" id="{63F60F27-F9A0-3A40-5527-CEB61B05DABB}"/>
                </a:ext>
              </a:extLst>
            </p:cNvPr>
            <p:cNvSpPr/>
            <p:nvPr/>
          </p:nvSpPr>
          <p:spPr>
            <a:xfrm>
              <a:off x="2137124" y="2998447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60" name="フリーフォーム 59">
              <a:extLst>
                <a:ext uri="{FF2B5EF4-FFF2-40B4-BE49-F238E27FC236}">
                  <a16:creationId xmlns:a16="http://schemas.microsoft.com/office/drawing/2014/main" xmlns="" id="{8FE63EEA-BF5C-5E4B-54FB-9E55B5318B47}"/>
                </a:ext>
              </a:extLst>
            </p:cNvPr>
            <p:cNvSpPr/>
            <p:nvPr/>
          </p:nvSpPr>
          <p:spPr>
            <a:xfrm>
              <a:off x="2137124" y="2998447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61" name="フリーフォーム 60">
              <a:extLst>
                <a:ext uri="{FF2B5EF4-FFF2-40B4-BE49-F238E27FC236}">
                  <a16:creationId xmlns:a16="http://schemas.microsoft.com/office/drawing/2014/main" xmlns="" id="{171319D2-0D69-1281-C221-C8EC1EF7E34B}"/>
                </a:ext>
              </a:extLst>
            </p:cNvPr>
            <p:cNvSpPr/>
            <p:nvPr/>
          </p:nvSpPr>
          <p:spPr>
            <a:xfrm>
              <a:off x="2170998" y="3052943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62" name="フリーフォーム 61">
              <a:extLst>
                <a:ext uri="{FF2B5EF4-FFF2-40B4-BE49-F238E27FC236}">
                  <a16:creationId xmlns:a16="http://schemas.microsoft.com/office/drawing/2014/main" xmlns="" id="{D4806325-EADC-8D1F-EAFA-CDC53FE42D16}"/>
                </a:ext>
              </a:extLst>
            </p:cNvPr>
            <p:cNvSpPr/>
            <p:nvPr/>
          </p:nvSpPr>
          <p:spPr>
            <a:xfrm>
              <a:off x="2170998" y="3052943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63" name="フリーフォーム 62">
              <a:extLst>
                <a:ext uri="{FF2B5EF4-FFF2-40B4-BE49-F238E27FC236}">
                  <a16:creationId xmlns:a16="http://schemas.microsoft.com/office/drawing/2014/main" xmlns="" id="{D2795CFE-42E2-0070-6ABE-65A98F6697C5}"/>
                </a:ext>
              </a:extLst>
            </p:cNvPr>
            <p:cNvSpPr/>
            <p:nvPr/>
          </p:nvSpPr>
          <p:spPr>
            <a:xfrm>
              <a:off x="2177792" y="3052943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52" name="フリーフォーム 951">
              <a:extLst>
                <a:ext uri="{FF2B5EF4-FFF2-40B4-BE49-F238E27FC236}">
                  <a16:creationId xmlns:a16="http://schemas.microsoft.com/office/drawing/2014/main" xmlns="" id="{DBDC43A6-502E-2B01-CCF5-E2F9C216DF40}"/>
                </a:ext>
              </a:extLst>
            </p:cNvPr>
            <p:cNvSpPr/>
            <p:nvPr/>
          </p:nvSpPr>
          <p:spPr>
            <a:xfrm>
              <a:off x="2177792" y="3052943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53" name="フリーフォーム 952">
              <a:extLst>
                <a:ext uri="{FF2B5EF4-FFF2-40B4-BE49-F238E27FC236}">
                  <a16:creationId xmlns:a16="http://schemas.microsoft.com/office/drawing/2014/main" xmlns="" id="{E43D1ECF-70A1-B1FB-2D64-4CEACC8F5679}"/>
                </a:ext>
              </a:extLst>
            </p:cNvPr>
            <p:cNvSpPr/>
            <p:nvPr/>
          </p:nvSpPr>
          <p:spPr>
            <a:xfrm>
              <a:off x="2204872" y="3170688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54" name="フリーフォーム 953">
              <a:extLst>
                <a:ext uri="{FF2B5EF4-FFF2-40B4-BE49-F238E27FC236}">
                  <a16:creationId xmlns:a16="http://schemas.microsoft.com/office/drawing/2014/main" xmlns="" id="{12E8BFBD-7AA9-ED09-A502-96ED6894E6C0}"/>
                </a:ext>
              </a:extLst>
            </p:cNvPr>
            <p:cNvSpPr/>
            <p:nvPr/>
          </p:nvSpPr>
          <p:spPr>
            <a:xfrm>
              <a:off x="2204872" y="3170688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55" name="フリーフォーム 954">
              <a:extLst>
                <a:ext uri="{FF2B5EF4-FFF2-40B4-BE49-F238E27FC236}">
                  <a16:creationId xmlns:a16="http://schemas.microsoft.com/office/drawing/2014/main" xmlns="" id="{4A4E8647-A6F2-D16D-ADB0-DF95BFCE9BE0}"/>
                </a:ext>
              </a:extLst>
            </p:cNvPr>
            <p:cNvSpPr/>
            <p:nvPr/>
          </p:nvSpPr>
          <p:spPr>
            <a:xfrm>
              <a:off x="2204872" y="3170688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56" name="フリーフォーム 955">
              <a:extLst>
                <a:ext uri="{FF2B5EF4-FFF2-40B4-BE49-F238E27FC236}">
                  <a16:creationId xmlns:a16="http://schemas.microsoft.com/office/drawing/2014/main" xmlns="" id="{E862AFE5-8574-DF1B-A8E5-6336F302E989}"/>
                </a:ext>
              </a:extLst>
            </p:cNvPr>
            <p:cNvSpPr/>
            <p:nvPr/>
          </p:nvSpPr>
          <p:spPr>
            <a:xfrm>
              <a:off x="2204872" y="3170688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57" name="フリーフォーム 956">
              <a:extLst>
                <a:ext uri="{FF2B5EF4-FFF2-40B4-BE49-F238E27FC236}">
                  <a16:creationId xmlns:a16="http://schemas.microsoft.com/office/drawing/2014/main" xmlns="" id="{EF9D5A05-DA98-B97B-BA36-67EB0D0B5BAF}"/>
                </a:ext>
              </a:extLst>
            </p:cNvPr>
            <p:cNvSpPr/>
            <p:nvPr/>
          </p:nvSpPr>
          <p:spPr>
            <a:xfrm>
              <a:off x="2259081" y="3235196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58" name="フリーフォーム 957">
              <a:extLst>
                <a:ext uri="{FF2B5EF4-FFF2-40B4-BE49-F238E27FC236}">
                  <a16:creationId xmlns:a16="http://schemas.microsoft.com/office/drawing/2014/main" xmlns="" id="{FAE5D49B-D062-5947-892E-86073F0AB538}"/>
                </a:ext>
              </a:extLst>
            </p:cNvPr>
            <p:cNvSpPr/>
            <p:nvPr/>
          </p:nvSpPr>
          <p:spPr>
            <a:xfrm>
              <a:off x="2259081" y="3235196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59" name="フリーフォーム 958">
              <a:extLst>
                <a:ext uri="{FF2B5EF4-FFF2-40B4-BE49-F238E27FC236}">
                  <a16:creationId xmlns:a16="http://schemas.microsoft.com/office/drawing/2014/main" xmlns="" id="{80A5841D-746B-BFE2-2654-863C1198AF5B}"/>
                </a:ext>
              </a:extLst>
            </p:cNvPr>
            <p:cNvSpPr/>
            <p:nvPr/>
          </p:nvSpPr>
          <p:spPr>
            <a:xfrm>
              <a:off x="2299702" y="3235196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24" name="フリーフォーム 1023">
              <a:extLst>
                <a:ext uri="{FF2B5EF4-FFF2-40B4-BE49-F238E27FC236}">
                  <a16:creationId xmlns:a16="http://schemas.microsoft.com/office/drawing/2014/main" xmlns="" id="{58373E3C-E6CC-3BB8-8419-1C7EF748C014}"/>
                </a:ext>
              </a:extLst>
            </p:cNvPr>
            <p:cNvSpPr/>
            <p:nvPr/>
          </p:nvSpPr>
          <p:spPr>
            <a:xfrm>
              <a:off x="2299702" y="3235196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25" name="フリーフォーム 1024">
              <a:extLst>
                <a:ext uri="{FF2B5EF4-FFF2-40B4-BE49-F238E27FC236}">
                  <a16:creationId xmlns:a16="http://schemas.microsoft.com/office/drawing/2014/main" xmlns="" id="{49F4823D-3211-1993-DD29-4AF55A6A9C9B}"/>
                </a:ext>
              </a:extLst>
            </p:cNvPr>
            <p:cNvSpPr/>
            <p:nvPr/>
          </p:nvSpPr>
          <p:spPr>
            <a:xfrm>
              <a:off x="2326829" y="3306839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26" name="フリーフォーム 1025">
              <a:extLst>
                <a:ext uri="{FF2B5EF4-FFF2-40B4-BE49-F238E27FC236}">
                  <a16:creationId xmlns:a16="http://schemas.microsoft.com/office/drawing/2014/main" xmlns="" id="{1AC5AC51-2F3C-20B0-809C-0C53BBAC8989}"/>
                </a:ext>
              </a:extLst>
            </p:cNvPr>
            <p:cNvSpPr/>
            <p:nvPr/>
          </p:nvSpPr>
          <p:spPr>
            <a:xfrm>
              <a:off x="2326829" y="3306839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27" name="フリーフォーム 1026">
              <a:extLst>
                <a:ext uri="{FF2B5EF4-FFF2-40B4-BE49-F238E27FC236}">
                  <a16:creationId xmlns:a16="http://schemas.microsoft.com/office/drawing/2014/main" xmlns="" id="{52AB4710-5734-AF37-51B1-1444AEBCAECD}"/>
                </a:ext>
              </a:extLst>
            </p:cNvPr>
            <p:cNvSpPr/>
            <p:nvPr/>
          </p:nvSpPr>
          <p:spPr>
            <a:xfrm>
              <a:off x="2401324" y="3459116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28" name="フリーフォーム 1027">
              <a:extLst>
                <a:ext uri="{FF2B5EF4-FFF2-40B4-BE49-F238E27FC236}">
                  <a16:creationId xmlns:a16="http://schemas.microsoft.com/office/drawing/2014/main" xmlns="" id="{211908AF-4214-97EB-B9A4-03F564734F0E}"/>
                </a:ext>
              </a:extLst>
            </p:cNvPr>
            <p:cNvSpPr/>
            <p:nvPr/>
          </p:nvSpPr>
          <p:spPr>
            <a:xfrm>
              <a:off x="2401324" y="3459116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06 h 33872"/>
                <a:gd name="connsiteX2" fmla="*/ 13352 w 26703"/>
                <a:gd name="connsiteY2" fmla="*/ 33873 h 33872"/>
                <a:gd name="connsiteX3" fmla="*/ 0 w 26703"/>
                <a:gd name="connsiteY3" fmla="*/ 1690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06"/>
                  </a:lnTo>
                  <a:lnTo>
                    <a:pt x="13352" y="33873"/>
                  </a:lnTo>
                  <a:lnTo>
                    <a:pt x="0" y="1690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29" name="フリーフォーム 1028">
              <a:extLst>
                <a:ext uri="{FF2B5EF4-FFF2-40B4-BE49-F238E27FC236}">
                  <a16:creationId xmlns:a16="http://schemas.microsoft.com/office/drawing/2014/main" xmlns="" id="{FE0024F8-C75E-3E4D-F8CB-3E04D1144F44}"/>
                </a:ext>
              </a:extLst>
            </p:cNvPr>
            <p:cNvSpPr/>
            <p:nvPr/>
          </p:nvSpPr>
          <p:spPr>
            <a:xfrm>
              <a:off x="2441992" y="3541070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0" name="フリーフォーム 1029">
              <a:extLst>
                <a:ext uri="{FF2B5EF4-FFF2-40B4-BE49-F238E27FC236}">
                  <a16:creationId xmlns:a16="http://schemas.microsoft.com/office/drawing/2014/main" xmlns="" id="{A5774D8A-130B-6C27-3395-73E360AF3167}"/>
                </a:ext>
              </a:extLst>
            </p:cNvPr>
            <p:cNvSpPr/>
            <p:nvPr/>
          </p:nvSpPr>
          <p:spPr>
            <a:xfrm>
              <a:off x="2441992" y="3541070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1" name="フリーフォーム 1030">
              <a:extLst>
                <a:ext uri="{FF2B5EF4-FFF2-40B4-BE49-F238E27FC236}">
                  <a16:creationId xmlns:a16="http://schemas.microsoft.com/office/drawing/2014/main" xmlns="" id="{2973A435-A7C9-159A-8F0C-19D6AC231037}"/>
                </a:ext>
              </a:extLst>
            </p:cNvPr>
            <p:cNvSpPr/>
            <p:nvPr/>
          </p:nvSpPr>
          <p:spPr>
            <a:xfrm>
              <a:off x="2496154" y="3541070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2" name="フリーフォーム 1031">
              <a:extLst>
                <a:ext uri="{FF2B5EF4-FFF2-40B4-BE49-F238E27FC236}">
                  <a16:creationId xmlns:a16="http://schemas.microsoft.com/office/drawing/2014/main" xmlns="" id="{477F633A-1D37-2134-E381-E88167448C81}"/>
                </a:ext>
              </a:extLst>
            </p:cNvPr>
            <p:cNvSpPr/>
            <p:nvPr/>
          </p:nvSpPr>
          <p:spPr>
            <a:xfrm>
              <a:off x="2496154" y="3541070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3" name="フリーフォーム 1032">
              <a:extLst>
                <a:ext uri="{FF2B5EF4-FFF2-40B4-BE49-F238E27FC236}">
                  <a16:creationId xmlns:a16="http://schemas.microsoft.com/office/drawing/2014/main" xmlns="" id="{BB4D4DC5-B15F-490D-254C-FEB1795A4838}"/>
                </a:ext>
              </a:extLst>
            </p:cNvPr>
            <p:cNvSpPr/>
            <p:nvPr/>
          </p:nvSpPr>
          <p:spPr>
            <a:xfrm>
              <a:off x="2699399" y="373783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4" name="フリーフォーム 1033">
              <a:extLst>
                <a:ext uri="{FF2B5EF4-FFF2-40B4-BE49-F238E27FC236}">
                  <a16:creationId xmlns:a16="http://schemas.microsoft.com/office/drawing/2014/main" xmlns="" id="{B24807F0-E5F7-7136-8726-095B4CF1BCC9}"/>
                </a:ext>
              </a:extLst>
            </p:cNvPr>
            <p:cNvSpPr/>
            <p:nvPr/>
          </p:nvSpPr>
          <p:spPr>
            <a:xfrm>
              <a:off x="2699399" y="373783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5" name="フリーフォーム 1034">
              <a:extLst>
                <a:ext uri="{FF2B5EF4-FFF2-40B4-BE49-F238E27FC236}">
                  <a16:creationId xmlns:a16="http://schemas.microsoft.com/office/drawing/2014/main" xmlns="" id="{0704A651-B515-15A3-973D-0EF46BBA742D}"/>
                </a:ext>
              </a:extLst>
            </p:cNvPr>
            <p:cNvSpPr/>
            <p:nvPr/>
          </p:nvSpPr>
          <p:spPr>
            <a:xfrm>
              <a:off x="2712940" y="373783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6" name="フリーフォーム 1035">
              <a:extLst>
                <a:ext uri="{FF2B5EF4-FFF2-40B4-BE49-F238E27FC236}">
                  <a16:creationId xmlns:a16="http://schemas.microsoft.com/office/drawing/2014/main" xmlns="" id="{1AC9BF87-4879-C143-2C79-DB647A70335A}"/>
                </a:ext>
              </a:extLst>
            </p:cNvPr>
            <p:cNvSpPr/>
            <p:nvPr/>
          </p:nvSpPr>
          <p:spPr>
            <a:xfrm>
              <a:off x="2712940" y="373783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7" name="フリーフォーム 1036">
              <a:extLst>
                <a:ext uri="{FF2B5EF4-FFF2-40B4-BE49-F238E27FC236}">
                  <a16:creationId xmlns:a16="http://schemas.microsoft.com/office/drawing/2014/main" xmlns="" id="{C2BD2F73-D4D5-FCE3-6683-89CD29BE92F8}"/>
                </a:ext>
              </a:extLst>
            </p:cNvPr>
            <p:cNvSpPr/>
            <p:nvPr/>
          </p:nvSpPr>
          <p:spPr>
            <a:xfrm>
              <a:off x="2895851" y="373783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8" name="フリーフォーム 1037">
              <a:extLst>
                <a:ext uri="{FF2B5EF4-FFF2-40B4-BE49-F238E27FC236}">
                  <a16:creationId xmlns:a16="http://schemas.microsoft.com/office/drawing/2014/main" xmlns="" id="{EEF7BB39-B403-EFCD-5522-AB434D928A5C}"/>
                </a:ext>
              </a:extLst>
            </p:cNvPr>
            <p:cNvSpPr/>
            <p:nvPr/>
          </p:nvSpPr>
          <p:spPr>
            <a:xfrm>
              <a:off x="2895851" y="3737831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9" name="フリーフォーム 1038">
              <a:extLst>
                <a:ext uri="{FF2B5EF4-FFF2-40B4-BE49-F238E27FC236}">
                  <a16:creationId xmlns:a16="http://schemas.microsoft.com/office/drawing/2014/main" xmlns="" id="{55FFD3BC-CBB5-CE5E-D316-A2E9875F3D9A}"/>
                </a:ext>
              </a:extLst>
            </p:cNvPr>
            <p:cNvSpPr/>
            <p:nvPr/>
          </p:nvSpPr>
          <p:spPr>
            <a:xfrm>
              <a:off x="3336217" y="3895204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0" name="フリーフォーム 1039">
              <a:extLst>
                <a:ext uri="{FF2B5EF4-FFF2-40B4-BE49-F238E27FC236}">
                  <a16:creationId xmlns:a16="http://schemas.microsoft.com/office/drawing/2014/main" xmlns="" id="{90BA0F9B-B7B8-1803-93F0-9B24A80184E3}"/>
                </a:ext>
              </a:extLst>
            </p:cNvPr>
            <p:cNvSpPr/>
            <p:nvPr/>
          </p:nvSpPr>
          <p:spPr>
            <a:xfrm>
              <a:off x="3336217" y="3895204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1" name="フリーフォーム 1040">
              <a:extLst>
                <a:ext uri="{FF2B5EF4-FFF2-40B4-BE49-F238E27FC236}">
                  <a16:creationId xmlns:a16="http://schemas.microsoft.com/office/drawing/2014/main" xmlns="" id="{28CAF8C5-B433-0A33-3352-ADB24EED3C8D}"/>
                </a:ext>
              </a:extLst>
            </p:cNvPr>
            <p:cNvSpPr/>
            <p:nvPr/>
          </p:nvSpPr>
          <p:spPr>
            <a:xfrm>
              <a:off x="3444587" y="3895204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2" name="フリーフォーム 1041">
              <a:extLst>
                <a:ext uri="{FF2B5EF4-FFF2-40B4-BE49-F238E27FC236}">
                  <a16:creationId xmlns:a16="http://schemas.microsoft.com/office/drawing/2014/main" xmlns="" id="{686EDE24-5FD4-549D-0D33-F7CFA6C915A1}"/>
                </a:ext>
              </a:extLst>
            </p:cNvPr>
            <p:cNvSpPr/>
            <p:nvPr/>
          </p:nvSpPr>
          <p:spPr>
            <a:xfrm>
              <a:off x="3444587" y="3895204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3" name="フリーフォーム 1042">
              <a:extLst>
                <a:ext uri="{FF2B5EF4-FFF2-40B4-BE49-F238E27FC236}">
                  <a16:creationId xmlns:a16="http://schemas.microsoft.com/office/drawing/2014/main" xmlns="" id="{A32BFE4A-51D3-A634-F25A-E89AA25AF310}"/>
                </a:ext>
              </a:extLst>
            </p:cNvPr>
            <p:cNvSpPr/>
            <p:nvPr/>
          </p:nvSpPr>
          <p:spPr>
            <a:xfrm>
              <a:off x="3851079" y="3895204"/>
              <a:ext cx="25200" cy="25200"/>
            </a:xfrm>
            <a:custGeom>
              <a:avLst/>
              <a:gdLst>
                <a:gd name="connsiteX0" fmla="*/ 13352 w 26656"/>
                <a:gd name="connsiteY0" fmla="*/ 0 h 33932"/>
                <a:gd name="connsiteX1" fmla="*/ 26656 w 26656"/>
                <a:gd name="connsiteY1" fmla="*/ 16966 h 33932"/>
                <a:gd name="connsiteX2" fmla="*/ 13352 w 26656"/>
                <a:gd name="connsiteY2" fmla="*/ 33933 h 33932"/>
                <a:gd name="connsiteX3" fmla="*/ 0 w 26656"/>
                <a:gd name="connsiteY3" fmla="*/ 16966 h 33932"/>
                <a:gd name="connsiteX4" fmla="*/ 13352 w 26656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6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4" name="フリーフォーム 1043">
              <a:extLst>
                <a:ext uri="{FF2B5EF4-FFF2-40B4-BE49-F238E27FC236}">
                  <a16:creationId xmlns:a16="http://schemas.microsoft.com/office/drawing/2014/main" xmlns="" id="{0A26EC9A-67C1-64D4-5F5D-D3BA1B27002D}"/>
                </a:ext>
              </a:extLst>
            </p:cNvPr>
            <p:cNvSpPr/>
            <p:nvPr/>
          </p:nvSpPr>
          <p:spPr>
            <a:xfrm>
              <a:off x="3851079" y="3895204"/>
              <a:ext cx="25200" cy="25200"/>
            </a:xfrm>
            <a:custGeom>
              <a:avLst/>
              <a:gdLst>
                <a:gd name="connsiteX0" fmla="*/ 13352 w 26656"/>
                <a:gd name="connsiteY0" fmla="*/ 0 h 33932"/>
                <a:gd name="connsiteX1" fmla="*/ 26656 w 26656"/>
                <a:gd name="connsiteY1" fmla="*/ 16966 h 33932"/>
                <a:gd name="connsiteX2" fmla="*/ 13352 w 26656"/>
                <a:gd name="connsiteY2" fmla="*/ 33933 h 33932"/>
                <a:gd name="connsiteX3" fmla="*/ 0 w 26656"/>
                <a:gd name="connsiteY3" fmla="*/ 16966 h 33932"/>
                <a:gd name="connsiteX4" fmla="*/ 13352 w 26656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6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5" name="フリーフォーム 1044">
              <a:extLst>
                <a:ext uri="{FF2B5EF4-FFF2-40B4-BE49-F238E27FC236}">
                  <a16:creationId xmlns:a16="http://schemas.microsoft.com/office/drawing/2014/main" xmlns="" id="{C3304897-B4DE-83B4-442A-2920B133F359}"/>
                </a:ext>
              </a:extLst>
            </p:cNvPr>
            <p:cNvSpPr/>
            <p:nvPr/>
          </p:nvSpPr>
          <p:spPr>
            <a:xfrm>
              <a:off x="1791634" y="2042234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6" name="フリーフォーム 1045">
              <a:extLst>
                <a:ext uri="{FF2B5EF4-FFF2-40B4-BE49-F238E27FC236}">
                  <a16:creationId xmlns:a16="http://schemas.microsoft.com/office/drawing/2014/main" xmlns="" id="{E5D31899-D4DD-26AC-2216-C4E262769939}"/>
                </a:ext>
              </a:extLst>
            </p:cNvPr>
            <p:cNvSpPr/>
            <p:nvPr/>
          </p:nvSpPr>
          <p:spPr>
            <a:xfrm>
              <a:off x="1791634" y="2042234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7" name="フリーフォーム 1046">
              <a:extLst>
                <a:ext uri="{FF2B5EF4-FFF2-40B4-BE49-F238E27FC236}">
                  <a16:creationId xmlns:a16="http://schemas.microsoft.com/office/drawing/2014/main" xmlns="" id="{7BBF4B0C-7B3B-F566-D163-F5C4D7F90006}"/>
                </a:ext>
              </a:extLst>
            </p:cNvPr>
            <p:cNvSpPr/>
            <p:nvPr/>
          </p:nvSpPr>
          <p:spPr>
            <a:xfrm>
              <a:off x="1879717" y="2394084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8" name="フリーフォーム 1047">
              <a:extLst>
                <a:ext uri="{FF2B5EF4-FFF2-40B4-BE49-F238E27FC236}">
                  <a16:creationId xmlns:a16="http://schemas.microsoft.com/office/drawing/2014/main" xmlns="" id="{6B63692B-32EE-D158-DDDA-B1A7323D6A5F}"/>
                </a:ext>
              </a:extLst>
            </p:cNvPr>
            <p:cNvSpPr/>
            <p:nvPr/>
          </p:nvSpPr>
          <p:spPr>
            <a:xfrm>
              <a:off x="1879717" y="2394084"/>
              <a:ext cx="25200" cy="25200"/>
            </a:xfrm>
            <a:custGeom>
              <a:avLst/>
              <a:gdLst>
                <a:gd name="connsiteX0" fmla="*/ 13352 w 26655"/>
                <a:gd name="connsiteY0" fmla="*/ 0 h 33932"/>
                <a:gd name="connsiteX1" fmla="*/ 26656 w 26655"/>
                <a:gd name="connsiteY1" fmla="*/ 16966 h 33932"/>
                <a:gd name="connsiteX2" fmla="*/ 13352 w 26655"/>
                <a:gd name="connsiteY2" fmla="*/ 33933 h 33932"/>
                <a:gd name="connsiteX3" fmla="*/ 0 w 26655"/>
                <a:gd name="connsiteY3" fmla="*/ 16966 h 33932"/>
                <a:gd name="connsiteX4" fmla="*/ 13352 w 26655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932">
                  <a:moveTo>
                    <a:pt x="13352" y="0"/>
                  </a:moveTo>
                  <a:lnTo>
                    <a:pt x="26656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49" name="フリーフォーム 1048">
              <a:extLst>
                <a:ext uri="{FF2B5EF4-FFF2-40B4-BE49-F238E27FC236}">
                  <a16:creationId xmlns:a16="http://schemas.microsoft.com/office/drawing/2014/main" xmlns="" id="{684B7ED1-B834-94A7-CE85-4F0CC18634B3}"/>
                </a:ext>
              </a:extLst>
            </p:cNvPr>
            <p:cNvSpPr/>
            <p:nvPr/>
          </p:nvSpPr>
          <p:spPr>
            <a:xfrm>
              <a:off x="1900004" y="2394084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0" name="フリーフォーム 1049">
              <a:extLst>
                <a:ext uri="{FF2B5EF4-FFF2-40B4-BE49-F238E27FC236}">
                  <a16:creationId xmlns:a16="http://schemas.microsoft.com/office/drawing/2014/main" xmlns="" id="{A0A73F6D-AAED-751E-FAAA-BD4341492364}"/>
                </a:ext>
              </a:extLst>
            </p:cNvPr>
            <p:cNvSpPr/>
            <p:nvPr/>
          </p:nvSpPr>
          <p:spPr>
            <a:xfrm>
              <a:off x="1900004" y="2394084"/>
              <a:ext cx="25200" cy="25200"/>
            </a:xfrm>
            <a:custGeom>
              <a:avLst/>
              <a:gdLst>
                <a:gd name="connsiteX0" fmla="*/ 13352 w 26703"/>
                <a:gd name="connsiteY0" fmla="*/ 0 h 33932"/>
                <a:gd name="connsiteX1" fmla="*/ 26703 w 26703"/>
                <a:gd name="connsiteY1" fmla="*/ 16966 h 33932"/>
                <a:gd name="connsiteX2" fmla="*/ 13352 w 26703"/>
                <a:gd name="connsiteY2" fmla="*/ 33933 h 33932"/>
                <a:gd name="connsiteX3" fmla="*/ 0 w 26703"/>
                <a:gd name="connsiteY3" fmla="*/ 16966 h 33932"/>
                <a:gd name="connsiteX4" fmla="*/ 13352 w 26703"/>
                <a:gd name="connsiteY4" fmla="*/ 0 h 33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932">
                  <a:moveTo>
                    <a:pt x="13352" y="0"/>
                  </a:moveTo>
                  <a:lnTo>
                    <a:pt x="26703" y="16966"/>
                  </a:lnTo>
                  <a:lnTo>
                    <a:pt x="13352" y="3393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1" name="フリーフォーム 1050">
              <a:extLst>
                <a:ext uri="{FF2B5EF4-FFF2-40B4-BE49-F238E27FC236}">
                  <a16:creationId xmlns:a16="http://schemas.microsoft.com/office/drawing/2014/main" xmlns="" id="{1FB1AFAE-3B02-9971-764C-87903C0CC719}"/>
                </a:ext>
              </a:extLst>
            </p:cNvPr>
            <p:cNvSpPr/>
            <p:nvPr/>
          </p:nvSpPr>
          <p:spPr>
            <a:xfrm>
              <a:off x="1981340" y="3158458"/>
              <a:ext cx="25200" cy="25200"/>
            </a:xfrm>
            <a:custGeom>
              <a:avLst/>
              <a:gdLst>
                <a:gd name="connsiteX0" fmla="*/ 13304 w 26655"/>
                <a:gd name="connsiteY0" fmla="*/ 0 h 33872"/>
                <a:gd name="connsiteX1" fmla="*/ 26656 w 26655"/>
                <a:gd name="connsiteY1" fmla="*/ 16966 h 33872"/>
                <a:gd name="connsiteX2" fmla="*/ 13304 w 26655"/>
                <a:gd name="connsiteY2" fmla="*/ 33873 h 33872"/>
                <a:gd name="connsiteX3" fmla="*/ 0 w 26655"/>
                <a:gd name="connsiteY3" fmla="*/ 16966 h 33872"/>
                <a:gd name="connsiteX4" fmla="*/ 13304 w 26655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872">
                  <a:moveTo>
                    <a:pt x="13304" y="0"/>
                  </a:moveTo>
                  <a:lnTo>
                    <a:pt x="26656" y="16966"/>
                  </a:lnTo>
                  <a:lnTo>
                    <a:pt x="13304" y="33873"/>
                  </a:lnTo>
                  <a:lnTo>
                    <a:pt x="0" y="16966"/>
                  </a:lnTo>
                  <a:lnTo>
                    <a:pt x="13304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2" name="フリーフォーム 1051">
              <a:extLst>
                <a:ext uri="{FF2B5EF4-FFF2-40B4-BE49-F238E27FC236}">
                  <a16:creationId xmlns:a16="http://schemas.microsoft.com/office/drawing/2014/main" xmlns="" id="{32DFA508-389C-750D-6195-362A99458A15}"/>
                </a:ext>
              </a:extLst>
            </p:cNvPr>
            <p:cNvSpPr/>
            <p:nvPr/>
          </p:nvSpPr>
          <p:spPr>
            <a:xfrm>
              <a:off x="1981340" y="3158458"/>
              <a:ext cx="25200" cy="25200"/>
            </a:xfrm>
            <a:custGeom>
              <a:avLst/>
              <a:gdLst>
                <a:gd name="connsiteX0" fmla="*/ 13304 w 26655"/>
                <a:gd name="connsiteY0" fmla="*/ 0 h 33872"/>
                <a:gd name="connsiteX1" fmla="*/ 26656 w 26655"/>
                <a:gd name="connsiteY1" fmla="*/ 16966 h 33872"/>
                <a:gd name="connsiteX2" fmla="*/ 13304 w 26655"/>
                <a:gd name="connsiteY2" fmla="*/ 33873 h 33872"/>
                <a:gd name="connsiteX3" fmla="*/ 0 w 26655"/>
                <a:gd name="connsiteY3" fmla="*/ 16966 h 33872"/>
                <a:gd name="connsiteX4" fmla="*/ 13304 w 26655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872">
                  <a:moveTo>
                    <a:pt x="13304" y="0"/>
                  </a:moveTo>
                  <a:lnTo>
                    <a:pt x="26656" y="16966"/>
                  </a:lnTo>
                  <a:lnTo>
                    <a:pt x="13304" y="33873"/>
                  </a:lnTo>
                  <a:lnTo>
                    <a:pt x="0" y="16966"/>
                  </a:lnTo>
                  <a:lnTo>
                    <a:pt x="13304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3" name="フリーフォーム 1052">
              <a:extLst>
                <a:ext uri="{FF2B5EF4-FFF2-40B4-BE49-F238E27FC236}">
                  <a16:creationId xmlns:a16="http://schemas.microsoft.com/office/drawing/2014/main" xmlns="" id="{2E748C94-F736-64E4-C7FE-5006ADF367C9}"/>
                </a:ext>
              </a:extLst>
            </p:cNvPr>
            <p:cNvSpPr/>
            <p:nvPr/>
          </p:nvSpPr>
          <p:spPr>
            <a:xfrm>
              <a:off x="2157458" y="3683838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4" name="フリーフォーム 1053">
              <a:extLst>
                <a:ext uri="{FF2B5EF4-FFF2-40B4-BE49-F238E27FC236}">
                  <a16:creationId xmlns:a16="http://schemas.microsoft.com/office/drawing/2014/main" xmlns="" id="{DE7DE51D-5937-12E5-8127-8A4E59532D72}"/>
                </a:ext>
              </a:extLst>
            </p:cNvPr>
            <p:cNvSpPr/>
            <p:nvPr/>
          </p:nvSpPr>
          <p:spPr>
            <a:xfrm>
              <a:off x="2157458" y="3683838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5" name="フリーフォーム 1054">
              <a:extLst>
                <a:ext uri="{FF2B5EF4-FFF2-40B4-BE49-F238E27FC236}">
                  <a16:creationId xmlns:a16="http://schemas.microsoft.com/office/drawing/2014/main" xmlns="" id="{194FAB4D-2881-A787-562E-A6D6CF8B3AD8}"/>
                </a:ext>
              </a:extLst>
            </p:cNvPr>
            <p:cNvSpPr/>
            <p:nvPr/>
          </p:nvSpPr>
          <p:spPr>
            <a:xfrm>
              <a:off x="2408118" y="3683838"/>
              <a:ext cx="25200" cy="25200"/>
            </a:xfrm>
            <a:custGeom>
              <a:avLst/>
              <a:gdLst>
                <a:gd name="connsiteX0" fmla="*/ 13352 w 26655"/>
                <a:gd name="connsiteY0" fmla="*/ 0 h 33872"/>
                <a:gd name="connsiteX1" fmla="*/ 26656 w 26655"/>
                <a:gd name="connsiteY1" fmla="*/ 16966 h 33872"/>
                <a:gd name="connsiteX2" fmla="*/ 13352 w 26655"/>
                <a:gd name="connsiteY2" fmla="*/ 33873 h 33872"/>
                <a:gd name="connsiteX3" fmla="*/ 0 w 26655"/>
                <a:gd name="connsiteY3" fmla="*/ 16966 h 33872"/>
                <a:gd name="connsiteX4" fmla="*/ 13352 w 26655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872">
                  <a:moveTo>
                    <a:pt x="13352" y="0"/>
                  </a:moveTo>
                  <a:lnTo>
                    <a:pt x="26656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6" name="フリーフォーム 1055">
              <a:extLst>
                <a:ext uri="{FF2B5EF4-FFF2-40B4-BE49-F238E27FC236}">
                  <a16:creationId xmlns:a16="http://schemas.microsoft.com/office/drawing/2014/main" xmlns="" id="{1BD645E2-0C5B-F390-EB51-66B266A922B4}"/>
                </a:ext>
              </a:extLst>
            </p:cNvPr>
            <p:cNvSpPr/>
            <p:nvPr/>
          </p:nvSpPr>
          <p:spPr>
            <a:xfrm>
              <a:off x="2408118" y="3683838"/>
              <a:ext cx="25200" cy="25200"/>
            </a:xfrm>
            <a:custGeom>
              <a:avLst/>
              <a:gdLst>
                <a:gd name="connsiteX0" fmla="*/ 13352 w 26655"/>
                <a:gd name="connsiteY0" fmla="*/ 0 h 33872"/>
                <a:gd name="connsiteX1" fmla="*/ 26656 w 26655"/>
                <a:gd name="connsiteY1" fmla="*/ 16966 h 33872"/>
                <a:gd name="connsiteX2" fmla="*/ 13352 w 26655"/>
                <a:gd name="connsiteY2" fmla="*/ 33873 h 33872"/>
                <a:gd name="connsiteX3" fmla="*/ 0 w 26655"/>
                <a:gd name="connsiteY3" fmla="*/ 16966 h 33872"/>
                <a:gd name="connsiteX4" fmla="*/ 13352 w 26655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872">
                  <a:moveTo>
                    <a:pt x="13352" y="0"/>
                  </a:moveTo>
                  <a:lnTo>
                    <a:pt x="26656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7" name="フリーフォーム 1056">
              <a:extLst>
                <a:ext uri="{FF2B5EF4-FFF2-40B4-BE49-F238E27FC236}">
                  <a16:creationId xmlns:a16="http://schemas.microsoft.com/office/drawing/2014/main" xmlns="" id="{96257B7C-5701-862A-361D-E903016FD5DE}"/>
                </a:ext>
              </a:extLst>
            </p:cNvPr>
            <p:cNvSpPr/>
            <p:nvPr/>
          </p:nvSpPr>
          <p:spPr>
            <a:xfrm>
              <a:off x="2441992" y="3683838"/>
              <a:ext cx="25200" cy="25200"/>
            </a:xfrm>
            <a:custGeom>
              <a:avLst/>
              <a:gdLst>
                <a:gd name="connsiteX0" fmla="*/ 13352 w 26655"/>
                <a:gd name="connsiteY0" fmla="*/ 0 h 33872"/>
                <a:gd name="connsiteX1" fmla="*/ 26656 w 26655"/>
                <a:gd name="connsiteY1" fmla="*/ 16966 h 33872"/>
                <a:gd name="connsiteX2" fmla="*/ 13352 w 26655"/>
                <a:gd name="connsiteY2" fmla="*/ 33873 h 33872"/>
                <a:gd name="connsiteX3" fmla="*/ 0 w 26655"/>
                <a:gd name="connsiteY3" fmla="*/ 16966 h 33872"/>
                <a:gd name="connsiteX4" fmla="*/ 13352 w 26655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872">
                  <a:moveTo>
                    <a:pt x="13352" y="0"/>
                  </a:moveTo>
                  <a:lnTo>
                    <a:pt x="26656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8" name="フリーフォーム 1057">
              <a:extLst>
                <a:ext uri="{FF2B5EF4-FFF2-40B4-BE49-F238E27FC236}">
                  <a16:creationId xmlns:a16="http://schemas.microsoft.com/office/drawing/2014/main" xmlns="" id="{0C0FE8A9-F1C5-CA8F-66B3-0C595D76F0DA}"/>
                </a:ext>
              </a:extLst>
            </p:cNvPr>
            <p:cNvSpPr/>
            <p:nvPr/>
          </p:nvSpPr>
          <p:spPr>
            <a:xfrm>
              <a:off x="2441992" y="3683838"/>
              <a:ext cx="25200" cy="25200"/>
            </a:xfrm>
            <a:custGeom>
              <a:avLst/>
              <a:gdLst>
                <a:gd name="connsiteX0" fmla="*/ 13352 w 26655"/>
                <a:gd name="connsiteY0" fmla="*/ 0 h 33872"/>
                <a:gd name="connsiteX1" fmla="*/ 26656 w 26655"/>
                <a:gd name="connsiteY1" fmla="*/ 16966 h 33872"/>
                <a:gd name="connsiteX2" fmla="*/ 13352 w 26655"/>
                <a:gd name="connsiteY2" fmla="*/ 33873 h 33872"/>
                <a:gd name="connsiteX3" fmla="*/ 0 w 26655"/>
                <a:gd name="connsiteY3" fmla="*/ 16966 h 33872"/>
                <a:gd name="connsiteX4" fmla="*/ 13352 w 26655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655" h="33872">
                  <a:moveTo>
                    <a:pt x="13352" y="0"/>
                  </a:moveTo>
                  <a:lnTo>
                    <a:pt x="26656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59" name="フリーフォーム 1058">
              <a:extLst>
                <a:ext uri="{FF2B5EF4-FFF2-40B4-BE49-F238E27FC236}">
                  <a16:creationId xmlns:a16="http://schemas.microsoft.com/office/drawing/2014/main" xmlns="" id="{63E7B012-C707-0427-2F78-DF8C5421602D}"/>
                </a:ext>
              </a:extLst>
            </p:cNvPr>
            <p:cNvSpPr/>
            <p:nvPr/>
          </p:nvSpPr>
          <p:spPr>
            <a:xfrm>
              <a:off x="2469073" y="3683838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solidFill>
              <a:srgbClr val="000000"/>
            </a:solidFill>
            <a:ln w="4712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60" name="フリーフォーム 1059">
              <a:extLst>
                <a:ext uri="{FF2B5EF4-FFF2-40B4-BE49-F238E27FC236}">
                  <a16:creationId xmlns:a16="http://schemas.microsoft.com/office/drawing/2014/main" xmlns="" id="{2754A0D8-756A-BE19-BC92-C8AB4DE0446C}"/>
                </a:ext>
              </a:extLst>
            </p:cNvPr>
            <p:cNvSpPr/>
            <p:nvPr/>
          </p:nvSpPr>
          <p:spPr>
            <a:xfrm>
              <a:off x="2469073" y="3683838"/>
              <a:ext cx="25200" cy="25200"/>
            </a:xfrm>
            <a:custGeom>
              <a:avLst/>
              <a:gdLst>
                <a:gd name="connsiteX0" fmla="*/ 13352 w 26703"/>
                <a:gd name="connsiteY0" fmla="*/ 0 h 33872"/>
                <a:gd name="connsiteX1" fmla="*/ 26703 w 26703"/>
                <a:gd name="connsiteY1" fmla="*/ 16966 h 33872"/>
                <a:gd name="connsiteX2" fmla="*/ 13352 w 26703"/>
                <a:gd name="connsiteY2" fmla="*/ 33873 h 33872"/>
                <a:gd name="connsiteX3" fmla="*/ 0 w 26703"/>
                <a:gd name="connsiteY3" fmla="*/ 16966 h 33872"/>
                <a:gd name="connsiteX4" fmla="*/ 13352 w 26703"/>
                <a:gd name="connsiteY4" fmla="*/ 0 h 33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703" h="33872">
                  <a:moveTo>
                    <a:pt x="13352" y="0"/>
                  </a:moveTo>
                  <a:lnTo>
                    <a:pt x="26703" y="16966"/>
                  </a:lnTo>
                  <a:lnTo>
                    <a:pt x="13352" y="33873"/>
                  </a:lnTo>
                  <a:lnTo>
                    <a:pt x="0" y="16966"/>
                  </a:lnTo>
                  <a:lnTo>
                    <a:pt x="13352" y="0"/>
                  </a:lnTo>
                  <a:close/>
                </a:path>
              </a:pathLst>
            </a:custGeom>
            <a:noFill/>
            <a:ln w="4712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xmlns="" id="{9446191F-B91F-BFAE-D961-FE4337DD9E99}"/>
              </a:ext>
            </a:extLst>
          </p:cNvPr>
          <p:cNvGrpSpPr/>
          <p:nvPr/>
        </p:nvGrpSpPr>
        <p:grpSpPr>
          <a:xfrm>
            <a:off x="6053681" y="1259801"/>
            <a:ext cx="5035640" cy="3688712"/>
            <a:chOff x="6053681" y="1259801"/>
            <a:chExt cx="5035640" cy="3688712"/>
          </a:xfrm>
        </p:grpSpPr>
        <p:sp>
          <p:nvSpPr>
            <p:cNvPr id="304" name="テキスト ボックス 303">
              <a:extLst>
                <a:ext uri="{FF2B5EF4-FFF2-40B4-BE49-F238E27FC236}">
                  <a16:creationId xmlns:a16="http://schemas.microsoft.com/office/drawing/2014/main" xmlns="" id="{71D4AAD4-4BF8-B361-AC73-69DF4DC3C335}"/>
                </a:ext>
              </a:extLst>
            </p:cNvPr>
            <p:cNvSpPr txBox="1"/>
            <p:nvPr/>
          </p:nvSpPr>
          <p:spPr>
            <a:xfrm>
              <a:off x="6823765" y="1259801"/>
              <a:ext cx="20778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 First stent to revision stent 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8" name="フリーフォーム 637">
              <a:extLst>
                <a:ext uri="{FF2B5EF4-FFF2-40B4-BE49-F238E27FC236}">
                  <a16:creationId xmlns:a16="http://schemas.microsoft.com/office/drawing/2014/main" xmlns="" id="{F3888FBE-5515-ECCE-B7F6-306BA676E2C1}"/>
                </a:ext>
              </a:extLst>
            </p:cNvPr>
            <p:cNvSpPr/>
            <p:nvPr/>
          </p:nvSpPr>
          <p:spPr>
            <a:xfrm>
              <a:off x="7365457" y="4675730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39" name="フリーフォーム 638">
              <a:extLst>
                <a:ext uri="{FF2B5EF4-FFF2-40B4-BE49-F238E27FC236}">
                  <a16:creationId xmlns:a16="http://schemas.microsoft.com/office/drawing/2014/main" xmlns="" id="{9B8C2A48-F09D-8987-54EE-73300D271667}"/>
                </a:ext>
              </a:extLst>
            </p:cNvPr>
            <p:cNvSpPr/>
            <p:nvPr/>
          </p:nvSpPr>
          <p:spPr>
            <a:xfrm>
              <a:off x="8048145" y="4675730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0" name="フリーフォーム 639">
              <a:extLst>
                <a:ext uri="{FF2B5EF4-FFF2-40B4-BE49-F238E27FC236}">
                  <a16:creationId xmlns:a16="http://schemas.microsoft.com/office/drawing/2014/main" xmlns="" id="{D40C7410-6A19-5F50-8F47-FB8AB0F888FE}"/>
                </a:ext>
              </a:extLst>
            </p:cNvPr>
            <p:cNvSpPr/>
            <p:nvPr/>
          </p:nvSpPr>
          <p:spPr>
            <a:xfrm>
              <a:off x="8730834" y="4675730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1" name="フリーフォーム 640">
              <a:extLst>
                <a:ext uri="{FF2B5EF4-FFF2-40B4-BE49-F238E27FC236}">
                  <a16:creationId xmlns:a16="http://schemas.microsoft.com/office/drawing/2014/main" xmlns="" id="{3CC72819-AD30-78FC-C867-8C469A9A07F4}"/>
                </a:ext>
              </a:extLst>
            </p:cNvPr>
            <p:cNvSpPr/>
            <p:nvPr/>
          </p:nvSpPr>
          <p:spPr>
            <a:xfrm>
              <a:off x="9413524" y="4675730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2" name="フリーフォーム 641">
              <a:extLst>
                <a:ext uri="{FF2B5EF4-FFF2-40B4-BE49-F238E27FC236}">
                  <a16:creationId xmlns:a16="http://schemas.microsoft.com/office/drawing/2014/main" xmlns="" id="{64AB6BDD-D97A-C951-DEBC-EDDEE603717A}"/>
                </a:ext>
              </a:extLst>
            </p:cNvPr>
            <p:cNvSpPr/>
            <p:nvPr/>
          </p:nvSpPr>
          <p:spPr>
            <a:xfrm>
              <a:off x="10096212" y="4675730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3" name="フリーフォーム 642">
              <a:extLst>
                <a:ext uri="{FF2B5EF4-FFF2-40B4-BE49-F238E27FC236}">
                  <a16:creationId xmlns:a16="http://schemas.microsoft.com/office/drawing/2014/main" xmlns="" id="{034CE216-D78B-0F84-A6AB-6DB034A4D813}"/>
                </a:ext>
              </a:extLst>
            </p:cNvPr>
            <p:cNvSpPr/>
            <p:nvPr/>
          </p:nvSpPr>
          <p:spPr>
            <a:xfrm>
              <a:off x="10778976" y="4675730"/>
              <a:ext cx="7425" cy="24518"/>
            </a:xfrm>
            <a:custGeom>
              <a:avLst/>
              <a:gdLst>
                <a:gd name="connsiteX0" fmla="*/ 0 w 9517"/>
                <a:gd name="connsiteY0" fmla="*/ 0 h 33527"/>
                <a:gd name="connsiteX1" fmla="*/ 0 w 9517"/>
                <a:gd name="connsiteY1" fmla="*/ 33528 h 335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3527">
                  <a:moveTo>
                    <a:pt x="0" y="0"/>
                  </a:moveTo>
                  <a:lnTo>
                    <a:pt x="0" y="33528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4" name="フリーフォーム 643">
              <a:extLst>
                <a:ext uri="{FF2B5EF4-FFF2-40B4-BE49-F238E27FC236}">
                  <a16:creationId xmlns:a16="http://schemas.microsoft.com/office/drawing/2014/main" xmlns="" id="{6CC2EDF4-21A3-F99D-506B-BAE01E3D1E55}"/>
                </a:ext>
              </a:extLst>
            </p:cNvPr>
            <p:cNvSpPr/>
            <p:nvPr/>
          </p:nvSpPr>
          <p:spPr>
            <a:xfrm>
              <a:off x="7024112" y="4675730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5" name="フリーフォーム 644">
              <a:extLst>
                <a:ext uri="{FF2B5EF4-FFF2-40B4-BE49-F238E27FC236}">
                  <a16:creationId xmlns:a16="http://schemas.microsoft.com/office/drawing/2014/main" xmlns="" id="{8502B3B4-B168-CC64-A33F-279B612D3405}"/>
                </a:ext>
              </a:extLst>
            </p:cNvPr>
            <p:cNvSpPr/>
            <p:nvPr/>
          </p:nvSpPr>
          <p:spPr>
            <a:xfrm>
              <a:off x="7706801" y="4675730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6" name="フリーフォーム 645">
              <a:extLst>
                <a:ext uri="{FF2B5EF4-FFF2-40B4-BE49-F238E27FC236}">
                  <a16:creationId xmlns:a16="http://schemas.microsoft.com/office/drawing/2014/main" xmlns="" id="{5A2BFB2D-5A62-7347-6FC8-B087A4D6211E}"/>
                </a:ext>
              </a:extLst>
            </p:cNvPr>
            <p:cNvSpPr/>
            <p:nvPr/>
          </p:nvSpPr>
          <p:spPr>
            <a:xfrm>
              <a:off x="8389490" y="4675730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7" name="フリーフォーム 646">
              <a:extLst>
                <a:ext uri="{FF2B5EF4-FFF2-40B4-BE49-F238E27FC236}">
                  <a16:creationId xmlns:a16="http://schemas.microsoft.com/office/drawing/2014/main" xmlns="" id="{19E85394-BB6F-2493-09AB-5F4209741C0E}"/>
                </a:ext>
              </a:extLst>
            </p:cNvPr>
            <p:cNvSpPr/>
            <p:nvPr/>
          </p:nvSpPr>
          <p:spPr>
            <a:xfrm>
              <a:off x="9072179" y="4675730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8" name="フリーフォーム 647">
              <a:extLst>
                <a:ext uri="{FF2B5EF4-FFF2-40B4-BE49-F238E27FC236}">
                  <a16:creationId xmlns:a16="http://schemas.microsoft.com/office/drawing/2014/main" xmlns="" id="{051FD307-7861-8568-C561-48D555287F4C}"/>
                </a:ext>
              </a:extLst>
            </p:cNvPr>
            <p:cNvSpPr/>
            <p:nvPr/>
          </p:nvSpPr>
          <p:spPr>
            <a:xfrm>
              <a:off x="9754868" y="4675730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49" name="フリーフォーム 648">
              <a:extLst>
                <a:ext uri="{FF2B5EF4-FFF2-40B4-BE49-F238E27FC236}">
                  <a16:creationId xmlns:a16="http://schemas.microsoft.com/office/drawing/2014/main" xmlns="" id="{10078ADE-9862-33C2-F4C5-C670E6962BE6}"/>
                </a:ext>
              </a:extLst>
            </p:cNvPr>
            <p:cNvSpPr/>
            <p:nvPr/>
          </p:nvSpPr>
          <p:spPr>
            <a:xfrm>
              <a:off x="10437631" y="4675730"/>
              <a:ext cx="7425" cy="49036"/>
            </a:xfrm>
            <a:custGeom>
              <a:avLst/>
              <a:gdLst>
                <a:gd name="connsiteX0" fmla="*/ 0 w 9517"/>
                <a:gd name="connsiteY0" fmla="*/ 0 h 67055"/>
                <a:gd name="connsiteX1" fmla="*/ 0 w 9517"/>
                <a:gd name="connsiteY1" fmla="*/ 67056 h 670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67055">
                  <a:moveTo>
                    <a:pt x="0" y="0"/>
                  </a:moveTo>
                  <a:lnTo>
                    <a:pt x="0" y="67056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0" name="フリーフォーム 649">
              <a:extLst>
                <a:ext uri="{FF2B5EF4-FFF2-40B4-BE49-F238E27FC236}">
                  <a16:creationId xmlns:a16="http://schemas.microsoft.com/office/drawing/2014/main" xmlns="" id="{FF6ADBCB-FED5-0973-9ED8-830238DFEB92}"/>
                </a:ext>
              </a:extLst>
            </p:cNvPr>
            <p:cNvSpPr/>
            <p:nvPr/>
          </p:nvSpPr>
          <p:spPr>
            <a:xfrm>
              <a:off x="6815459" y="4675730"/>
              <a:ext cx="4172095" cy="6966"/>
            </a:xfrm>
            <a:custGeom>
              <a:avLst/>
              <a:gdLst>
                <a:gd name="connsiteX0" fmla="*/ 0 w 5347614"/>
                <a:gd name="connsiteY0" fmla="*/ 0 h 9525"/>
                <a:gd name="connsiteX1" fmla="*/ 5347615 w 5347614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347614" h="9525">
                  <a:moveTo>
                    <a:pt x="0" y="0"/>
                  </a:moveTo>
                  <a:lnTo>
                    <a:pt x="5347615" y="0"/>
                  </a:lnTo>
                </a:path>
              </a:pathLst>
            </a:custGeom>
            <a:noFill/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1" name="フリーフォーム 650">
              <a:extLst>
                <a:ext uri="{FF2B5EF4-FFF2-40B4-BE49-F238E27FC236}">
                  <a16:creationId xmlns:a16="http://schemas.microsoft.com/office/drawing/2014/main" xmlns="" id="{1516CAD4-ED9D-8E25-69AB-2811A95B29DE}"/>
                </a:ext>
              </a:extLst>
            </p:cNvPr>
            <p:cNvSpPr/>
            <p:nvPr/>
          </p:nvSpPr>
          <p:spPr>
            <a:xfrm>
              <a:off x="6789322" y="4287194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2" name="フリーフォーム 651">
              <a:extLst>
                <a:ext uri="{FF2B5EF4-FFF2-40B4-BE49-F238E27FC236}">
                  <a16:creationId xmlns:a16="http://schemas.microsoft.com/office/drawing/2014/main" xmlns="" id="{0EE755BD-2F66-4943-59D1-A3F13B3330B6}"/>
                </a:ext>
              </a:extLst>
            </p:cNvPr>
            <p:cNvSpPr/>
            <p:nvPr/>
          </p:nvSpPr>
          <p:spPr>
            <a:xfrm>
              <a:off x="6789322" y="3787628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3" name="フリーフォーム 652">
              <a:extLst>
                <a:ext uri="{FF2B5EF4-FFF2-40B4-BE49-F238E27FC236}">
                  <a16:creationId xmlns:a16="http://schemas.microsoft.com/office/drawing/2014/main" xmlns="" id="{6FCB366E-30F9-98B9-8D95-C4B514DFC3C5}"/>
                </a:ext>
              </a:extLst>
            </p:cNvPr>
            <p:cNvSpPr/>
            <p:nvPr/>
          </p:nvSpPr>
          <p:spPr>
            <a:xfrm>
              <a:off x="6789322" y="3287991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4" name="フリーフォーム 653">
              <a:extLst>
                <a:ext uri="{FF2B5EF4-FFF2-40B4-BE49-F238E27FC236}">
                  <a16:creationId xmlns:a16="http://schemas.microsoft.com/office/drawing/2014/main" xmlns="" id="{0A28EDD1-0263-8459-5143-1AC215AD71C5}"/>
                </a:ext>
              </a:extLst>
            </p:cNvPr>
            <p:cNvSpPr/>
            <p:nvPr/>
          </p:nvSpPr>
          <p:spPr>
            <a:xfrm>
              <a:off x="6789322" y="2788425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5" name="フリーフォーム 654">
              <a:extLst>
                <a:ext uri="{FF2B5EF4-FFF2-40B4-BE49-F238E27FC236}">
                  <a16:creationId xmlns:a16="http://schemas.microsoft.com/office/drawing/2014/main" xmlns="" id="{439CA076-C1E6-DA93-B922-7F1D0B01D533}"/>
                </a:ext>
              </a:extLst>
            </p:cNvPr>
            <p:cNvSpPr/>
            <p:nvPr/>
          </p:nvSpPr>
          <p:spPr>
            <a:xfrm>
              <a:off x="6789322" y="2288858"/>
              <a:ext cx="26137" cy="6966"/>
            </a:xfrm>
            <a:custGeom>
              <a:avLst/>
              <a:gdLst>
                <a:gd name="connsiteX0" fmla="*/ 33502 w 33501"/>
                <a:gd name="connsiteY0" fmla="*/ 0 h 9525"/>
                <a:gd name="connsiteX1" fmla="*/ 0 w 33501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501" h="9525">
                  <a:moveTo>
                    <a:pt x="33502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6" name="フリーフォーム 655">
              <a:extLst>
                <a:ext uri="{FF2B5EF4-FFF2-40B4-BE49-F238E27FC236}">
                  <a16:creationId xmlns:a16="http://schemas.microsoft.com/office/drawing/2014/main" xmlns="" id="{870571E3-A19E-A678-DE3B-DF9DB6A47BE8}"/>
                </a:ext>
              </a:extLst>
            </p:cNvPr>
            <p:cNvSpPr/>
            <p:nvPr/>
          </p:nvSpPr>
          <p:spPr>
            <a:xfrm>
              <a:off x="6763184" y="4536977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7" name="フリーフォーム 656">
              <a:extLst>
                <a:ext uri="{FF2B5EF4-FFF2-40B4-BE49-F238E27FC236}">
                  <a16:creationId xmlns:a16="http://schemas.microsoft.com/office/drawing/2014/main" xmlns="" id="{2C723400-D60B-252C-896E-93CDC59819CA}"/>
                </a:ext>
              </a:extLst>
            </p:cNvPr>
            <p:cNvSpPr/>
            <p:nvPr/>
          </p:nvSpPr>
          <p:spPr>
            <a:xfrm>
              <a:off x="6763184" y="4037410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8" name="フリーフォーム 657">
              <a:extLst>
                <a:ext uri="{FF2B5EF4-FFF2-40B4-BE49-F238E27FC236}">
                  <a16:creationId xmlns:a16="http://schemas.microsoft.com/office/drawing/2014/main" xmlns="" id="{E526C459-B0F5-01C5-1B41-4F86B2F96C6C}"/>
                </a:ext>
              </a:extLst>
            </p:cNvPr>
            <p:cNvSpPr/>
            <p:nvPr/>
          </p:nvSpPr>
          <p:spPr>
            <a:xfrm>
              <a:off x="6763184" y="3537844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59" name="フリーフォーム 658">
              <a:extLst>
                <a:ext uri="{FF2B5EF4-FFF2-40B4-BE49-F238E27FC236}">
                  <a16:creationId xmlns:a16="http://schemas.microsoft.com/office/drawing/2014/main" xmlns="" id="{9D1CF4AD-812A-6D7A-408F-D75299BA902B}"/>
                </a:ext>
              </a:extLst>
            </p:cNvPr>
            <p:cNvSpPr/>
            <p:nvPr/>
          </p:nvSpPr>
          <p:spPr>
            <a:xfrm>
              <a:off x="6763184" y="3038208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60" name="フリーフォーム 659">
              <a:extLst>
                <a:ext uri="{FF2B5EF4-FFF2-40B4-BE49-F238E27FC236}">
                  <a16:creationId xmlns:a16="http://schemas.microsoft.com/office/drawing/2014/main" xmlns="" id="{BEA27D2D-49B3-F4ED-D4B9-CFAAE5A95FA4}"/>
                </a:ext>
              </a:extLst>
            </p:cNvPr>
            <p:cNvSpPr/>
            <p:nvPr/>
          </p:nvSpPr>
          <p:spPr>
            <a:xfrm>
              <a:off x="6763184" y="2538642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61" name="フリーフォーム 660">
              <a:extLst>
                <a:ext uri="{FF2B5EF4-FFF2-40B4-BE49-F238E27FC236}">
                  <a16:creationId xmlns:a16="http://schemas.microsoft.com/office/drawing/2014/main" xmlns="" id="{6097EA6C-D518-415F-AD07-1D7A4282657E}"/>
                </a:ext>
              </a:extLst>
            </p:cNvPr>
            <p:cNvSpPr/>
            <p:nvPr/>
          </p:nvSpPr>
          <p:spPr>
            <a:xfrm>
              <a:off x="6763184" y="2039076"/>
              <a:ext cx="52274" cy="6966"/>
            </a:xfrm>
            <a:custGeom>
              <a:avLst/>
              <a:gdLst>
                <a:gd name="connsiteX0" fmla="*/ 67003 w 67003"/>
                <a:gd name="connsiteY0" fmla="*/ 0 h 9525"/>
                <a:gd name="connsiteX1" fmla="*/ 0 w 67003"/>
                <a:gd name="connsiteY1" fmla="*/ 0 h 9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7003" h="9525">
                  <a:moveTo>
                    <a:pt x="67003" y="0"/>
                  </a:moveTo>
                  <a:lnTo>
                    <a:pt x="0" y="0"/>
                  </a:lnTo>
                </a:path>
              </a:pathLst>
            </a:custGeom>
            <a:ln w="9514" cap="flat">
              <a:solidFill>
                <a:srgbClr val="AEAEAE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62" name="フリーフォーム 661">
              <a:extLst>
                <a:ext uri="{FF2B5EF4-FFF2-40B4-BE49-F238E27FC236}">
                  <a16:creationId xmlns:a16="http://schemas.microsoft.com/office/drawing/2014/main" xmlns="" id="{76B20A6D-69D4-9664-3262-9C6BB44EE7FE}"/>
                </a:ext>
              </a:extLst>
            </p:cNvPr>
            <p:cNvSpPr/>
            <p:nvPr/>
          </p:nvSpPr>
          <p:spPr>
            <a:xfrm>
              <a:off x="6815459" y="1900253"/>
              <a:ext cx="7425" cy="2775477"/>
            </a:xfrm>
            <a:custGeom>
              <a:avLst/>
              <a:gdLst>
                <a:gd name="connsiteX0" fmla="*/ 0 w 9517"/>
                <a:gd name="connsiteY0" fmla="*/ 0 h 3795331"/>
                <a:gd name="connsiteX1" fmla="*/ 0 w 9517"/>
                <a:gd name="connsiteY1" fmla="*/ 3795332 h 37953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517" h="3795331">
                  <a:moveTo>
                    <a:pt x="0" y="0"/>
                  </a:moveTo>
                  <a:lnTo>
                    <a:pt x="0" y="3795332"/>
                  </a:lnTo>
                </a:path>
              </a:pathLst>
            </a:custGeom>
            <a:noFill/>
            <a:ln w="9514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b="1"/>
            </a:p>
          </p:txBody>
        </p:sp>
        <p:sp>
          <p:nvSpPr>
            <p:cNvPr id="663" name="テキスト ボックス 662">
              <a:extLst>
                <a:ext uri="{FF2B5EF4-FFF2-40B4-BE49-F238E27FC236}">
                  <a16:creationId xmlns:a16="http://schemas.microsoft.com/office/drawing/2014/main" xmlns="" id="{6292222C-94E4-63A6-DE90-FC52B46DE95F}"/>
                </a:ext>
              </a:extLst>
            </p:cNvPr>
            <p:cNvSpPr txBox="1"/>
            <p:nvPr/>
          </p:nvSpPr>
          <p:spPr>
            <a:xfrm>
              <a:off x="6159645" y="1936239"/>
              <a:ext cx="6366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4" name="テキスト ボックス 663">
              <a:extLst>
                <a:ext uri="{FF2B5EF4-FFF2-40B4-BE49-F238E27FC236}">
                  <a16:creationId xmlns:a16="http://schemas.microsoft.com/office/drawing/2014/main" xmlns="" id="{80F64593-C95A-056A-A1DA-4C8005075348}"/>
                </a:ext>
              </a:extLst>
            </p:cNvPr>
            <p:cNvSpPr txBox="1"/>
            <p:nvPr/>
          </p:nvSpPr>
          <p:spPr>
            <a:xfrm>
              <a:off x="6214300" y="2432661"/>
              <a:ext cx="582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5" name="テキスト ボックス 664">
              <a:extLst>
                <a:ext uri="{FF2B5EF4-FFF2-40B4-BE49-F238E27FC236}">
                  <a16:creationId xmlns:a16="http://schemas.microsoft.com/office/drawing/2014/main" xmlns="" id="{98658270-F928-EE4F-2F7A-8EDBC6B04ACF}"/>
                </a:ext>
              </a:extLst>
            </p:cNvPr>
            <p:cNvSpPr txBox="1"/>
            <p:nvPr/>
          </p:nvSpPr>
          <p:spPr>
            <a:xfrm>
              <a:off x="6202696" y="2929083"/>
              <a:ext cx="5936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6" name="テキスト ボックス 665">
              <a:extLst>
                <a:ext uri="{FF2B5EF4-FFF2-40B4-BE49-F238E27FC236}">
                  <a16:creationId xmlns:a16="http://schemas.microsoft.com/office/drawing/2014/main" xmlns="" id="{8A31DF10-1462-40BF-9D6F-F4085629ECBE}"/>
                </a:ext>
              </a:extLst>
            </p:cNvPr>
            <p:cNvSpPr txBox="1"/>
            <p:nvPr/>
          </p:nvSpPr>
          <p:spPr>
            <a:xfrm>
              <a:off x="6194318" y="3425505"/>
              <a:ext cx="6020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7" name="テキスト ボックス 666">
              <a:extLst>
                <a:ext uri="{FF2B5EF4-FFF2-40B4-BE49-F238E27FC236}">
                  <a16:creationId xmlns:a16="http://schemas.microsoft.com/office/drawing/2014/main" xmlns="" id="{78B17EAD-B908-9400-0851-9CBC60CCC247}"/>
                </a:ext>
              </a:extLst>
            </p:cNvPr>
            <p:cNvSpPr txBox="1"/>
            <p:nvPr/>
          </p:nvSpPr>
          <p:spPr>
            <a:xfrm>
              <a:off x="6229628" y="3921927"/>
              <a:ext cx="5667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8" name="テキスト ボックス 667">
              <a:extLst>
                <a:ext uri="{FF2B5EF4-FFF2-40B4-BE49-F238E27FC236}">
                  <a16:creationId xmlns:a16="http://schemas.microsoft.com/office/drawing/2014/main" xmlns="" id="{6FB10371-83B6-DFDB-5EED-5BC7DE6FAF01}"/>
                </a:ext>
              </a:extLst>
            </p:cNvPr>
            <p:cNvSpPr txBox="1"/>
            <p:nvPr/>
          </p:nvSpPr>
          <p:spPr>
            <a:xfrm>
              <a:off x="6118613" y="4418351"/>
              <a:ext cx="6777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 %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9" name="テキスト ボックス 668">
              <a:extLst>
                <a:ext uri="{FF2B5EF4-FFF2-40B4-BE49-F238E27FC236}">
                  <a16:creationId xmlns:a16="http://schemas.microsoft.com/office/drawing/2014/main" xmlns="" id="{70DF7AFC-A204-533E-07DC-CC8E6C09B374}"/>
                </a:ext>
              </a:extLst>
            </p:cNvPr>
            <p:cNvSpPr txBox="1"/>
            <p:nvPr/>
          </p:nvSpPr>
          <p:spPr>
            <a:xfrm>
              <a:off x="6914505" y="472103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0" name="テキスト ボックス 669">
              <a:extLst>
                <a:ext uri="{FF2B5EF4-FFF2-40B4-BE49-F238E27FC236}">
                  <a16:creationId xmlns:a16="http://schemas.microsoft.com/office/drawing/2014/main" xmlns="" id="{3BFC7088-6D7F-57D6-8D66-D38A97A925A4}"/>
                </a:ext>
              </a:extLst>
            </p:cNvPr>
            <p:cNvSpPr txBox="1"/>
            <p:nvPr/>
          </p:nvSpPr>
          <p:spPr>
            <a:xfrm>
              <a:off x="7527265" y="473306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1" name="テキスト ボックス 670">
              <a:extLst>
                <a:ext uri="{FF2B5EF4-FFF2-40B4-BE49-F238E27FC236}">
                  <a16:creationId xmlns:a16="http://schemas.microsoft.com/office/drawing/2014/main" xmlns="" id="{A47C026D-024A-656A-98B8-990C277BFDA2}"/>
                </a:ext>
              </a:extLst>
            </p:cNvPr>
            <p:cNvSpPr txBox="1"/>
            <p:nvPr/>
          </p:nvSpPr>
          <p:spPr>
            <a:xfrm>
              <a:off x="8212537" y="473306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2" name="テキスト ボックス 671">
              <a:extLst>
                <a:ext uri="{FF2B5EF4-FFF2-40B4-BE49-F238E27FC236}">
                  <a16:creationId xmlns:a16="http://schemas.microsoft.com/office/drawing/2014/main" xmlns="" id="{6D9B55AD-A474-8FBF-0184-4EBF0EA941CB}"/>
                </a:ext>
              </a:extLst>
            </p:cNvPr>
            <p:cNvSpPr txBox="1"/>
            <p:nvPr/>
          </p:nvSpPr>
          <p:spPr>
            <a:xfrm>
              <a:off x="8897809" y="473306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3" name="テキスト ボックス 672">
              <a:extLst>
                <a:ext uri="{FF2B5EF4-FFF2-40B4-BE49-F238E27FC236}">
                  <a16:creationId xmlns:a16="http://schemas.microsoft.com/office/drawing/2014/main" xmlns="" id="{92BAEC3D-BCC9-A07E-AFC2-6ED32D3BE40E}"/>
                </a:ext>
              </a:extLst>
            </p:cNvPr>
            <p:cNvSpPr txBox="1"/>
            <p:nvPr/>
          </p:nvSpPr>
          <p:spPr>
            <a:xfrm>
              <a:off x="9583081" y="473306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4" name="テキスト ボックス 673">
              <a:extLst>
                <a:ext uri="{FF2B5EF4-FFF2-40B4-BE49-F238E27FC236}">
                  <a16:creationId xmlns:a16="http://schemas.microsoft.com/office/drawing/2014/main" xmlns="" id="{F4F24374-8DB1-54A8-9198-BAA7CBBF3244}"/>
                </a:ext>
              </a:extLst>
            </p:cNvPr>
            <p:cNvSpPr txBox="1"/>
            <p:nvPr/>
          </p:nvSpPr>
          <p:spPr>
            <a:xfrm>
              <a:off x="10268354" y="473306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5" name="テキスト ボックス 674">
              <a:extLst>
                <a:ext uri="{FF2B5EF4-FFF2-40B4-BE49-F238E27FC236}">
                  <a16:creationId xmlns:a16="http://schemas.microsoft.com/office/drawing/2014/main" xmlns="" id="{8326F3DC-6549-92CA-9FE7-6B66CC7EE824}"/>
                </a:ext>
              </a:extLst>
            </p:cNvPr>
            <p:cNvSpPr txBox="1"/>
            <p:nvPr/>
          </p:nvSpPr>
          <p:spPr>
            <a:xfrm>
              <a:off x="10244218" y="4408312"/>
              <a:ext cx="8451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</a:t>
              </a:r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</a:t>
              </a:r>
              <a:r>
                <a:rPr kumimoji="1"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 sz="11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6" name="テキスト ボックス 675">
              <a:extLst>
                <a:ext uri="{FF2B5EF4-FFF2-40B4-BE49-F238E27FC236}">
                  <a16:creationId xmlns:a16="http://schemas.microsoft.com/office/drawing/2014/main" xmlns="" id="{D4D94898-1602-E296-B68B-F4DF9C7CAF96}"/>
                </a:ext>
              </a:extLst>
            </p:cNvPr>
            <p:cNvSpPr txBox="1"/>
            <p:nvPr/>
          </p:nvSpPr>
          <p:spPr>
            <a:xfrm rot="16200000">
              <a:off x="5531102" y="3125023"/>
              <a:ext cx="13067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BO-free rate</a:t>
              </a:r>
              <a:r>
                <a:rPr kumimoji="1"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%)</a:t>
              </a:r>
              <a:endParaRPr kumimoji="1" lang="ja-JP" altLang="en-US" sz="11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4" name="テキスト ボックス 683">
              <a:extLst>
                <a:ext uri="{FF2B5EF4-FFF2-40B4-BE49-F238E27FC236}">
                  <a16:creationId xmlns:a16="http://schemas.microsoft.com/office/drawing/2014/main" xmlns="" id="{80549874-E7FD-310B-59BB-975641C4003B}"/>
                </a:ext>
              </a:extLst>
            </p:cNvPr>
            <p:cNvSpPr txBox="1"/>
            <p:nvPr/>
          </p:nvSpPr>
          <p:spPr>
            <a:xfrm>
              <a:off x="8911682" y="3340189"/>
              <a:ext cx="191110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atified by log-rank test</a:t>
              </a:r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kumimoji="1" lang="en-US" altLang="ja-JP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342</a:t>
              </a:r>
              <a:endParaRPr kumimoji="1" lang="ja-JP" alt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xmlns="" id="{4FEA55D2-6B78-9251-6EEB-6090B93EB7BB}"/>
                </a:ext>
              </a:extLst>
            </p:cNvPr>
            <p:cNvGrpSpPr/>
            <p:nvPr/>
          </p:nvGrpSpPr>
          <p:grpSpPr>
            <a:xfrm>
              <a:off x="9224795" y="2019499"/>
              <a:ext cx="1324240" cy="1231660"/>
              <a:chOff x="9224795" y="2019499"/>
              <a:chExt cx="1324240" cy="1231660"/>
            </a:xfrm>
          </p:grpSpPr>
          <p:sp>
            <p:nvSpPr>
              <p:cNvPr id="678" name="正方形/長方形 677">
                <a:extLst>
                  <a:ext uri="{FF2B5EF4-FFF2-40B4-BE49-F238E27FC236}">
                    <a16:creationId xmlns:a16="http://schemas.microsoft.com/office/drawing/2014/main" xmlns="" id="{0B2C0F7E-1274-671E-B1E6-3458C6FB8D6A}"/>
                  </a:ext>
                </a:extLst>
              </p:cNvPr>
              <p:cNvSpPr/>
              <p:nvPr/>
            </p:nvSpPr>
            <p:spPr>
              <a:xfrm>
                <a:off x="9224795" y="2019499"/>
                <a:ext cx="1324240" cy="1231660"/>
              </a:xfrm>
              <a:prstGeom prst="rect">
                <a:avLst/>
              </a:prstGeom>
              <a:noFill/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00" b="1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680" name="直線コネクタ 679">
                <a:extLst>
                  <a:ext uri="{FF2B5EF4-FFF2-40B4-BE49-F238E27FC236}">
                    <a16:creationId xmlns:a16="http://schemas.microsoft.com/office/drawing/2014/main" xmlns="" id="{9CB20D6A-7415-20B4-7572-C59F785AB1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432918" y="2430114"/>
                <a:ext cx="169277" cy="0"/>
              </a:xfrm>
              <a:prstGeom prst="line">
                <a:avLst/>
              </a:prstGeom>
              <a:ln w="19050">
                <a:solidFill>
                  <a:schemeClr val="accent1">
                    <a:lumMod val="50000"/>
                  </a:schemeClr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1" name="テキスト ボックス 680">
                <a:extLst>
                  <a:ext uri="{FF2B5EF4-FFF2-40B4-BE49-F238E27FC236}">
                    <a16:creationId xmlns:a16="http://schemas.microsoft.com/office/drawing/2014/main" xmlns="" id="{333C1AD7-829C-45CD-A618-00B2ED0B52ED}"/>
                  </a:ext>
                </a:extLst>
              </p:cNvPr>
              <p:cNvSpPr txBox="1"/>
              <p:nvPr/>
            </p:nvSpPr>
            <p:spPr>
              <a:xfrm>
                <a:off x="9647095" y="2311019"/>
                <a:ext cx="68480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 to MS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2" name="テキスト ボックス 681">
                <a:extLst>
                  <a:ext uri="{FF2B5EF4-FFF2-40B4-BE49-F238E27FC236}">
                    <a16:creationId xmlns:a16="http://schemas.microsoft.com/office/drawing/2014/main" xmlns="" id="{E4A3314E-F740-C6C7-81A0-773D5FE48709}"/>
                  </a:ext>
                </a:extLst>
              </p:cNvPr>
              <p:cNvSpPr txBox="1"/>
              <p:nvPr/>
            </p:nvSpPr>
            <p:spPr>
              <a:xfrm>
                <a:off x="9647095" y="2532446"/>
                <a:ext cx="67518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 to PS 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83" name="直線コネクタ 682">
                <a:extLst>
                  <a:ext uri="{FF2B5EF4-FFF2-40B4-BE49-F238E27FC236}">
                    <a16:creationId xmlns:a16="http://schemas.microsoft.com/office/drawing/2014/main" xmlns="" id="{1CE88A75-3A81-F9F0-1C97-F127CD59E6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432918" y="2658904"/>
                <a:ext cx="169277" cy="0"/>
              </a:xfrm>
              <a:prstGeom prst="line">
                <a:avLst/>
              </a:prstGeom>
              <a:ln w="1905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2" name="直線コネクタ 1071">
                <a:extLst>
                  <a:ext uri="{FF2B5EF4-FFF2-40B4-BE49-F238E27FC236}">
                    <a16:creationId xmlns:a16="http://schemas.microsoft.com/office/drawing/2014/main" xmlns="" id="{5DC089A4-2A11-08F2-D98D-D55AC3535CF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432918" y="2857225"/>
                <a:ext cx="169277" cy="0"/>
              </a:xfrm>
              <a:prstGeom prst="line">
                <a:avLst/>
              </a:prstGeom>
              <a:ln w="19050">
                <a:solidFill>
                  <a:srgbClr val="00B050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3" name="テキスト ボックス 1072">
                <a:extLst>
                  <a:ext uri="{FF2B5EF4-FFF2-40B4-BE49-F238E27FC236}">
                    <a16:creationId xmlns:a16="http://schemas.microsoft.com/office/drawing/2014/main" xmlns="" id="{9C43E51B-97F2-3C4C-F2D9-952644110695}"/>
                  </a:ext>
                </a:extLst>
              </p:cNvPr>
              <p:cNvSpPr txBox="1"/>
              <p:nvPr/>
            </p:nvSpPr>
            <p:spPr>
              <a:xfrm>
                <a:off x="9647095" y="2738130"/>
                <a:ext cx="67518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 to MS 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4" name="テキスト ボックス 1073">
                <a:extLst>
                  <a:ext uri="{FF2B5EF4-FFF2-40B4-BE49-F238E27FC236}">
                    <a16:creationId xmlns:a16="http://schemas.microsoft.com/office/drawing/2014/main" xmlns="" id="{BA5A6628-9248-3A21-0B58-318283551FFA}"/>
                  </a:ext>
                </a:extLst>
              </p:cNvPr>
              <p:cNvSpPr txBox="1"/>
              <p:nvPr/>
            </p:nvSpPr>
            <p:spPr>
              <a:xfrm>
                <a:off x="9647095" y="2959557"/>
                <a:ext cx="63671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 to PS 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75" name="直線コネクタ 1074">
                <a:extLst>
                  <a:ext uri="{FF2B5EF4-FFF2-40B4-BE49-F238E27FC236}">
                    <a16:creationId xmlns:a16="http://schemas.microsoft.com/office/drawing/2014/main" xmlns="" id="{3C34B555-776D-5766-A80D-07B5F79ED5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432918" y="3086015"/>
                <a:ext cx="169277" cy="0"/>
              </a:xfrm>
              <a:prstGeom prst="line">
                <a:avLst/>
              </a:prstGeom>
              <a:ln w="19050"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6" name="テキスト ボックス 1075">
                <a:extLst>
                  <a:ext uri="{FF2B5EF4-FFF2-40B4-BE49-F238E27FC236}">
                    <a16:creationId xmlns:a16="http://schemas.microsoft.com/office/drawing/2014/main" xmlns="" id="{7850C9D9-AE96-CA81-8A8E-59F1F0C2653F}"/>
                  </a:ext>
                </a:extLst>
              </p:cNvPr>
              <p:cNvSpPr txBox="1"/>
              <p:nvPr/>
            </p:nvSpPr>
            <p:spPr>
              <a:xfrm>
                <a:off x="9270693" y="2066299"/>
                <a:ext cx="12330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rst to revision stent</a:t>
                </a:r>
                <a:endParaRPr kumimoji="1" lang="ja-JP" alt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50" name="グループ化 849">
              <a:extLst>
                <a:ext uri="{FF2B5EF4-FFF2-40B4-BE49-F238E27FC236}">
                  <a16:creationId xmlns:a16="http://schemas.microsoft.com/office/drawing/2014/main" xmlns="" id="{2425D61F-EC2D-791E-2573-EFAF84343E68}"/>
                </a:ext>
              </a:extLst>
            </p:cNvPr>
            <p:cNvGrpSpPr/>
            <p:nvPr/>
          </p:nvGrpSpPr>
          <p:grpSpPr>
            <a:xfrm>
              <a:off x="7020565" y="2039717"/>
              <a:ext cx="2533534" cy="2491076"/>
              <a:chOff x="6829758" y="6476067"/>
              <a:chExt cx="2533534" cy="2491076"/>
            </a:xfrm>
          </p:grpSpPr>
          <p:sp>
            <p:nvSpPr>
              <p:cNvPr id="608" name="フリーフォーム 607">
                <a:extLst>
                  <a:ext uri="{FF2B5EF4-FFF2-40B4-BE49-F238E27FC236}">
                    <a16:creationId xmlns:a16="http://schemas.microsoft.com/office/drawing/2014/main" xmlns="" id="{5C6E87CE-AB56-67DC-A63A-9942D311A3A1}"/>
                  </a:ext>
                </a:extLst>
              </p:cNvPr>
              <p:cNvSpPr/>
              <p:nvPr/>
            </p:nvSpPr>
            <p:spPr>
              <a:xfrm>
                <a:off x="6829758" y="6487965"/>
                <a:ext cx="1117712" cy="1574555"/>
              </a:xfrm>
              <a:custGeom>
                <a:avLst/>
                <a:gdLst>
                  <a:gd name="connsiteX0" fmla="*/ 0 w 1117712"/>
                  <a:gd name="connsiteY0" fmla="*/ 0 h 1574555"/>
                  <a:gd name="connsiteX1" fmla="*/ 6746 w 1117712"/>
                  <a:gd name="connsiteY1" fmla="*/ 0 h 1574555"/>
                  <a:gd name="connsiteX2" fmla="*/ 6746 w 1117712"/>
                  <a:gd name="connsiteY2" fmla="*/ 0 h 1574555"/>
                  <a:gd name="connsiteX3" fmla="*/ 27079 w 1117712"/>
                  <a:gd name="connsiteY3" fmla="*/ 0 h 1574555"/>
                  <a:gd name="connsiteX4" fmla="*/ 27079 w 1117712"/>
                  <a:gd name="connsiteY4" fmla="*/ 88549 h 1574555"/>
                  <a:gd name="connsiteX5" fmla="*/ 54159 w 1117712"/>
                  <a:gd name="connsiteY5" fmla="*/ 88549 h 1574555"/>
                  <a:gd name="connsiteX6" fmla="*/ 54159 w 1117712"/>
                  <a:gd name="connsiteY6" fmla="*/ 180457 h 1574555"/>
                  <a:gd name="connsiteX7" fmla="*/ 115159 w 1117712"/>
                  <a:gd name="connsiteY7" fmla="*/ 180457 h 1574555"/>
                  <a:gd name="connsiteX8" fmla="*/ 115159 w 1117712"/>
                  <a:gd name="connsiteY8" fmla="*/ 280404 h 1574555"/>
                  <a:gd name="connsiteX9" fmla="*/ 121905 w 1117712"/>
                  <a:gd name="connsiteY9" fmla="*/ 280404 h 1574555"/>
                  <a:gd name="connsiteX10" fmla="*/ 121905 w 1117712"/>
                  <a:gd name="connsiteY10" fmla="*/ 380351 h 1574555"/>
                  <a:gd name="connsiteX11" fmla="*/ 149031 w 1117712"/>
                  <a:gd name="connsiteY11" fmla="*/ 380351 h 1574555"/>
                  <a:gd name="connsiteX12" fmla="*/ 149031 w 1117712"/>
                  <a:gd name="connsiteY12" fmla="*/ 485277 h 1574555"/>
                  <a:gd name="connsiteX13" fmla="*/ 182904 w 1117712"/>
                  <a:gd name="connsiteY13" fmla="*/ 485277 h 1574555"/>
                  <a:gd name="connsiteX14" fmla="*/ 182904 w 1117712"/>
                  <a:gd name="connsiteY14" fmla="*/ 590264 h 1574555"/>
                  <a:gd name="connsiteX15" fmla="*/ 284476 w 1117712"/>
                  <a:gd name="connsiteY15" fmla="*/ 590264 h 1574555"/>
                  <a:gd name="connsiteX16" fmla="*/ 284476 w 1117712"/>
                  <a:gd name="connsiteY16" fmla="*/ 725186 h 1574555"/>
                  <a:gd name="connsiteX17" fmla="*/ 304809 w 1117712"/>
                  <a:gd name="connsiteY17" fmla="*/ 725186 h 1574555"/>
                  <a:gd name="connsiteX18" fmla="*/ 304809 w 1117712"/>
                  <a:gd name="connsiteY18" fmla="*/ 860109 h 1574555"/>
                  <a:gd name="connsiteX19" fmla="*/ 331936 w 1117712"/>
                  <a:gd name="connsiteY19" fmla="*/ 860109 h 1574555"/>
                  <a:gd name="connsiteX20" fmla="*/ 331936 w 1117712"/>
                  <a:gd name="connsiteY20" fmla="*/ 995031 h 1574555"/>
                  <a:gd name="connsiteX21" fmla="*/ 386095 w 1117712"/>
                  <a:gd name="connsiteY21" fmla="*/ 995031 h 1574555"/>
                  <a:gd name="connsiteX22" fmla="*/ 386095 w 1117712"/>
                  <a:gd name="connsiteY22" fmla="*/ 1159950 h 1574555"/>
                  <a:gd name="connsiteX23" fmla="*/ 467380 w 1117712"/>
                  <a:gd name="connsiteY23" fmla="*/ 1159950 h 1574555"/>
                  <a:gd name="connsiteX24" fmla="*/ 467380 w 1117712"/>
                  <a:gd name="connsiteY24" fmla="*/ 1348385 h 1574555"/>
                  <a:gd name="connsiteX25" fmla="*/ 568999 w 1117712"/>
                  <a:gd name="connsiteY25" fmla="*/ 1348385 h 1574555"/>
                  <a:gd name="connsiteX26" fmla="*/ 568999 w 1117712"/>
                  <a:gd name="connsiteY26" fmla="*/ 1574556 h 1574555"/>
                  <a:gd name="connsiteX27" fmla="*/ 1117712 w 1117712"/>
                  <a:gd name="connsiteY27" fmla="*/ 1574556 h 1574555"/>
                  <a:gd name="connsiteX28" fmla="*/ 1117712 w 1117712"/>
                  <a:gd name="connsiteY28" fmla="*/ 1574556 h 15745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1117712" h="1574555">
                    <a:moveTo>
                      <a:pt x="0" y="0"/>
                    </a:moveTo>
                    <a:lnTo>
                      <a:pt x="6746" y="0"/>
                    </a:lnTo>
                    <a:lnTo>
                      <a:pt x="6746" y="0"/>
                    </a:lnTo>
                    <a:lnTo>
                      <a:pt x="27079" y="0"/>
                    </a:lnTo>
                    <a:lnTo>
                      <a:pt x="27079" y="88549"/>
                    </a:lnTo>
                    <a:lnTo>
                      <a:pt x="54159" y="88549"/>
                    </a:lnTo>
                    <a:lnTo>
                      <a:pt x="54159" y="180457"/>
                    </a:lnTo>
                    <a:lnTo>
                      <a:pt x="115159" y="180457"/>
                    </a:lnTo>
                    <a:lnTo>
                      <a:pt x="115159" y="280404"/>
                    </a:lnTo>
                    <a:lnTo>
                      <a:pt x="121905" y="280404"/>
                    </a:lnTo>
                    <a:lnTo>
                      <a:pt x="121905" y="380351"/>
                    </a:lnTo>
                    <a:lnTo>
                      <a:pt x="149031" y="380351"/>
                    </a:lnTo>
                    <a:lnTo>
                      <a:pt x="149031" y="485277"/>
                    </a:lnTo>
                    <a:lnTo>
                      <a:pt x="182904" y="485277"/>
                    </a:lnTo>
                    <a:lnTo>
                      <a:pt x="182904" y="590264"/>
                    </a:lnTo>
                    <a:lnTo>
                      <a:pt x="284476" y="590264"/>
                    </a:lnTo>
                    <a:lnTo>
                      <a:pt x="284476" y="725186"/>
                    </a:lnTo>
                    <a:lnTo>
                      <a:pt x="304809" y="725186"/>
                    </a:lnTo>
                    <a:lnTo>
                      <a:pt x="304809" y="860109"/>
                    </a:lnTo>
                    <a:lnTo>
                      <a:pt x="331936" y="860109"/>
                    </a:lnTo>
                    <a:lnTo>
                      <a:pt x="331936" y="995031"/>
                    </a:lnTo>
                    <a:lnTo>
                      <a:pt x="386095" y="995031"/>
                    </a:lnTo>
                    <a:lnTo>
                      <a:pt x="386095" y="1159950"/>
                    </a:lnTo>
                    <a:lnTo>
                      <a:pt x="467380" y="1159950"/>
                    </a:lnTo>
                    <a:lnTo>
                      <a:pt x="467380" y="1348385"/>
                    </a:lnTo>
                    <a:lnTo>
                      <a:pt x="568999" y="1348385"/>
                    </a:lnTo>
                    <a:lnTo>
                      <a:pt x="568999" y="1574556"/>
                    </a:lnTo>
                    <a:lnTo>
                      <a:pt x="1117712" y="1574556"/>
                    </a:lnTo>
                    <a:lnTo>
                      <a:pt x="1117712" y="1574556"/>
                    </a:lnTo>
                  </a:path>
                </a:pathLst>
              </a:custGeom>
              <a:noFill/>
              <a:ln w="19050" cap="flat">
                <a:solidFill>
                  <a:schemeClr val="accent4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09" name="フリーフォーム 608">
                <a:extLst>
                  <a:ext uri="{FF2B5EF4-FFF2-40B4-BE49-F238E27FC236}">
                    <a16:creationId xmlns:a16="http://schemas.microsoft.com/office/drawing/2014/main" xmlns="" id="{17B4F81D-709B-EEA9-E22B-D5932B2FA1A1}"/>
                  </a:ext>
                </a:extLst>
              </p:cNvPr>
              <p:cNvSpPr/>
              <p:nvPr/>
            </p:nvSpPr>
            <p:spPr>
              <a:xfrm>
                <a:off x="6829758" y="6487965"/>
                <a:ext cx="379348" cy="1239559"/>
              </a:xfrm>
              <a:custGeom>
                <a:avLst/>
                <a:gdLst>
                  <a:gd name="connsiteX0" fmla="*/ 0 w 379348"/>
                  <a:gd name="connsiteY0" fmla="*/ 0 h 1239559"/>
                  <a:gd name="connsiteX1" fmla="*/ 6746 w 379348"/>
                  <a:gd name="connsiteY1" fmla="*/ 0 h 1239559"/>
                  <a:gd name="connsiteX2" fmla="*/ 6746 w 379348"/>
                  <a:gd name="connsiteY2" fmla="*/ 0 h 1239559"/>
                  <a:gd name="connsiteX3" fmla="*/ 264190 w 379348"/>
                  <a:gd name="connsiteY3" fmla="*/ 0 h 1239559"/>
                  <a:gd name="connsiteX4" fmla="*/ 264190 w 379348"/>
                  <a:gd name="connsiteY4" fmla="*/ 1239559 h 1239559"/>
                  <a:gd name="connsiteX5" fmla="*/ 379348 w 379348"/>
                  <a:gd name="connsiteY5" fmla="*/ 1239559 h 1239559"/>
                  <a:gd name="connsiteX6" fmla="*/ 379348 w 379348"/>
                  <a:gd name="connsiteY6" fmla="*/ 1239559 h 12395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379348" h="1239559">
                    <a:moveTo>
                      <a:pt x="0" y="0"/>
                    </a:moveTo>
                    <a:lnTo>
                      <a:pt x="6746" y="0"/>
                    </a:lnTo>
                    <a:lnTo>
                      <a:pt x="6746" y="0"/>
                    </a:lnTo>
                    <a:lnTo>
                      <a:pt x="264190" y="0"/>
                    </a:lnTo>
                    <a:lnTo>
                      <a:pt x="264190" y="1239559"/>
                    </a:lnTo>
                    <a:lnTo>
                      <a:pt x="379348" y="1239559"/>
                    </a:lnTo>
                    <a:lnTo>
                      <a:pt x="379348" y="1239559"/>
                    </a:lnTo>
                  </a:path>
                </a:pathLst>
              </a:custGeom>
              <a:noFill/>
              <a:ln w="19050" cap="flat">
                <a:solidFill>
                  <a:srgbClr val="00B05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10" name="フリーフォーム 609">
                <a:extLst>
                  <a:ext uri="{FF2B5EF4-FFF2-40B4-BE49-F238E27FC236}">
                    <a16:creationId xmlns:a16="http://schemas.microsoft.com/office/drawing/2014/main" xmlns="" id="{EB2A4B3E-5496-5891-056E-8CA0F3CB54B3}"/>
                  </a:ext>
                </a:extLst>
              </p:cNvPr>
              <p:cNvSpPr/>
              <p:nvPr/>
            </p:nvSpPr>
            <p:spPr>
              <a:xfrm>
                <a:off x="6829758" y="6487965"/>
                <a:ext cx="2533534" cy="2479178"/>
              </a:xfrm>
              <a:custGeom>
                <a:avLst/>
                <a:gdLst>
                  <a:gd name="connsiteX0" fmla="*/ 0 w 2533534"/>
                  <a:gd name="connsiteY0" fmla="*/ 0 h 2479178"/>
                  <a:gd name="connsiteX1" fmla="*/ 6746 w 2533534"/>
                  <a:gd name="connsiteY1" fmla="*/ 0 h 2479178"/>
                  <a:gd name="connsiteX2" fmla="*/ 6746 w 2533534"/>
                  <a:gd name="connsiteY2" fmla="*/ 60472 h 2479178"/>
                  <a:gd name="connsiteX3" fmla="*/ 13540 w 2533534"/>
                  <a:gd name="connsiteY3" fmla="*/ 60472 h 2479178"/>
                  <a:gd name="connsiteX4" fmla="*/ 13540 w 2533534"/>
                  <a:gd name="connsiteY4" fmla="*/ 120944 h 2479178"/>
                  <a:gd name="connsiteX5" fmla="*/ 88032 w 2533534"/>
                  <a:gd name="connsiteY5" fmla="*/ 120944 h 2479178"/>
                  <a:gd name="connsiteX6" fmla="*/ 88032 w 2533534"/>
                  <a:gd name="connsiteY6" fmla="*/ 184656 h 2479178"/>
                  <a:gd name="connsiteX7" fmla="*/ 101572 w 2533534"/>
                  <a:gd name="connsiteY7" fmla="*/ 184656 h 2479178"/>
                  <a:gd name="connsiteX8" fmla="*/ 101619 w 2533534"/>
                  <a:gd name="connsiteY8" fmla="*/ 248428 h 2479178"/>
                  <a:gd name="connsiteX9" fmla="*/ 121905 w 2533534"/>
                  <a:gd name="connsiteY9" fmla="*/ 248428 h 2479178"/>
                  <a:gd name="connsiteX10" fmla="*/ 121905 w 2533534"/>
                  <a:gd name="connsiteY10" fmla="*/ 312140 h 2479178"/>
                  <a:gd name="connsiteX11" fmla="*/ 155778 w 2533534"/>
                  <a:gd name="connsiteY11" fmla="*/ 312140 h 2479178"/>
                  <a:gd name="connsiteX12" fmla="*/ 155778 w 2533534"/>
                  <a:gd name="connsiteY12" fmla="*/ 379871 h 2479178"/>
                  <a:gd name="connsiteX13" fmla="*/ 189651 w 2533534"/>
                  <a:gd name="connsiteY13" fmla="*/ 379871 h 2479178"/>
                  <a:gd name="connsiteX14" fmla="*/ 189651 w 2533534"/>
                  <a:gd name="connsiteY14" fmla="*/ 524632 h 2479178"/>
                  <a:gd name="connsiteX15" fmla="*/ 237063 w 2533534"/>
                  <a:gd name="connsiteY15" fmla="*/ 524632 h 2479178"/>
                  <a:gd name="connsiteX16" fmla="*/ 237063 w 2533534"/>
                  <a:gd name="connsiteY16" fmla="*/ 599802 h 2479178"/>
                  <a:gd name="connsiteX17" fmla="*/ 284476 w 2533534"/>
                  <a:gd name="connsiteY17" fmla="*/ 599802 h 2479178"/>
                  <a:gd name="connsiteX18" fmla="*/ 284476 w 2533534"/>
                  <a:gd name="connsiteY18" fmla="*/ 678092 h 2479178"/>
                  <a:gd name="connsiteX19" fmla="*/ 318349 w 2533534"/>
                  <a:gd name="connsiteY19" fmla="*/ 678092 h 2479178"/>
                  <a:gd name="connsiteX20" fmla="*/ 318349 w 2533534"/>
                  <a:gd name="connsiteY20" fmla="*/ 759982 h 2479178"/>
                  <a:gd name="connsiteX21" fmla="*/ 325142 w 2533534"/>
                  <a:gd name="connsiteY21" fmla="*/ 759982 h 2479178"/>
                  <a:gd name="connsiteX22" fmla="*/ 325142 w 2533534"/>
                  <a:gd name="connsiteY22" fmla="*/ 841871 h 2479178"/>
                  <a:gd name="connsiteX23" fmla="*/ 338682 w 2533534"/>
                  <a:gd name="connsiteY23" fmla="*/ 841871 h 2479178"/>
                  <a:gd name="connsiteX24" fmla="*/ 338682 w 2533534"/>
                  <a:gd name="connsiteY24" fmla="*/ 923700 h 2479178"/>
                  <a:gd name="connsiteX25" fmla="*/ 413221 w 2533534"/>
                  <a:gd name="connsiteY25" fmla="*/ 923700 h 2479178"/>
                  <a:gd name="connsiteX26" fmla="*/ 413221 w 2533534"/>
                  <a:gd name="connsiteY26" fmla="*/ 1015188 h 2479178"/>
                  <a:gd name="connsiteX27" fmla="*/ 426761 w 2533534"/>
                  <a:gd name="connsiteY27" fmla="*/ 1015188 h 2479178"/>
                  <a:gd name="connsiteX28" fmla="*/ 426761 w 2533534"/>
                  <a:gd name="connsiteY28" fmla="*/ 1106737 h 2479178"/>
                  <a:gd name="connsiteX29" fmla="*/ 528380 w 2533534"/>
                  <a:gd name="connsiteY29" fmla="*/ 1106737 h 2479178"/>
                  <a:gd name="connsiteX30" fmla="*/ 528380 w 2533534"/>
                  <a:gd name="connsiteY30" fmla="*/ 1221082 h 2479178"/>
                  <a:gd name="connsiteX31" fmla="*/ 596126 w 2533534"/>
                  <a:gd name="connsiteY31" fmla="*/ 1221082 h 2479178"/>
                  <a:gd name="connsiteX32" fmla="*/ 596126 w 2533534"/>
                  <a:gd name="connsiteY32" fmla="*/ 1335427 h 2479178"/>
                  <a:gd name="connsiteX33" fmla="*/ 663824 w 2533534"/>
                  <a:gd name="connsiteY33" fmla="*/ 1335427 h 2479178"/>
                  <a:gd name="connsiteX34" fmla="*/ 663872 w 2533534"/>
                  <a:gd name="connsiteY34" fmla="*/ 1449832 h 2479178"/>
                  <a:gd name="connsiteX35" fmla="*/ 738364 w 2533534"/>
                  <a:gd name="connsiteY35" fmla="*/ 1449832 h 2479178"/>
                  <a:gd name="connsiteX36" fmla="*/ 738364 w 2533534"/>
                  <a:gd name="connsiteY36" fmla="*/ 1564177 h 2479178"/>
                  <a:gd name="connsiteX37" fmla="*/ 772237 w 2533534"/>
                  <a:gd name="connsiteY37" fmla="*/ 1564177 h 2479178"/>
                  <a:gd name="connsiteX38" fmla="*/ 772237 w 2533534"/>
                  <a:gd name="connsiteY38" fmla="*/ 1678582 h 2479178"/>
                  <a:gd name="connsiteX39" fmla="*/ 1131252 w 2533534"/>
                  <a:gd name="connsiteY39" fmla="*/ 1678582 h 2479178"/>
                  <a:gd name="connsiteX40" fmla="*/ 1131252 w 2533534"/>
                  <a:gd name="connsiteY40" fmla="*/ 1838702 h 2479178"/>
                  <a:gd name="connsiteX41" fmla="*/ 2533534 w 2533534"/>
                  <a:gd name="connsiteY41" fmla="*/ 1838702 h 2479178"/>
                  <a:gd name="connsiteX42" fmla="*/ 2533534 w 2533534"/>
                  <a:gd name="connsiteY42" fmla="*/ 2479179 h 24791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</a:cxnLst>
                <a:rect l="l" t="t" r="r" b="b"/>
                <a:pathLst>
                  <a:path w="2533534" h="2479178">
                    <a:moveTo>
                      <a:pt x="0" y="0"/>
                    </a:moveTo>
                    <a:lnTo>
                      <a:pt x="6746" y="0"/>
                    </a:lnTo>
                    <a:lnTo>
                      <a:pt x="6746" y="60472"/>
                    </a:lnTo>
                    <a:lnTo>
                      <a:pt x="13540" y="60472"/>
                    </a:lnTo>
                    <a:lnTo>
                      <a:pt x="13540" y="120944"/>
                    </a:lnTo>
                    <a:lnTo>
                      <a:pt x="88032" y="120944"/>
                    </a:lnTo>
                    <a:lnTo>
                      <a:pt x="88032" y="184656"/>
                    </a:lnTo>
                    <a:lnTo>
                      <a:pt x="101572" y="184656"/>
                    </a:lnTo>
                    <a:lnTo>
                      <a:pt x="101619" y="248428"/>
                    </a:lnTo>
                    <a:lnTo>
                      <a:pt x="121905" y="248428"/>
                    </a:lnTo>
                    <a:lnTo>
                      <a:pt x="121905" y="312140"/>
                    </a:lnTo>
                    <a:lnTo>
                      <a:pt x="155778" y="312140"/>
                    </a:lnTo>
                    <a:lnTo>
                      <a:pt x="155778" y="379871"/>
                    </a:lnTo>
                    <a:lnTo>
                      <a:pt x="189651" y="379871"/>
                    </a:lnTo>
                    <a:lnTo>
                      <a:pt x="189651" y="524632"/>
                    </a:lnTo>
                    <a:lnTo>
                      <a:pt x="237063" y="524632"/>
                    </a:lnTo>
                    <a:lnTo>
                      <a:pt x="237063" y="599802"/>
                    </a:lnTo>
                    <a:lnTo>
                      <a:pt x="284476" y="599802"/>
                    </a:lnTo>
                    <a:lnTo>
                      <a:pt x="284476" y="678092"/>
                    </a:lnTo>
                    <a:lnTo>
                      <a:pt x="318349" y="678092"/>
                    </a:lnTo>
                    <a:lnTo>
                      <a:pt x="318349" y="759982"/>
                    </a:lnTo>
                    <a:lnTo>
                      <a:pt x="325142" y="759982"/>
                    </a:lnTo>
                    <a:lnTo>
                      <a:pt x="325142" y="841871"/>
                    </a:lnTo>
                    <a:lnTo>
                      <a:pt x="338682" y="841871"/>
                    </a:lnTo>
                    <a:lnTo>
                      <a:pt x="338682" y="923700"/>
                    </a:lnTo>
                    <a:lnTo>
                      <a:pt x="413221" y="923700"/>
                    </a:lnTo>
                    <a:lnTo>
                      <a:pt x="413221" y="1015188"/>
                    </a:lnTo>
                    <a:lnTo>
                      <a:pt x="426761" y="1015188"/>
                    </a:lnTo>
                    <a:lnTo>
                      <a:pt x="426761" y="1106737"/>
                    </a:lnTo>
                    <a:lnTo>
                      <a:pt x="528380" y="1106737"/>
                    </a:lnTo>
                    <a:lnTo>
                      <a:pt x="528380" y="1221082"/>
                    </a:lnTo>
                    <a:lnTo>
                      <a:pt x="596126" y="1221082"/>
                    </a:lnTo>
                    <a:lnTo>
                      <a:pt x="596126" y="1335427"/>
                    </a:lnTo>
                    <a:lnTo>
                      <a:pt x="663824" y="1335427"/>
                    </a:lnTo>
                    <a:lnTo>
                      <a:pt x="663872" y="1449832"/>
                    </a:lnTo>
                    <a:lnTo>
                      <a:pt x="738364" y="1449832"/>
                    </a:lnTo>
                    <a:lnTo>
                      <a:pt x="738364" y="1564177"/>
                    </a:lnTo>
                    <a:lnTo>
                      <a:pt x="772237" y="1564177"/>
                    </a:lnTo>
                    <a:lnTo>
                      <a:pt x="772237" y="1678582"/>
                    </a:lnTo>
                    <a:lnTo>
                      <a:pt x="1131252" y="1678582"/>
                    </a:lnTo>
                    <a:lnTo>
                      <a:pt x="1131252" y="1838702"/>
                    </a:lnTo>
                    <a:lnTo>
                      <a:pt x="2533534" y="1838702"/>
                    </a:lnTo>
                    <a:lnTo>
                      <a:pt x="2533534" y="2479179"/>
                    </a:lnTo>
                  </a:path>
                </a:pathLst>
              </a:custGeom>
              <a:noFill/>
              <a:ln w="19050" cap="flat">
                <a:solidFill>
                  <a:srgbClr val="C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11" name="フリーフォーム 610">
                <a:extLst>
                  <a:ext uri="{FF2B5EF4-FFF2-40B4-BE49-F238E27FC236}">
                    <a16:creationId xmlns:a16="http://schemas.microsoft.com/office/drawing/2014/main" xmlns="" id="{FAEA185A-E4F7-107A-C893-DCA9C12961F5}"/>
                  </a:ext>
                </a:extLst>
              </p:cNvPr>
              <p:cNvSpPr/>
              <p:nvPr/>
            </p:nvSpPr>
            <p:spPr>
              <a:xfrm>
                <a:off x="6829758" y="6487965"/>
                <a:ext cx="690951" cy="1704439"/>
              </a:xfrm>
              <a:custGeom>
                <a:avLst/>
                <a:gdLst>
                  <a:gd name="connsiteX0" fmla="*/ 0 w 690951"/>
                  <a:gd name="connsiteY0" fmla="*/ 0 h 1704439"/>
                  <a:gd name="connsiteX1" fmla="*/ 6746 w 690951"/>
                  <a:gd name="connsiteY1" fmla="*/ 0 h 1704439"/>
                  <a:gd name="connsiteX2" fmla="*/ 6746 w 690951"/>
                  <a:gd name="connsiteY2" fmla="*/ 0 h 1704439"/>
                  <a:gd name="connsiteX3" fmla="*/ 40619 w 690951"/>
                  <a:gd name="connsiteY3" fmla="*/ 0 h 1704439"/>
                  <a:gd name="connsiteX4" fmla="*/ 40619 w 690951"/>
                  <a:gd name="connsiteY4" fmla="*/ 413166 h 1704439"/>
                  <a:gd name="connsiteX5" fmla="*/ 149031 w 690951"/>
                  <a:gd name="connsiteY5" fmla="*/ 413166 h 1704439"/>
                  <a:gd name="connsiteX6" fmla="*/ 149031 w 690951"/>
                  <a:gd name="connsiteY6" fmla="*/ 671433 h 1704439"/>
                  <a:gd name="connsiteX7" fmla="*/ 176111 w 690951"/>
                  <a:gd name="connsiteY7" fmla="*/ 671433 h 1704439"/>
                  <a:gd name="connsiteX8" fmla="*/ 176111 w 690951"/>
                  <a:gd name="connsiteY8" fmla="*/ 1187906 h 1704439"/>
                  <a:gd name="connsiteX9" fmla="*/ 203190 w 690951"/>
                  <a:gd name="connsiteY9" fmla="*/ 1187906 h 1704439"/>
                  <a:gd name="connsiteX10" fmla="*/ 203190 w 690951"/>
                  <a:gd name="connsiteY10" fmla="*/ 1446173 h 1704439"/>
                  <a:gd name="connsiteX11" fmla="*/ 230317 w 690951"/>
                  <a:gd name="connsiteY11" fmla="*/ 1446173 h 1704439"/>
                  <a:gd name="connsiteX12" fmla="*/ 230317 w 690951"/>
                  <a:gd name="connsiteY12" fmla="*/ 1704439 h 1704439"/>
                  <a:gd name="connsiteX13" fmla="*/ 690951 w 690951"/>
                  <a:gd name="connsiteY13" fmla="*/ 1704439 h 1704439"/>
                  <a:gd name="connsiteX14" fmla="*/ 690951 w 690951"/>
                  <a:gd name="connsiteY14" fmla="*/ 1704439 h 17044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690951" h="1704439">
                    <a:moveTo>
                      <a:pt x="0" y="0"/>
                    </a:moveTo>
                    <a:lnTo>
                      <a:pt x="6746" y="0"/>
                    </a:lnTo>
                    <a:lnTo>
                      <a:pt x="6746" y="0"/>
                    </a:lnTo>
                    <a:lnTo>
                      <a:pt x="40619" y="0"/>
                    </a:lnTo>
                    <a:lnTo>
                      <a:pt x="40619" y="413166"/>
                    </a:lnTo>
                    <a:lnTo>
                      <a:pt x="149031" y="413166"/>
                    </a:lnTo>
                    <a:lnTo>
                      <a:pt x="149031" y="671433"/>
                    </a:lnTo>
                    <a:lnTo>
                      <a:pt x="176111" y="671433"/>
                    </a:lnTo>
                    <a:lnTo>
                      <a:pt x="176111" y="1187906"/>
                    </a:lnTo>
                    <a:lnTo>
                      <a:pt x="203190" y="1187906"/>
                    </a:lnTo>
                    <a:lnTo>
                      <a:pt x="203190" y="1446173"/>
                    </a:lnTo>
                    <a:lnTo>
                      <a:pt x="230317" y="1446173"/>
                    </a:lnTo>
                    <a:lnTo>
                      <a:pt x="230317" y="1704439"/>
                    </a:lnTo>
                    <a:lnTo>
                      <a:pt x="690951" y="1704439"/>
                    </a:lnTo>
                    <a:lnTo>
                      <a:pt x="690951" y="1704439"/>
                    </a:lnTo>
                  </a:path>
                </a:pathLst>
              </a:custGeom>
              <a:noFill/>
              <a:ln w="19050" cap="flat">
                <a:solidFill>
                  <a:schemeClr val="accent5">
                    <a:lumMod val="50000"/>
                  </a:schemeClr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13" name="フリーフォーム 612">
                <a:extLst>
                  <a:ext uri="{FF2B5EF4-FFF2-40B4-BE49-F238E27FC236}">
                    <a16:creationId xmlns:a16="http://schemas.microsoft.com/office/drawing/2014/main" xmlns="" id="{54B5EA9D-FB94-4865-11C9-FD0A5C943A43}"/>
                  </a:ext>
                </a:extLst>
              </p:cNvPr>
              <p:cNvSpPr/>
              <p:nvPr/>
            </p:nvSpPr>
            <p:spPr>
              <a:xfrm>
                <a:off x="6857026" y="6564615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14" name="フリーフォーム 613">
                <a:extLst>
                  <a:ext uri="{FF2B5EF4-FFF2-40B4-BE49-F238E27FC236}">
                    <a16:creationId xmlns:a16="http://schemas.microsoft.com/office/drawing/2014/main" xmlns="" id="{4F286B20-369D-8722-EA60-B52E5612E520}"/>
                  </a:ext>
                </a:extLst>
              </p:cNvPr>
              <p:cNvSpPr/>
              <p:nvPr/>
            </p:nvSpPr>
            <p:spPr>
              <a:xfrm>
                <a:off x="6857026" y="6564615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15" name="フリーフォーム 614">
                <a:extLst>
                  <a:ext uri="{FF2B5EF4-FFF2-40B4-BE49-F238E27FC236}">
                    <a16:creationId xmlns:a16="http://schemas.microsoft.com/office/drawing/2014/main" xmlns="" id="{04FEBA44-0519-3B93-078F-9FF90C32F581}"/>
                  </a:ext>
                </a:extLst>
              </p:cNvPr>
              <p:cNvSpPr/>
              <p:nvPr/>
            </p:nvSpPr>
            <p:spPr>
              <a:xfrm>
                <a:off x="6924772" y="6656584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16" name="フリーフォーム 615">
                <a:extLst>
                  <a:ext uri="{FF2B5EF4-FFF2-40B4-BE49-F238E27FC236}">
                    <a16:creationId xmlns:a16="http://schemas.microsoft.com/office/drawing/2014/main" xmlns="" id="{A0FAD8F9-B9E5-49AE-B8FD-7E1F83008AEB}"/>
                  </a:ext>
                </a:extLst>
              </p:cNvPr>
              <p:cNvSpPr/>
              <p:nvPr/>
            </p:nvSpPr>
            <p:spPr>
              <a:xfrm>
                <a:off x="6924772" y="6656584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17" name="フリーフォーム 616">
                <a:extLst>
                  <a:ext uri="{FF2B5EF4-FFF2-40B4-BE49-F238E27FC236}">
                    <a16:creationId xmlns:a16="http://schemas.microsoft.com/office/drawing/2014/main" xmlns="" id="{C9BB8905-508A-5BF2-A298-D33E10ED15AD}"/>
                  </a:ext>
                </a:extLst>
              </p:cNvPr>
              <p:cNvSpPr/>
              <p:nvPr/>
            </p:nvSpPr>
            <p:spPr>
              <a:xfrm>
                <a:off x="6924772" y="6656584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18" name="フリーフォーム 617">
                <a:extLst>
                  <a:ext uri="{FF2B5EF4-FFF2-40B4-BE49-F238E27FC236}">
                    <a16:creationId xmlns:a16="http://schemas.microsoft.com/office/drawing/2014/main" xmlns="" id="{9BB8B50E-E7F4-D35A-0921-954B32776AD6}"/>
                  </a:ext>
                </a:extLst>
              </p:cNvPr>
              <p:cNvSpPr/>
              <p:nvPr/>
            </p:nvSpPr>
            <p:spPr>
              <a:xfrm>
                <a:off x="6924772" y="6656584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19" name="フリーフォーム 618">
                <a:extLst>
                  <a:ext uri="{FF2B5EF4-FFF2-40B4-BE49-F238E27FC236}">
                    <a16:creationId xmlns:a16="http://schemas.microsoft.com/office/drawing/2014/main" xmlns="" id="{968B00DE-E456-3F63-7E7A-5BEF46168654}"/>
                  </a:ext>
                </a:extLst>
              </p:cNvPr>
              <p:cNvSpPr/>
              <p:nvPr/>
            </p:nvSpPr>
            <p:spPr>
              <a:xfrm>
                <a:off x="6958645" y="685641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0" name="フリーフォーム 619">
                <a:extLst>
                  <a:ext uri="{FF2B5EF4-FFF2-40B4-BE49-F238E27FC236}">
                    <a16:creationId xmlns:a16="http://schemas.microsoft.com/office/drawing/2014/main" xmlns="" id="{1C2BAAB2-AC0F-CD29-2FEE-896283742FC0}"/>
                  </a:ext>
                </a:extLst>
              </p:cNvPr>
              <p:cNvSpPr/>
              <p:nvPr/>
            </p:nvSpPr>
            <p:spPr>
              <a:xfrm>
                <a:off x="6958645" y="685641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1" name="フリーフォーム 620">
                <a:extLst>
                  <a:ext uri="{FF2B5EF4-FFF2-40B4-BE49-F238E27FC236}">
                    <a16:creationId xmlns:a16="http://schemas.microsoft.com/office/drawing/2014/main" xmlns="" id="{E3E5B18E-6F4D-1B5D-211C-1D7BBA948332}"/>
                  </a:ext>
                </a:extLst>
              </p:cNvPr>
              <p:cNvSpPr/>
              <p:nvPr/>
            </p:nvSpPr>
            <p:spPr>
              <a:xfrm>
                <a:off x="6999311" y="7066330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2" name="フリーフォーム 621">
                <a:extLst>
                  <a:ext uri="{FF2B5EF4-FFF2-40B4-BE49-F238E27FC236}">
                    <a16:creationId xmlns:a16="http://schemas.microsoft.com/office/drawing/2014/main" xmlns="" id="{6868387E-FA54-6584-65CA-6A9903B562D3}"/>
                  </a:ext>
                </a:extLst>
              </p:cNvPr>
              <p:cNvSpPr/>
              <p:nvPr/>
            </p:nvSpPr>
            <p:spPr>
              <a:xfrm>
                <a:off x="6999311" y="7066330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3" name="フリーフォーム 622">
                <a:extLst>
                  <a:ext uri="{FF2B5EF4-FFF2-40B4-BE49-F238E27FC236}">
                    <a16:creationId xmlns:a16="http://schemas.microsoft.com/office/drawing/2014/main" xmlns="" id="{CA736606-AD4D-06F4-BDE4-56E09C1B2D26}"/>
                  </a:ext>
                </a:extLst>
              </p:cNvPr>
              <p:cNvSpPr/>
              <p:nvPr/>
            </p:nvSpPr>
            <p:spPr>
              <a:xfrm>
                <a:off x="7012851" y="7066330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4" name="フリーフォーム 623">
                <a:extLst>
                  <a:ext uri="{FF2B5EF4-FFF2-40B4-BE49-F238E27FC236}">
                    <a16:creationId xmlns:a16="http://schemas.microsoft.com/office/drawing/2014/main" xmlns="" id="{D407051F-3FD6-D85C-8FDA-77267FF715A3}"/>
                  </a:ext>
                </a:extLst>
              </p:cNvPr>
              <p:cNvSpPr/>
              <p:nvPr/>
            </p:nvSpPr>
            <p:spPr>
              <a:xfrm>
                <a:off x="7012851" y="7066330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5" name="フリーフォーム 624">
                <a:extLst>
                  <a:ext uri="{FF2B5EF4-FFF2-40B4-BE49-F238E27FC236}">
                    <a16:creationId xmlns:a16="http://schemas.microsoft.com/office/drawing/2014/main" xmlns="" id="{E15A6D45-8D19-7CB1-0161-6C235C50D73B}"/>
                  </a:ext>
                </a:extLst>
              </p:cNvPr>
              <p:cNvSpPr/>
              <p:nvPr/>
            </p:nvSpPr>
            <p:spPr>
              <a:xfrm>
                <a:off x="7012851" y="7066330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6" name="フリーフォーム 625">
                <a:extLst>
                  <a:ext uri="{FF2B5EF4-FFF2-40B4-BE49-F238E27FC236}">
                    <a16:creationId xmlns:a16="http://schemas.microsoft.com/office/drawing/2014/main" xmlns="" id="{E8E0DE5E-E487-74F5-6682-28538D03D383}"/>
                  </a:ext>
                </a:extLst>
              </p:cNvPr>
              <p:cNvSpPr/>
              <p:nvPr/>
            </p:nvSpPr>
            <p:spPr>
              <a:xfrm>
                <a:off x="7012851" y="7066330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7" name="フリーフォーム 626">
                <a:extLst>
                  <a:ext uri="{FF2B5EF4-FFF2-40B4-BE49-F238E27FC236}">
                    <a16:creationId xmlns:a16="http://schemas.microsoft.com/office/drawing/2014/main" xmlns="" id="{6BDA3064-8BB6-E8A4-0602-01A923C7D842}"/>
                  </a:ext>
                </a:extLst>
              </p:cNvPr>
              <p:cNvSpPr/>
              <p:nvPr/>
            </p:nvSpPr>
            <p:spPr>
              <a:xfrm>
                <a:off x="7012851" y="7066330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8" name="フリーフォーム 627">
                <a:extLst>
                  <a:ext uri="{FF2B5EF4-FFF2-40B4-BE49-F238E27FC236}">
                    <a16:creationId xmlns:a16="http://schemas.microsoft.com/office/drawing/2014/main" xmlns="" id="{539D2C44-CD6E-E609-A9E9-ACFFE97E8EE4}"/>
                  </a:ext>
                </a:extLst>
              </p:cNvPr>
              <p:cNvSpPr/>
              <p:nvPr/>
            </p:nvSpPr>
            <p:spPr>
              <a:xfrm>
                <a:off x="7012851" y="7066330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29" name="フリーフォーム 628">
                <a:extLst>
                  <a:ext uri="{FF2B5EF4-FFF2-40B4-BE49-F238E27FC236}">
                    <a16:creationId xmlns:a16="http://schemas.microsoft.com/office/drawing/2014/main" xmlns="" id="{F111E62C-BCC7-BED6-D995-3B81B785C7CB}"/>
                  </a:ext>
                </a:extLst>
              </p:cNvPr>
              <p:cNvSpPr/>
              <p:nvPr/>
            </p:nvSpPr>
            <p:spPr>
              <a:xfrm>
                <a:off x="7175422" y="747109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30" name="フリーフォーム 629">
                <a:extLst>
                  <a:ext uri="{FF2B5EF4-FFF2-40B4-BE49-F238E27FC236}">
                    <a16:creationId xmlns:a16="http://schemas.microsoft.com/office/drawing/2014/main" xmlns="" id="{BB628363-5C3A-0822-C70D-455790C0A762}"/>
                  </a:ext>
                </a:extLst>
              </p:cNvPr>
              <p:cNvSpPr/>
              <p:nvPr/>
            </p:nvSpPr>
            <p:spPr>
              <a:xfrm>
                <a:off x="7175422" y="747109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31" name="フリーフォーム 630">
                <a:extLst>
                  <a:ext uri="{FF2B5EF4-FFF2-40B4-BE49-F238E27FC236}">
                    <a16:creationId xmlns:a16="http://schemas.microsoft.com/office/drawing/2014/main" xmlns="" id="{B26388BB-900F-B977-0C86-615CDFCAC569}"/>
                  </a:ext>
                </a:extLst>
              </p:cNvPr>
              <p:cNvSpPr/>
              <p:nvPr/>
            </p:nvSpPr>
            <p:spPr>
              <a:xfrm>
                <a:off x="7175422" y="747109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32" name="フリーフォーム 631">
                <a:extLst>
                  <a:ext uri="{FF2B5EF4-FFF2-40B4-BE49-F238E27FC236}">
                    <a16:creationId xmlns:a16="http://schemas.microsoft.com/office/drawing/2014/main" xmlns="" id="{1407DDDC-098B-E6C1-73B5-EA5115FBCFB9}"/>
                  </a:ext>
                </a:extLst>
              </p:cNvPr>
              <p:cNvSpPr/>
              <p:nvPr/>
            </p:nvSpPr>
            <p:spPr>
              <a:xfrm>
                <a:off x="7175422" y="747109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33" name="フリーフォーム 632">
                <a:extLst>
                  <a:ext uri="{FF2B5EF4-FFF2-40B4-BE49-F238E27FC236}">
                    <a16:creationId xmlns:a16="http://schemas.microsoft.com/office/drawing/2014/main" xmlns="" id="{AA8806BD-050B-2937-9CE4-3E022FCF3CE0}"/>
                  </a:ext>
                </a:extLst>
              </p:cNvPr>
              <p:cNvSpPr/>
              <p:nvPr/>
            </p:nvSpPr>
            <p:spPr>
              <a:xfrm>
                <a:off x="7243168" y="763601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78 h 33895"/>
                  <a:gd name="connsiteX2" fmla="*/ 13351 w 26702"/>
                  <a:gd name="connsiteY2" fmla="*/ 33896 h 33895"/>
                  <a:gd name="connsiteX3" fmla="*/ 0 w 26702"/>
                  <a:gd name="connsiteY3" fmla="*/ 1697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89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34" name="フリーフォーム 633">
                <a:extLst>
                  <a:ext uri="{FF2B5EF4-FFF2-40B4-BE49-F238E27FC236}">
                    <a16:creationId xmlns:a16="http://schemas.microsoft.com/office/drawing/2014/main" xmlns="" id="{3A6B1722-06F2-F106-8641-A7865B104912}"/>
                  </a:ext>
                </a:extLst>
              </p:cNvPr>
              <p:cNvSpPr/>
              <p:nvPr/>
            </p:nvSpPr>
            <p:spPr>
              <a:xfrm>
                <a:off x="7243168" y="763601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78 h 33895"/>
                  <a:gd name="connsiteX2" fmla="*/ 13351 w 26702"/>
                  <a:gd name="connsiteY2" fmla="*/ 33896 h 33895"/>
                  <a:gd name="connsiteX3" fmla="*/ 0 w 26702"/>
                  <a:gd name="connsiteY3" fmla="*/ 1697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89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35" name="フリーフォーム 634">
                <a:extLst>
                  <a:ext uri="{FF2B5EF4-FFF2-40B4-BE49-F238E27FC236}">
                    <a16:creationId xmlns:a16="http://schemas.microsoft.com/office/drawing/2014/main" xmlns="" id="{D0DFBE09-378E-D29E-18CB-0B312886F308}"/>
                  </a:ext>
                </a:extLst>
              </p:cNvPr>
              <p:cNvSpPr/>
              <p:nvPr/>
            </p:nvSpPr>
            <p:spPr>
              <a:xfrm>
                <a:off x="7365120" y="7824452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36" name="フリーフォーム 635">
                <a:extLst>
                  <a:ext uri="{FF2B5EF4-FFF2-40B4-BE49-F238E27FC236}">
                    <a16:creationId xmlns:a16="http://schemas.microsoft.com/office/drawing/2014/main" xmlns="" id="{98F6334D-0EE2-651E-DA07-3A9E18D5ACBE}"/>
                  </a:ext>
                </a:extLst>
              </p:cNvPr>
              <p:cNvSpPr/>
              <p:nvPr/>
            </p:nvSpPr>
            <p:spPr>
              <a:xfrm>
                <a:off x="7365120" y="7824452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37" name="フリーフォーム 636">
                <a:extLst>
                  <a:ext uri="{FF2B5EF4-FFF2-40B4-BE49-F238E27FC236}">
                    <a16:creationId xmlns:a16="http://schemas.microsoft.com/office/drawing/2014/main" xmlns="" id="{E3695347-8D20-3309-5471-3EE3F8B24704}"/>
                  </a:ext>
                </a:extLst>
              </p:cNvPr>
              <p:cNvSpPr/>
              <p:nvPr/>
            </p:nvSpPr>
            <p:spPr>
              <a:xfrm>
                <a:off x="7439612" y="8050623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77" name="フリーフォーム 676">
                <a:extLst>
                  <a:ext uri="{FF2B5EF4-FFF2-40B4-BE49-F238E27FC236}">
                    <a16:creationId xmlns:a16="http://schemas.microsoft.com/office/drawing/2014/main" xmlns="" id="{FD0577BA-4545-59C9-FD96-FF1487E5A629}"/>
                  </a:ext>
                </a:extLst>
              </p:cNvPr>
              <p:cNvSpPr/>
              <p:nvPr/>
            </p:nvSpPr>
            <p:spPr>
              <a:xfrm>
                <a:off x="7439612" y="8050623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79" name="フリーフォーム 678">
                <a:extLst>
                  <a:ext uri="{FF2B5EF4-FFF2-40B4-BE49-F238E27FC236}">
                    <a16:creationId xmlns:a16="http://schemas.microsoft.com/office/drawing/2014/main" xmlns="" id="{C80AEBBA-C324-3A24-5C61-F5CB8DBFD201}"/>
                  </a:ext>
                </a:extLst>
              </p:cNvPr>
              <p:cNvSpPr/>
              <p:nvPr/>
            </p:nvSpPr>
            <p:spPr>
              <a:xfrm>
                <a:off x="7480278" y="8050623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85" name="フリーフォーム 684">
                <a:extLst>
                  <a:ext uri="{FF2B5EF4-FFF2-40B4-BE49-F238E27FC236}">
                    <a16:creationId xmlns:a16="http://schemas.microsoft.com/office/drawing/2014/main" xmlns="" id="{49677EAE-D6CD-6C57-D25B-1ADF383BD481}"/>
                  </a:ext>
                </a:extLst>
              </p:cNvPr>
              <p:cNvSpPr/>
              <p:nvPr/>
            </p:nvSpPr>
            <p:spPr>
              <a:xfrm>
                <a:off x="7480278" y="8050623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86" name="フリーフォーム 685">
                <a:extLst>
                  <a:ext uri="{FF2B5EF4-FFF2-40B4-BE49-F238E27FC236}">
                    <a16:creationId xmlns:a16="http://schemas.microsoft.com/office/drawing/2014/main" xmlns="" id="{ABE563E2-4215-7DC5-FE30-0AD93753A29A}"/>
                  </a:ext>
                </a:extLst>
              </p:cNvPr>
              <p:cNvSpPr/>
              <p:nvPr/>
            </p:nvSpPr>
            <p:spPr>
              <a:xfrm>
                <a:off x="7534437" y="8050623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87" name="フリーフォーム 686">
                <a:extLst>
                  <a:ext uri="{FF2B5EF4-FFF2-40B4-BE49-F238E27FC236}">
                    <a16:creationId xmlns:a16="http://schemas.microsoft.com/office/drawing/2014/main" xmlns="" id="{83943186-4230-7465-A748-55A4F346FD13}"/>
                  </a:ext>
                </a:extLst>
              </p:cNvPr>
              <p:cNvSpPr/>
              <p:nvPr/>
            </p:nvSpPr>
            <p:spPr>
              <a:xfrm>
                <a:off x="7534437" y="8050623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88" name="フリーフォーム 687">
                <a:extLst>
                  <a:ext uri="{FF2B5EF4-FFF2-40B4-BE49-F238E27FC236}">
                    <a16:creationId xmlns:a16="http://schemas.microsoft.com/office/drawing/2014/main" xmlns="" id="{7AD8A5F2-0DC4-DAB1-4998-8D4E06306AFA}"/>
                  </a:ext>
                </a:extLst>
              </p:cNvPr>
              <p:cNvSpPr/>
              <p:nvPr/>
            </p:nvSpPr>
            <p:spPr>
              <a:xfrm>
                <a:off x="7934119" y="8050623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89" name="フリーフォーム 688">
                <a:extLst>
                  <a:ext uri="{FF2B5EF4-FFF2-40B4-BE49-F238E27FC236}">
                    <a16:creationId xmlns:a16="http://schemas.microsoft.com/office/drawing/2014/main" xmlns="" id="{998E302A-6FC1-2565-957E-3D74CC5A3196}"/>
                  </a:ext>
                </a:extLst>
              </p:cNvPr>
              <p:cNvSpPr/>
              <p:nvPr/>
            </p:nvSpPr>
            <p:spPr>
              <a:xfrm>
                <a:off x="7934119" y="8050623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90" name="フリーフォーム 689">
                <a:extLst>
                  <a:ext uri="{FF2B5EF4-FFF2-40B4-BE49-F238E27FC236}">
                    <a16:creationId xmlns:a16="http://schemas.microsoft.com/office/drawing/2014/main" xmlns="" id="{543EB38A-FC37-C44E-A6E8-D7B0BF8EAFF0}"/>
                  </a:ext>
                </a:extLst>
              </p:cNvPr>
              <p:cNvSpPr/>
              <p:nvPr/>
            </p:nvSpPr>
            <p:spPr>
              <a:xfrm>
                <a:off x="7019644" y="6476067"/>
                <a:ext cx="25200" cy="25200"/>
              </a:xfrm>
              <a:custGeom>
                <a:avLst/>
                <a:gdLst>
                  <a:gd name="connsiteX0" fmla="*/ 13304 w 26654"/>
                  <a:gd name="connsiteY0" fmla="*/ 0 h 33955"/>
                  <a:gd name="connsiteX1" fmla="*/ 26655 w 26654"/>
                  <a:gd name="connsiteY1" fmla="*/ 16978 h 33955"/>
                  <a:gd name="connsiteX2" fmla="*/ 13304 w 26654"/>
                  <a:gd name="connsiteY2" fmla="*/ 33956 h 33955"/>
                  <a:gd name="connsiteX3" fmla="*/ 0 w 26654"/>
                  <a:gd name="connsiteY3" fmla="*/ 16978 h 33955"/>
                  <a:gd name="connsiteX4" fmla="*/ 13304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04" y="0"/>
                    </a:moveTo>
                    <a:lnTo>
                      <a:pt x="26655" y="16978"/>
                    </a:lnTo>
                    <a:lnTo>
                      <a:pt x="13304" y="33956"/>
                    </a:lnTo>
                    <a:lnTo>
                      <a:pt x="0" y="16978"/>
                    </a:lnTo>
                    <a:lnTo>
                      <a:pt x="13304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91" name="フリーフォーム 690">
                <a:extLst>
                  <a:ext uri="{FF2B5EF4-FFF2-40B4-BE49-F238E27FC236}">
                    <a16:creationId xmlns:a16="http://schemas.microsoft.com/office/drawing/2014/main" xmlns="" id="{C1359228-C0F6-3688-6BCA-5E1FB2FBE79B}"/>
                  </a:ext>
                </a:extLst>
              </p:cNvPr>
              <p:cNvSpPr/>
              <p:nvPr/>
            </p:nvSpPr>
            <p:spPr>
              <a:xfrm>
                <a:off x="7019644" y="6476067"/>
                <a:ext cx="25200" cy="25200"/>
              </a:xfrm>
              <a:custGeom>
                <a:avLst/>
                <a:gdLst>
                  <a:gd name="connsiteX0" fmla="*/ 13304 w 26654"/>
                  <a:gd name="connsiteY0" fmla="*/ 0 h 33955"/>
                  <a:gd name="connsiteX1" fmla="*/ 26655 w 26654"/>
                  <a:gd name="connsiteY1" fmla="*/ 16978 h 33955"/>
                  <a:gd name="connsiteX2" fmla="*/ 13304 w 26654"/>
                  <a:gd name="connsiteY2" fmla="*/ 33956 h 33955"/>
                  <a:gd name="connsiteX3" fmla="*/ 0 w 26654"/>
                  <a:gd name="connsiteY3" fmla="*/ 16978 h 33955"/>
                  <a:gd name="connsiteX4" fmla="*/ 13304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04" y="0"/>
                    </a:moveTo>
                    <a:lnTo>
                      <a:pt x="26655" y="16978"/>
                    </a:lnTo>
                    <a:lnTo>
                      <a:pt x="13304" y="33956"/>
                    </a:lnTo>
                    <a:lnTo>
                      <a:pt x="0" y="16978"/>
                    </a:lnTo>
                    <a:lnTo>
                      <a:pt x="13304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92" name="フリーフォーム 691">
                <a:extLst>
                  <a:ext uri="{FF2B5EF4-FFF2-40B4-BE49-F238E27FC236}">
                    <a16:creationId xmlns:a16="http://schemas.microsoft.com/office/drawing/2014/main" xmlns="" id="{5BEED471-5F14-A0CE-522F-DC0B72E4904D}"/>
                  </a:ext>
                </a:extLst>
              </p:cNvPr>
              <p:cNvSpPr/>
              <p:nvPr/>
            </p:nvSpPr>
            <p:spPr>
              <a:xfrm>
                <a:off x="7195755" y="7715686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93" name="フリーフォーム 692">
                <a:extLst>
                  <a:ext uri="{FF2B5EF4-FFF2-40B4-BE49-F238E27FC236}">
                    <a16:creationId xmlns:a16="http://schemas.microsoft.com/office/drawing/2014/main" xmlns="" id="{6D610E69-D91B-6771-95D8-4FDF8EAE1B84}"/>
                  </a:ext>
                </a:extLst>
              </p:cNvPr>
              <p:cNvSpPr/>
              <p:nvPr/>
            </p:nvSpPr>
            <p:spPr>
              <a:xfrm>
                <a:off x="7195755" y="7715686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94" name="フリーフォーム 693">
                <a:extLst>
                  <a:ext uri="{FF2B5EF4-FFF2-40B4-BE49-F238E27FC236}">
                    <a16:creationId xmlns:a16="http://schemas.microsoft.com/office/drawing/2014/main" xmlns="" id="{B8B20B9F-DE5D-4CF2-98B6-5147168EE176}"/>
                  </a:ext>
                </a:extLst>
              </p:cNvPr>
              <p:cNvSpPr/>
              <p:nvPr/>
            </p:nvSpPr>
            <p:spPr>
              <a:xfrm>
                <a:off x="6863820" y="6597011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95" name="フリーフォーム 694">
                <a:extLst>
                  <a:ext uri="{FF2B5EF4-FFF2-40B4-BE49-F238E27FC236}">
                    <a16:creationId xmlns:a16="http://schemas.microsoft.com/office/drawing/2014/main" xmlns="" id="{ECAB6410-C435-2A89-F54E-7FA2C2A159E3}"/>
                  </a:ext>
                </a:extLst>
              </p:cNvPr>
              <p:cNvSpPr/>
              <p:nvPr/>
            </p:nvSpPr>
            <p:spPr>
              <a:xfrm>
                <a:off x="6863820" y="6597011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96" name="フリーフォーム 695">
                <a:extLst>
                  <a:ext uri="{FF2B5EF4-FFF2-40B4-BE49-F238E27FC236}">
                    <a16:creationId xmlns:a16="http://schemas.microsoft.com/office/drawing/2014/main" xmlns="" id="{E06E8E30-E573-2E5A-A5B9-19262B38FE72}"/>
                  </a:ext>
                </a:extLst>
              </p:cNvPr>
              <p:cNvSpPr/>
              <p:nvPr/>
            </p:nvSpPr>
            <p:spPr>
              <a:xfrm>
                <a:off x="6897692" y="6597011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699" name="フリーフォーム 698">
                <a:extLst>
                  <a:ext uri="{FF2B5EF4-FFF2-40B4-BE49-F238E27FC236}">
                    <a16:creationId xmlns:a16="http://schemas.microsoft.com/office/drawing/2014/main" xmlns="" id="{617CE487-68FF-0950-2796-39F4BFA89C5C}"/>
                  </a:ext>
                </a:extLst>
              </p:cNvPr>
              <p:cNvSpPr/>
              <p:nvPr/>
            </p:nvSpPr>
            <p:spPr>
              <a:xfrm>
                <a:off x="6897692" y="6597011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256" name="フリーフォーム 255">
                <a:extLst>
                  <a:ext uri="{FF2B5EF4-FFF2-40B4-BE49-F238E27FC236}">
                    <a16:creationId xmlns:a16="http://schemas.microsoft.com/office/drawing/2014/main" xmlns="" id="{E5727695-39AD-B294-68F1-325AFE9C87AC}"/>
                  </a:ext>
                </a:extLst>
              </p:cNvPr>
              <p:cNvSpPr/>
              <p:nvPr/>
            </p:nvSpPr>
            <p:spPr>
              <a:xfrm>
                <a:off x="6938312" y="678820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257" name="フリーフォーム 256">
                <a:extLst>
                  <a:ext uri="{FF2B5EF4-FFF2-40B4-BE49-F238E27FC236}">
                    <a16:creationId xmlns:a16="http://schemas.microsoft.com/office/drawing/2014/main" xmlns="" id="{7CEC733C-3978-E3D7-D711-8A32E23A67D6}"/>
                  </a:ext>
                </a:extLst>
              </p:cNvPr>
              <p:cNvSpPr/>
              <p:nvPr/>
            </p:nvSpPr>
            <p:spPr>
              <a:xfrm>
                <a:off x="6938312" y="678820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05" name="フリーフォーム 304">
                <a:extLst>
                  <a:ext uri="{FF2B5EF4-FFF2-40B4-BE49-F238E27FC236}">
                    <a16:creationId xmlns:a16="http://schemas.microsoft.com/office/drawing/2014/main" xmlns="" id="{6F016007-4196-B0F9-B0AA-8C921FF7CDB6}"/>
                  </a:ext>
                </a:extLst>
              </p:cNvPr>
              <p:cNvSpPr/>
              <p:nvPr/>
            </p:nvSpPr>
            <p:spPr>
              <a:xfrm>
                <a:off x="6958645" y="678820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06" name="フリーフォーム 305">
                <a:extLst>
                  <a:ext uri="{FF2B5EF4-FFF2-40B4-BE49-F238E27FC236}">
                    <a16:creationId xmlns:a16="http://schemas.microsoft.com/office/drawing/2014/main" xmlns="" id="{2AF10738-E7A0-C0AD-C3B1-E6725E231D18}"/>
                  </a:ext>
                </a:extLst>
              </p:cNvPr>
              <p:cNvSpPr/>
              <p:nvPr/>
            </p:nvSpPr>
            <p:spPr>
              <a:xfrm>
                <a:off x="6958645" y="678820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07" name="フリーフォーム 306">
                <a:extLst>
                  <a:ext uri="{FF2B5EF4-FFF2-40B4-BE49-F238E27FC236}">
                    <a16:creationId xmlns:a16="http://schemas.microsoft.com/office/drawing/2014/main" xmlns="" id="{E549FE36-B92D-8022-2564-BAC566EF115E}"/>
                  </a:ext>
                </a:extLst>
              </p:cNvPr>
              <p:cNvSpPr/>
              <p:nvPr/>
            </p:nvSpPr>
            <p:spPr>
              <a:xfrm>
                <a:off x="6972185" y="685593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08" name="フリーフォーム 307">
                <a:extLst>
                  <a:ext uri="{FF2B5EF4-FFF2-40B4-BE49-F238E27FC236}">
                    <a16:creationId xmlns:a16="http://schemas.microsoft.com/office/drawing/2014/main" xmlns="" id="{D4913E56-4E27-275D-4FE5-F6955AA9A603}"/>
                  </a:ext>
                </a:extLst>
              </p:cNvPr>
              <p:cNvSpPr/>
              <p:nvPr/>
            </p:nvSpPr>
            <p:spPr>
              <a:xfrm>
                <a:off x="6972185" y="685593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09" name="フリーフォーム 308">
                <a:extLst>
                  <a:ext uri="{FF2B5EF4-FFF2-40B4-BE49-F238E27FC236}">
                    <a16:creationId xmlns:a16="http://schemas.microsoft.com/office/drawing/2014/main" xmlns="" id="{2561AA9A-CEF7-B92C-40BD-1CF580BFE63F}"/>
                  </a:ext>
                </a:extLst>
              </p:cNvPr>
              <p:cNvSpPr/>
              <p:nvPr/>
            </p:nvSpPr>
            <p:spPr>
              <a:xfrm>
                <a:off x="6978978" y="685593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0" name="フリーフォーム 309">
                <a:extLst>
                  <a:ext uri="{FF2B5EF4-FFF2-40B4-BE49-F238E27FC236}">
                    <a16:creationId xmlns:a16="http://schemas.microsoft.com/office/drawing/2014/main" xmlns="" id="{0A95CFA8-9320-257B-60B5-180310AB2D2F}"/>
                  </a:ext>
                </a:extLst>
              </p:cNvPr>
              <p:cNvSpPr/>
              <p:nvPr/>
            </p:nvSpPr>
            <p:spPr>
              <a:xfrm>
                <a:off x="6978978" y="6855938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1" name="フリーフォーム 310">
                <a:extLst>
                  <a:ext uri="{FF2B5EF4-FFF2-40B4-BE49-F238E27FC236}">
                    <a16:creationId xmlns:a16="http://schemas.microsoft.com/office/drawing/2014/main" xmlns="" id="{7E38FEF6-1206-1994-1157-B54AF4F0D9C6}"/>
                  </a:ext>
                </a:extLst>
              </p:cNvPr>
              <p:cNvSpPr/>
              <p:nvPr/>
            </p:nvSpPr>
            <p:spPr>
              <a:xfrm>
                <a:off x="7026391" y="700069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2" name="フリーフォーム 311">
                <a:extLst>
                  <a:ext uri="{FF2B5EF4-FFF2-40B4-BE49-F238E27FC236}">
                    <a16:creationId xmlns:a16="http://schemas.microsoft.com/office/drawing/2014/main" xmlns="" id="{01018FFF-FCA8-E63E-6615-F460ED6416F5}"/>
                  </a:ext>
                </a:extLst>
              </p:cNvPr>
              <p:cNvSpPr/>
              <p:nvPr/>
            </p:nvSpPr>
            <p:spPr>
              <a:xfrm>
                <a:off x="7026391" y="700069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3" name="フリーフォーム 312">
                <a:extLst>
                  <a:ext uri="{FF2B5EF4-FFF2-40B4-BE49-F238E27FC236}">
                    <a16:creationId xmlns:a16="http://schemas.microsoft.com/office/drawing/2014/main" xmlns="" id="{D084CF84-724D-FE2E-A21D-BA3C19DE5ED7}"/>
                  </a:ext>
                </a:extLst>
              </p:cNvPr>
              <p:cNvSpPr/>
              <p:nvPr/>
            </p:nvSpPr>
            <p:spPr>
              <a:xfrm>
                <a:off x="7060264" y="707586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4" name="フリーフォーム 313">
                <a:extLst>
                  <a:ext uri="{FF2B5EF4-FFF2-40B4-BE49-F238E27FC236}">
                    <a16:creationId xmlns:a16="http://schemas.microsoft.com/office/drawing/2014/main" xmlns="" id="{14B7695F-D3FB-C3AE-B18D-F65F123F866B}"/>
                  </a:ext>
                </a:extLst>
              </p:cNvPr>
              <p:cNvSpPr/>
              <p:nvPr/>
            </p:nvSpPr>
            <p:spPr>
              <a:xfrm>
                <a:off x="7060264" y="707586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5" name="フリーフォーム 314">
                <a:extLst>
                  <a:ext uri="{FF2B5EF4-FFF2-40B4-BE49-F238E27FC236}">
                    <a16:creationId xmlns:a16="http://schemas.microsoft.com/office/drawing/2014/main" xmlns="" id="{D11894C1-F71A-7EF2-B06F-9F23C5300CAB}"/>
                  </a:ext>
                </a:extLst>
              </p:cNvPr>
              <p:cNvSpPr/>
              <p:nvPr/>
            </p:nvSpPr>
            <p:spPr>
              <a:xfrm>
                <a:off x="7107676" y="715421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6" name="フリーフォーム 315">
                <a:extLst>
                  <a:ext uri="{FF2B5EF4-FFF2-40B4-BE49-F238E27FC236}">
                    <a16:creationId xmlns:a16="http://schemas.microsoft.com/office/drawing/2014/main" xmlns="" id="{A0D286C3-7306-1A45-6C3B-0DE680A04BB8}"/>
                  </a:ext>
                </a:extLst>
              </p:cNvPr>
              <p:cNvSpPr/>
              <p:nvPr/>
            </p:nvSpPr>
            <p:spPr>
              <a:xfrm>
                <a:off x="7107676" y="715421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7" name="フリーフォーム 316">
                <a:extLst>
                  <a:ext uri="{FF2B5EF4-FFF2-40B4-BE49-F238E27FC236}">
                    <a16:creationId xmlns:a16="http://schemas.microsoft.com/office/drawing/2014/main" xmlns="" id="{8826F5E6-4B06-6993-48AA-2A521598D4DB}"/>
                  </a:ext>
                </a:extLst>
              </p:cNvPr>
              <p:cNvSpPr/>
              <p:nvPr/>
            </p:nvSpPr>
            <p:spPr>
              <a:xfrm>
                <a:off x="7209295" y="739976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8" name="フリーフォーム 317">
                <a:extLst>
                  <a:ext uri="{FF2B5EF4-FFF2-40B4-BE49-F238E27FC236}">
                    <a16:creationId xmlns:a16="http://schemas.microsoft.com/office/drawing/2014/main" xmlns="" id="{BFA23CC3-0E96-208F-E1C2-60CBAA738F62}"/>
                  </a:ext>
                </a:extLst>
              </p:cNvPr>
              <p:cNvSpPr/>
              <p:nvPr/>
            </p:nvSpPr>
            <p:spPr>
              <a:xfrm>
                <a:off x="7209295" y="739976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319" name="フリーフォーム 318">
                <a:extLst>
                  <a:ext uri="{FF2B5EF4-FFF2-40B4-BE49-F238E27FC236}">
                    <a16:creationId xmlns:a16="http://schemas.microsoft.com/office/drawing/2014/main" xmlns="" id="{4D4940B1-66AB-70E7-4E12-7E2DDB6B9079}"/>
                  </a:ext>
                </a:extLst>
              </p:cNvPr>
              <p:cNvSpPr/>
              <p:nvPr/>
            </p:nvSpPr>
            <p:spPr>
              <a:xfrm>
                <a:off x="7216088" y="7399767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74" name="フリーフォーム 773">
                <a:extLst>
                  <a:ext uri="{FF2B5EF4-FFF2-40B4-BE49-F238E27FC236}">
                    <a16:creationId xmlns:a16="http://schemas.microsoft.com/office/drawing/2014/main" xmlns="" id="{08920158-F166-905A-587A-BBD2865D928A}"/>
                  </a:ext>
                </a:extLst>
              </p:cNvPr>
              <p:cNvSpPr/>
              <p:nvPr/>
            </p:nvSpPr>
            <p:spPr>
              <a:xfrm>
                <a:off x="7216088" y="7399767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75" name="フリーフォーム 774">
                <a:extLst>
                  <a:ext uri="{FF2B5EF4-FFF2-40B4-BE49-F238E27FC236}">
                    <a16:creationId xmlns:a16="http://schemas.microsoft.com/office/drawing/2014/main" xmlns="" id="{FD9944D9-743F-3592-D6AF-F08726BD1B94}"/>
                  </a:ext>
                </a:extLst>
              </p:cNvPr>
              <p:cNvSpPr/>
              <p:nvPr/>
            </p:nvSpPr>
            <p:spPr>
              <a:xfrm>
                <a:off x="7243168" y="7582804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78 h 33895"/>
                  <a:gd name="connsiteX2" fmla="*/ 13351 w 26702"/>
                  <a:gd name="connsiteY2" fmla="*/ 33896 h 33895"/>
                  <a:gd name="connsiteX3" fmla="*/ 0 w 26702"/>
                  <a:gd name="connsiteY3" fmla="*/ 1697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89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76" name="フリーフォーム 775">
                <a:extLst>
                  <a:ext uri="{FF2B5EF4-FFF2-40B4-BE49-F238E27FC236}">
                    <a16:creationId xmlns:a16="http://schemas.microsoft.com/office/drawing/2014/main" xmlns="" id="{1EB33740-21AC-9543-0327-62A799F98460}"/>
                  </a:ext>
                </a:extLst>
              </p:cNvPr>
              <p:cNvSpPr/>
              <p:nvPr/>
            </p:nvSpPr>
            <p:spPr>
              <a:xfrm>
                <a:off x="7243168" y="7582804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78 h 33895"/>
                  <a:gd name="connsiteX2" fmla="*/ 13351 w 26702"/>
                  <a:gd name="connsiteY2" fmla="*/ 33896 h 33895"/>
                  <a:gd name="connsiteX3" fmla="*/ 0 w 26702"/>
                  <a:gd name="connsiteY3" fmla="*/ 1697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89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77" name="フリーフォーム 776">
                <a:extLst>
                  <a:ext uri="{FF2B5EF4-FFF2-40B4-BE49-F238E27FC236}">
                    <a16:creationId xmlns:a16="http://schemas.microsoft.com/office/drawing/2014/main" xmlns="" id="{CB3AEE39-0C4F-A9DB-7ABB-E3C72C2F020B}"/>
                  </a:ext>
                </a:extLst>
              </p:cNvPr>
              <p:cNvSpPr/>
              <p:nvPr/>
            </p:nvSpPr>
            <p:spPr>
              <a:xfrm>
                <a:off x="7297374" y="7582804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895"/>
                  <a:gd name="connsiteX1" fmla="*/ 26655 w 26654"/>
                  <a:gd name="connsiteY1" fmla="*/ 16978 h 33895"/>
                  <a:gd name="connsiteX2" fmla="*/ 13351 w 26654"/>
                  <a:gd name="connsiteY2" fmla="*/ 33896 h 33895"/>
                  <a:gd name="connsiteX3" fmla="*/ 0 w 26654"/>
                  <a:gd name="connsiteY3" fmla="*/ 16978 h 33895"/>
                  <a:gd name="connsiteX4" fmla="*/ 13351 w 26654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89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89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78" name="フリーフォーム 777">
                <a:extLst>
                  <a:ext uri="{FF2B5EF4-FFF2-40B4-BE49-F238E27FC236}">
                    <a16:creationId xmlns:a16="http://schemas.microsoft.com/office/drawing/2014/main" xmlns="" id="{8AE240D6-95BE-03D9-5F3E-4B3DFFBB4369}"/>
                  </a:ext>
                </a:extLst>
              </p:cNvPr>
              <p:cNvSpPr/>
              <p:nvPr/>
            </p:nvSpPr>
            <p:spPr>
              <a:xfrm>
                <a:off x="7297374" y="7582804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895"/>
                  <a:gd name="connsiteX1" fmla="*/ 26655 w 26654"/>
                  <a:gd name="connsiteY1" fmla="*/ 16978 h 33895"/>
                  <a:gd name="connsiteX2" fmla="*/ 13351 w 26654"/>
                  <a:gd name="connsiteY2" fmla="*/ 33896 h 33895"/>
                  <a:gd name="connsiteX3" fmla="*/ 0 w 26654"/>
                  <a:gd name="connsiteY3" fmla="*/ 16978 h 33895"/>
                  <a:gd name="connsiteX4" fmla="*/ 13351 w 26654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89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89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79" name="フリーフォーム 778">
                <a:extLst>
                  <a:ext uri="{FF2B5EF4-FFF2-40B4-BE49-F238E27FC236}">
                    <a16:creationId xmlns:a16="http://schemas.microsoft.com/office/drawing/2014/main" xmlns="" id="{A88CD3BB-B02E-508A-8AB0-95E6537159F8}"/>
                  </a:ext>
                </a:extLst>
              </p:cNvPr>
              <p:cNvSpPr/>
              <p:nvPr/>
            </p:nvSpPr>
            <p:spPr>
              <a:xfrm>
                <a:off x="7337993" y="7582804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78 h 33895"/>
                  <a:gd name="connsiteX2" fmla="*/ 13351 w 26702"/>
                  <a:gd name="connsiteY2" fmla="*/ 33896 h 33895"/>
                  <a:gd name="connsiteX3" fmla="*/ 0 w 26702"/>
                  <a:gd name="connsiteY3" fmla="*/ 1697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89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0" name="フリーフォーム 779">
                <a:extLst>
                  <a:ext uri="{FF2B5EF4-FFF2-40B4-BE49-F238E27FC236}">
                    <a16:creationId xmlns:a16="http://schemas.microsoft.com/office/drawing/2014/main" xmlns="" id="{7B28291B-9F4A-5F9E-1C4F-364CE35FBD4D}"/>
                  </a:ext>
                </a:extLst>
              </p:cNvPr>
              <p:cNvSpPr/>
              <p:nvPr/>
            </p:nvSpPr>
            <p:spPr>
              <a:xfrm>
                <a:off x="7337993" y="7582804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78 h 33895"/>
                  <a:gd name="connsiteX2" fmla="*/ 13351 w 26702"/>
                  <a:gd name="connsiteY2" fmla="*/ 33896 h 33895"/>
                  <a:gd name="connsiteX3" fmla="*/ 0 w 26702"/>
                  <a:gd name="connsiteY3" fmla="*/ 1697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89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1" name="フリーフォーム 780">
                <a:extLst>
                  <a:ext uri="{FF2B5EF4-FFF2-40B4-BE49-F238E27FC236}">
                    <a16:creationId xmlns:a16="http://schemas.microsoft.com/office/drawing/2014/main" xmlns="" id="{21028BE8-83CB-6F0C-C69F-B211BF9B79B4}"/>
                  </a:ext>
                </a:extLst>
              </p:cNvPr>
              <p:cNvSpPr/>
              <p:nvPr/>
            </p:nvSpPr>
            <p:spPr>
              <a:xfrm>
                <a:off x="7737675" y="815464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5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5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2" name="フリーフォーム 781">
                <a:extLst>
                  <a:ext uri="{FF2B5EF4-FFF2-40B4-BE49-F238E27FC236}">
                    <a16:creationId xmlns:a16="http://schemas.microsoft.com/office/drawing/2014/main" xmlns="" id="{0F49A2C3-24CE-1106-B614-1E4EAF77A38A}"/>
                  </a:ext>
                </a:extLst>
              </p:cNvPr>
              <p:cNvSpPr/>
              <p:nvPr/>
            </p:nvSpPr>
            <p:spPr>
              <a:xfrm>
                <a:off x="7737675" y="815464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5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5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3" name="フリーフォーム 782">
                <a:extLst>
                  <a:ext uri="{FF2B5EF4-FFF2-40B4-BE49-F238E27FC236}">
                    <a16:creationId xmlns:a16="http://schemas.microsoft.com/office/drawing/2014/main" xmlns="" id="{74B21C2C-61A3-6508-AF0C-72C2225227FE}"/>
                  </a:ext>
                </a:extLst>
              </p:cNvPr>
              <p:cNvSpPr/>
              <p:nvPr/>
            </p:nvSpPr>
            <p:spPr>
              <a:xfrm>
                <a:off x="7751215" y="815464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5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5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4" name="フリーフォーム 783">
                <a:extLst>
                  <a:ext uri="{FF2B5EF4-FFF2-40B4-BE49-F238E27FC236}">
                    <a16:creationId xmlns:a16="http://schemas.microsoft.com/office/drawing/2014/main" xmlns="" id="{882D60C8-EA62-4ECB-9974-F281C2A6FEBF}"/>
                  </a:ext>
                </a:extLst>
              </p:cNvPr>
              <p:cNvSpPr/>
              <p:nvPr/>
            </p:nvSpPr>
            <p:spPr>
              <a:xfrm>
                <a:off x="7751215" y="815464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5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5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5" name="フリーフォーム 784">
                <a:extLst>
                  <a:ext uri="{FF2B5EF4-FFF2-40B4-BE49-F238E27FC236}">
                    <a16:creationId xmlns:a16="http://schemas.microsoft.com/office/drawing/2014/main" xmlns="" id="{30ABF0EF-88F7-DABE-9AC8-313BAD59B199}"/>
                  </a:ext>
                </a:extLst>
              </p:cNvPr>
              <p:cNvSpPr/>
              <p:nvPr/>
            </p:nvSpPr>
            <p:spPr>
              <a:xfrm>
                <a:off x="8374467" y="831476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6" name="フリーフォーム 785">
                <a:extLst>
                  <a:ext uri="{FF2B5EF4-FFF2-40B4-BE49-F238E27FC236}">
                    <a16:creationId xmlns:a16="http://schemas.microsoft.com/office/drawing/2014/main" xmlns="" id="{BE8CD7D2-3B50-D3CF-9015-72AABDF936F7}"/>
                  </a:ext>
                </a:extLst>
              </p:cNvPr>
              <p:cNvSpPr/>
              <p:nvPr/>
            </p:nvSpPr>
            <p:spPr>
              <a:xfrm>
                <a:off x="8374467" y="831476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7" name="フリーフォーム 786">
                <a:extLst>
                  <a:ext uri="{FF2B5EF4-FFF2-40B4-BE49-F238E27FC236}">
                    <a16:creationId xmlns:a16="http://schemas.microsoft.com/office/drawing/2014/main" xmlns="" id="{1622F0DE-E223-95A1-2D96-BF7D8E53C538}"/>
                  </a:ext>
                </a:extLst>
              </p:cNvPr>
              <p:cNvSpPr/>
              <p:nvPr/>
            </p:nvSpPr>
            <p:spPr>
              <a:xfrm>
                <a:off x="8482832" y="831476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8" name="フリーフォーム 787">
                <a:extLst>
                  <a:ext uri="{FF2B5EF4-FFF2-40B4-BE49-F238E27FC236}">
                    <a16:creationId xmlns:a16="http://schemas.microsoft.com/office/drawing/2014/main" xmlns="" id="{869A53C0-866D-1F2D-A4DE-469863BDD653}"/>
                  </a:ext>
                </a:extLst>
              </p:cNvPr>
              <p:cNvSpPr/>
              <p:nvPr/>
            </p:nvSpPr>
            <p:spPr>
              <a:xfrm>
                <a:off x="8482832" y="8314769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89" name="フリーフォーム 788">
                <a:extLst>
                  <a:ext uri="{FF2B5EF4-FFF2-40B4-BE49-F238E27FC236}">
                    <a16:creationId xmlns:a16="http://schemas.microsoft.com/office/drawing/2014/main" xmlns="" id="{A769E340-D4CC-DFB3-480C-B596805BE607}"/>
                  </a:ext>
                </a:extLst>
              </p:cNvPr>
              <p:cNvSpPr/>
              <p:nvPr/>
            </p:nvSpPr>
            <p:spPr>
              <a:xfrm>
                <a:off x="8889307" y="8314769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0" name="フリーフォーム 789">
                <a:extLst>
                  <a:ext uri="{FF2B5EF4-FFF2-40B4-BE49-F238E27FC236}">
                    <a16:creationId xmlns:a16="http://schemas.microsoft.com/office/drawing/2014/main" xmlns="" id="{44E41FDE-6198-7770-2509-7199E7A173DE}"/>
                  </a:ext>
                </a:extLst>
              </p:cNvPr>
              <p:cNvSpPr/>
              <p:nvPr/>
            </p:nvSpPr>
            <p:spPr>
              <a:xfrm>
                <a:off x="8889307" y="8314769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1" name="フリーフォーム 790">
                <a:extLst>
                  <a:ext uri="{FF2B5EF4-FFF2-40B4-BE49-F238E27FC236}">
                    <a16:creationId xmlns:a16="http://schemas.microsoft.com/office/drawing/2014/main" xmlns="" id="{83695871-7572-D626-64B0-8DD5C7C207F0}"/>
                  </a:ext>
                </a:extLst>
              </p:cNvPr>
              <p:cNvSpPr/>
              <p:nvPr/>
            </p:nvSpPr>
            <p:spPr>
              <a:xfrm>
                <a:off x="6829947" y="647606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2" name="フリーフォーム 791">
                <a:extLst>
                  <a:ext uri="{FF2B5EF4-FFF2-40B4-BE49-F238E27FC236}">
                    <a16:creationId xmlns:a16="http://schemas.microsoft.com/office/drawing/2014/main" xmlns="" id="{D5D5C2C1-8044-8E6C-4999-F0E4897680CB}"/>
                  </a:ext>
                </a:extLst>
              </p:cNvPr>
              <p:cNvSpPr/>
              <p:nvPr/>
            </p:nvSpPr>
            <p:spPr>
              <a:xfrm>
                <a:off x="6829947" y="6476067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3" name="フリーフォーム 792">
                <a:extLst>
                  <a:ext uri="{FF2B5EF4-FFF2-40B4-BE49-F238E27FC236}">
                    <a16:creationId xmlns:a16="http://schemas.microsoft.com/office/drawing/2014/main" xmlns="" id="{0202EDB4-A3DD-5F70-CAC6-DD8D1CFE8800}"/>
                  </a:ext>
                </a:extLst>
              </p:cNvPr>
              <p:cNvSpPr/>
              <p:nvPr/>
            </p:nvSpPr>
            <p:spPr>
              <a:xfrm>
                <a:off x="6918026" y="6889293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895"/>
                  <a:gd name="connsiteX1" fmla="*/ 26655 w 26654"/>
                  <a:gd name="connsiteY1" fmla="*/ 16918 h 33895"/>
                  <a:gd name="connsiteX2" fmla="*/ 13351 w 26654"/>
                  <a:gd name="connsiteY2" fmla="*/ 33896 h 33895"/>
                  <a:gd name="connsiteX3" fmla="*/ 0 w 26654"/>
                  <a:gd name="connsiteY3" fmla="*/ 16918 h 33895"/>
                  <a:gd name="connsiteX4" fmla="*/ 13351 w 26654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895">
                    <a:moveTo>
                      <a:pt x="13351" y="0"/>
                    </a:moveTo>
                    <a:lnTo>
                      <a:pt x="26655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4" name="フリーフォーム 793">
                <a:extLst>
                  <a:ext uri="{FF2B5EF4-FFF2-40B4-BE49-F238E27FC236}">
                    <a16:creationId xmlns:a16="http://schemas.microsoft.com/office/drawing/2014/main" xmlns="" id="{F5F51182-F11F-EBB3-9071-67C2B3BE940D}"/>
                  </a:ext>
                </a:extLst>
              </p:cNvPr>
              <p:cNvSpPr/>
              <p:nvPr/>
            </p:nvSpPr>
            <p:spPr>
              <a:xfrm>
                <a:off x="6918026" y="6889293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895"/>
                  <a:gd name="connsiteX1" fmla="*/ 26655 w 26654"/>
                  <a:gd name="connsiteY1" fmla="*/ 16918 h 33895"/>
                  <a:gd name="connsiteX2" fmla="*/ 13351 w 26654"/>
                  <a:gd name="connsiteY2" fmla="*/ 33896 h 33895"/>
                  <a:gd name="connsiteX3" fmla="*/ 0 w 26654"/>
                  <a:gd name="connsiteY3" fmla="*/ 16918 h 33895"/>
                  <a:gd name="connsiteX4" fmla="*/ 13351 w 26654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895">
                    <a:moveTo>
                      <a:pt x="13351" y="0"/>
                    </a:moveTo>
                    <a:lnTo>
                      <a:pt x="26655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5" name="フリーフォーム 794">
                <a:extLst>
                  <a:ext uri="{FF2B5EF4-FFF2-40B4-BE49-F238E27FC236}">
                    <a16:creationId xmlns:a16="http://schemas.microsoft.com/office/drawing/2014/main" xmlns="" id="{CCFB13FF-5494-7434-4E3B-240E69B9A6F1}"/>
                  </a:ext>
                </a:extLst>
              </p:cNvPr>
              <p:cNvSpPr/>
              <p:nvPr/>
            </p:nvSpPr>
            <p:spPr>
              <a:xfrm>
                <a:off x="6938312" y="6889293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6" name="フリーフォーム 795">
                <a:extLst>
                  <a:ext uri="{FF2B5EF4-FFF2-40B4-BE49-F238E27FC236}">
                    <a16:creationId xmlns:a16="http://schemas.microsoft.com/office/drawing/2014/main" xmlns="" id="{1DE3971C-F90D-3A83-FC6E-CE50C0F036A0}"/>
                  </a:ext>
                </a:extLst>
              </p:cNvPr>
              <p:cNvSpPr/>
              <p:nvPr/>
            </p:nvSpPr>
            <p:spPr>
              <a:xfrm>
                <a:off x="6938312" y="6889293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895"/>
                  <a:gd name="connsiteX1" fmla="*/ 26702 w 26702"/>
                  <a:gd name="connsiteY1" fmla="*/ 16918 h 33895"/>
                  <a:gd name="connsiteX2" fmla="*/ 13351 w 26702"/>
                  <a:gd name="connsiteY2" fmla="*/ 33896 h 33895"/>
                  <a:gd name="connsiteX3" fmla="*/ 0 w 26702"/>
                  <a:gd name="connsiteY3" fmla="*/ 16918 h 33895"/>
                  <a:gd name="connsiteX4" fmla="*/ 13351 w 26702"/>
                  <a:gd name="connsiteY4" fmla="*/ 0 h 33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895">
                    <a:moveTo>
                      <a:pt x="13351" y="0"/>
                    </a:moveTo>
                    <a:lnTo>
                      <a:pt x="26702" y="16918"/>
                    </a:lnTo>
                    <a:lnTo>
                      <a:pt x="13351" y="33896"/>
                    </a:lnTo>
                    <a:lnTo>
                      <a:pt x="0" y="1691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7" name="フリーフォーム 796">
                <a:extLst>
                  <a:ext uri="{FF2B5EF4-FFF2-40B4-BE49-F238E27FC236}">
                    <a16:creationId xmlns:a16="http://schemas.microsoft.com/office/drawing/2014/main" xmlns="" id="{3C2A4AF1-5E14-7A1B-39CD-55F65B0C4DBB}"/>
                  </a:ext>
                </a:extLst>
              </p:cNvPr>
              <p:cNvSpPr/>
              <p:nvPr/>
            </p:nvSpPr>
            <p:spPr>
              <a:xfrm>
                <a:off x="7446405" y="8180506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8" name="フリーフォーム 797">
                <a:extLst>
                  <a:ext uri="{FF2B5EF4-FFF2-40B4-BE49-F238E27FC236}">
                    <a16:creationId xmlns:a16="http://schemas.microsoft.com/office/drawing/2014/main" xmlns="" id="{FF47BE73-9774-2F0A-82B7-B786F9524685}"/>
                  </a:ext>
                </a:extLst>
              </p:cNvPr>
              <p:cNvSpPr/>
              <p:nvPr/>
            </p:nvSpPr>
            <p:spPr>
              <a:xfrm>
                <a:off x="7446405" y="8180506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799" name="フリーフォーム 798">
                <a:extLst>
                  <a:ext uri="{FF2B5EF4-FFF2-40B4-BE49-F238E27FC236}">
                    <a16:creationId xmlns:a16="http://schemas.microsoft.com/office/drawing/2014/main" xmlns="" id="{9B05EFB5-382D-AC6D-05AB-6862787CB106}"/>
                  </a:ext>
                </a:extLst>
              </p:cNvPr>
              <p:cNvSpPr/>
              <p:nvPr/>
            </p:nvSpPr>
            <p:spPr>
              <a:xfrm>
                <a:off x="7480278" y="8180506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800" name="フリーフォーム 799">
                <a:extLst>
                  <a:ext uri="{FF2B5EF4-FFF2-40B4-BE49-F238E27FC236}">
                    <a16:creationId xmlns:a16="http://schemas.microsoft.com/office/drawing/2014/main" xmlns="" id="{7F55502E-C94D-1CDA-9DD5-CA8C8648BB2A}"/>
                  </a:ext>
                </a:extLst>
              </p:cNvPr>
              <p:cNvSpPr/>
              <p:nvPr/>
            </p:nvSpPr>
            <p:spPr>
              <a:xfrm>
                <a:off x="7480278" y="8180506"/>
                <a:ext cx="25200" cy="25200"/>
              </a:xfrm>
              <a:custGeom>
                <a:avLst/>
                <a:gdLst>
                  <a:gd name="connsiteX0" fmla="*/ 13351 w 26654"/>
                  <a:gd name="connsiteY0" fmla="*/ 0 h 33955"/>
                  <a:gd name="connsiteX1" fmla="*/ 26655 w 26654"/>
                  <a:gd name="connsiteY1" fmla="*/ 16978 h 33955"/>
                  <a:gd name="connsiteX2" fmla="*/ 13351 w 26654"/>
                  <a:gd name="connsiteY2" fmla="*/ 33956 h 33955"/>
                  <a:gd name="connsiteX3" fmla="*/ 0 w 26654"/>
                  <a:gd name="connsiteY3" fmla="*/ 16978 h 33955"/>
                  <a:gd name="connsiteX4" fmla="*/ 13351 w 26654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654" h="33955">
                    <a:moveTo>
                      <a:pt x="13351" y="0"/>
                    </a:moveTo>
                    <a:lnTo>
                      <a:pt x="26655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801" name="フリーフォーム 800">
                <a:extLst>
                  <a:ext uri="{FF2B5EF4-FFF2-40B4-BE49-F238E27FC236}">
                    <a16:creationId xmlns:a16="http://schemas.microsoft.com/office/drawing/2014/main" xmlns="" id="{53DAD630-9A60-F139-4326-3035B1459B3F}"/>
                  </a:ext>
                </a:extLst>
              </p:cNvPr>
              <p:cNvSpPr/>
              <p:nvPr/>
            </p:nvSpPr>
            <p:spPr>
              <a:xfrm>
                <a:off x="7507358" y="8180506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solidFill>
                <a:srgbClr val="000000"/>
              </a:solidFill>
              <a:ln w="4712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802" name="フリーフォーム 801">
                <a:extLst>
                  <a:ext uri="{FF2B5EF4-FFF2-40B4-BE49-F238E27FC236}">
                    <a16:creationId xmlns:a16="http://schemas.microsoft.com/office/drawing/2014/main" xmlns="" id="{65F52D7B-AD16-3654-BE84-1D91EEE529A0}"/>
                  </a:ext>
                </a:extLst>
              </p:cNvPr>
              <p:cNvSpPr/>
              <p:nvPr/>
            </p:nvSpPr>
            <p:spPr>
              <a:xfrm>
                <a:off x="7507358" y="8180506"/>
                <a:ext cx="25200" cy="25200"/>
              </a:xfrm>
              <a:custGeom>
                <a:avLst/>
                <a:gdLst>
                  <a:gd name="connsiteX0" fmla="*/ 13351 w 26702"/>
                  <a:gd name="connsiteY0" fmla="*/ 0 h 33955"/>
                  <a:gd name="connsiteX1" fmla="*/ 26702 w 26702"/>
                  <a:gd name="connsiteY1" fmla="*/ 16978 h 33955"/>
                  <a:gd name="connsiteX2" fmla="*/ 13351 w 26702"/>
                  <a:gd name="connsiteY2" fmla="*/ 33956 h 33955"/>
                  <a:gd name="connsiteX3" fmla="*/ 0 w 26702"/>
                  <a:gd name="connsiteY3" fmla="*/ 16978 h 33955"/>
                  <a:gd name="connsiteX4" fmla="*/ 13351 w 26702"/>
                  <a:gd name="connsiteY4" fmla="*/ 0 h 339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6702" h="33955">
                    <a:moveTo>
                      <a:pt x="13351" y="0"/>
                    </a:moveTo>
                    <a:lnTo>
                      <a:pt x="26702" y="16978"/>
                    </a:lnTo>
                    <a:lnTo>
                      <a:pt x="13351" y="33956"/>
                    </a:lnTo>
                    <a:lnTo>
                      <a:pt x="0" y="16978"/>
                    </a:lnTo>
                    <a:lnTo>
                      <a:pt x="13351" y="0"/>
                    </a:lnTo>
                    <a:close/>
                  </a:path>
                </a:pathLst>
              </a:custGeom>
              <a:noFill/>
              <a:ln w="4712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33477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45</TotalTime>
  <Words>347</Words>
  <Application>Microsoft Office PowerPoint</Application>
  <PresentationFormat>Widescreen</PresentationFormat>
  <Paragraphs>168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游ゴシック</vt:lpstr>
      <vt:lpstr>游ゴシック Light</vt:lpstr>
      <vt:lpstr>Arial</vt:lpstr>
      <vt:lpstr>Meiryo UI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ong-term outcomes of EUS-guided hepaticogastrostomy/hepaticoduodenostomy-based  internal drainage for malignant hilar biliary obstruction</dc:title>
  <dc:creator>Yamashige Daiki　</dc:creator>
  <cp:lastModifiedBy>Pachaiyappan M Murugesan M</cp:lastModifiedBy>
  <cp:revision>19</cp:revision>
  <dcterms:created xsi:type="dcterms:W3CDTF">2023-08-11T12:13:42Z</dcterms:created>
  <dcterms:modified xsi:type="dcterms:W3CDTF">2024-10-14T02:04:25Z</dcterms:modified>
</cp:coreProperties>
</file>